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wdp" ContentType="image/vnd.ms-photo"/>
  <Default Extension="vml" ContentType="application/vnd.openxmlformats-officedocument.vmlDrawing"/>
  <Default Extension="tiff" ContentType="image/tiff"/>
  <Default Extension="jpg" ContentType="image/jpeg"/>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 id="2147483660" r:id="rId5"/>
  </p:sldMasterIdLst>
  <p:notesMasterIdLst>
    <p:notesMasterId r:id="rId16"/>
  </p:notesMasterIdLst>
  <p:sldIdLst>
    <p:sldId id="319" r:id="rId6"/>
    <p:sldId id="317" r:id="rId7"/>
    <p:sldId id="328" r:id="rId8"/>
    <p:sldId id="325" r:id="rId9"/>
    <p:sldId id="324" r:id="rId10"/>
    <p:sldId id="329" r:id="rId11"/>
    <p:sldId id="326" r:id="rId12"/>
    <p:sldId id="303" r:id="rId13"/>
    <p:sldId id="327" r:id="rId14"/>
    <p:sldId id="322" r:id="rId1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200F2"/>
    <a:srgbClr val="FF00FF"/>
    <a:srgbClr val="A70990"/>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114" d="100"/>
          <a:sy n="114" d="100"/>
        </p:scale>
        <p:origin x="474" y="102"/>
      </p:cViewPr>
      <p:guideLst/>
    </p:cSldViewPr>
  </p:slideViewPr>
  <p:notesTextViewPr>
    <p:cViewPr>
      <p:scale>
        <a:sx n="1" d="1"/>
        <a:sy n="1" d="1"/>
      </p:scale>
      <p:origin x="0" y="0"/>
    </p:cViewPr>
  </p:notesTextViewPr>
  <p:sorterViewPr>
    <p:cViewPr varScale="1">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presProps" Target="presProps.xml"/><Relationship Id="rId2" Type="http://schemas.openxmlformats.org/officeDocument/2006/relationships/customXml" Target="../customXml/item2.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1.xml"/><Relationship Id="rId11" Type="http://schemas.openxmlformats.org/officeDocument/2006/relationships/slide" Target="slides/slide6.xml"/><Relationship Id="rId5" Type="http://schemas.openxmlformats.org/officeDocument/2006/relationships/slideMaster" Target="slideMasters/slideMaster2.xml"/><Relationship Id="rId15" Type="http://schemas.openxmlformats.org/officeDocument/2006/relationships/slide" Target="slides/slide10.xml"/><Relationship Id="rId10" Type="http://schemas.openxmlformats.org/officeDocument/2006/relationships/slide" Target="slides/slide5.xml"/><Relationship Id="rId19"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slide" Target="slides/slide4.xml"/><Relationship Id="rId14" Type="http://schemas.openxmlformats.org/officeDocument/2006/relationships/slide" Target="slides/slide9.xml"/></Relationships>
</file>

<file path=ppt/charts/_rels/chart1.xml.rels><?xml version="1.0" encoding="UTF-8" standalone="yes"?>
<Relationships xmlns="http://schemas.openxmlformats.org/package/2006/relationships"><Relationship Id="rId3" Type="http://schemas.openxmlformats.org/officeDocument/2006/relationships/oleObject" Target="../embeddings/oleObject4.bin"/><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C:\Users\13232758\Desktop\0%20h\616.xlsx" TargetMode="External"/><Relationship Id="rId2" Type="http://schemas.microsoft.com/office/2011/relationships/chartColorStyle" Target="colors2.xml"/><Relationship Id="rId1" Type="http://schemas.microsoft.com/office/2011/relationships/chartStyle" Target="styl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0996984524193965"/>
          <c:y val="5.0925925925925923E-2"/>
          <c:w val="0.76690913532249061"/>
          <c:h val="0.8087020299544031"/>
        </c:manualLayout>
      </c:layout>
      <c:lineChart>
        <c:grouping val="standard"/>
        <c:varyColors val="0"/>
        <c:ser>
          <c:idx val="0"/>
          <c:order val="0"/>
          <c:tx>
            <c:strRef>
              <c:f>'[Chart in Microsoft PowerPoint]HCT116-Untreated'!$N$25</c:f>
              <c:strCache>
                <c:ptCount val="1"/>
                <c:pt idx="0">
                  <c:v>HCT116-miR-CTRL</c:v>
                </c:pt>
              </c:strCache>
            </c:strRef>
          </c:tx>
          <c:spPr>
            <a:ln w="28575" cap="rnd">
              <a:solidFill>
                <a:schemeClr val="accent1"/>
              </a:solidFill>
              <a:round/>
            </a:ln>
            <a:effectLst/>
          </c:spPr>
          <c:marker>
            <c:symbol val="circle"/>
            <c:size val="5"/>
            <c:spPr>
              <a:solidFill>
                <a:schemeClr val="accent1"/>
              </a:solidFill>
              <a:ln w="9525">
                <a:solidFill>
                  <a:schemeClr val="accent1"/>
                </a:solidFill>
              </a:ln>
              <a:effectLst/>
            </c:spPr>
          </c:marker>
          <c:errBars>
            <c:errDir val="y"/>
            <c:errBarType val="both"/>
            <c:errValType val="percentage"/>
            <c:noEndCap val="0"/>
            <c:val val="5"/>
            <c:spPr>
              <a:noFill/>
              <a:ln w="9525" cap="flat" cmpd="sng" algn="ctr">
                <a:solidFill>
                  <a:schemeClr val="tx1">
                    <a:lumMod val="65000"/>
                    <a:lumOff val="35000"/>
                  </a:schemeClr>
                </a:solidFill>
                <a:round/>
              </a:ln>
              <a:effectLst/>
            </c:spPr>
          </c:errBars>
          <c:cat>
            <c:strRef>
              <c:f>'[Chart in Microsoft PowerPoint]HCT116-Untreated'!$O$24:$Q$24</c:f>
              <c:strCache>
                <c:ptCount val="3"/>
                <c:pt idx="0">
                  <c:v>0h</c:v>
                </c:pt>
                <c:pt idx="1">
                  <c:v>24h</c:v>
                </c:pt>
                <c:pt idx="2">
                  <c:v>48h</c:v>
                </c:pt>
              </c:strCache>
            </c:strRef>
          </c:cat>
          <c:val>
            <c:numRef>
              <c:f>'[Chart in Microsoft PowerPoint]HCT116-Untreated'!$O$25:$Q$25</c:f>
              <c:numCache>
                <c:formatCode>0.000</c:formatCode>
                <c:ptCount val="3"/>
                <c:pt idx="0">
                  <c:v>7.3688888888888901E-2</c:v>
                </c:pt>
                <c:pt idx="1">
                  <c:v>0.14533333333333334</c:v>
                </c:pt>
                <c:pt idx="2">
                  <c:v>0.3424666666666667</c:v>
                </c:pt>
              </c:numCache>
            </c:numRef>
          </c:val>
          <c:smooth val="0"/>
          <c:extLst>
            <c:ext xmlns:c16="http://schemas.microsoft.com/office/drawing/2014/chart" uri="{C3380CC4-5D6E-409C-BE32-E72D297353CC}">
              <c16:uniqueId val="{00000000-6A3A-4213-9FE7-B97E84C9A189}"/>
            </c:ext>
          </c:extLst>
        </c:ser>
        <c:ser>
          <c:idx val="1"/>
          <c:order val="1"/>
          <c:tx>
            <c:strRef>
              <c:f>'[Chart in Microsoft PowerPoint]HCT116-Untreated'!$N$26</c:f>
              <c:strCache>
                <c:ptCount val="1"/>
                <c:pt idx="0">
                  <c:v>HCT116-miR-616</c:v>
                </c:pt>
              </c:strCache>
            </c:strRef>
          </c:tx>
          <c:spPr>
            <a:ln w="28575" cap="rnd">
              <a:solidFill>
                <a:schemeClr val="accent2"/>
              </a:solidFill>
              <a:round/>
            </a:ln>
            <a:effectLst/>
          </c:spPr>
          <c:marker>
            <c:symbol val="circle"/>
            <c:size val="5"/>
            <c:spPr>
              <a:solidFill>
                <a:schemeClr val="accent2"/>
              </a:solidFill>
              <a:ln w="9525">
                <a:solidFill>
                  <a:schemeClr val="accent2"/>
                </a:solidFill>
              </a:ln>
              <a:effectLst/>
            </c:spPr>
          </c:marker>
          <c:errBars>
            <c:errDir val="y"/>
            <c:errBarType val="both"/>
            <c:errValType val="percentage"/>
            <c:noEndCap val="0"/>
            <c:val val="5"/>
            <c:spPr>
              <a:noFill/>
              <a:ln w="9525" cap="flat" cmpd="sng" algn="ctr">
                <a:solidFill>
                  <a:schemeClr val="tx1">
                    <a:lumMod val="65000"/>
                    <a:lumOff val="35000"/>
                  </a:schemeClr>
                </a:solidFill>
                <a:round/>
              </a:ln>
              <a:effectLst/>
            </c:spPr>
          </c:errBars>
          <c:cat>
            <c:strRef>
              <c:f>'[Chart in Microsoft PowerPoint]HCT116-Untreated'!$O$24:$Q$24</c:f>
              <c:strCache>
                <c:ptCount val="3"/>
                <c:pt idx="0">
                  <c:v>0h</c:v>
                </c:pt>
                <c:pt idx="1">
                  <c:v>24h</c:v>
                </c:pt>
                <c:pt idx="2">
                  <c:v>48h</c:v>
                </c:pt>
              </c:strCache>
            </c:strRef>
          </c:cat>
          <c:val>
            <c:numRef>
              <c:f>'[Chart in Microsoft PowerPoint]HCT116-Untreated'!$O$26:$Q$26</c:f>
              <c:numCache>
                <c:formatCode>0.000</c:formatCode>
                <c:ptCount val="3"/>
                <c:pt idx="0">
                  <c:v>7.5555555555559997E-2</c:v>
                </c:pt>
                <c:pt idx="1">
                  <c:v>9.6333333333329996E-2</c:v>
                </c:pt>
                <c:pt idx="2">
                  <c:v>0.23100000000000001</c:v>
                </c:pt>
              </c:numCache>
            </c:numRef>
          </c:val>
          <c:smooth val="0"/>
          <c:extLst>
            <c:ext xmlns:c16="http://schemas.microsoft.com/office/drawing/2014/chart" uri="{C3380CC4-5D6E-409C-BE32-E72D297353CC}">
              <c16:uniqueId val="{00000001-6A3A-4213-9FE7-B97E84C9A189}"/>
            </c:ext>
          </c:extLst>
        </c:ser>
        <c:dLbls>
          <c:showLegendKey val="0"/>
          <c:showVal val="0"/>
          <c:showCatName val="0"/>
          <c:showSerName val="0"/>
          <c:showPercent val="0"/>
          <c:showBubbleSize val="0"/>
        </c:dLbls>
        <c:marker val="1"/>
        <c:smooth val="0"/>
        <c:axId val="329375768"/>
        <c:axId val="329376160"/>
      </c:lineChart>
      <c:catAx>
        <c:axId val="329375768"/>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329376160"/>
        <c:crosses val="autoZero"/>
        <c:auto val="1"/>
        <c:lblAlgn val="ctr"/>
        <c:lblOffset val="100"/>
        <c:noMultiLvlLbl val="0"/>
      </c:catAx>
      <c:valAx>
        <c:axId val="329376160"/>
        <c:scaling>
          <c:orientation val="minMax"/>
        </c:scaling>
        <c:delete val="0"/>
        <c:axPos val="l"/>
        <c:title>
          <c:tx>
            <c:rich>
              <a:bodyPr rot="-5400000" spcFirstLastPara="1" vertOverflow="ellipsis" vert="horz" wrap="square" anchor="ctr" anchorCtr="1"/>
              <a:lstStyle/>
              <a:p>
                <a:pPr>
                  <a:defRPr sz="1000" b="1" i="0" u="none" strike="noStrike" kern="1200" baseline="0">
                    <a:solidFill>
                      <a:schemeClr val="tx1"/>
                    </a:solidFill>
                    <a:latin typeface="+mn-lt"/>
                    <a:ea typeface="+mn-ea"/>
                    <a:cs typeface="+mn-cs"/>
                  </a:defRPr>
                </a:pPr>
                <a:r>
                  <a:rPr lang="en-US"/>
                  <a:t> OD 490 nm</a:t>
                </a:r>
              </a:p>
            </c:rich>
          </c:tx>
          <c:layout>
            <c:manualLayout>
              <c:xMode val="edge"/>
              <c:yMode val="edge"/>
              <c:x val="2.9514428946986679E-3"/>
              <c:y val="0.25547373716066007"/>
            </c:manualLayout>
          </c:layout>
          <c:overlay val="0"/>
          <c:spPr>
            <a:noFill/>
            <a:ln>
              <a:noFill/>
            </a:ln>
            <a:effectLst/>
          </c:spPr>
          <c:txPr>
            <a:bodyPr rot="-540000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title>
        <c:numFmt formatCode="0.00" sourceLinked="0"/>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crossAx val="329375768"/>
        <c:crosses val="autoZero"/>
        <c:crossBetween val="between"/>
      </c:valAx>
      <c:spPr>
        <a:noFill/>
        <a:ln>
          <a:noFill/>
        </a:ln>
        <a:effectLst/>
      </c:spPr>
    </c:plotArea>
    <c:legend>
      <c:legendPos val="r"/>
      <c:layout>
        <c:manualLayout>
          <c:xMode val="edge"/>
          <c:yMode val="edge"/>
          <c:x val="0.22185427453280679"/>
          <c:y val="4.8297012673016698E-2"/>
          <c:w val="0.50345323166593481"/>
          <c:h val="0.20570983497492981"/>
        </c:manualLayout>
      </c:layout>
      <c:overlay val="0"/>
      <c:spPr>
        <a:noFill/>
        <a:ln>
          <a:noFill/>
        </a:ln>
        <a:effectLst/>
      </c:spPr>
      <c:txPr>
        <a:bodyPr rot="0" spcFirstLastPara="1" vertOverflow="ellipsis" vert="horz" wrap="square" anchor="ctr" anchorCtr="1"/>
        <a:lstStyle/>
        <a:p>
          <a:pPr>
            <a:defRPr sz="900" b="1" i="0" u="none" strike="noStrike" kern="1200" baseline="0">
              <a:solidFill>
                <a:schemeClr val="tx1"/>
              </a:solidFill>
              <a:latin typeface="+mn-lt"/>
              <a:ea typeface="+mn-ea"/>
              <a:cs typeface="+mn-cs"/>
            </a:defRPr>
          </a:pPr>
          <a:endParaRPr lang="en-US"/>
        </a:p>
      </c:txPr>
    </c:legend>
    <c:plotVisOnly val="1"/>
    <c:dispBlanksAs val="gap"/>
    <c:showDLblsOverMax val="0"/>
  </c:chart>
  <c:spPr>
    <a:noFill/>
    <a:ln>
      <a:noFill/>
    </a:ln>
    <a:effectLst/>
  </c:spPr>
  <c:txPr>
    <a:bodyPr/>
    <a:lstStyle/>
    <a:p>
      <a:pPr>
        <a:defRPr b="1">
          <a:solidFill>
            <a:schemeClr val="tx1"/>
          </a:solidFill>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3301631944444445"/>
          <c:y val="5.1400554097404488E-2"/>
          <c:w val="0.71246909722222218"/>
          <c:h val="0.82400043744531937"/>
        </c:manualLayout>
      </c:layout>
      <c:lineChart>
        <c:grouping val="standard"/>
        <c:varyColors val="0"/>
        <c:ser>
          <c:idx val="0"/>
          <c:order val="0"/>
          <c:tx>
            <c:strRef>
              <c:f>Sheet1!$H$9</c:f>
              <c:strCache>
                <c:ptCount val="1"/>
                <c:pt idx="0">
                  <c:v>HCT116-miR-CTRL</c:v>
                </c:pt>
              </c:strCache>
            </c:strRef>
          </c:tx>
          <c:spPr>
            <a:ln w="28575" cap="rnd">
              <a:solidFill>
                <a:schemeClr val="accent1"/>
              </a:solidFill>
              <a:round/>
            </a:ln>
            <a:effectLst/>
          </c:spPr>
          <c:marker>
            <c:symbol val="none"/>
          </c:marker>
          <c:errBars>
            <c:errDir val="y"/>
            <c:errBarType val="both"/>
            <c:errValType val="fixedVal"/>
            <c:noEndCap val="0"/>
            <c:val val="2"/>
            <c:spPr>
              <a:noFill/>
              <a:ln w="9525" cap="flat" cmpd="sng" algn="ctr">
                <a:solidFill>
                  <a:schemeClr val="tx1">
                    <a:lumMod val="65000"/>
                    <a:lumOff val="35000"/>
                  </a:schemeClr>
                </a:solidFill>
                <a:round/>
              </a:ln>
              <a:effectLst/>
            </c:spPr>
          </c:errBars>
          <c:cat>
            <c:strRef>
              <c:f>Sheet1!$I$8:$K$8</c:f>
              <c:strCache>
                <c:ptCount val="3"/>
                <c:pt idx="0">
                  <c:v>0h</c:v>
                </c:pt>
                <c:pt idx="1">
                  <c:v>12h</c:v>
                </c:pt>
                <c:pt idx="2">
                  <c:v>24h</c:v>
                </c:pt>
              </c:strCache>
            </c:strRef>
          </c:cat>
          <c:val>
            <c:numRef>
              <c:f>Sheet1!$I$9:$K$9</c:f>
              <c:numCache>
                <c:formatCode>General</c:formatCode>
                <c:ptCount val="3"/>
                <c:pt idx="0">
                  <c:v>1189</c:v>
                </c:pt>
                <c:pt idx="1">
                  <c:v>605</c:v>
                </c:pt>
                <c:pt idx="2">
                  <c:v>0</c:v>
                </c:pt>
              </c:numCache>
            </c:numRef>
          </c:val>
          <c:smooth val="0"/>
          <c:extLst>
            <c:ext xmlns:c16="http://schemas.microsoft.com/office/drawing/2014/chart" uri="{C3380CC4-5D6E-409C-BE32-E72D297353CC}">
              <c16:uniqueId val="{00000000-1A48-4995-91E6-AAB024F5FCFD}"/>
            </c:ext>
          </c:extLst>
        </c:ser>
        <c:ser>
          <c:idx val="1"/>
          <c:order val="1"/>
          <c:tx>
            <c:strRef>
              <c:f>Sheet1!$H$10</c:f>
              <c:strCache>
                <c:ptCount val="1"/>
                <c:pt idx="0">
                  <c:v>HCT116-miR-616</c:v>
                </c:pt>
              </c:strCache>
            </c:strRef>
          </c:tx>
          <c:spPr>
            <a:ln w="28575" cap="rnd">
              <a:solidFill>
                <a:schemeClr val="accent2"/>
              </a:solidFill>
              <a:round/>
            </a:ln>
            <a:effectLst/>
          </c:spPr>
          <c:marker>
            <c:symbol val="none"/>
          </c:marker>
          <c:errBars>
            <c:errDir val="y"/>
            <c:errBarType val="both"/>
            <c:errValType val="fixedVal"/>
            <c:noEndCap val="0"/>
            <c:val val="12"/>
            <c:spPr>
              <a:noFill/>
              <a:ln w="9525" cap="flat" cmpd="sng" algn="ctr">
                <a:solidFill>
                  <a:schemeClr val="tx1">
                    <a:lumMod val="65000"/>
                    <a:lumOff val="35000"/>
                  </a:schemeClr>
                </a:solidFill>
                <a:round/>
              </a:ln>
              <a:effectLst/>
            </c:spPr>
          </c:errBars>
          <c:cat>
            <c:strRef>
              <c:f>Sheet1!$I$8:$K$8</c:f>
              <c:strCache>
                <c:ptCount val="3"/>
                <c:pt idx="0">
                  <c:v>0h</c:v>
                </c:pt>
                <c:pt idx="1">
                  <c:v>12h</c:v>
                </c:pt>
                <c:pt idx="2">
                  <c:v>24h</c:v>
                </c:pt>
              </c:strCache>
            </c:strRef>
          </c:cat>
          <c:val>
            <c:numRef>
              <c:f>Sheet1!$I$10:$K$10</c:f>
              <c:numCache>
                <c:formatCode>General</c:formatCode>
                <c:ptCount val="3"/>
                <c:pt idx="0">
                  <c:v>1189</c:v>
                </c:pt>
                <c:pt idx="1">
                  <c:v>855</c:v>
                </c:pt>
                <c:pt idx="2">
                  <c:v>379</c:v>
                </c:pt>
              </c:numCache>
            </c:numRef>
          </c:val>
          <c:smooth val="0"/>
          <c:extLst>
            <c:ext xmlns:c16="http://schemas.microsoft.com/office/drawing/2014/chart" uri="{C3380CC4-5D6E-409C-BE32-E72D297353CC}">
              <c16:uniqueId val="{00000001-1A48-4995-91E6-AAB024F5FCFD}"/>
            </c:ext>
          </c:extLst>
        </c:ser>
        <c:dLbls>
          <c:showLegendKey val="0"/>
          <c:showVal val="0"/>
          <c:showCatName val="0"/>
          <c:showSerName val="0"/>
          <c:showPercent val="0"/>
          <c:showBubbleSize val="0"/>
        </c:dLbls>
        <c:smooth val="0"/>
        <c:axId val="332639232"/>
        <c:axId val="332639624"/>
      </c:lineChart>
      <c:catAx>
        <c:axId val="332639232"/>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100" b="1" i="0" u="none" strike="noStrike" kern="1200" baseline="0">
                <a:solidFill>
                  <a:schemeClr val="tx1"/>
                </a:solidFill>
                <a:latin typeface="+mn-lt"/>
                <a:ea typeface="+mn-ea"/>
                <a:cs typeface="+mn-cs"/>
              </a:defRPr>
            </a:pPr>
            <a:endParaRPr lang="en-US"/>
          </a:p>
        </c:txPr>
        <c:crossAx val="332639624"/>
        <c:crosses val="autoZero"/>
        <c:auto val="1"/>
        <c:lblAlgn val="ctr"/>
        <c:lblOffset val="100"/>
        <c:noMultiLvlLbl val="0"/>
      </c:catAx>
      <c:valAx>
        <c:axId val="332639624"/>
        <c:scaling>
          <c:orientation val="minMax"/>
          <c:min val="0"/>
        </c:scaling>
        <c:delete val="0"/>
        <c:axPos val="l"/>
        <c:title>
          <c:tx>
            <c:rich>
              <a:bodyPr rot="-5400000" spcFirstLastPara="1" vertOverflow="ellipsis" vert="horz" wrap="square" anchor="ctr" anchorCtr="1"/>
              <a:lstStyle/>
              <a:p>
                <a:pPr>
                  <a:defRPr sz="1100" b="1" i="0" u="none" strike="noStrike" kern="1200" baseline="0">
                    <a:solidFill>
                      <a:schemeClr val="tx1"/>
                    </a:solidFill>
                    <a:latin typeface="+mn-lt"/>
                    <a:ea typeface="+mn-ea"/>
                    <a:cs typeface="+mn-cs"/>
                  </a:defRPr>
                </a:pPr>
                <a:r>
                  <a:rPr lang="en-US" sz="1100" b="1">
                    <a:solidFill>
                      <a:schemeClr val="tx1"/>
                    </a:solidFill>
                  </a:rPr>
                  <a:t>Gap area/mm</a:t>
                </a:r>
              </a:p>
            </c:rich>
          </c:tx>
          <c:layout/>
          <c:overlay val="0"/>
          <c:spPr>
            <a:noFill/>
            <a:ln>
              <a:noFill/>
            </a:ln>
            <a:effectLst/>
          </c:spPr>
          <c:txPr>
            <a:bodyPr rot="-5400000" spcFirstLastPara="1" vertOverflow="ellipsis" vert="horz" wrap="square" anchor="ctr" anchorCtr="1"/>
            <a:lstStyle/>
            <a:p>
              <a:pPr>
                <a:defRPr sz="1100" b="1"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000" b="1" i="0" u="none" strike="noStrike" kern="1200" baseline="0">
                <a:solidFill>
                  <a:schemeClr val="tx1"/>
                </a:solidFill>
                <a:latin typeface="+mn-lt"/>
                <a:ea typeface="+mn-ea"/>
                <a:cs typeface="+mn-cs"/>
              </a:defRPr>
            </a:pPr>
            <a:endParaRPr lang="en-US"/>
          </a:p>
        </c:txPr>
        <c:crossAx val="332639232"/>
        <c:crosses val="autoZero"/>
        <c:crossBetween val="between"/>
      </c:valAx>
      <c:spPr>
        <a:noFill/>
        <a:ln>
          <a:noFill/>
        </a:ln>
        <a:effectLst/>
      </c:spPr>
    </c:plotArea>
    <c:legend>
      <c:legendPos val="r"/>
      <c:layout>
        <c:manualLayout>
          <c:xMode val="edge"/>
          <c:yMode val="edge"/>
          <c:x val="0.3649297900262467"/>
          <c:y val="6.3445975503062121E-2"/>
          <c:w val="0.53055624999999995"/>
          <c:h val="0.17866360454943131"/>
        </c:manualLayout>
      </c:layout>
      <c:overlay val="0"/>
      <c:spPr>
        <a:noFill/>
        <a:ln>
          <a:noFill/>
        </a:ln>
        <a:effectLst/>
      </c:spPr>
      <c:txPr>
        <a:bodyPr rot="0" spcFirstLastPara="1" vertOverflow="ellipsis" vert="horz" wrap="square" anchor="ctr" anchorCtr="1"/>
        <a:lstStyle/>
        <a:p>
          <a:pPr>
            <a:defRPr sz="1100" b="1" i="0" u="none" strike="noStrike" kern="1200" baseline="0">
              <a:solidFill>
                <a:schemeClr val="tx1"/>
              </a:solidFill>
              <a:latin typeface="+mn-lt"/>
              <a:ea typeface="+mn-ea"/>
              <a:cs typeface="+mn-cs"/>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image" Target="../media/image2.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IE"/>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E9AA4E3-4DAB-41F3-9897-73915C6E517A}" type="datetimeFigureOut">
              <a:rPr lang="en-IE" smtClean="0"/>
              <a:t>21/08/2023</a:t>
            </a:fld>
            <a:endParaRPr lang="en-IE"/>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IE"/>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IE"/>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FD433C0-B094-43CF-B156-8259C955FC7F}" type="slidenum">
              <a:rPr lang="en-IE" smtClean="0"/>
              <a:t>‹#›</a:t>
            </a:fld>
            <a:endParaRPr lang="en-IE"/>
          </a:p>
        </p:txBody>
      </p:sp>
    </p:spTree>
    <p:extLst>
      <p:ext uri="{BB962C8B-B14F-4D97-AF65-F5344CB8AC3E}">
        <p14:creationId xmlns:p14="http://schemas.microsoft.com/office/powerpoint/2010/main" val="318133376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105AC44E-EC6D-4E8D-B23C-558C8AA970FB}" type="slidenum">
              <a:rPr lang="en-US" smtClean="0"/>
              <a:t>7</a:t>
            </a:fld>
            <a:endParaRPr lang="en-US"/>
          </a:p>
        </p:txBody>
      </p:sp>
    </p:spTree>
    <p:extLst>
      <p:ext uri="{BB962C8B-B14F-4D97-AF65-F5344CB8AC3E}">
        <p14:creationId xmlns:p14="http://schemas.microsoft.com/office/powerpoint/2010/main" val="287540311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IE"/>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IE"/>
          </a:p>
        </p:txBody>
      </p:sp>
      <p:sp>
        <p:nvSpPr>
          <p:cNvPr id="4" name="Date Placeholder 3"/>
          <p:cNvSpPr>
            <a:spLocks noGrp="1"/>
          </p:cNvSpPr>
          <p:nvPr>
            <p:ph type="dt" sz="half" idx="10"/>
          </p:nvPr>
        </p:nvSpPr>
        <p:spPr/>
        <p:txBody>
          <a:bodyPr/>
          <a:lstStyle/>
          <a:p>
            <a:fld id="{A539E27B-E9DB-4164-801F-BFC3A761BB45}" type="datetimeFigureOut">
              <a:rPr lang="en-IE" smtClean="0"/>
              <a:t>21/08/2023</a:t>
            </a:fld>
            <a:endParaRPr lang="en-IE"/>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DB5C0293-6F2D-4398-8C16-768381E8CE90}" type="slidenum">
              <a:rPr lang="en-IE" smtClean="0"/>
              <a:t>‹#›</a:t>
            </a:fld>
            <a:endParaRPr lang="en-IE"/>
          </a:p>
        </p:txBody>
      </p:sp>
    </p:spTree>
    <p:extLst>
      <p:ext uri="{BB962C8B-B14F-4D97-AF65-F5344CB8AC3E}">
        <p14:creationId xmlns:p14="http://schemas.microsoft.com/office/powerpoint/2010/main" val="31216106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IE"/>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4" name="Date Placeholder 3"/>
          <p:cNvSpPr>
            <a:spLocks noGrp="1"/>
          </p:cNvSpPr>
          <p:nvPr>
            <p:ph type="dt" sz="half" idx="10"/>
          </p:nvPr>
        </p:nvSpPr>
        <p:spPr/>
        <p:txBody>
          <a:bodyPr/>
          <a:lstStyle/>
          <a:p>
            <a:fld id="{A539E27B-E9DB-4164-801F-BFC3A761BB45}" type="datetimeFigureOut">
              <a:rPr lang="en-IE" smtClean="0"/>
              <a:t>21/08/2023</a:t>
            </a:fld>
            <a:endParaRPr lang="en-IE"/>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DB5C0293-6F2D-4398-8C16-768381E8CE90}" type="slidenum">
              <a:rPr lang="en-IE" smtClean="0"/>
              <a:t>‹#›</a:t>
            </a:fld>
            <a:endParaRPr lang="en-IE"/>
          </a:p>
        </p:txBody>
      </p:sp>
    </p:spTree>
    <p:extLst>
      <p:ext uri="{BB962C8B-B14F-4D97-AF65-F5344CB8AC3E}">
        <p14:creationId xmlns:p14="http://schemas.microsoft.com/office/powerpoint/2010/main" val="156155031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IE"/>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4" name="Date Placeholder 3"/>
          <p:cNvSpPr>
            <a:spLocks noGrp="1"/>
          </p:cNvSpPr>
          <p:nvPr>
            <p:ph type="dt" sz="half" idx="10"/>
          </p:nvPr>
        </p:nvSpPr>
        <p:spPr/>
        <p:txBody>
          <a:bodyPr/>
          <a:lstStyle/>
          <a:p>
            <a:fld id="{A539E27B-E9DB-4164-801F-BFC3A761BB45}" type="datetimeFigureOut">
              <a:rPr lang="en-IE" smtClean="0"/>
              <a:t>21/08/2023</a:t>
            </a:fld>
            <a:endParaRPr lang="en-IE"/>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DB5C0293-6F2D-4398-8C16-768381E8CE90}" type="slidenum">
              <a:rPr lang="en-IE" smtClean="0"/>
              <a:t>‹#›</a:t>
            </a:fld>
            <a:endParaRPr lang="en-IE"/>
          </a:p>
        </p:txBody>
      </p:sp>
    </p:spTree>
    <p:extLst>
      <p:ext uri="{BB962C8B-B14F-4D97-AF65-F5344CB8AC3E}">
        <p14:creationId xmlns:p14="http://schemas.microsoft.com/office/powerpoint/2010/main" val="3354570213"/>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x">
  <p:cSld name="Title and Content">
    <p:spTree>
      <p:nvGrpSpPr>
        <p:cNvPr id="1" name=""/>
        <p:cNvGrpSpPr/>
        <p:nvPr/>
      </p:nvGrpSpPr>
      <p:grpSpPr>
        <a:xfrm>
          <a:off x="0" y="0"/>
          <a:ext cx="0" cy="0"/>
          <a:chOff x="0" y="0"/>
          <a:chExt cx="0" cy="0"/>
        </a:xfrm>
      </p:grpSpPr>
      <p:sp>
        <p:nvSpPr>
          <p:cNvPr id="20" name="Title Text"/>
          <p:cNvSpPr txBox="1">
            <a:spLocks noGrp="1"/>
          </p:cNvSpPr>
          <p:nvPr>
            <p:ph type="title"/>
          </p:nvPr>
        </p:nvSpPr>
        <p:spPr>
          <a:xfrm>
            <a:off x="2684445" y="837241"/>
            <a:ext cx="6823113" cy="887731"/>
          </a:xfrm>
          <a:prstGeom prst="rect">
            <a:avLst/>
          </a:prstGeom>
        </p:spPr>
        <p:txBody>
          <a:bodyPr>
            <a:normAutofit/>
          </a:bodyPr>
          <a:lstStyle/>
          <a:p>
            <a:r>
              <a:t>Title Text</a:t>
            </a:r>
          </a:p>
        </p:txBody>
      </p:sp>
      <p:sp>
        <p:nvSpPr>
          <p:cNvPr id="21" name="Body Level One…"/>
          <p:cNvSpPr txBox="1">
            <a:spLocks noGrp="1"/>
          </p:cNvSpPr>
          <p:nvPr>
            <p:ph type="body" sz="half" idx="1"/>
          </p:nvPr>
        </p:nvSpPr>
        <p:spPr>
          <a:xfrm>
            <a:off x="1008798" y="2413636"/>
            <a:ext cx="10174412" cy="3096101"/>
          </a:xfrm>
          <a:prstGeom prst="rect">
            <a:avLst/>
          </a:prstGeom>
        </p:spPr>
        <p:txBody>
          <a:bodyPr>
            <a:normAutofit/>
          </a:bodyPr>
          <a:lstStyle/>
          <a:p>
            <a:r>
              <a:t>Body Level One</a:t>
            </a:r>
          </a:p>
          <a:p>
            <a:pPr lvl="1"/>
            <a:r>
              <a:t>Body Level Two</a:t>
            </a:r>
          </a:p>
          <a:p>
            <a:pPr lvl="2"/>
            <a:r>
              <a:t>Body Level Three</a:t>
            </a:r>
          </a:p>
          <a:p>
            <a:pPr lvl="3"/>
            <a:r>
              <a:t>Body Level Four</a:t>
            </a:r>
          </a:p>
          <a:p>
            <a:pPr lvl="4"/>
            <a:r>
              <a:t>Body Level Five</a:t>
            </a:r>
          </a:p>
        </p:txBody>
      </p:sp>
      <p:sp>
        <p:nvSpPr>
          <p:cNvPr id="22"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extLst>
      <p:ext uri="{BB962C8B-B14F-4D97-AF65-F5344CB8AC3E}">
        <p14:creationId xmlns:p14="http://schemas.microsoft.com/office/powerpoint/2010/main" val="2082976863"/>
      </p:ext>
    </p:extLst>
  </p:cSld>
  <p:clrMapOvr>
    <a:masterClrMapping/>
  </p:clrMapOvr>
  <p:transition spd="med"/>
</p:sldLayout>
</file>

<file path=ppt/slideLayouts/slideLayout13.xml><?xml version="1.0" encoding="utf-8"?>
<p:sldLayout xmlns:a="http://schemas.openxmlformats.org/drawingml/2006/main" xmlns:r="http://schemas.openxmlformats.org/officeDocument/2006/relationships" xmlns:p="http://schemas.openxmlformats.org/presentationml/2006/main" type="tx">
  <p:cSld name="Two Content">
    <p:spTree>
      <p:nvGrpSpPr>
        <p:cNvPr id="1" name=""/>
        <p:cNvGrpSpPr/>
        <p:nvPr/>
      </p:nvGrpSpPr>
      <p:grpSpPr>
        <a:xfrm>
          <a:off x="0" y="0"/>
          <a:ext cx="0" cy="0"/>
          <a:chOff x="0" y="0"/>
          <a:chExt cx="0" cy="0"/>
        </a:xfrm>
      </p:grpSpPr>
      <p:sp>
        <p:nvSpPr>
          <p:cNvPr id="38" name="Title Text"/>
          <p:cNvSpPr txBox="1">
            <a:spLocks noGrp="1"/>
          </p:cNvSpPr>
          <p:nvPr>
            <p:ph type="title"/>
          </p:nvPr>
        </p:nvSpPr>
        <p:spPr>
          <a:xfrm>
            <a:off x="2684445" y="837241"/>
            <a:ext cx="6823113" cy="887731"/>
          </a:xfrm>
          <a:prstGeom prst="rect">
            <a:avLst/>
          </a:prstGeom>
        </p:spPr>
        <p:txBody>
          <a:bodyPr>
            <a:normAutofit/>
          </a:bodyPr>
          <a:lstStyle/>
          <a:p>
            <a:r>
              <a:t>Title Text</a:t>
            </a:r>
          </a:p>
        </p:txBody>
      </p:sp>
      <p:sp>
        <p:nvSpPr>
          <p:cNvPr id="39" name="Body Level One…"/>
          <p:cNvSpPr txBox="1">
            <a:spLocks noGrp="1"/>
          </p:cNvSpPr>
          <p:nvPr>
            <p:ph type="body" sz="half" idx="1"/>
          </p:nvPr>
        </p:nvSpPr>
        <p:spPr>
          <a:xfrm>
            <a:off x="609599" y="1577344"/>
            <a:ext cx="5303523" cy="4526281"/>
          </a:xfrm>
          <a:prstGeom prst="rect">
            <a:avLst/>
          </a:prstGeom>
        </p:spPr>
        <p:txBody>
          <a:bodyPr>
            <a:normAutofit/>
          </a:bodyPr>
          <a:lstStyle/>
          <a:p>
            <a:r>
              <a:t>Body Level One</a:t>
            </a:r>
          </a:p>
          <a:p>
            <a:pPr lvl="1"/>
            <a:r>
              <a:t>Body Level Two</a:t>
            </a:r>
          </a:p>
          <a:p>
            <a:pPr lvl="2"/>
            <a:r>
              <a:t>Body Level Three</a:t>
            </a:r>
          </a:p>
          <a:p>
            <a:pPr lvl="3"/>
            <a:r>
              <a:t>Body Level Four</a:t>
            </a:r>
          </a:p>
          <a:p>
            <a:pPr lvl="4"/>
            <a:r>
              <a:t>Body Level Five</a:t>
            </a:r>
          </a:p>
        </p:txBody>
      </p:sp>
      <p:sp>
        <p:nvSpPr>
          <p:cNvPr id="40"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extLst>
      <p:ext uri="{BB962C8B-B14F-4D97-AF65-F5344CB8AC3E}">
        <p14:creationId xmlns:p14="http://schemas.microsoft.com/office/powerpoint/2010/main" val="286851950"/>
      </p:ext>
    </p:extLst>
  </p:cSld>
  <p:clrMapOvr>
    <a:masterClrMapping/>
  </p:clrMapOvr>
  <p:transition spd="med"/>
</p:sldLayout>
</file>

<file path=ppt/slideLayouts/slideLayout14.xml><?xml version="1.0" encoding="utf-8"?>
<p:sldLayout xmlns:a="http://schemas.openxmlformats.org/drawingml/2006/main" xmlns:r="http://schemas.openxmlformats.org/officeDocument/2006/relationships" xmlns:p="http://schemas.openxmlformats.org/presentationml/2006/main" type="titleOnly">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IE"/>
          </a:p>
        </p:txBody>
      </p:sp>
      <p:sp>
        <p:nvSpPr>
          <p:cNvPr id="3" name="Date Placeholder 2"/>
          <p:cNvSpPr>
            <a:spLocks noGrp="1"/>
          </p:cNvSpPr>
          <p:nvPr>
            <p:ph type="dt" sz="half" idx="10"/>
          </p:nvPr>
        </p:nvSpPr>
        <p:spPr>
          <a:xfrm>
            <a:off x="609600" y="6356352"/>
            <a:ext cx="2844800" cy="365125"/>
          </a:xfrm>
          <a:prstGeom prst="rect">
            <a:avLst/>
          </a:prstGeom>
        </p:spPr>
        <p:txBody>
          <a:bodyPr lIns="74889" tIns="37445" rIns="74889" bIns="37445"/>
          <a:lstStyle/>
          <a:p>
            <a:fld id="{42EED4E3-97FE-45CF-B18B-47D34ECDC04E}" type="datetimeFigureOut">
              <a:rPr lang="en-US" smtClean="0">
                <a:solidFill>
                  <a:prstClr val="black">
                    <a:tint val="75000"/>
                  </a:prstClr>
                </a:solidFill>
              </a:rPr>
              <a:pPr/>
              <a:t>8/21/2023</a:t>
            </a:fld>
            <a:endParaRPr lang="en-US">
              <a:solidFill>
                <a:prstClr val="black">
                  <a:tint val="75000"/>
                </a:prstClr>
              </a:solidFill>
            </a:endParaRPr>
          </a:p>
        </p:txBody>
      </p:sp>
      <p:sp>
        <p:nvSpPr>
          <p:cNvPr id="4" name="Footer Placeholder 3"/>
          <p:cNvSpPr>
            <a:spLocks noGrp="1"/>
          </p:cNvSpPr>
          <p:nvPr>
            <p:ph type="ftr" sz="quarter" idx="11"/>
          </p:nvPr>
        </p:nvSpPr>
        <p:spPr>
          <a:xfrm>
            <a:off x="4165601" y="6356352"/>
            <a:ext cx="3860800" cy="365125"/>
          </a:xfrm>
          <a:prstGeom prst="rect">
            <a:avLst/>
          </a:prstGeom>
        </p:spPr>
        <p:txBody>
          <a:bodyPr lIns="74889" tIns="37445" rIns="74889" bIns="37445"/>
          <a:lstStyle/>
          <a:p>
            <a:endParaRPr lang="en-US">
              <a:solidFill>
                <a:prstClr val="black">
                  <a:tint val="75000"/>
                </a:prstClr>
              </a:solidFill>
            </a:endParaRPr>
          </a:p>
        </p:txBody>
      </p:sp>
      <p:sp>
        <p:nvSpPr>
          <p:cNvPr id="5" name="Slide Number Placeholder 4"/>
          <p:cNvSpPr>
            <a:spLocks noGrp="1"/>
          </p:cNvSpPr>
          <p:nvPr>
            <p:ph type="sldNum" sz="quarter" idx="12"/>
          </p:nvPr>
        </p:nvSpPr>
        <p:spPr/>
        <p:txBody>
          <a:bodyPr/>
          <a:lstStyle/>
          <a:p>
            <a:fld id="{9CD62A7D-81F1-45F5-B7B4-F200CF970AF6}"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526773603"/>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blank" preserve="1">
  <p:cSld name="1_Blank">
    <p:spTree>
      <p:nvGrpSpPr>
        <p:cNvPr id="1" name=""/>
        <p:cNvGrpSpPr/>
        <p:nvPr/>
      </p:nvGrpSpPr>
      <p:grpSpPr>
        <a:xfrm>
          <a:off x="0" y="0"/>
          <a:ext cx="0" cy="0"/>
          <a:chOff x="0" y="0"/>
          <a:chExt cx="0" cy="0"/>
        </a:xfrm>
      </p:grpSpPr>
      <p:sp>
        <p:nvSpPr>
          <p:cNvPr id="2" name="Slide Number Placeholder 1"/>
          <p:cNvSpPr>
            <a:spLocks noGrp="1"/>
          </p:cNvSpPr>
          <p:nvPr>
            <p:ph type="sldNum" sz="quarter" idx="10"/>
          </p:nvPr>
        </p:nvSpPr>
        <p:spPr/>
        <p:txBody>
          <a:bodyPr/>
          <a:lstStyle/>
          <a:p>
            <a:fld id="{86CB4B4D-7CA3-9044-876B-883B54F8677D}" type="slidenum">
              <a:rPr lang="en-IE" smtClean="0"/>
              <a:t>‹#›</a:t>
            </a:fld>
            <a:endParaRPr lang="en-IE"/>
          </a:p>
        </p:txBody>
      </p:sp>
    </p:spTree>
    <p:extLst>
      <p:ext uri="{BB962C8B-B14F-4D97-AF65-F5344CB8AC3E}">
        <p14:creationId xmlns:p14="http://schemas.microsoft.com/office/powerpoint/2010/main" val="2110556464"/>
      </p:ext>
    </p:extLst>
  </p:cSld>
  <p:clrMapOvr>
    <a:masterClrMapping/>
  </p:clrMapOvr>
  <p:transition spd="med"/>
</p:sldLayout>
</file>

<file path=ppt/slideLayouts/slideLayout16.xml><?xml version="1.0" encoding="utf-8"?>
<p:sldLayout xmlns:a="http://schemas.openxmlformats.org/drawingml/2006/main" xmlns:r="http://schemas.openxmlformats.org/officeDocument/2006/relationships" xmlns:p="http://schemas.openxmlformats.org/presentationml/2006/main" type="title">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1122363"/>
            <a:ext cx="103632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B8AA6E6-F21D-42E3-BA45-2A3B9F186311}" type="datetimeFigureOut">
              <a:rPr lang="en-IE" smtClean="0"/>
              <a:t>21/08/2023</a:t>
            </a:fld>
            <a:endParaRPr lang="en-IE"/>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E6C7A3D8-DC76-4F47-A3F2-8AADF2348563}" type="slidenum">
              <a:rPr lang="en-IE" smtClean="0"/>
              <a:t>‹#›</a:t>
            </a:fld>
            <a:endParaRPr lang="en-IE"/>
          </a:p>
        </p:txBody>
      </p:sp>
    </p:spTree>
    <p:extLst>
      <p:ext uri="{BB962C8B-B14F-4D97-AF65-F5344CB8AC3E}">
        <p14:creationId xmlns:p14="http://schemas.microsoft.com/office/powerpoint/2010/main" val="41551618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IE"/>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4" name="Date Placeholder 3"/>
          <p:cNvSpPr>
            <a:spLocks noGrp="1"/>
          </p:cNvSpPr>
          <p:nvPr>
            <p:ph type="dt" sz="half" idx="10"/>
          </p:nvPr>
        </p:nvSpPr>
        <p:spPr/>
        <p:txBody>
          <a:bodyPr/>
          <a:lstStyle/>
          <a:p>
            <a:fld id="{A539E27B-E9DB-4164-801F-BFC3A761BB45}" type="datetimeFigureOut">
              <a:rPr lang="en-IE" smtClean="0"/>
              <a:t>21/08/2023</a:t>
            </a:fld>
            <a:endParaRPr lang="en-IE"/>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DB5C0293-6F2D-4398-8C16-768381E8CE90}" type="slidenum">
              <a:rPr lang="en-IE" smtClean="0"/>
              <a:t>‹#›</a:t>
            </a:fld>
            <a:endParaRPr lang="en-IE"/>
          </a:p>
        </p:txBody>
      </p:sp>
    </p:spTree>
    <p:extLst>
      <p:ext uri="{BB962C8B-B14F-4D97-AF65-F5344CB8AC3E}">
        <p14:creationId xmlns:p14="http://schemas.microsoft.com/office/powerpoint/2010/main" val="23798118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IE"/>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A539E27B-E9DB-4164-801F-BFC3A761BB45}" type="datetimeFigureOut">
              <a:rPr lang="en-IE" smtClean="0"/>
              <a:t>21/08/2023</a:t>
            </a:fld>
            <a:endParaRPr lang="en-IE"/>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DB5C0293-6F2D-4398-8C16-768381E8CE90}" type="slidenum">
              <a:rPr lang="en-IE" smtClean="0"/>
              <a:t>‹#›</a:t>
            </a:fld>
            <a:endParaRPr lang="en-IE"/>
          </a:p>
        </p:txBody>
      </p:sp>
    </p:spTree>
    <p:extLst>
      <p:ext uri="{BB962C8B-B14F-4D97-AF65-F5344CB8AC3E}">
        <p14:creationId xmlns:p14="http://schemas.microsoft.com/office/powerpoint/2010/main" val="35909540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IE"/>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5" name="Date Placeholder 4"/>
          <p:cNvSpPr>
            <a:spLocks noGrp="1"/>
          </p:cNvSpPr>
          <p:nvPr>
            <p:ph type="dt" sz="half" idx="10"/>
          </p:nvPr>
        </p:nvSpPr>
        <p:spPr/>
        <p:txBody>
          <a:bodyPr/>
          <a:lstStyle/>
          <a:p>
            <a:fld id="{A539E27B-E9DB-4164-801F-BFC3A761BB45}" type="datetimeFigureOut">
              <a:rPr lang="en-IE" smtClean="0"/>
              <a:t>21/08/2023</a:t>
            </a:fld>
            <a:endParaRPr lang="en-IE"/>
          </a:p>
        </p:txBody>
      </p:sp>
      <p:sp>
        <p:nvSpPr>
          <p:cNvPr id="6" name="Footer Placeholder 5"/>
          <p:cNvSpPr>
            <a:spLocks noGrp="1"/>
          </p:cNvSpPr>
          <p:nvPr>
            <p:ph type="ftr" sz="quarter" idx="11"/>
          </p:nvPr>
        </p:nvSpPr>
        <p:spPr/>
        <p:txBody>
          <a:bodyPr/>
          <a:lstStyle/>
          <a:p>
            <a:endParaRPr lang="en-IE"/>
          </a:p>
        </p:txBody>
      </p:sp>
      <p:sp>
        <p:nvSpPr>
          <p:cNvPr id="7" name="Slide Number Placeholder 6"/>
          <p:cNvSpPr>
            <a:spLocks noGrp="1"/>
          </p:cNvSpPr>
          <p:nvPr>
            <p:ph type="sldNum" sz="quarter" idx="12"/>
          </p:nvPr>
        </p:nvSpPr>
        <p:spPr/>
        <p:txBody>
          <a:bodyPr/>
          <a:lstStyle/>
          <a:p>
            <a:fld id="{DB5C0293-6F2D-4398-8C16-768381E8CE90}" type="slidenum">
              <a:rPr lang="en-IE" smtClean="0"/>
              <a:t>‹#›</a:t>
            </a:fld>
            <a:endParaRPr lang="en-IE"/>
          </a:p>
        </p:txBody>
      </p:sp>
    </p:spTree>
    <p:extLst>
      <p:ext uri="{BB962C8B-B14F-4D97-AF65-F5344CB8AC3E}">
        <p14:creationId xmlns:p14="http://schemas.microsoft.com/office/powerpoint/2010/main" val="311946767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IE"/>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7" name="Date Placeholder 6"/>
          <p:cNvSpPr>
            <a:spLocks noGrp="1"/>
          </p:cNvSpPr>
          <p:nvPr>
            <p:ph type="dt" sz="half" idx="10"/>
          </p:nvPr>
        </p:nvSpPr>
        <p:spPr/>
        <p:txBody>
          <a:bodyPr/>
          <a:lstStyle/>
          <a:p>
            <a:fld id="{A539E27B-E9DB-4164-801F-BFC3A761BB45}" type="datetimeFigureOut">
              <a:rPr lang="en-IE" smtClean="0"/>
              <a:t>21/08/2023</a:t>
            </a:fld>
            <a:endParaRPr lang="en-IE"/>
          </a:p>
        </p:txBody>
      </p:sp>
      <p:sp>
        <p:nvSpPr>
          <p:cNvPr id="8" name="Footer Placeholder 7"/>
          <p:cNvSpPr>
            <a:spLocks noGrp="1"/>
          </p:cNvSpPr>
          <p:nvPr>
            <p:ph type="ftr" sz="quarter" idx="11"/>
          </p:nvPr>
        </p:nvSpPr>
        <p:spPr/>
        <p:txBody>
          <a:bodyPr/>
          <a:lstStyle/>
          <a:p>
            <a:endParaRPr lang="en-IE"/>
          </a:p>
        </p:txBody>
      </p:sp>
      <p:sp>
        <p:nvSpPr>
          <p:cNvPr id="9" name="Slide Number Placeholder 8"/>
          <p:cNvSpPr>
            <a:spLocks noGrp="1"/>
          </p:cNvSpPr>
          <p:nvPr>
            <p:ph type="sldNum" sz="quarter" idx="12"/>
          </p:nvPr>
        </p:nvSpPr>
        <p:spPr/>
        <p:txBody>
          <a:bodyPr/>
          <a:lstStyle/>
          <a:p>
            <a:fld id="{DB5C0293-6F2D-4398-8C16-768381E8CE90}" type="slidenum">
              <a:rPr lang="en-IE" smtClean="0"/>
              <a:t>‹#›</a:t>
            </a:fld>
            <a:endParaRPr lang="en-IE"/>
          </a:p>
        </p:txBody>
      </p:sp>
    </p:spTree>
    <p:extLst>
      <p:ext uri="{BB962C8B-B14F-4D97-AF65-F5344CB8AC3E}">
        <p14:creationId xmlns:p14="http://schemas.microsoft.com/office/powerpoint/2010/main" val="24863114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IE"/>
          </a:p>
        </p:txBody>
      </p:sp>
      <p:sp>
        <p:nvSpPr>
          <p:cNvPr id="3" name="Date Placeholder 2"/>
          <p:cNvSpPr>
            <a:spLocks noGrp="1"/>
          </p:cNvSpPr>
          <p:nvPr>
            <p:ph type="dt" sz="half" idx="10"/>
          </p:nvPr>
        </p:nvSpPr>
        <p:spPr/>
        <p:txBody>
          <a:bodyPr/>
          <a:lstStyle/>
          <a:p>
            <a:fld id="{A539E27B-E9DB-4164-801F-BFC3A761BB45}" type="datetimeFigureOut">
              <a:rPr lang="en-IE" smtClean="0"/>
              <a:t>21/08/2023</a:t>
            </a:fld>
            <a:endParaRPr lang="en-IE"/>
          </a:p>
        </p:txBody>
      </p:sp>
      <p:sp>
        <p:nvSpPr>
          <p:cNvPr id="4" name="Footer Placeholder 3"/>
          <p:cNvSpPr>
            <a:spLocks noGrp="1"/>
          </p:cNvSpPr>
          <p:nvPr>
            <p:ph type="ftr" sz="quarter" idx="11"/>
          </p:nvPr>
        </p:nvSpPr>
        <p:spPr/>
        <p:txBody>
          <a:bodyPr/>
          <a:lstStyle/>
          <a:p>
            <a:endParaRPr lang="en-IE"/>
          </a:p>
        </p:txBody>
      </p:sp>
      <p:sp>
        <p:nvSpPr>
          <p:cNvPr id="5" name="Slide Number Placeholder 4"/>
          <p:cNvSpPr>
            <a:spLocks noGrp="1"/>
          </p:cNvSpPr>
          <p:nvPr>
            <p:ph type="sldNum" sz="quarter" idx="12"/>
          </p:nvPr>
        </p:nvSpPr>
        <p:spPr/>
        <p:txBody>
          <a:bodyPr/>
          <a:lstStyle/>
          <a:p>
            <a:fld id="{DB5C0293-6F2D-4398-8C16-768381E8CE90}" type="slidenum">
              <a:rPr lang="en-IE" smtClean="0"/>
              <a:t>‹#›</a:t>
            </a:fld>
            <a:endParaRPr lang="en-IE"/>
          </a:p>
        </p:txBody>
      </p:sp>
    </p:spTree>
    <p:extLst>
      <p:ext uri="{BB962C8B-B14F-4D97-AF65-F5344CB8AC3E}">
        <p14:creationId xmlns:p14="http://schemas.microsoft.com/office/powerpoint/2010/main" val="29509938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539E27B-E9DB-4164-801F-BFC3A761BB45}" type="datetimeFigureOut">
              <a:rPr lang="en-IE" smtClean="0"/>
              <a:t>21/08/2023</a:t>
            </a:fld>
            <a:endParaRPr lang="en-IE"/>
          </a:p>
        </p:txBody>
      </p:sp>
      <p:sp>
        <p:nvSpPr>
          <p:cNvPr id="3" name="Footer Placeholder 2"/>
          <p:cNvSpPr>
            <a:spLocks noGrp="1"/>
          </p:cNvSpPr>
          <p:nvPr>
            <p:ph type="ftr" sz="quarter" idx="11"/>
          </p:nvPr>
        </p:nvSpPr>
        <p:spPr/>
        <p:txBody>
          <a:bodyPr/>
          <a:lstStyle/>
          <a:p>
            <a:endParaRPr lang="en-IE"/>
          </a:p>
        </p:txBody>
      </p:sp>
      <p:sp>
        <p:nvSpPr>
          <p:cNvPr id="4" name="Slide Number Placeholder 3"/>
          <p:cNvSpPr>
            <a:spLocks noGrp="1"/>
          </p:cNvSpPr>
          <p:nvPr>
            <p:ph type="sldNum" sz="quarter" idx="12"/>
          </p:nvPr>
        </p:nvSpPr>
        <p:spPr/>
        <p:txBody>
          <a:bodyPr/>
          <a:lstStyle/>
          <a:p>
            <a:fld id="{DB5C0293-6F2D-4398-8C16-768381E8CE90}" type="slidenum">
              <a:rPr lang="en-IE" smtClean="0"/>
              <a:t>‹#›</a:t>
            </a:fld>
            <a:endParaRPr lang="en-IE"/>
          </a:p>
        </p:txBody>
      </p:sp>
    </p:spTree>
    <p:extLst>
      <p:ext uri="{BB962C8B-B14F-4D97-AF65-F5344CB8AC3E}">
        <p14:creationId xmlns:p14="http://schemas.microsoft.com/office/powerpoint/2010/main" val="25960644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E"/>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A539E27B-E9DB-4164-801F-BFC3A761BB45}" type="datetimeFigureOut">
              <a:rPr lang="en-IE" smtClean="0"/>
              <a:t>21/08/2023</a:t>
            </a:fld>
            <a:endParaRPr lang="en-IE"/>
          </a:p>
        </p:txBody>
      </p:sp>
      <p:sp>
        <p:nvSpPr>
          <p:cNvPr id="6" name="Footer Placeholder 5"/>
          <p:cNvSpPr>
            <a:spLocks noGrp="1"/>
          </p:cNvSpPr>
          <p:nvPr>
            <p:ph type="ftr" sz="quarter" idx="11"/>
          </p:nvPr>
        </p:nvSpPr>
        <p:spPr/>
        <p:txBody>
          <a:bodyPr/>
          <a:lstStyle/>
          <a:p>
            <a:endParaRPr lang="en-IE"/>
          </a:p>
        </p:txBody>
      </p:sp>
      <p:sp>
        <p:nvSpPr>
          <p:cNvPr id="7" name="Slide Number Placeholder 6"/>
          <p:cNvSpPr>
            <a:spLocks noGrp="1"/>
          </p:cNvSpPr>
          <p:nvPr>
            <p:ph type="sldNum" sz="quarter" idx="12"/>
          </p:nvPr>
        </p:nvSpPr>
        <p:spPr/>
        <p:txBody>
          <a:bodyPr/>
          <a:lstStyle/>
          <a:p>
            <a:fld id="{DB5C0293-6F2D-4398-8C16-768381E8CE90}" type="slidenum">
              <a:rPr lang="en-IE" smtClean="0"/>
              <a:t>‹#›</a:t>
            </a:fld>
            <a:endParaRPr lang="en-IE"/>
          </a:p>
        </p:txBody>
      </p:sp>
    </p:spTree>
    <p:extLst>
      <p:ext uri="{BB962C8B-B14F-4D97-AF65-F5344CB8AC3E}">
        <p14:creationId xmlns:p14="http://schemas.microsoft.com/office/powerpoint/2010/main" val="39440054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E"/>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IE"/>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A539E27B-E9DB-4164-801F-BFC3A761BB45}" type="datetimeFigureOut">
              <a:rPr lang="en-IE" smtClean="0"/>
              <a:t>21/08/2023</a:t>
            </a:fld>
            <a:endParaRPr lang="en-IE"/>
          </a:p>
        </p:txBody>
      </p:sp>
      <p:sp>
        <p:nvSpPr>
          <p:cNvPr id="6" name="Footer Placeholder 5"/>
          <p:cNvSpPr>
            <a:spLocks noGrp="1"/>
          </p:cNvSpPr>
          <p:nvPr>
            <p:ph type="ftr" sz="quarter" idx="11"/>
          </p:nvPr>
        </p:nvSpPr>
        <p:spPr/>
        <p:txBody>
          <a:bodyPr/>
          <a:lstStyle/>
          <a:p>
            <a:endParaRPr lang="en-IE"/>
          </a:p>
        </p:txBody>
      </p:sp>
      <p:sp>
        <p:nvSpPr>
          <p:cNvPr id="7" name="Slide Number Placeholder 6"/>
          <p:cNvSpPr>
            <a:spLocks noGrp="1"/>
          </p:cNvSpPr>
          <p:nvPr>
            <p:ph type="sldNum" sz="quarter" idx="12"/>
          </p:nvPr>
        </p:nvSpPr>
        <p:spPr/>
        <p:txBody>
          <a:bodyPr/>
          <a:lstStyle/>
          <a:p>
            <a:fld id="{DB5C0293-6F2D-4398-8C16-768381E8CE90}" type="slidenum">
              <a:rPr lang="en-IE" smtClean="0"/>
              <a:t>‹#›</a:t>
            </a:fld>
            <a:endParaRPr lang="en-IE"/>
          </a:p>
        </p:txBody>
      </p:sp>
    </p:spTree>
    <p:extLst>
      <p:ext uri="{BB962C8B-B14F-4D97-AF65-F5344CB8AC3E}">
        <p14:creationId xmlns:p14="http://schemas.microsoft.com/office/powerpoint/2010/main" val="319944504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14.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theme" Target="../theme/theme2.xml"/><Relationship Id="rId5" Type="http://schemas.openxmlformats.org/officeDocument/2006/relationships/slideLayout" Target="../slideLayouts/slideLayout16.xml"/><Relationship Id="rId4" Type="http://schemas.openxmlformats.org/officeDocument/2006/relationships/slideLayout" Target="../slideLayouts/slideLayout15.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IE"/>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539E27B-E9DB-4164-801F-BFC3A761BB45}" type="datetimeFigureOut">
              <a:rPr lang="en-IE" smtClean="0"/>
              <a:t>21/08/2023</a:t>
            </a:fld>
            <a:endParaRPr lang="en-IE"/>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IE"/>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B5C0293-6F2D-4398-8C16-768381E8CE90}" type="slidenum">
              <a:rPr lang="en-IE" smtClean="0"/>
              <a:t>‹#›</a:t>
            </a:fld>
            <a:endParaRPr lang="en-IE"/>
          </a:p>
        </p:txBody>
      </p:sp>
    </p:spTree>
    <p:extLst>
      <p:ext uri="{BB962C8B-B14F-4D97-AF65-F5344CB8AC3E}">
        <p14:creationId xmlns:p14="http://schemas.microsoft.com/office/powerpoint/2010/main" val="93748521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Title Text"/>
          <p:cNvSpPr txBox="1">
            <a:spLocks noGrp="1"/>
          </p:cNvSpPr>
          <p:nvPr>
            <p:ph type="title"/>
          </p:nvPr>
        </p:nvSpPr>
        <p:spPr>
          <a:xfrm>
            <a:off x="609600" y="274638"/>
            <a:ext cx="10972803" cy="1325564"/>
          </a:xfrm>
          <a:prstGeom prst="rect">
            <a:avLst/>
          </a:prstGeom>
          <a:ln w="12700">
            <a:miter lim="400000"/>
          </a:ln>
          <a:extLst>
            <a:ext uri="{C572A759-6A51-4108-AA02-DFA0A04FC94B}">
              <ma14:wrappingTextBoxFlag xmlns:ma14="http://schemas.microsoft.com/office/mac/drawingml/2011/main" xmlns="" val="1"/>
            </a:ext>
          </a:extLst>
        </p:spPr>
        <p:txBody>
          <a:bodyPr lIns="0" tIns="0" rIns="0" bIns="0"/>
          <a:lstStyle/>
          <a:p>
            <a:r>
              <a:t>Title Text</a:t>
            </a:r>
          </a:p>
        </p:txBody>
      </p:sp>
      <p:sp>
        <p:nvSpPr>
          <p:cNvPr id="3" name="Body Level One…"/>
          <p:cNvSpPr txBox="1">
            <a:spLocks noGrp="1"/>
          </p:cNvSpPr>
          <p:nvPr>
            <p:ph type="body" idx="1"/>
          </p:nvPr>
        </p:nvSpPr>
        <p:spPr>
          <a:xfrm>
            <a:off x="609600" y="1600201"/>
            <a:ext cx="10972803" cy="5257800"/>
          </a:xfrm>
          <a:prstGeom prst="rect">
            <a:avLst/>
          </a:prstGeom>
          <a:ln w="12700">
            <a:miter lim="400000"/>
          </a:ln>
          <a:extLst>
            <a:ext uri="{C572A759-6A51-4108-AA02-DFA0A04FC94B}">
              <ma14:wrappingTextBoxFlag xmlns:ma14="http://schemas.microsoft.com/office/mac/drawingml/2011/main" xmlns="" val="1"/>
            </a:ext>
          </a:extLst>
        </p:spPr>
        <p:txBody>
          <a:bodyPr lIns="0" tIns="0" rIns="0" bIns="0"/>
          <a:lstStyle/>
          <a:p>
            <a:r>
              <a:t>Body Level One</a:t>
            </a:r>
          </a:p>
          <a:p>
            <a:pPr lvl="1"/>
            <a:r>
              <a:t>Body Level Two</a:t>
            </a:r>
          </a:p>
          <a:p>
            <a:pPr lvl="2"/>
            <a:r>
              <a:t>Body Level Three</a:t>
            </a:r>
          </a:p>
          <a:p>
            <a:pPr lvl="3"/>
            <a:r>
              <a:t>Body Level Four</a:t>
            </a:r>
          </a:p>
          <a:p>
            <a:pPr lvl="4"/>
            <a:r>
              <a:t>Body Level Five</a:t>
            </a:r>
          </a:p>
        </p:txBody>
      </p:sp>
      <p:sp>
        <p:nvSpPr>
          <p:cNvPr id="4" name="Slide Number"/>
          <p:cNvSpPr txBox="1">
            <a:spLocks noGrp="1"/>
          </p:cNvSpPr>
          <p:nvPr>
            <p:ph type="sldNum" sz="quarter" idx="2"/>
          </p:nvPr>
        </p:nvSpPr>
        <p:spPr>
          <a:xfrm>
            <a:off x="11300273" y="6377940"/>
            <a:ext cx="282130" cy="276999"/>
          </a:xfrm>
          <a:prstGeom prst="rect">
            <a:avLst/>
          </a:prstGeom>
          <a:ln w="12700">
            <a:miter lim="400000"/>
          </a:ln>
        </p:spPr>
        <p:txBody>
          <a:bodyPr wrap="none" lIns="0" tIns="0" rIns="0" bIns="0">
            <a:spAutoFit/>
          </a:bodyPr>
          <a:lstStyle>
            <a:lvl1pPr algn="r">
              <a:defRPr>
                <a:solidFill>
                  <a:srgbClr val="888888"/>
                </a:solidFill>
                <a:latin typeface="+mn-lt"/>
                <a:ea typeface="+mn-ea"/>
                <a:cs typeface="+mn-cs"/>
                <a:sym typeface="Helvetica"/>
              </a:defRPr>
            </a:lvl1pPr>
          </a:lstStyle>
          <a:p>
            <a:fld id="{86CB4B4D-7CA3-9044-876B-883B54F8677D}" type="slidenum">
              <a:t>‹#›</a:t>
            </a:fld>
            <a:endParaRPr/>
          </a:p>
        </p:txBody>
      </p:sp>
    </p:spTree>
    <p:extLst>
      <p:ext uri="{BB962C8B-B14F-4D97-AF65-F5344CB8AC3E}">
        <p14:creationId xmlns:p14="http://schemas.microsoft.com/office/powerpoint/2010/main" val="400103725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4" r:id="rId3"/>
    <p:sldLayoutId id="2147483665" r:id="rId4"/>
    <p:sldLayoutId id="2147483666" r:id="rId5"/>
  </p:sldLayoutIdLst>
  <p:transition spd="med"/>
  <p:txStyles>
    <p:titleStyle>
      <a:lvl1pPr marL="0" marR="0" indent="0" algn="l" defTabSz="748875" rtl="0" latinLnBrk="0">
        <a:lnSpc>
          <a:spcPct val="100000"/>
        </a:lnSpc>
        <a:spcBef>
          <a:spcPts val="0"/>
        </a:spcBef>
        <a:spcAft>
          <a:spcPts val="0"/>
        </a:spcAft>
        <a:buClrTx/>
        <a:buSzTx/>
        <a:buFontTx/>
        <a:buNone/>
        <a:tabLst/>
        <a:defRPr sz="3067" b="1" i="0" u="none" strike="noStrike" cap="none" spc="0" baseline="0">
          <a:ln>
            <a:noFill/>
          </a:ln>
          <a:solidFill>
            <a:srgbClr val="001B2F"/>
          </a:solidFill>
          <a:uFillTx/>
          <a:latin typeface="Poppins-ExtraBold"/>
          <a:ea typeface="Poppins-ExtraBold"/>
          <a:cs typeface="Poppins-ExtraBold"/>
          <a:sym typeface="Poppins-ExtraBold"/>
        </a:defRPr>
      </a:lvl1pPr>
      <a:lvl2pPr marL="0" marR="0" indent="0" algn="l" defTabSz="748875" rtl="0" latinLnBrk="0">
        <a:lnSpc>
          <a:spcPct val="100000"/>
        </a:lnSpc>
        <a:spcBef>
          <a:spcPts val="0"/>
        </a:spcBef>
        <a:spcAft>
          <a:spcPts val="0"/>
        </a:spcAft>
        <a:buClrTx/>
        <a:buSzTx/>
        <a:buFontTx/>
        <a:buNone/>
        <a:tabLst/>
        <a:defRPr sz="3067" b="1" i="0" u="none" strike="noStrike" cap="none" spc="0" baseline="0">
          <a:ln>
            <a:noFill/>
          </a:ln>
          <a:solidFill>
            <a:srgbClr val="001B2F"/>
          </a:solidFill>
          <a:uFillTx/>
          <a:latin typeface="Poppins-ExtraBold"/>
          <a:ea typeface="Poppins-ExtraBold"/>
          <a:cs typeface="Poppins-ExtraBold"/>
          <a:sym typeface="Poppins-ExtraBold"/>
        </a:defRPr>
      </a:lvl2pPr>
      <a:lvl3pPr marL="0" marR="0" indent="0" algn="l" defTabSz="748875" rtl="0" latinLnBrk="0">
        <a:lnSpc>
          <a:spcPct val="100000"/>
        </a:lnSpc>
        <a:spcBef>
          <a:spcPts val="0"/>
        </a:spcBef>
        <a:spcAft>
          <a:spcPts val="0"/>
        </a:spcAft>
        <a:buClrTx/>
        <a:buSzTx/>
        <a:buFontTx/>
        <a:buNone/>
        <a:tabLst/>
        <a:defRPr sz="3067" b="1" i="0" u="none" strike="noStrike" cap="none" spc="0" baseline="0">
          <a:ln>
            <a:noFill/>
          </a:ln>
          <a:solidFill>
            <a:srgbClr val="001B2F"/>
          </a:solidFill>
          <a:uFillTx/>
          <a:latin typeface="Poppins-ExtraBold"/>
          <a:ea typeface="Poppins-ExtraBold"/>
          <a:cs typeface="Poppins-ExtraBold"/>
          <a:sym typeface="Poppins-ExtraBold"/>
        </a:defRPr>
      </a:lvl3pPr>
      <a:lvl4pPr marL="0" marR="0" indent="0" algn="l" defTabSz="748875" rtl="0" latinLnBrk="0">
        <a:lnSpc>
          <a:spcPct val="100000"/>
        </a:lnSpc>
        <a:spcBef>
          <a:spcPts val="0"/>
        </a:spcBef>
        <a:spcAft>
          <a:spcPts val="0"/>
        </a:spcAft>
        <a:buClrTx/>
        <a:buSzTx/>
        <a:buFontTx/>
        <a:buNone/>
        <a:tabLst/>
        <a:defRPr sz="3067" b="1" i="0" u="none" strike="noStrike" cap="none" spc="0" baseline="0">
          <a:ln>
            <a:noFill/>
          </a:ln>
          <a:solidFill>
            <a:srgbClr val="001B2F"/>
          </a:solidFill>
          <a:uFillTx/>
          <a:latin typeface="Poppins-ExtraBold"/>
          <a:ea typeface="Poppins-ExtraBold"/>
          <a:cs typeface="Poppins-ExtraBold"/>
          <a:sym typeface="Poppins-ExtraBold"/>
        </a:defRPr>
      </a:lvl4pPr>
      <a:lvl5pPr marL="0" marR="0" indent="0" algn="l" defTabSz="748875" rtl="0" latinLnBrk="0">
        <a:lnSpc>
          <a:spcPct val="100000"/>
        </a:lnSpc>
        <a:spcBef>
          <a:spcPts val="0"/>
        </a:spcBef>
        <a:spcAft>
          <a:spcPts val="0"/>
        </a:spcAft>
        <a:buClrTx/>
        <a:buSzTx/>
        <a:buFontTx/>
        <a:buNone/>
        <a:tabLst/>
        <a:defRPr sz="3067" b="1" i="0" u="none" strike="noStrike" cap="none" spc="0" baseline="0">
          <a:ln>
            <a:noFill/>
          </a:ln>
          <a:solidFill>
            <a:srgbClr val="001B2F"/>
          </a:solidFill>
          <a:uFillTx/>
          <a:latin typeface="Poppins-ExtraBold"/>
          <a:ea typeface="Poppins-ExtraBold"/>
          <a:cs typeface="Poppins-ExtraBold"/>
          <a:sym typeface="Poppins-ExtraBold"/>
        </a:defRPr>
      </a:lvl5pPr>
      <a:lvl6pPr marL="0" marR="0" indent="0" algn="l" defTabSz="748875" rtl="0" latinLnBrk="0">
        <a:lnSpc>
          <a:spcPct val="100000"/>
        </a:lnSpc>
        <a:spcBef>
          <a:spcPts val="0"/>
        </a:spcBef>
        <a:spcAft>
          <a:spcPts val="0"/>
        </a:spcAft>
        <a:buClrTx/>
        <a:buSzTx/>
        <a:buFontTx/>
        <a:buNone/>
        <a:tabLst/>
        <a:defRPr sz="3067" b="1" i="0" u="none" strike="noStrike" cap="none" spc="0" baseline="0">
          <a:ln>
            <a:noFill/>
          </a:ln>
          <a:solidFill>
            <a:srgbClr val="001B2F"/>
          </a:solidFill>
          <a:uFillTx/>
          <a:latin typeface="Poppins-ExtraBold"/>
          <a:ea typeface="Poppins-ExtraBold"/>
          <a:cs typeface="Poppins-ExtraBold"/>
          <a:sym typeface="Poppins-ExtraBold"/>
        </a:defRPr>
      </a:lvl6pPr>
      <a:lvl7pPr marL="0" marR="0" indent="0" algn="l" defTabSz="748875" rtl="0" latinLnBrk="0">
        <a:lnSpc>
          <a:spcPct val="100000"/>
        </a:lnSpc>
        <a:spcBef>
          <a:spcPts val="0"/>
        </a:spcBef>
        <a:spcAft>
          <a:spcPts val="0"/>
        </a:spcAft>
        <a:buClrTx/>
        <a:buSzTx/>
        <a:buFontTx/>
        <a:buNone/>
        <a:tabLst/>
        <a:defRPr sz="3067" b="1" i="0" u="none" strike="noStrike" cap="none" spc="0" baseline="0">
          <a:ln>
            <a:noFill/>
          </a:ln>
          <a:solidFill>
            <a:srgbClr val="001B2F"/>
          </a:solidFill>
          <a:uFillTx/>
          <a:latin typeface="Poppins-ExtraBold"/>
          <a:ea typeface="Poppins-ExtraBold"/>
          <a:cs typeface="Poppins-ExtraBold"/>
          <a:sym typeface="Poppins-ExtraBold"/>
        </a:defRPr>
      </a:lvl7pPr>
      <a:lvl8pPr marL="0" marR="0" indent="0" algn="l" defTabSz="748875" rtl="0" latinLnBrk="0">
        <a:lnSpc>
          <a:spcPct val="100000"/>
        </a:lnSpc>
        <a:spcBef>
          <a:spcPts val="0"/>
        </a:spcBef>
        <a:spcAft>
          <a:spcPts val="0"/>
        </a:spcAft>
        <a:buClrTx/>
        <a:buSzTx/>
        <a:buFontTx/>
        <a:buNone/>
        <a:tabLst/>
        <a:defRPr sz="3067" b="1" i="0" u="none" strike="noStrike" cap="none" spc="0" baseline="0">
          <a:ln>
            <a:noFill/>
          </a:ln>
          <a:solidFill>
            <a:srgbClr val="001B2F"/>
          </a:solidFill>
          <a:uFillTx/>
          <a:latin typeface="Poppins-ExtraBold"/>
          <a:ea typeface="Poppins-ExtraBold"/>
          <a:cs typeface="Poppins-ExtraBold"/>
          <a:sym typeface="Poppins-ExtraBold"/>
        </a:defRPr>
      </a:lvl8pPr>
      <a:lvl9pPr marL="0" marR="0" indent="0" algn="l" defTabSz="748875" rtl="0" latinLnBrk="0">
        <a:lnSpc>
          <a:spcPct val="100000"/>
        </a:lnSpc>
        <a:spcBef>
          <a:spcPts val="0"/>
        </a:spcBef>
        <a:spcAft>
          <a:spcPts val="0"/>
        </a:spcAft>
        <a:buClrTx/>
        <a:buSzTx/>
        <a:buFontTx/>
        <a:buNone/>
        <a:tabLst/>
        <a:defRPr sz="3067" b="1" i="0" u="none" strike="noStrike" cap="none" spc="0" baseline="0">
          <a:ln>
            <a:noFill/>
          </a:ln>
          <a:solidFill>
            <a:srgbClr val="001B2F"/>
          </a:solidFill>
          <a:uFillTx/>
          <a:latin typeface="Poppins-ExtraBold"/>
          <a:ea typeface="Poppins-ExtraBold"/>
          <a:cs typeface="Poppins-ExtraBold"/>
          <a:sym typeface="Poppins-ExtraBold"/>
        </a:defRPr>
      </a:lvl9pPr>
    </p:titleStyle>
    <p:bodyStyle>
      <a:lvl1pPr marL="0" marR="0" indent="0" algn="l" defTabSz="748875" rtl="0" latinLnBrk="0">
        <a:lnSpc>
          <a:spcPct val="100000"/>
        </a:lnSpc>
        <a:spcBef>
          <a:spcPts val="0"/>
        </a:spcBef>
        <a:spcAft>
          <a:spcPts val="0"/>
        </a:spcAft>
        <a:buClrTx/>
        <a:buSzTx/>
        <a:buFontTx/>
        <a:buNone/>
        <a:tabLst/>
        <a:defRPr sz="1467" b="0" i="0" u="none" strike="noStrike" cap="none" spc="0" baseline="0">
          <a:ln>
            <a:noFill/>
          </a:ln>
          <a:solidFill>
            <a:srgbClr val="000000"/>
          </a:solidFill>
          <a:uFillTx/>
          <a:latin typeface="Calibri"/>
          <a:ea typeface="Calibri"/>
          <a:cs typeface="Calibri"/>
          <a:sym typeface="Calibri"/>
        </a:defRPr>
      </a:lvl1pPr>
      <a:lvl2pPr marL="0" marR="0" indent="374437" algn="l" defTabSz="748875" rtl="0" latinLnBrk="0">
        <a:lnSpc>
          <a:spcPct val="100000"/>
        </a:lnSpc>
        <a:spcBef>
          <a:spcPts val="0"/>
        </a:spcBef>
        <a:spcAft>
          <a:spcPts val="0"/>
        </a:spcAft>
        <a:buClrTx/>
        <a:buSzTx/>
        <a:buFontTx/>
        <a:buNone/>
        <a:tabLst/>
        <a:defRPr sz="1467" b="0" i="0" u="none" strike="noStrike" cap="none" spc="0" baseline="0">
          <a:ln>
            <a:noFill/>
          </a:ln>
          <a:solidFill>
            <a:srgbClr val="000000"/>
          </a:solidFill>
          <a:uFillTx/>
          <a:latin typeface="Calibri"/>
          <a:ea typeface="Calibri"/>
          <a:cs typeface="Calibri"/>
          <a:sym typeface="Calibri"/>
        </a:defRPr>
      </a:lvl2pPr>
      <a:lvl3pPr marL="0" marR="0" indent="748875" algn="l" defTabSz="748875" rtl="0" latinLnBrk="0">
        <a:lnSpc>
          <a:spcPct val="100000"/>
        </a:lnSpc>
        <a:spcBef>
          <a:spcPts val="0"/>
        </a:spcBef>
        <a:spcAft>
          <a:spcPts val="0"/>
        </a:spcAft>
        <a:buClrTx/>
        <a:buSzTx/>
        <a:buFontTx/>
        <a:buNone/>
        <a:tabLst/>
        <a:defRPr sz="1467" b="0" i="0" u="none" strike="noStrike" cap="none" spc="0" baseline="0">
          <a:ln>
            <a:noFill/>
          </a:ln>
          <a:solidFill>
            <a:srgbClr val="000000"/>
          </a:solidFill>
          <a:uFillTx/>
          <a:latin typeface="Calibri"/>
          <a:ea typeface="Calibri"/>
          <a:cs typeface="Calibri"/>
          <a:sym typeface="Calibri"/>
        </a:defRPr>
      </a:lvl3pPr>
      <a:lvl4pPr marL="0" marR="0" indent="1123312" algn="l" defTabSz="748875" rtl="0" latinLnBrk="0">
        <a:lnSpc>
          <a:spcPct val="100000"/>
        </a:lnSpc>
        <a:spcBef>
          <a:spcPts val="0"/>
        </a:spcBef>
        <a:spcAft>
          <a:spcPts val="0"/>
        </a:spcAft>
        <a:buClrTx/>
        <a:buSzTx/>
        <a:buFontTx/>
        <a:buNone/>
        <a:tabLst/>
        <a:defRPr sz="1467" b="0" i="0" u="none" strike="noStrike" cap="none" spc="0" baseline="0">
          <a:ln>
            <a:noFill/>
          </a:ln>
          <a:solidFill>
            <a:srgbClr val="000000"/>
          </a:solidFill>
          <a:uFillTx/>
          <a:latin typeface="Calibri"/>
          <a:ea typeface="Calibri"/>
          <a:cs typeface="Calibri"/>
          <a:sym typeface="Calibri"/>
        </a:defRPr>
      </a:lvl4pPr>
      <a:lvl5pPr marL="0" marR="0" indent="1497749" algn="l" defTabSz="748875" rtl="0" latinLnBrk="0">
        <a:lnSpc>
          <a:spcPct val="100000"/>
        </a:lnSpc>
        <a:spcBef>
          <a:spcPts val="0"/>
        </a:spcBef>
        <a:spcAft>
          <a:spcPts val="0"/>
        </a:spcAft>
        <a:buClrTx/>
        <a:buSzTx/>
        <a:buFontTx/>
        <a:buNone/>
        <a:tabLst/>
        <a:defRPr sz="1467" b="0" i="0" u="none" strike="noStrike" cap="none" spc="0" baseline="0">
          <a:ln>
            <a:noFill/>
          </a:ln>
          <a:solidFill>
            <a:srgbClr val="000000"/>
          </a:solidFill>
          <a:uFillTx/>
          <a:latin typeface="Calibri"/>
          <a:ea typeface="Calibri"/>
          <a:cs typeface="Calibri"/>
          <a:sym typeface="Calibri"/>
        </a:defRPr>
      </a:lvl5pPr>
      <a:lvl6pPr marL="0" marR="0" indent="1872188" algn="l" defTabSz="748875" rtl="0" latinLnBrk="0">
        <a:lnSpc>
          <a:spcPct val="100000"/>
        </a:lnSpc>
        <a:spcBef>
          <a:spcPts val="0"/>
        </a:spcBef>
        <a:spcAft>
          <a:spcPts val="0"/>
        </a:spcAft>
        <a:buClrTx/>
        <a:buSzTx/>
        <a:buFontTx/>
        <a:buNone/>
        <a:tabLst/>
        <a:defRPr sz="1467" b="0" i="0" u="none" strike="noStrike" cap="none" spc="0" baseline="0">
          <a:ln>
            <a:noFill/>
          </a:ln>
          <a:solidFill>
            <a:srgbClr val="000000"/>
          </a:solidFill>
          <a:uFillTx/>
          <a:latin typeface="Calibri"/>
          <a:ea typeface="Calibri"/>
          <a:cs typeface="Calibri"/>
          <a:sym typeface="Calibri"/>
        </a:defRPr>
      </a:lvl6pPr>
      <a:lvl7pPr marL="0" marR="0" indent="2246625" algn="l" defTabSz="748875" rtl="0" latinLnBrk="0">
        <a:lnSpc>
          <a:spcPct val="100000"/>
        </a:lnSpc>
        <a:spcBef>
          <a:spcPts val="0"/>
        </a:spcBef>
        <a:spcAft>
          <a:spcPts val="0"/>
        </a:spcAft>
        <a:buClrTx/>
        <a:buSzTx/>
        <a:buFontTx/>
        <a:buNone/>
        <a:tabLst/>
        <a:defRPr sz="1467" b="0" i="0" u="none" strike="noStrike" cap="none" spc="0" baseline="0">
          <a:ln>
            <a:noFill/>
          </a:ln>
          <a:solidFill>
            <a:srgbClr val="000000"/>
          </a:solidFill>
          <a:uFillTx/>
          <a:latin typeface="Calibri"/>
          <a:ea typeface="Calibri"/>
          <a:cs typeface="Calibri"/>
          <a:sym typeface="Calibri"/>
        </a:defRPr>
      </a:lvl7pPr>
      <a:lvl8pPr marL="0" marR="0" indent="2621062" algn="l" defTabSz="748875" rtl="0" latinLnBrk="0">
        <a:lnSpc>
          <a:spcPct val="100000"/>
        </a:lnSpc>
        <a:spcBef>
          <a:spcPts val="0"/>
        </a:spcBef>
        <a:spcAft>
          <a:spcPts val="0"/>
        </a:spcAft>
        <a:buClrTx/>
        <a:buSzTx/>
        <a:buFontTx/>
        <a:buNone/>
        <a:tabLst/>
        <a:defRPr sz="1467" b="0" i="0" u="none" strike="noStrike" cap="none" spc="0" baseline="0">
          <a:ln>
            <a:noFill/>
          </a:ln>
          <a:solidFill>
            <a:srgbClr val="000000"/>
          </a:solidFill>
          <a:uFillTx/>
          <a:latin typeface="Calibri"/>
          <a:ea typeface="Calibri"/>
          <a:cs typeface="Calibri"/>
          <a:sym typeface="Calibri"/>
        </a:defRPr>
      </a:lvl8pPr>
      <a:lvl9pPr marL="0" marR="0" indent="2995500" algn="l" defTabSz="748875" rtl="0" latinLnBrk="0">
        <a:lnSpc>
          <a:spcPct val="100000"/>
        </a:lnSpc>
        <a:spcBef>
          <a:spcPts val="0"/>
        </a:spcBef>
        <a:spcAft>
          <a:spcPts val="0"/>
        </a:spcAft>
        <a:buClrTx/>
        <a:buSzTx/>
        <a:buFontTx/>
        <a:buNone/>
        <a:tabLst/>
        <a:defRPr sz="1467" b="0" i="0" u="none" strike="noStrike" cap="none" spc="0" baseline="0">
          <a:ln>
            <a:noFill/>
          </a:ln>
          <a:solidFill>
            <a:srgbClr val="000000"/>
          </a:solidFill>
          <a:uFillTx/>
          <a:latin typeface="Calibri"/>
          <a:ea typeface="Calibri"/>
          <a:cs typeface="Calibri"/>
          <a:sym typeface="Calibri"/>
        </a:defRPr>
      </a:lvl9pPr>
    </p:bodyStyle>
    <p:otherStyle>
      <a:lvl1pPr marL="0" marR="0" indent="0" algn="r" defTabSz="748875" rtl="0" latinLnBrk="0">
        <a:lnSpc>
          <a:spcPct val="100000"/>
        </a:lnSpc>
        <a:spcBef>
          <a:spcPts val="0"/>
        </a:spcBef>
        <a:spcAft>
          <a:spcPts val="0"/>
        </a:spcAft>
        <a:buClrTx/>
        <a:buSzTx/>
        <a:buFontTx/>
        <a:buNone/>
        <a:tabLst/>
        <a:defRPr sz="1467" b="0" i="0" u="none" strike="noStrike" cap="none" spc="0" baseline="0">
          <a:ln>
            <a:noFill/>
          </a:ln>
          <a:solidFill>
            <a:schemeClr val="tx1"/>
          </a:solidFill>
          <a:uFillTx/>
          <a:latin typeface="+mn-lt"/>
          <a:ea typeface="+mn-ea"/>
          <a:cs typeface="+mn-cs"/>
          <a:sym typeface="Helvetica"/>
        </a:defRPr>
      </a:lvl1pPr>
      <a:lvl2pPr marL="0" marR="0" indent="0" algn="r" defTabSz="748875" rtl="0" latinLnBrk="0">
        <a:lnSpc>
          <a:spcPct val="100000"/>
        </a:lnSpc>
        <a:spcBef>
          <a:spcPts val="0"/>
        </a:spcBef>
        <a:spcAft>
          <a:spcPts val="0"/>
        </a:spcAft>
        <a:buClrTx/>
        <a:buSzTx/>
        <a:buFontTx/>
        <a:buNone/>
        <a:tabLst/>
        <a:defRPr sz="1467" b="0" i="0" u="none" strike="noStrike" cap="none" spc="0" baseline="0">
          <a:ln>
            <a:noFill/>
          </a:ln>
          <a:solidFill>
            <a:schemeClr val="tx1"/>
          </a:solidFill>
          <a:uFillTx/>
          <a:latin typeface="+mn-lt"/>
          <a:ea typeface="+mn-ea"/>
          <a:cs typeface="+mn-cs"/>
          <a:sym typeface="Helvetica"/>
        </a:defRPr>
      </a:lvl2pPr>
      <a:lvl3pPr marL="0" marR="0" indent="0" algn="r" defTabSz="748875" rtl="0" latinLnBrk="0">
        <a:lnSpc>
          <a:spcPct val="100000"/>
        </a:lnSpc>
        <a:spcBef>
          <a:spcPts val="0"/>
        </a:spcBef>
        <a:spcAft>
          <a:spcPts val="0"/>
        </a:spcAft>
        <a:buClrTx/>
        <a:buSzTx/>
        <a:buFontTx/>
        <a:buNone/>
        <a:tabLst/>
        <a:defRPr sz="1467" b="0" i="0" u="none" strike="noStrike" cap="none" spc="0" baseline="0">
          <a:ln>
            <a:noFill/>
          </a:ln>
          <a:solidFill>
            <a:schemeClr val="tx1"/>
          </a:solidFill>
          <a:uFillTx/>
          <a:latin typeface="+mn-lt"/>
          <a:ea typeface="+mn-ea"/>
          <a:cs typeface="+mn-cs"/>
          <a:sym typeface="Helvetica"/>
        </a:defRPr>
      </a:lvl3pPr>
      <a:lvl4pPr marL="0" marR="0" indent="0" algn="r" defTabSz="748875" rtl="0" latinLnBrk="0">
        <a:lnSpc>
          <a:spcPct val="100000"/>
        </a:lnSpc>
        <a:spcBef>
          <a:spcPts val="0"/>
        </a:spcBef>
        <a:spcAft>
          <a:spcPts val="0"/>
        </a:spcAft>
        <a:buClrTx/>
        <a:buSzTx/>
        <a:buFontTx/>
        <a:buNone/>
        <a:tabLst/>
        <a:defRPr sz="1467" b="0" i="0" u="none" strike="noStrike" cap="none" spc="0" baseline="0">
          <a:ln>
            <a:noFill/>
          </a:ln>
          <a:solidFill>
            <a:schemeClr val="tx1"/>
          </a:solidFill>
          <a:uFillTx/>
          <a:latin typeface="+mn-lt"/>
          <a:ea typeface="+mn-ea"/>
          <a:cs typeface="+mn-cs"/>
          <a:sym typeface="Helvetica"/>
        </a:defRPr>
      </a:lvl4pPr>
      <a:lvl5pPr marL="0" marR="0" indent="0" algn="r" defTabSz="748875" rtl="0" latinLnBrk="0">
        <a:lnSpc>
          <a:spcPct val="100000"/>
        </a:lnSpc>
        <a:spcBef>
          <a:spcPts val="0"/>
        </a:spcBef>
        <a:spcAft>
          <a:spcPts val="0"/>
        </a:spcAft>
        <a:buClrTx/>
        <a:buSzTx/>
        <a:buFontTx/>
        <a:buNone/>
        <a:tabLst/>
        <a:defRPr sz="1467" b="0" i="0" u="none" strike="noStrike" cap="none" spc="0" baseline="0">
          <a:ln>
            <a:noFill/>
          </a:ln>
          <a:solidFill>
            <a:schemeClr val="tx1"/>
          </a:solidFill>
          <a:uFillTx/>
          <a:latin typeface="+mn-lt"/>
          <a:ea typeface="+mn-ea"/>
          <a:cs typeface="+mn-cs"/>
          <a:sym typeface="Helvetica"/>
        </a:defRPr>
      </a:lvl5pPr>
      <a:lvl6pPr marL="0" marR="0" indent="0" algn="r" defTabSz="748875" rtl="0" latinLnBrk="0">
        <a:lnSpc>
          <a:spcPct val="100000"/>
        </a:lnSpc>
        <a:spcBef>
          <a:spcPts val="0"/>
        </a:spcBef>
        <a:spcAft>
          <a:spcPts val="0"/>
        </a:spcAft>
        <a:buClrTx/>
        <a:buSzTx/>
        <a:buFontTx/>
        <a:buNone/>
        <a:tabLst/>
        <a:defRPr sz="1467" b="0" i="0" u="none" strike="noStrike" cap="none" spc="0" baseline="0">
          <a:ln>
            <a:noFill/>
          </a:ln>
          <a:solidFill>
            <a:schemeClr val="tx1"/>
          </a:solidFill>
          <a:uFillTx/>
          <a:latin typeface="+mn-lt"/>
          <a:ea typeface="+mn-ea"/>
          <a:cs typeface="+mn-cs"/>
          <a:sym typeface="Helvetica"/>
        </a:defRPr>
      </a:lvl6pPr>
      <a:lvl7pPr marL="0" marR="0" indent="0" algn="r" defTabSz="748875" rtl="0" latinLnBrk="0">
        <a:lnSpc>
          <a:spcPct val="100000"/>
        </a:lnSpc>
        <a:spcBef>
          <a:spcPts val="0"/>
        </a:spcBef>
        <a:spcAft>
          <a:spcPts val="0"/>
        </a:spcAft>
        <a:buClrTx/>
        <a:buSzTx/>
        <a:buFontTx/>
        <a:buNone/>
        <a:tabLst/>
        <a:defRPr sz="1467" b="0" i="0" u="none" strike="noStrike" cap="none" spc="0" baseline="0">
          <a:ln>
            <a:noFill/>
          </a:ln>
          <a:solidFill>
            <a:schemeClr val="tx1"/>
          </a:solidFill>
          <a:uFillTx/>
          <a:latin typeface="+mn-lt"/>
          <a:ea typeface="+mn-ea"/>
          <a:cs typeface="+mn-cs"/>
          <a:sym typeface="Helvetica"/>
        </a:defRPr>
      </a:lvl7pPr>
      <a:lvl8pPr marL="0" marR="0" indent="0" algn="r" defTabSz="748875" rtl="0" latinLnBrk="0">
        <a:lnSpc>
          <a:spcPct val="100000"/>
        </a:lnSpc>
        <a:spcBef>
          <a:spcPts val="0"/>
        </a:spcBef>
        <a:spcAft>
          <a:spcPts val="0"/>
        </a:spcAft>
        <a:buClrTx/>
        <a:buSzTx/>
        <a:buFontTx/>
        <a:buNone/>
        <a:tabLst/>
        <a:defRPr sz="1467" b="0" i="0" u="none" strike="noStrike" cap="none" spc="0" baseline="0">
          <a:ln>
            <a:noFill/>
          </a:ln>
          <a:solidFill>
            <a:schemeClr val="tx1"/>
          </a:solidFill>
          <a:uFillTx/>
          <a:latin typeface="+mn-lt"/>
          <a:ea typeface="+mn-ea"/>
          <a:cs typeface="+mn-cs"/>
          <a:sym typeface="Helvetica"/>
        </a:defRPr>
      </a:lvl8pPr>
      <a:lvl9pPr marL="0" marR="0" indent="0" algn="r" defTabSz="748875" rtl="0" latinLnBrk="0">
        <a:lnSpc>
          <a:spcPct val="100000"/>
        </a:lnSpc>
        <a:spcBef>
          <a:spcPts val="0"/>
        </a:spcBef>
        <a:spcAft>
          <a:spcPts val="0"/>
        </a:spcAft>
        <a:buClrTx/>
        <a:buSzTx/>
        <a:buFontTx/>
        <a:buNone/>
        <a:tabLst/>
        <a:defRPr sz="1467" b="0" i="0" u="none" strike="noStrike" cap="none" spc="0" baseline="0">
          <a:ln>
            <a:noFill/>
          </a:ln>
          <a:solidFill>
            <a:schemeClr val="tx1"/>
          </a:solidFill>
          <a:uFillTx/>
          <a:latin typeface="+mn-lt"/>
          <a:ea typeface="+mn-ea"/>
          <a:cs typeface="+mn-cs"/>
          <a:sym typeface="Helvetica"/>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image" Target="../media/image33.png"/><Relationship Id="rId1" Type="http://schemas.openxmlformats.org/officeDocument/2006/relationships/slideLayout" Target="../slideLayouts/slideLayout16.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openxmlformats.org/officeDocument/2006/relationships/image" Target="../media/image4.emf"/><Relationship Id="rId3" Type="http://schemas.openxmlformats.org/officeDocument/2006/relationships/oleObject" Target="../embeddings/oleObject1.bin"/><Relationship Id="rId7" Type="http://schemas.openxmlformats.org/officeDocument/2006/relationships/oleObject" Target="../embeddings/oleObject3.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3.emf"/><Relationship Id="rId5" Type="http://schemas.openxmlformats.org/officeDocument/2006/relationships/oleObject" Target="../embeddings/oleObject2.bin"/><Relationship Id="rId4" Type="http://schemas.openxmlformats.org/officeDocument/2006/relationships/image" Target="../media/image2.emf"/><Relationship Id="rId9" Type="http://schemas.openxmlformats.org/officeDocument/2006/relationships/image" Target="../media/image5.emf"/></Relationships>
</file>

<file path=ppt/slides/_rels/slide4.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11.tiff"/><Relationship Id="rId4" Type="http://schemas.openxmlformats.org/officeDocument/2006/relationships/image" Target="../media/image10.png"/></Relationships>
</file>

<file path=ppt/slides/_rels/slide8.xml.rels><?xml version="1.0" encoding="UTF-8" standalone="yes"?>
<Relationships xmlns="http://schemas.openxmlformats.org/package/2006/relationships"><Relationship Id="rId8" Type="http://schemas.openxmlformats.org/officeDocument/2006/relationships/image" Target="../media/image15.png"/><Relationship Id="rId13" Type="http://schemas.microsoft.com/office/2007/relationships/hdphoto" Target="../media/hdphoto5.wdp"/><Relationship Id="rId18" Type="http://schemas.openxmlformats.org/officeDocument/2006/relationships/image" Target="../media/image20.png"/><Relationship Id="rId3" Type="http://schemas.openxmlformats.org/officeDocument/2006/relationships/chart" Target="../charts/chart1.xml"/><Relationship Id="rId7" Type="http://schemas.microsoft.com/office/2007/relationships/hdphoto" Target="../media/hdphoto2.wdp"/><Relationship Id="rId12" Type="http://schemas.openxmlformats.org/officeDocument/2006/relationships/image" Target="../media/image17.png"/><Relationship Id="rId17" Type="http://schemas.openxmlformats.org/officeDocument/2006/relationships/image" Target="../media/image19.png"/><Relationship Id="rId2" Type="http://schemas.openxmlformats.org/officeDocument/2006/relationships/image" Target="../media/image12.png"/><Relationship Id="rId16" Type="http://schemas.openxmlformats.org/officeDocument/2006/relationships/chart" Target="../charts/chart2.xml"/><Relationship Id="rId1" Type="http://schemas.openxmlformats.org/officeDocument/2006/relationships/slideLayout" Target="../slideLayouts/slideLayout7.xml"/><Relationship Id="rId6" Type="http://schemas.openxmlformats.org/officeDocument/2006/relationships/image" Target="../media/image14.png"/><Relationship Id="rId11" Type="http://schemas.microsoft.com/office/2007/relationships/hdphoto" Target="../media/hdphoto4.wdp"/><Relationship Id="rId5" Type="http://schemas.microsoft.com/office/2007/relationships/hdphoto" Target="../media/hdphoto1.wdp"/><Relationship Id="rId15" Type="http://schemas.microsoft.com/office/2007/relationships/hdphoto" Target="../media/hdphoto6.wdp"/><Relationship Id="rId10" Type="http://schemas.openxmlformats.org/officeDocument/2006/relationships/image" Target="../media/image16.png"/><Relationship Id="rId4" Type="http://schemas.openxmlformats.org/officeDocument/2006/relationships/image" Target="../media/image13.png"/><Relationship Id="rId9" Type="http://schemas.microsoft.com/office/2007/relationships/hdphoto" Target="../media/hdphoto3.wdp"/><Relationship Id="rId14" Type="http://schemas.openxmlformats.org/officeDocument/2006/relationships/image" Target="../media/image18.png"/></Relationships>
</file>

<file path=ppt/slides/_rels/slide9.xml.rels><?xml version="1.0" encoding="UTF-8" standalone="yes"?>
<Relationships xmlns="http://schemas.openxmlformats.org/package/2006/relationships"><Relationship Id="rId8" Type="http://schemas.openxmlformats.org/officeDocument/2006/relationships/image" Target="../media/image27.png"/><Relationship Id="rId13" Type="http://schemas.openxmlformats.org/officeDocument/2006/relationships/image" Target="../media/image32.png"/><Relationship Id="rId3" Type="http://schemas.openxmlformats.org/officeDocument/2006/relationships/image" Target="../media/image22.png"/><Relationship Id="rId7" Type="http://schemas.openxmlformats.org/officeDocument/2006/relationships/image" Target="../media/image26.png"/><Relationship Id="rId12" Type="http://schemas.openxmlformats.org/officeDocument/2006/relationships/image" Target="../media/image31.jpeg"/><Relationship Id="rId2" Type="http://schemas.openxmlformats.org/officeDocument/2006/relationships/image" Target="../media/image21.jpg"/><Relationship Id="rId1" Type="http://schemas.openxmlformats.org/officeDocument/2006/relationships/slideLayout" Target="../slideLayouts/slideLayout7.xml"/><Relationship Id="rId6" Type="http://schemas.openxmlformats.org/officeDocument/2006/relationships/image" Target="../media/image25.jpeg"/><Relationship Id="rId11" Type="http://schemas.openxmlformats.org/officeDocument/2006/relationships/image" Target="../media/image30.jpeg"/><Relationship Id="rId5" Type="http://schemas.openxmlformats.org/officeDocument/2006/relationships/image" Target="../media/image24.png"/><Relationship Id="rId10" Type="http://schemas.openxmlformats.org/officeDocument/2006/relationships/image" Target="../media/image29.png"/><Relationship Id="rId4" Type="http://schemas.openxmlformats.org/officeDocument/2006/relationships/image" Target="../media/image23.jpeg"/><Relationship Id="rId9" Type="http://schemas.openxmlformats.org/officeDocument/2006/relationships/image" Target="../media/image28.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2027769114"/>
              </p:ext>
            </p:extLst>
          </p:nvPr>
        </p:nvGraphicFramePr>
        <p:xfrm>
          <a:off x="2969682" y="1283759"/>
          <a:ext cx="5459943" cy="2340993"/>
        </p:xfrm>
        <a:graphic>
          <a:graphicData uri="http://schemas.openxmlformats.org/drawingml/2006/table">
            <a:tbl>
              <a:tblPr/>
              <a:tblGrid>
                <a:gridCol w="2816913">
                  <a:extLst>
                    <a:ext uri="{9D8B030D-6E8A-4147-A177-3AD203B41FA5}">
                      <a16:colId xmlns:a16="http://schemas.microsoft.com/office/drawing/2014/main" val="1304653103"/>
                    </a:ext>
                  </a:extLst>
                </a:gridCol>
                <a:gridCol w="1414253">
                  <a:extLst>
                    <a:ext uri="{9D8B030D-6E8A-4147-A177-3AD203B41FA5}">
                      <a16:colId xmlns:a16="http://schemas.microsoft.com/office/drawing/2014/main" val="2431647783"/>
                    </a:ext>
                  </a:extLst>
                </a:gridCol>
                <a:gridCol w="1228777">
                  <a:extLst>
                    <a:ext uri="{9D8B030D-6E8A-4147-A177-3AD203B41FA5}">
                      <a16:colId xmlns:a16="http://schemas.microsoft.com/office/drawing/2014/main" val="2255427340"/>
                    </a:ext>
                  </a:extLst>
                </a:gridCol>
              </a:tblGrid>
              <a:tr h="207320">
                <a:tc rowSpan="2">
                  <a:txBody>
                    <a:bodyPr/>
                    <a:lstStyle/>
                    <a:p>
                      <a:pPr algn="ctr" fontAlgn="ctr"/>
                      <a:r>
                        <a:rPr lang="en-IE" sz="1100" b="1" i="0" u="none" strike="noStrike" dirty="0">
                          <a:solidFill>
                            <a:srgbClr val="000000"/>
                          </a:solidFill>
                          <a:effectLst/>
                          <a:latin typeface="Calibri" panose="020F0502020204030204" pitchFamily="34" charset="0"/>
                        </a:rPr>
                        <a:t>Cancer type</a:t>
                      </a:r>
                    </a:p>
                  </a:txBody>
                  <a:tcPr marL="9525" marR="9525" marT="9525"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gridSpan="2">
                  <a:txBody>
                    <a:bodyPr/>
                    <a:lstStyle/>
                    <a:p>
                      <a:pPr algn="ctr" fontAlgn="b"/>
                      <a:r>
                        <a:rPr lang="en-IE" sz="1100" b="1" i="0" u="none" strike="noStrike">
                          <a:solidFill>
                            <a:srgbClr val="000000"/>
                          </a:solidFill>
                          <a:effectLst/>
                          <a:latin typeface="Calibri" panose="020F0502020204030204" pitchFamily="34" charset="0"/>
                        </a:rPr>
                        <a:t> hsa-miR-616</a:t>
                      </a:r>
                    </a:p>
                  </a:txBody>
                  <a:tcPr marL="9525" marR="9525" marT="9525"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IE"/>
                    </a:p>
                  </a:txBody>
                  <a:tcPr/>
                </a:tc>
                <a:extLst>
                  <a:ext uri="{0D108BD9-81ED-4DB2-BD59-A6C34878D82A}">
                    <a16:rowId xmlns:a16="http://schemas.microsoft.com/office/drawing/2014/main" val="339045088"/>
                  </a:ext>
                </a:extLst>
              </a:tr>
              <a:tr h="215959">
                <a:tc vMerge="1">
                  <a:txBody>
                    <a:bodyPr/>
                    <a:lstStyle/>
                    <a:p>
                      <a:endParaRPr lang="en-IE"/>
                    </a:p>
                  </a:txBody>
                  <a:tcPr/>
                </a:tc>
                <a:tc>
                  <a:txBody>
                    <a:bodyPr/>
                    <a:lstStyle/>
                    <a:p>
                      <a:pPr algn="ctr" fontAlgn="b"/>
                      <a:r>
                        <a:rPr lang="en-IE" sz="1100" b="0" i="0" u="none" strike="noStrike">
                          <a:solidFill>
                            <a:srgbClr val="000000"/>
                          </a:solidFill>
                          <a:effectLst/>
                          <a:latin typeface="Calibri" panose="020F0502020204030204" pitchFamily="34" charset="0"/>
                        </a:rPr>
                        <a:t>Hazard Ratio</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IE" sz="1100" b="0" i="0" u="none" strike="noStrike">
                          <a:solidFill>
                            <a:srgbClr val="000000"/>
                          </a:solidFill>
                          <a:effectLst/>
                          <a:latin typeface="Calibri" panose="020F0502020204030204" pitchFamily="34" charset="0"/>
                        </a:rPr>
                        <a:t>Logrank P</a:t>
                      </a:r>
                    </a:p>
                  </a:txBody>
                  <a:tcPr marL="9525" marR="9525" marT="9525"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19390620"/>
                  </a:ext>
                </a:extLst>
              </a:tr>
              <a:tr h="207320">
                <a:tc>
                  <a:txBody>
                    <a:bodyPr/>
                    <a:lstStyle/>
                    <a:p>
                      <a:pPr algn="ctr" fontAlgn="b"/>
                      <a:r>
                        <a:rPr lang="en-IE" sz="1100" b="0" i="0" u="none" strike="noStrike" dirty="0">
                          <a:solidFill>
                            <a:srgbClr val="000000"/>
                          </a:solidFill>
                          <a:effectLst/>
                          <a:latin typeface="Calibri" panose="020F0502020204030204" pitchFamily="34" charset="0"/>
                        </a:rPr>
                        <a:t>Cervical Squamous Cell Carcinoma</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a:solidFill>
                            <a:srgbClr val="000000"/>
                          </a:solidFill>
                          <a:effectLst/>
                          <a:latin typeface="Calibri" panose="020F0502020204030204" pitchFamily="34" charset="0"/>
                        </a:rPr>
                        <a:t>0.61 (0.38 - 0.97)</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0.03700</a:t>
                      </a:r>
                    </a:p>
                  </a:txBody>
                  <a:tcPr marL="9525" marR="9525" marT="9525"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36021904"/>
                  </a:ext>
                </a:extLst>
              </a:tr>
              <a:tr h="207320">
                <a:tc>
                  <a:txBody>
                    <a:bodyPr/>
                    <a:lstStyle/>
                    <a:p>
                      <a:pPr algn="ctr" fontAlgn="b"/>
                      <a:r>
                        <a:rPr lang="en-IE" sz="1100" b="0" i="0" u="none" strike="noStrike" dirty="0">
                          <a:solidFill>
                            <a:srgbClr val="000000"/>
                          </a:solidFill>
                          <a:effectLst/>
                          <a:latin typeface="Calibri" panose="020F0502020204030204" pitchFamily="34" charset="0"/>
                        </a:rPr>
                        <a:t>Head-neck Squamous Cell Carcinoma</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a:solidFill>
                            <a:srgbClr val="000000"/>
                          </a:solidFill>
                          <a:effectLst/>
                          <a:latin typeface="Calibri" panose="020F0502020204030204" pitchFamily="34" charset="0"/>
                        </a:rPr>
                        <a:t>0.73 (0.56 - 0.95)</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0.02100</a:t>
                      </a:r>
                    </a:p>
                  </a:txBody>
                  <a:tcPr marL="9525" marR="9525" marT="9525"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12068967"/>
                  </a:ext>
                </a:extLst>
              </a:tr>
              <a:tr h="207320">
                <a:tc>
                  <a:txBody>
                    <a:bodyPr/>
                    <a:lstStyle/>
                    <a:p>
                      <a:pPr algn="ctr" fontAlgn="b"/>
                      <a:r>
                        <a:rPr lang="en-IE" sz="1100" b="0" i="0" u="none" strike="noStrike" dirty="0">
                          <a:solidFill>
                            <a:srgbClr val="000000"/>
                          </a:solidFill>
                          <a:effectLst/>
                          <a:latin typeface="Calibri" panose="020F0502020204030204" pitchFamily="34" charset="0"/>
                        </a:rPr>
                        <a:t>Thymoma</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a:solidFill>
                            <a:srgbClr val="000000"/>
                          </a:solidFill>
                          <a:effectLst/>
                          <a:latin typeface="Calibri" panose="020F0502020204030204" pitchFamily="34" charset="0"/>
                        </a:rPr>
                        <a:t>0.21 (0.03- 0.49)</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0.00049</a:t>
                      </a:r>
                    </a:p>
                  </a:txBody>
                  <a:tcPr marL="9525" marR="9525" marT="9525"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17274491"/>
                  </a:ext>
                </a:extLst>
              </a:tr>
              <a:tr h="215959">
                <a:tc>
                  <a:txBody>
                    <a:bodyPr/>
                    <a:lstStyle/>
                    <a:p>
                      <a:pPr algn="ctr" fontAlgn="b"/>
                      <a:r>
                        <a:rPr lang="en-IE" sz="1100" b="0" i="0" u="none" strike="noStrike" dirty="0">
                          <a:solidFill>
                            <a:srgbClr val="000000"/>
                          </a:solidFill>
                          <a:effectLst/>
                          <a:latin typeface="Calibri" panose="020F0502020204030204" pitchFamily="34" charset="0"/>
                        </a:rPr>
                        <a:t>Uterine corpus endometrial carcinoma</a:t>
                      </a:r>
                    </a:p>
                  </a:txBody>
                  <a:tcPr marL="9525" marR="9525" marT="9525"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0.50 (0.30 - 0.84)</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0.00790</a:t>
                      </a:r>
                    </a:p>
                  </a:txBody>
                  <a:tcPr marL="9525" marR="9525" marT="9525"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19803438"/>
                  </a:ext>
                </a:extLst>
              </a:tr>
              <a:tr h="215959">
                <a:tc>
                  <a:txBody>
                    <a:bodyPr/>
                    <a:lstStyle/>
                    <a:p>
                      <a:pPr algn="ctr" fontAlgn="b"/>
                      <a:r>
                        <a:rPr lang="en-IE" sz="1100" b="0" i="0" u="none" strike="noStrike" dirty="0">
                          <a:solidFill>
                            <a:srgbClr val="000000"/>
                          </a:solidFill>
                          <a:effectLst/>
                          <a:latin typeface="Calibri" panose="020F0502020204030204" pitchFamily="34" charset="0"/>
                        </a:rPr>
                        <a:t>Esophageal Adenocarcinoma</a:t>
                      </a:r>
                    </a:p>
                  </a:txBody>
                  <a:tcPr marL="7620" marR="7620" marT="762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a:solidFill>
                            <a:srgbClr val="000000"/>
                          </a:solidFill>
                          <a:effectLst/>
                          <a:latin typeface="Calibri" panose="020F0502020204030204" pitchFamily="34" charset="0"/>
                        </a:rPr>
                        <a:t>2.52 (1.38 - 4.59)</a:t>
                      </a:r>
                    </a:p>
                  </a:txBody>
                  <a:tcPr marL="7620" marR="7620" marT="762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0.00100</a:t>
                      </a:r>
                    </a:p>
                  </a:txBody>
                  <a:tcPr marL="7620" marR="7620" marT="762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8153984"/>
                  </a:ext>
                </a:extLst>
              </a:tr>
              <a:tr h="215959">
                <a:tc>
                  <a:txBody>
                    <a:bodyPr/>
                    <a:lstStyle/>
                    <a:p>
                      <a:pPr algn="ctr" fontAlgn="b"/>
                      <a:r>
                        <a:rPr lang="en-IE" sz="1100" b="0" i="0" u="none" strike="noStrike" dirty="0">
                          <a:solidFill>
                            <a:srgbClr val="000000"/>
                          </a:solidFill>
                          <a:effectLst/>
                          <a:latin typeface="Calibri" panose="020F0502020204030204" pitchFamily="34" charset="0"/>
                        </a:rPr>
                        <a:t>Sarcoma</a:t>
                      </a:r>
                    </a:p>
                  </a:txBody>
                  <a:tcPr marL="7620" marR="7620" marT="762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a:solidFill>
                            <a:srgbClr val="000000"/>
                          </a:solidFill>
                          <a:effectLst/>
                          <a:latin typeface="Calibri" panose="020F0502020204030204" pitchFamily="34" charset="0"/>
                        </a:rPr>
                        <a:t>2.07 (1.36 - 3.17)</a:t>
                      </a:r>
                    </a:p>
                  </a:txBody>
                  <a:tcPr marL="7620" marR="7620" marT="762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0.00050</a:t>
                      </a:r>
                    </a:p>
                  </a:txBody>
                  <a:tcPr marL="7620" marR="7620" marT="762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44663364"/>
                  </a:ext>
                </a:extLst>
              </a:tr>
              <a:tr h="215959">
                <a:tc>
                  <a:txBody>
                    <a:bodyPr/>
                    <a:lstStyle/>
                    <a:p>
                      <a:pPr algn="ctr" fontAlgn="b"/>
                      <a:r>
                        <a:rPr lang="en-IE" sz="1100" b="0" i="0" u="none" strike="noStrike" dirty="0">
                          <a:solidFill>
                            <a:srgbClr val="000000"/>
                          </a:solidFill>
                          <a:effectLst/>
                          <a:latin typeface="Calibri" panose="020F0502020204030204" pitchFamily="34" charset="0"/>
                        </a:rPr>
                        <a:t>Renal Clear Cell Carcinoma</a:t>
                      </a:r>
                    </a:p>
                  </a:txBody>
                  <a:tcPr marL="7620" marR="7620" marT="762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a:solidFill>
                            <a:srgbClr val="000000"/>
                          </a:solidFill>
                          <a:effectLst/>
                          <a:latin typeface="Calibri" panose="020F0502020204030204" pitchFamily="34" charset="0"/>
                        </a:rPr>
                        <a:t>2.01 (1.49 - 2.72)</a:t>
                      </a:r>
                    </a:p>
                  </a:txBody>
                  <a:tcPr marL="7620" marR="7620" marT="762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0.00000</a:t>
                      </a:r>
                    </a:p>
                  </a:txBody>
                  <a:tcPr marL="7620" marR="7620" marT="762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31671177"/>
                  </a:ext>
                </a:extLst>
              </a:tr>
              <a:tr h="215959">
                <a:tc>
                  <a:txBody>
                    <a:bodyPr/>
                    <a:lstStyle/>
                    <a:p>
                      <a:pPr algn="ctr" fontAlgn="b"/>
                      <a:r>
                        <a:rPr lang="en-IE" sz="1100" b="0" i="0" u="none" strike="noStrike" dirty="0">
                          <a:solidFill>
                            <a:srgbClr val="000000"/>
                          </a:solidFill>
                          <a:effectLst/>
                          <a:latin typeface="Calibri" panose="020F0502020204030204" pitchFamily="34" charset="0"/>
                        </a:rPr>
                        <a:t>Lung Squamous Cell Carcinoma</a:t>
                      </a:r>
                    </a:p>
                  </a:txBody>
                  <a:tcPr marL="7620" marR="7620" marT="762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1.34 (1.01 - 1.78)</a:t>
                      </a:r>
                    </a:p>
                  </a:txBody>
                  <a:tcPr marL="7620" marR="7620" marT="762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0.04400</a:t>
                      </a:r>
                    </a:p>
                  </a:txBody>
                  <a:tcPr marL="7620" marR="7620" marT="762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79463055"/>
                  </a:ext>
                </a:extLst>
              </a:tr>
              <a:tr h="215959">
                <a:tc>
                  <a:txBody>
                    <a:bodyPr/>
                    <a:lstStyle/>
                    <a:p>
                      <a:pPr algn="ctr" fontAlgn="b"/>
                      <a:r>
                        <a:rPr lang="en-IE" sz="1100" b="0" i="0" u="none" strike="noStrike" dirty="0">
                          <a:solidFill>
                            <a:srgbClr val="000000"/>
                          </a:solidFill>
                          <a:effectLst/>
                          <a:latin typeface="Calibri" panose="020F0502020204030204" pitchFamily="34" charset="0"/>
                        </a:rPr>
                        <a:t>Hepatocellular Carcinoma</a:t>
                      </a:r>
                    </a:p>
                  </a:txBody>
                  <a:tcPr marL="7620" marR="7620" marT="762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1.89 (1.31 - 2.72)</a:t>
                      </a:r>
                    </a:p>
                  </a:txBody>
                  <a:tcPr marL="7620" marR="7620" marT="762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IE" sz="1100" b="0" i="0" u="none" strike="noStrike" dirty="0">
                          <a:solidFill>
                            <a:srgbClr val="000000"/>
                          </a:solidFill>
                          <a:effectLst/>
                          <a:latin typeface="Calibri" panose="020F0502020204030204" pitchFamily="34" charset="0"/>
                        </a:rPr>
                        <a:t>0.00040</a:t>
                      </a:r>
                    </a:p>
                  </a:txBody>
                  <a:tcPr marL="7620" marR="7620" marT="7620" marB="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45424149"/>
                  </a:ext>
                </a:extLst>
              </a:tr>
            </a:tbl>
          </a:graphicData>
        </a:graphic>
      </p:graphicFrame>
      <p:sp>
        <p:nvSpPr>
          <p:cNvPr id="5" name="Rectangle 4"/>
          <p:cNvSpPr/>
          <p:nvPr/>
        </p:nvSpPr>
        <p:spPr>
          <a:xfrm>
            <a:off x="2891204" y="3741605"/>
            <a:ext cx="5713534" cy="646331"/>
          </a:xfrm>
          <a:prstGeom prst="rect">
            <a:avLst/>
          </a:prstGeom>
        </p:spPr>
        <p:txBody>
          <a:bodyPr wrap="square">
            <a:spAutoFit/>
          </a:bodyPr>
          <a:lstStyle/>
          <a:p>
            <a:pPr algn="just" fontAlgn="base">
              <a:spcBef>
                <a:spcPct val="0"/>
              </a:spcBef>
              <a:spcAft>
                <a:spcPct val="0"/>
              </a:spcAft>
            </a:pPr>
            <a:r>
              <a:rPr lang="en-IE" sz="1200" dirty="0">
                <a:effectLst/>
                <a:ea typeface="Calibri" panose="020F0502020204030204" pitchFamily="34" charset="0"/>
                <a:cs typeface="Arial" panose="020B0604020202020204" pitchFamily="34" charset="0"/>
              </a:rPr>
              <a:t>Supplementary figure </a:t>
            </a:r>
            <a:r>
              <a:rPr lang="en-IE" sz="1200" dirty="0">
                <a:solidFill>
                  <a:srgbClr val="2E2E2E"/>
                </a:solidFill>
              </a:rPr>
              <a:t>1. </a:t>
            </a:r>
            <a:r>
              <a:rPr lang="en-IE" sz="1200" b="1" dirty="0">
                <a:ea typeface="Calibri" pitchFamily="34" charset="0"/>
                <a:cs typeface="Arial" panose="020B0604020202020204" pitchFamily="34" charset="0"/>
              </a:rPr>
              <a:t> Association between miR-616 expression and overall survival </a:t>
            </a:r>
            <a:r>
              <a:rPr lang="en-IE" sz="1200" b="1" dirty="0">
                <a:solidFill>
                  <a:srgbClr val="2E2E2E"/>
                </a:solidFill>
              </a:rPr>
              <a:t>in human cancer</a:t>
            </a:r>
            <a:r>
              <a:rPr lang="en-IE" sz="1200" dirty="0">
                <a:solidFill>
                  <a:srgbClr val="2E2E2E"/>
                </a:solidFill>
              </a:rPr>
              <a:t>. Web-based algorithm KM plotter (http://kmplot.com/analysis/) was used to evaluate the association between miR-616 with overall (OS) survival.</a:t>
            </a:r>
            <a:endParaRPr lang="en-IE" sz="1200" dirty="0"/>
          </a:p>
        </p:txBody>
      </p:sp>
    </p:spTree>
    <p:extLst>
      <p:ext uri="{BB962C8B-B14F-4D97-AF65-F5344CB8AC3E}">
        <p14:creationId xmlns:p14="http://schemas.microsoft.com/office/powerpoint/2010/main" val="208166598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694977" y="2145316"/>
            <a:ext cx="10802046" cy="830997"/>
          </a:xfrm>
          <a:prstGeom prst="rect">
            <a:avLst/>
          </a:prstGeom>
          <a:noFill/>
        </p:spPr>
        <p:txBody>
          <a:bodyPr wrap="square" rtlCol="0">
            <a:spAutoFit/>
          </a:bodyPr>
          <a:lstStyle/>
          <a:p>
            <a:pPr algn="just"/>
            <a:r>
              <a:rPr lang="en-IE" sz="1200" dirty="0">
                <a:effectLst/>
                <a:latin typeface="Calibri" panose="020F0502020204030204" pitchFamily="34" charset="0"/>
                <a:ea typeface="Calibri" panose="020F0502020204030204" pitchFamily="34" charset="0"/>
                <a:cs typeface="Calibri" panose="020F0502020204030204" pitchFamily="34" charset="0"/>
              </a:rPr>
              <a:t>Supplementary figure </a:t>
            </a:r>
            <a:r>
              <a:rPr lang="en-IE" sz="1200" dirty="0" smtClean="0">
                <a:effectLst/>
                <a:latin typeface="Calibri" panose="020F0502020204030204" pitchFamily="34" charset="0"/>
                <a:ea typeface="Calibri" panose="020F0502020204030204" pitchFamily="34" charset="0"/>
                <a:cs typeface="Calibri" panose="020F0502020204030204" pitchFamily="34" charset="0"/>
              </a:rPr>
              <a:t>10</a:t>
            </a:r>
            <a:r>
              <a:rPr lang="en-IE" sz="1200" dirty="0" smtClean="0">
                <a:latin typeface="Calibri" panose="020F0502020204030204" pitchFamily="34" charset="0"/>
                <a:cs typeface="Calibri" panose="020F0502020204030204" pitchFamily="34" charset="0"/>
              </a:rPr>
              <a:t>. </a:t>
            </a:r>
            <a:r>
              <a:rPr lang="en-IE" sz="1200" b="1" dirty="0">
                <a:latin typeface="Calibri" panose="020F0502020204030204" pitchFamily="34" charset="0"/>
                <a:cs typeface="Calibri" panose="020F0502020204030204" pitchFamily="34" charset="0"/>
              </a:rPr>
              <a:t>Prediction of the effect of miR-616-5p and miR-616-3p on cell viability through their 6mer seed sequence. </a:t>
            </a:r>
            <a:r>
              <a:rPr lang="en-IE" sz="1200" dirty="0">
                <a:latin typeface="Calibri" panose="020F0502020204030204" pitchFamily="34" charset="0"/>
                <a:cs typeface="Calibri" panose="020F0502020204030204" pitchFamily="34" charset="0"/>
              </a:rPr>
              <a:t>The activity of 6-mer seed of was evaluated in three human (HeyA8-ovarian, H460-lung and H4-brain) and three mouse (M565-liver, 3LL-lung and GL261-brain) cell lines. MiRNAs with low viability (high toxicity) are shown in red and with high viability (low toxicity) are shown in green. Predominantly expressed mature miRNAs (guide miRNA) are shown in dark purple while lesser expressed (passenger miRNA) are shown in light purple. The miRNAs sharing seed sequence with miR-616-5p are also shown. </a:t>
            </a:r>
          </a:p>
        </p:txBody>
      </p:sp>
      <p:grpSp>
        <p:nvGrpSpPr>
          <p:cNvPr id="15" name="Group 14"/>
          <p:cNvGrpSpPr/>
          <p:nvPr/>
        </p:nvGrpSpPr>
        <p:grpSpPr>
          <a:xfrm>
            <a:off x="647699" y="731451"/>
            <a:ext cx="10980000" cy="1278746"/>
            <a:chOff x="647699" y="731451"/>
            <a:chExt cx="10980000" cy="1278746"/>
          </a:xfrm>
        </p:grpSpPr>
        <p:pic>
          <p:nvPicPr>
            <p:cNvPr id="3" name="Picture 2"/>
            <p:cNvPicPr>
              <a:picLocks noChangeAspect="1"/>
            </p:cNvPicPr>
            <p:nvPr/>
          </p:nvPicPr>
          <p:blipFill>
            <a:blip r:embed="rId2"/>
            <a:stretch>
              <a:fillRect/>
            </a:stretch>
          </p:blipFill>
          <p:spPr>
            <a:xfrm>
              <a:off x="647699" y="731451"/>
              <a:ext cx="10980000" cy="1278746"/>
            </a:xfrm>
            <a:prstGeom prst="rect">
              <a:avLst/>
            </a:prstGeom>
          </p:spPr>
        </p:pic>
        <p:pic>
          <p:nvPicPr>
            <p:cNvPr id="13" name="Picture 12"/>
            <p:cNvPicPr>
              <a:picLocks/>
            </p:cNvPicPr>
            <p:nvPr/>
          </p:nvPicPr>
          <p:blipFill rotWithShape="1">
            <a:blip r:embed="rId3"/>
            <a:srcRect t="45886"/>
            <a:stretch/>
          </p:blipFill>
          <p:spPr>
            <a:xfrm>
              <a:off x="685800" y="1533525"/>
              <a:ext cx="10908000" cy="421996"/>
            </a:xfrm>
            <a:prstGeom prst="rect">
              <a:avLst/>
            </a:prstGeom>
          </p:spPr>
        </p:pic>
        <p:sp>
          <p:nvSpPr>
            <p:cNvPr id="14" name="Rectangle 13"/>
            <p:cNvSpPr/>
            <p:nvPr/>
          </p:nvSpPr>
          <p:spPr>
            <a:xfrm>
              <a:off x="676275" y="762000"/>
              <a:ext cx="10908000" cy="1171575"/>
            </a:xfrm>
            <a:prstGeom prst="rect">
              <a:avLst/>
            </a:prstGeom>
            <a:noFill/>
            <a:ln w="25400" cap="flat">
              <a:solidFill>
                <a:schemeClr val="tx1"/>
              </a:solidFill>
              <a:prstDash val="solid"/>
              <a:round/>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anchor="ctr">
              <a:spAutoFit/>
            </a:bodyPr>
            <a:lstStyle/>
            <a:p>
              <a:pPr marL="0" marR="0" indent="0" algn="l" defTabSz="914400" rtl="0" fontAlgn="auto" latinLnBrk="0" hangingPunct="0">
                <a:lnSpc>
                  <a:spcPct val="100000"/>
                </a:lnSpc>
                <a:spcBef>
                  <a:spcPts val="0"/>
                </a:spcBef>
                <a:spcAft>
                  <a:spcPts val="0"/>
                </a:spcAft>
                <a:buClrTx/>
                <a:buSzTx/>
                <a:buFontTx/>
                <a:buNone/>
                <a:tabLst/>
              </a:pPr>
              <a:endParaRPr kumimoji="0" lang="en-IE" sz="1800" b="0" i="0" u="none" strike="noStrike" cap="none" spc="0" normalizeH="0" baseline="0">
                <a:ln>
                  <a:noFill/>
                </a:ln>
                <a:solidFill>
                  <a:srgbClr val="000000"/>
                </a:solidFill>
                <a:effectLst/>
                <a:uFillTx/>
                <a:latin typeface="Calibri"/>
                <a:ea typeface="Calibri"/>
                <a:cs typeface="Calibri"/>
                <a:sym typeface="Calibri"/>
              </a:endParaRPr>
            </a:p>
          </p:txBody>
        </p:sp>
      </p:grpSp>
    </p:spTree>
    <p:extLst>
      <p:ext uri="{BB962C8B-B14F-4D97-AF65-F5344CB8AC3E}">
        <p14:creationId xmlns:p14="http://schemas.microsoft.com/office/powerpoint/2010/main" val="174943397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2178294" y="3948957"/>
            <a:ext cx="7943850" cy="2308324"/>
          </a:xfrm>
          <a:prstGeom prst="rect">
            <a:avLst/>
          </a:prstGeom>
        </p:spPr>
        <p:txBody>
          <a:bodyPr wrap="square">
            <a:spAutoFit/>
          </a:bodyPr>
          <a:lstStyle/>
          <a:p>
            <a:pPr algn="just"/>
            <a:r>
              <a:rPr lang="en-IE" sz="1200" dirty="0">
                <a:effectLst/>
                <a:ea typeface="Calibri" panose="020F0502020204030204" pitchFamily="34" charset="0"/>
                <a:cs typeface="Arial" panose="020B0604020202020204" pitchFamily="34" charset="0"/>
              </a:rPr>
              <a:t>Supplementary figure</a:t>
            </a:r>
            <a:r>
              <a:rPr lang="en-IE" sz="1200" dirty="0"/>
              <a:t> 2. </a:t>
            </a:r>
            <a:r>
              <a:rPr lang="en-IE" sz="1200" b="1" dirty="0"/>
              <a:t> Expression of miR-616-5p and miR-616-3p in human cancers</a:t>
            </a:r>
            <a:r>
              <a:rPr lang="en-IE" sz="1200" dirty="0"/>
              <a:t>. Web-based algorithm at (http://www.oncomir.org/</a:t>
            </a:r>
            <a:r>
              <a:rPr lang="en-IE" sz="1200" u="sng" dirty="0"/>
              <a:t>)</a:t>
            </a:r>
            <a:r>
              <a:rPr lang="en-IE" sz="1200" dirty="0"/>
              <a:t> was used to assess the expression of miR-616-5p and miR-616-3p. Log2 mean expression of miR-616-5p and 3p in indicated cancer types is shown.  (N = number samples in each cancer type). ACC: adrenocortical carcinoma; BLCA: bladder urothelial carcinoma; BRCA: breast invasive carcinoma; CESC: cervical squamous cell carcinoma and endocervical adenocarcinoma; CHOL: cholangiocarcinoma; COAD: colon adenocarcinoma; ESCA: esophageal carcinoma; HNSC: head and neck squamous cell carcinoma; KICH: kidney chromophobe; KIRC: kidney renal clear cell carcinoma; KIRP: kidney renal papillary cell carcinoma; LGG: brain lower grade glioma; LIHC: liver hepatocellular carcinoma; LUAD: lung adenocarcinoma; LUSC: lung squamous cell carcinoma; MESO: mesothelioma; OV: ovarian serous cystadenocarcinoma; PAAD: pancreatic adenocarcinoma; PCPG: pheochromocytoma and paraganglioma; PRAD: prostate adenocarcinoma; READ: rectal adenocarcinoma; SARC: sarcoma; SKCM: skin cutaneous melanoma; STAD: stomach adenocarcinoma; TGCT: testicular germ cell tumours; THCA: thyroid carcinoma; THYM: thymoma; UCEC: uterine corpus endometrial carcinoma; UCS: uterine carcinosarcoma; UVM: uveal melanoma</a:t>
            </a:r>
          </a:p>
        </p:txBody>
      </p:sp>
      <p:pic>
        <p:nvPicPr>
          <p:cNvPr id="5" name="Picture 4"/>
          <p:cNvPicPr/>
          <p:nvPr/>
        </p:nvPicPr>
        <p:blipFill rotWithShape="1">
          <a:blip r:embed="rId2">
            <a:extLst>
              <a:ext uri="{28A0092B-C50C-407E-A947-70E740481C1C}">
                <a14:useLocalDpi xmlns:a14="http://schemas.microsoft.com/office/drawing/2010/main" val="0"/>
              </a:ext>
            </a:extLst>
          </a:blip>
          <a:srcRect b="45163"/>
          <a:stretch/>
        </p:blipFill>
        <p:spPr bwMode="auto">
          <a:xfrm>
            <a:off x="2130742" y="142977"/>
            <a:ext cx="7902257" cy="3810955"/>
          </a:xfrm>
          <a:prstGeom prst="rect">
            <a:avLst/>
          </a:prstGeom>
          <a:noFill/>
        </p:spPr>
      </p:pic>
    </p:spTree>
    <p:extLst>
      <p:ext uri="{BB962C8B-B14F-4D97-AF65-F5344CB8AC3E}">
        <p14:creationId xmlns:p14="http://schemas.microsoft.com/office/powerpoint/2010/main" val="203449246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3656922" y="981111"/>
            <a:ext cx="5587335" cy="1779588"/>
            <a:chOff x="3004988" y="3817445"/>
            <a:chExt cx="5587335" cy="1779588"/>
          </a:xfrm>
        </p:grpSpPr>
        <p:graphicFrame>
          <p:nvGraphicFramePr>
            <p:cNvPr id="3" name="Object 2"/>
            <p:cNvGraphicFramePr>
              <a:graphicFrameLocks noChangeAspect="1"/>
            </p:cNvGraphicFramePr>
            <p:nvPr>
              <p:extLst>
                <p:ext uri="{D42A27DB-BD31-4B8C-83A1-F6EECF244321}">
                  <p14:modId xmlns:p14="http://schemas.microsoft.com/office/powerpoint/2010/main" val="3313794572"/>
                </p:ext>
              </p:extLst>
            </p:nvPr>
          </p:nvGraphicFramePr>
          <p:xfrm>
            <a:off x="3004988" y="3817445"/>
            <a:ext cx="1804987" cy="1779588"/>
          </p:xfrm>
          <a:graphic>
            <a:graphicData uri="http://schemas.openxmlformats.org/presentationml/2006/ole">
              <mc:AlternateContent xmlns:mc="http://schemas.openxmlformats.org/markup-compatibility/2006">
                <mc:Choice xmlns:v="urn:schemas-microsoft-com:vml" Requires="v">
                  <p:oleObj spid="_x0000_s1035" name="Prism 8" r:id="rId3" imgW="2403055" imgH="2372507" progId="Prism8.Document">
                    <p:embed/>
                  </p:oleObj>
                </mc:Choice>
                <mc:Fallback>
                  <p:oleObj name="Prism 8" r:id="rId3" imgW="2403055" imgH="2372507" progId="Prism8.Document">
                    <p:embed/>
                    <p:pic>
                      <p:nvPicPr>
                        <p:cNvPr id="15" name="Object 14"/>
                        <p:cNvPicPr/>
                        <p:nvPr/>
                      </p:nvPicPr>
                      <p:blipFill>
                        <a:blip r:embed="rId4"/>
                        <a:stretch>
                          <a:fillRect/>
                        </a:stretch>
                      </p:blipFill>
                      <p:spPr>
                        <a:xfrm>
                          <a:off x="3004988" y="3817445"/>
                          <a:ext cx="1804987" cy="1779588"/>
                        </a:xfrm>
                        <a:prstGeom prst="rect">
                          <a:avLst/>
                        </a:prstGeom>
                      </p:spPr>
                    </p:pic>
                  </p:oleObj>
                </mc:Fallback>
              </mc:AlternateContent>
            </a:graphicData>
          </a:graphic>
        </p:graphicFrame>
        <p:graphicFrame>
          <p:nvGraphicFramePr>
            <p:cNvPr id="4" name="Object 3"/>
            <p:cNvGraphicFramePr>
              <a:graphicFrameLocks/>
            </p:cNvGraphicFramePr>
            <p:nvPr>
              <p:extLst>
                <p:ext uri="{D42A27DB-BD31-4B8C-83A1-F6EECF244321}">
                  <p14:modId xmlns:p14="http://schemas.microsoft.com/office/powerpoint/2010/main" val="3558076059"/>
                </p:ext>
              </p:extLst>
            </p:nvPr>
          </p:nvGraphicFramePr>
          <p:xfrm>
            <a:off x="5964056" y="3841435"/>
            <a:ext cx="1800000" cy="1746000"/>
          </p:xfrm>
          <a:graphic>
            <a:graphicData uri="http://schemas.openxmlformats.org/presentationml/2006/ole">
              <mc:AlternateContent xmlns:mc="http://schemas.openxmlformats.org/markup-compatibility/2006">
                <mc:Choice xmlns:v="urn:schemas-microsoft-com:vml" Requires="v">
                  <p:oleObj spid="_x0000_s1036" name="Prism 8" r:id="rId5" imgW="2242875" imgH="2345150" progId="Prism8.Document">
                    <p:embed/>
                  </p:oleObj>
                </mc:Choice>
                <mc:Fallback>
                  <p:oleObj name="Prism 8" r:id="rId5" imgW="2242875" imgH="2345150" progId="Prism8.Document">
                    <p:embed/>
                    <p:pic>
                      <p:nvPicPr>
                        <p:cNvPr id="16" name="Object 15"/>
                        <p:cNvPicPr/>
                        <p:nvPr/>
                      </p:nvPicPr>
                      <p:blipFill>
                        <a:blip r:embed="rId6"/>
                        <a:stretch>
                          <a:fillRect/>
                        </a:stretch>
                      </p:blipFill>
                      <p:spPr>
                        <a:xfrm>
                          <a:off x="5964056" y="3841435"/>
                          <a:ext cx="1800000" cy="1746000"/>
                        </a:xfrm>
                        <a:prstGeom prst="rect">
                          <a:avLst/>
                        </a:prstGeom>
                      </p:spPr>
                    </p:pic>
                  </p:oleObj>
                </mc:Fallback>
              </mc:AlternateContent>
            </a:graphicData>
          </a:graphic>
        </p:graphicFrame>
        <p:graphicFrame>
          <p:nvGraphicFramePr>
            <p:cNvPr id="5" name="Object 4"/>
            <p:cNvGraphicFramePr>
              <a:graphicFrameLocks/>
            </p:cNvGraphicFramePr>
            <p:nvPr>
              <p:extLst>
                <p:ext uri="{D42A27DB-BD31-4B8C-83A1-F6EECF244321}">
                  <p14:modId xmlns:p14="http://schemas.microsoft.com/office/powerpoint/2010/main" val="3982110796"/>
                </p:ext>
              </p:extLst>
            </p:nvPr>
          </p:nvGraphicFramePr>
          <p:xfrm>
            <a:off x="4466328" y="3844698"/>
            <a:ext cx="1836000" cy="1746000"/>
          </p:xfrm>
          <a:graphic>
            <a:graphicData uri="http://schemas.openxmlformats.org/presentationml/2006/ole">
              <mc:AlternateContent xmlns:mc="http://schemas.openxmlformats.org/markup-compatibility/2006">
                <mc:Choice xmlns:v="urn:schemas-microsoft-com:vml" Requires="v">
                  <p:oleObj spid="_x0000_s1037" name="Prism 8" r:id="rId7" imgW="2242875" imgH="2345150" progId="Prism8.Document">
                    <p:embed/>
                  </p:oleObj>
                </mc:Choice>
                <mc:Fallback>
                  <p:oleObj name="Prism 8" r:id="rId7" imgW="2242875" imgH="2345150" progId="Prism8.Document">
                    <p:embed/>
                    <p:pic>
                      <p:nvPicPr>
                        <p:cNvPr id="17" name="Object 16"/>
                        <p:cNvPicPr/>
                        <p:nvPr/>
                      </p:nvPicPr>
                      <p:blipFill>
                        <a:blip r:embed="rId8"/>
                        <a:stretch>
                          <a:fillRect/>
                        </a:stretch>
                      </p:blipFill>
                      <p:spPr>
                        <a:xfrm>
                          <a:off x="4466328" y="3844698"/>
                          <a:ext cx="1836000" cy="1746000"/>
                        </a:xfrm>
                        <a:prstGeom prst="rect">
                          <a:avLst/>
                        </a:prstGeom>
                      </p:spPr>
                    </p:pic>
                  </p:oleObj>
                </mc:Fallback>
              </mc:AlternateContent>
            </a:graphicData>
          </a:graphic>
        </p:graphicFrame>
        <p:pic>
          <p:nvPicPr>
            <p:cNvPr id="6" name="Picture 5"/>
            <p:cNvPicPr>
              <a:picLocks noChangeAspect="1"/>
            </p:cNvPicPr>
            <p:nvPr/>
          </p:nvPicPr>
          <p:blipFill rotWithShape="1">
            <a:blip r:embed="rId9"/>
            <a:srcRect l="24508" r="13915" b="72881"/>
            <a:stretch/>
          </p:blipFill>
          <p:spPr>
            <a:xfrm>
              <a:off x="7325814" y="4115618"/>
              <a:ext cx="1266509" cy="647634"/>
            </a:xfrm>
            <a:prstGeom prst="rect">
              <a:avLst/>
            </a:prstGeom>
          </p:spPr>
        </p:pic>
      </p:grpSp>
      <p:sp>
        <p:nvSpPr>
          <p:cNvPr id="7" name="Rectangle 6"/>
          <p:cNvSpPr/>
          <p:nvPr/>
        </p:nvSpPr>
        <p:spPr>
          <a:xfrm>
            <a:off x="3598334" y="3025340"/>
            <a:ext cx="6096000" cy="1200329"/>
          </a:xfrm>
          <a:prstGeom prst="rect">
            <a:avLst/>
          </a:prstGeom>
        </p:spPr>
        <p:txBody>
          <a:bodyPr>
            <a:spAutoFit/>
          </a:bodyPr>
          <a:lstStyle/>
          <a:p>
            <a:pPr algn="just"/>
            <a:r>
              <a:rPr lang="en-IE" sz="1200" dirty="0">
                <a:ea typeface="Calibri" panose="020F0502020204030204" pitchFamily="34" charset="0"/>
                <a:cs typeface="Arial" panose="020B0604020202020204" pitchFamily="34" charset="0"/>
              </a:rPr>
              <a:t>Supplementary figure </a:t>
            </a:r>
            <a:r>
              <a:rPr lang="en-IE" sz="1200" dirty="0"/>
              <a:t>3</a:t>
            </a:r>
            <a:r>
              <a:rPr lang="en-IE" sz="1200" dirty="0" smtClean="0"/>
              <a:t>. </a:t>
            </a:r>
            <a:r>
              <a:rPr lang="en-IE" sz="1200" b="1" dirty="0"/>
              <a:t>Upregulation of miR-616 (5p and 3p) and its host gene CHOP during UPR. </a:t>
            </a:r>
            <a:r>
              <a:rPr lang="en-IE" sz="1200" dirty="0" smtClean="0"/>
              <a:t>HCT116 cells </a:t>
            </a:r>
            <a:r>
              <a:rPr lang="en-IE" sz="1200" dirty="0"/>
              <a:t>were treated with (1 µM) TG or (0.5 μg/ml) BFA for 24 hours. Expression of CHOP was quantified by RT-qPCR, normalized using RPLP0. The expression level of miR-616 -5p and -3p was quantified by RT-qPCR, normalized using RNU6b. Error bars represent mean ±S.D. from three independent experiments performed in triplicate. </a:t>
            </a:r>
            <a:r>
              <a:rPr lang="en-IE" sz="1200" dirty="0" smtClean="0"/>
              <a:t>*p </a:t>
            </a:r>
            <a:r>
              <a:rPr lang="en-IE" sz="1200" dirty="0"/>
              <a:t>&lt; 0.05, two-tailed unpaired t-test as compared to vehicle control.</a:t>
            </a:r>
          </a:p>
        </p:txBody>
      </p:sp>
    </p:spTree>
    <p:extLst>
      <p:ext uri="{BB962C8B-B14F-4D97-AF65-F5344CB8AC3E}">
        <p14:creationId xmlns:p14="http://schemas.microsoft.com/office/powerpoint/2010/main" val="268968121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1879599" y="4209177"/>
            <a:ext cx="9050997" cy="830997"/>
          </a:xfrm>
          <a:prstGeom prst="rect">
            <a:avLst/>
          </a:prstGeom>
        </p:spPr>
        <p:txBody>
          <a:bodyPr wrap="square">
            <a:spAutoFit/>
          </a:bodyPr>
          <a:lstStyle/>
          <a:p>
            <a:pPr algn="just"/>
            <a:r>
              <a:rPr lang="en-IE" sz="1200" dirty="0">
                <a:effectLst/>
                <a:ea typeface="Calibri" panose="020F0502020204030204" pitchFamily="34" charset="0"/>
                <a:cs typeface="Arial" panose="020B0604020202020204" pitchFamily="34" charset="0"/>
              </a:rPr>
              <a:t>Supplementary figure </a:t>
            </a:r>
            <a:r>
              <a:rPr lang="en-IE" sz="1200" dirty="0"/>
              <a:t>4</a:t>
            </a:r>
            <a:r>
              <a:rPr lang="en-IE" sz="1200" dirty="0" smtClean="0"/>
              <a:t>. </a:t>
            </a:r>
            <a:r>
              <a:rPr lang="en-IE" sz="1200" b="1" dirty="0"/>
              <a:t>Successful knockdown of UPR sensors in MCF7 cells</a:t>
            </a:r>
            <a:r>
              <a:rPr lang="en-IE" sz="1200" dirty="0"/>
              <a:t>. MCF7 PKLO, MCF7 XBP1 knockdown (XBP1-KD) and MCF7 PERK knockdown (PERK-KD) and MCF7 ATF6 knockdown (ATF6-KD) clones were generated using respective shRNA and knockdown efficiency was evaluated by (A-B) real-time RT-PCR for PERK and ATF6 and (C) conventional PCR for XBP1 after treatment with (1.0 </a:t>
            </a:r>
            <a:r>
              <a:rPr lang="el-GR" sz="1200" dirty="0"/>
              <a:t>μ</a:t>
            </a:r>
            <a:r>
              <a:rPr lang="en-IE" sz="1200" dirty="0"/>
              <a:t>M) Brefeldin A (BFA) for 24 h. * p &lt; </a:t>
            </a:r>
            <a:r>
              <a:rPr lang="en-IE" sz="1200" dirty="0" smtClean="0"/>
              <a:t>0.05; </a:t>
            </a:r>
            <a:r>
              <a:rPr lang="en-IE" sz="1200" dirty="0"/>
              <a:t>** p &lt; 0.001.</a:t>
            </a:r>
          </a:p>
        </p:txBody>
      </p:sp>
      <p:pic>
        <p:nvPicPr>
          <p:cNvPr id="4" name="Picture 3">
            <a:extLst>
              <a:ext uri="{FF2B5EF4-FFF2-40B4-BE49-F238E27FC236}">
                <a16:creationId xmlns:a16="http://schemas.microsoft.com/office/drawing/2014/main" id="{0BE57168-4B98-BC9E-2114-C5E57109D92E}"/>
              </a:ext>
            </a:extLst>
          </p:cNvPr>
          <p:cNvPicPr>
            <a:picLocks noChangeAspect="1"/>
          </p:cNvPicPr>
          <p:nvPr/>
        </p:nvPicPr>
        <p:blipFill>
          <a:blip r:embed="rId2"/>
          <a:stretch>
            <a:fillRect/>
          </a:stretch>
        </p:blipFill>
        <p:spPr>
          <a:xfrm>
            <a:off x="2084484" y="1152125"/>
            <a:ext cx="8023031" cy="2993395"/>
          </a:xfrm>
          <a:prstGeom prst="rect">
            <a:avLst/>
          </a:prstGeom>
        </p:spPr>
      </p:pic>
    </p:spTree>
    <p:extLst>
      <p:ext uri="{BB962C8B-B14F-4D97-AF65-F5344CB8AC3E}">
        <p14:creationId xmlns:p14="http://schemas.microsoft.com/office/powerpoint/2010/main" val="185408201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947333" y="4107577"/>
            <a:ext cx="9015828" cy="830997"/>
          </a:xfrm>
          <a:prstGeom prst="rect">
            <a:avLst/>
          </a:prstGeom>
        </p:spPr>
        <p:txBody>
          <a:bodyPr wrap="square">
            <a:spAutoFit/>
          </a:bodyPr>
          <a:lstStyle/>
          <a:p>
            <a:pPr algn="just"/>
            <a:r>
              <a:rPr lang="en-IE" sz="1200" dirty="0">
                <a:effectLst/>
                <a:ea typeface="Calibri" panose="020F0502020204030204" pitchFamily="34" charset="0"/>
                <a:cs typeface="Arial" panose="020B0604020202020204" pitchFamily="34" charset="0"/>
              </a:rPr>
              <a:t>Supplementary figure </a:t>
            </a:r>
            <a:r>
              <a:rPr lang="en-IE" sz="1200" dirty="0" smtClean="0">
                <a:effectLst/>
                <a:ea typeface="Calibri" panose="020F0502020204030204" pitchFamily="34" charset="0"/>
                <a:cs typeface="Arial" panose="020B0604020202020204" pitchFamily="34" charset="0"/>
              </a:rPr>
              <a:t>5</a:t>
            </a:r>
            <a:r>
              <a:rPr lang="en-IE" sz="1200" dirty="0" smtClean="0"/>
              <a:t>. </a:t>
            </a:r>
            <a:r>
              <a:rPr lang="en-IE" sz="1200" b="1" dirty="0"/>
              <a:t>Successful knockdown of UPR sensors in HCT116 cells</a:t>
            </a:r>
            <a:r>
              <a:rPr lang="en-IE" sz="1200" dirty="0"/>
              <a:t>. HCT116 PKLO, HCT116 XBP1 knockdown (XBP1-KD) and HCT116 PERK knockdown (PERK-KD) and HCT116 ATF6 knockdown (ATF6-KD) clones were generated using respective shRNA and knockdown efficiency was evaluated by  (A-B) real-time RT-PCR for PERK and ATF6 and (C) conventional PCR for XBP1 after treatment with (1.0 </a:t>
            </a:r>
            <a:r>
              <a:rPr lang="el-GR" sz="1200" dirty="0"/>
              <a:t>μ</a:t>
            </a:r>
            <a:r>
              <a:rPr lang="en-IE" sz="1200" dirty="0"/>
              <a:t>M) Brefeldin A (BFA) for 24 h. * p &lt; </a:t>
            </a:r>
            <a:r>
              <a:rPr lang="en-IE" sz="1200" dirty="0" smtClean="0"/>
              <a:t>0.05</a:t>
            </a:r>
            <a:r>
              <a:rPr lang="en-IE" sz="1200" dirty="0"/>
              <a:t>.</a:t>
            </a:r>
          </a:p>
        </p:txBody>
      </p:sp>
      <p:pic>
        <p:nvPicPr>
          <p:cNvPr id="7" name="Picture 6">
            <a:extLst>
              <a:ext uri="{FF2B5EF4-FFF2-40B4-BE49-F238E27FC236}">
                <a16:creationId xmlns:a16="http://schemas.microsoft.com/office/drawing/2014/main" id="{81E33BD2-D03A-1727-01B7-D8EF8FB009F6}"/>
              </a:ext>
            </a:extLst>
          </p:cNvPr>
          <p:cNvPicPr>
            <a:picLocks noChangeAspect="1"/>
          </p:cNvPicPr>
          <p:nvPr/>
        </p:nvPicPr>
        <p:blipFill>
          <a:blip r:embed="rId2"/>
          <a:stretch>
            <a:fillRect/>
          </a:stretch>
        </p:blipFill>
        <p:spPr>
          <a:xfrm>
            <a:off x="3062511" y="1265200"/>
            <a:ext cx="6201483" cy="2629467"/>
          </a:xfrm>
          <a:prstGeom prst="rect">
            <a:avLst/>
          </a:prstGeom>
        </p:spPr>
      </p:pic>
    </p:spTree>
    <p:extLst>
      <p:ext uri="{BB962C8B-B14F-4D97-AF65-F5344CB8AC3E}">
        <p14:creationId xmlns:p14="http://schemas.microsoft.com/office/powerpoint/2010/main" val="288754777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3875443" y="337476"/>
            <a:ext cx="4591225" cy="4895394"/>
          </a:xfrm>
          <a:prstGeom prst="rect">
            <a:avLst/>
          </a:prstGeom>
        </p:spPr>
      </p:pic>
      <p:sp>
        <p:nvSpPr>
          <p:cNvPr id="3" name="Rectangle 2"/>
          <p:cNvSpPr/>
          <p:nvPr/>
        </p:nvSpPr>
        <p:spPr>
          <a:xfrm>
            <a:off x="2717800" y="5354010"/>
            <a:ext cx="8635999" cy="646331"/>
          </a:xfrm>
          <a:prstGeom prst="rect">
            <a:avLst/>
          </a:prstGeom>
        </p:spPr>
        <p:txBody>
          <a:bodyPr wrap="square">
            <a:spAutoFit/>
          </a:bodyPr>
          <a:lstStyle/>
          <a:p>
            <a:r>
              <a:rPr lang="en-IE" sz="1200" dirty="0">
                <a:ea typeface="Calibri" panose="020F0502020204030204" pitchFamily="34" charset="0"/>
                <a:cs typeface="Arial" panose="020B0604020202020204" pitchFamily="34" charset="0"/>
              </a:rPr>
              <a:t>Supplementary figure </a:t>
            </a:r>
            <a:r>
              <a:rPr lang="en-IE" sz="1200" dirty="0" smtClean="0"/>
              <a:t>6. </a:t>
            </a:r>
            <a:r>
              <a:rPr lang="en-IE" sz="1200" b="1" dirty="0"/>
              <a:t>Upregulation of miR-616 during ER stress is dependent on PERK pathway.</a:t>
            </a:r>
            <a:r>
              <a:rPr lang="en-IE" sz="1200" dirty="0"/>
              <a:t> </a:t>
            </a:r>
            <a:r>
              <a:rPr lang="en-IE" sz="1200" dirty="0" smtClean="0"/>
              <a:t>HCT116-PKLO</a:t>
            </a:r>
            <a:r>
              <a:rPr lang="en-IE" sz="1200" dirty="0"/>
              <a:t>, HCT116-XBP1-KD, HCT116-PERK-KD and HCT116-ATF6-KD cells were treated with BFA, expression level of pri-miR-616, miR-616 -5p and -3p was quantified by real-time RT-PCR. </a:t>
            </a:r>
            <a:r>
              <a:rPr lang="en-IE" sz="1200" dirty="0" smtClean="0"/>
              <a:t>*p&lt;0.05</a:t>
            </a:r>
            <a:r>
              <a:rPr lang="en-IE" sz="1200" dirty="0"/>
              <a:t>, </a:t>
            </a:r>
            <a:r>
              <a:rPr lang="en-IE" sz="1200" dirty="0" smtClean="0"/>
              <a:t>**p </a:t>
            </a:r>
            <a:r>
              <a:rPr lang="en-IE" sz="1200" dirty="0"/>
              <a:t>&lt; 0.001, two-tailed unpaired t-test. </a:t>
            </a:r>
            <a:r>
              <a:rPr lang="en-IE" sz="1200" dirty="0" smtClean="0"/>
              <a:t>ns, </a:t>
            </a:r>
            <a:r>
              <a:rPr lang="en-IE" sz="1200" dirty="0"/>
              <a:t>not significant.</a:t>
            </a:r>
          </a:p>
        </p:txBody>
      </p:sp>
      <p:sp>
        <p:nvSpPr>
          <p:cNvPr id="4" name="Rectangle 3"/>
          <p:cNvSpPr/>
          <p:nvPr/>
        </p:nvSpPr>
        <p:spPr>
          <a:xfrm>
            <a:off x="3909270" y="318782"/>
            <a:ext cx="184558" cy="20133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a:p>
        </p:txBody>
      </p:sp>
      <p:sp>
        <p:nvSpPr>
          <p:cNvPr id="5" name="Rectangle 4"/>
          <p:cNvSpPr/>
          <p:nvPr/>
        </p:nvSpPr>
        <p:spPr>
          <a:xfrm>
            <a:off x="5521355" y="336958"/>
            <a:ext cx="184558" cy="20133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a:p>
        </p:txBody>
      </p:sp>
      <p:sp>
        <p:nvSpPr>
          <p:cNvPr id="6" name="Rectangle 5"/>
          <p:cNvSpPr/>
          <p:nvPr/>
        </p:nvSpPr>
        <p:spPr>
          <a:xfrm>
            <a:off x="7056540" y="345347"/>
            <a:ext cx="184558" cy="20133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a:p>
        </p:txBody>
      </p:sp>
    </p:spTree>
    <p:extLst>
      <p:ext uri="{BB962C8B-B14F-4D97-AF65-F5344CB8AC3E}">
        <p14:creationId xmlns:p14="http://schemas.microsoft.com/office/powerpoint/2010/main" val="241153573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1717381" y="145797"/>
            <a:ext cx="8656033" cy="5531419"/>
            <a:chOff x="1653881" y="247397"/>
            <a:chExt cx="8656033" cy="5531419"/>
          </a:xfrm>
        </p:grpSpPr>
        <p:grpSp>
          <p:nvGrpSpPr>
            <p:cNvPr id="13" name="Group 12"/>
            <p:cNvGrpSpPr/>
            <p:nvPr/>
          </p:nvGrpSpPr>
          <p:grpSpPr>
            <a:xfrm>
              <a:off x="1653881" y="247397"/>
              <a:ext cx="2915195" cy="5506887"/>
              <a:chOff x="701381" y="463297"/>
              <a:chExt cx="2915195" cy="5506887"/>
            </a:xfrm>
          </p:grpSpPr>
          <p:pic>
            <p:nvPicPr>
              <p:cNvPr id="46" name="Picture 45"/>
              <p:cNvPicPr>
                <a:picLocks/>
              </p:cNvPicPr>
              <p:nvPr/>
            </p:nvPicPr>
            <p:blipFill rotWithShape="1">
              <a:blip r:embed="rId3" cstate="print">
                <a:extLst>
                  <a:ext uri="{28A0092B-C50C-407E-A947-70E740481C1C}">
                    <a14:useLocalDpi xmlns:a14="http://schemas.microsoft.com/office/drawing/2010/main" val="0"/>
                  </a:ext>
                </a:extLst>
              </a:blip>
              <a:srcRect l="5201" t="9452" b="5673"/>
              <a:stretch/>
            </p:blipFill>
            <p:spPr>
              <a:xfrm>
                <a:off x="1013432" y="3257203"/>
                <a:ext cx="2593742" cy="2352761"/>
              </a:xfrm>
              <a:prstGeom prst="rect">
                <a:avLst/>
              </a:prstGeom>
            </p:spPr>
          </p:pic>
          <p:grpSp>
            <p:nvGrpSpPr>
              <p:cNvPr id="53" name="Group 52"/>
              <p:cNvGrpSpPr/>
              <p:nvPr/>
            </p:nvGrpSpPr>
            <p:grpSpPr>
              <a:xfrm>
                <a:off x="701381" y="3266259"/>
                <a:ext cx="411019" cy="2333993"/>
                <a:chOff x="1349041" y="3665329"/>
                <a:chExt cx="589241" cy="2921239"/>
              </a:xfrm>
            </p:grpSpPr>
            <p:grpSp>
              <p:nvGrpSpPr>
                <p:cNvPr id="65" name="Group 64"/>
                <p:cNvGrpSpPr/>
                <p:nvPr/>
              </p:nvGrpSpPr>
              <p:grpSpPr>
                <a:xfrm>
                  <a:off x="1478073" y="3665329"/>
                  <a:ext cx="460209" cy="2921239"/>
                  <a:chOff x="763688" y="3665329"/>
                  <a:chExt cx="460209" cy="2921239"/>
                </a:xfrm>
              </p:grpSpPr>
              <p:sp>
                <p:nvSpPr>
                  <p:cNvPr id="67" name="TextBox 66"/>
                  <p:cNvSpPr txBox="1"/>
                  <p:nvPr/>
                </p:nvSpPr>
                <p:spPr>
                  <a:xfrm>
                    <a:off x="763688" y="3665329"/>
                    <a:ext cx="453185" cy="308171"/>
                  </a:xfrm>
                  <a:prstGeom prst="rect">
                    <a:avLst/>
                  </a:prstGeom>
                  <a:noFill/>
                </p:spPr>
                <p:txBody>
                  <a:bodyPr wrap="none" rtlCol="0">
                    <a:spAutoFit/>
                  </a:bodyPr>
                  <a:lstStyle/>
                  <a:p>
                    <a:r>
                      <a:rPr lang="en-IE" sz="1000" dirty="0"/>
                      <a:t>15</a:t>
                    </a:r>
                  </a:p>
                </p:txBody>
              </p:sp>
              <p:sp>
                <p:nvSpPr>
                  <p:cNvPr id="72" name="TextBox 71"/>
                  <p:cNvSpPr txBox="1"/>
                  <p:nvPr/>
                </p:nvSpPr>
                <p:spPr>
                  <a:xfrm>
                    <a:off x="770717" y="4535980"/>
                    <a:ext cx="453180" cy="308171"/>
                  </a:xfrm>
                  <a:prstGeom prst="rect">
                    <a:avLst/>
                  </a:prstGeom>
                  <a:noFill/>
                </p:spPr>
                <p:txBody>
                  <a:bodyPr wrap="none" rtlCol="0">
                    <a:spAutoFit/>
                  </a:bodyPr>
                  <a:lstStyle/>
                  <a:p>
                    <a:r>
                      <a:rPr lang="en-IE" sz="1000" dirty="0"/>
                      <a:t>10</a:t>
                    </a:r>
                  </a:p>
                </p:txBody>
              </p:sp>
              <p:sp>
                <p:nvSpPr>
                  <p:cNvPr id="73" name="TextBox 72"/>
                  <p:cNvSpPr txBox="1"/>
                  <p:nvPr/>
                </p:nvSpPr>
                <p:spPr>
                  <a:xfrm>
                    <a:off x="854931" y="5403825"/>
                    <a:ext cx="358961" cy="308172"/>
                  </a:xfrm>
                  <a:prstGeom prst="rect">
                    <a:avLst/>
                  </a:prstGeom>
                  <a:noFill/>
                </p:spPr>
                <p:txBody>
                  <a:bodyPr wrap="none" rtlCol="0">
                    <a:spAutoFit/>
                  </a:bodyPr>
                  <a:lstStyle/>
                  <a:p>
                    <a:r>
                      <a:rPr lang="en-IE" sz="1000" dirty="0"/>
                      <a:t>5</a:t>
                    </a:r>
                  </a:p>
                </p:txBody>
              </p:sp>
              <p:sp>
                <p:nvSpPr>
                  <p:cNvPr id="75" name="TextBox 74"/>
                  <p:cNvSpPr txBox="1"/>
                  <p:nvPr/>
                </p:nvSpPr>
                <p:spPr>
                  <a:xfrm>
                    <a:off x="857124" y="6278396"/>
                    <a:ext cx="358962" cy="308172"/>
                  </a:xfrm>
                  <a:prstGeom prst="rect">
                    <a:avLst/>
                  </a:prstGeom>
                  <a:noFill/>
                </p:spPr>
                <p:txBody>
                  <a:bodyPr wrap="none" rtlCol="0">
                    <a:spAutoFit/>
                  </a:bodyPr>
                  <a:lstStyle/>
                  <a:p>
                    <a:r>
                      <a:rPr lang="en-IE" sz="1000" dirty="0"/>
                      <a:t>0</a:t>
                    </a:r>
                  </a:p>
                </p:txBody>
              </p:sp>
            </p:grpSp>
            <p:sp>
              <p:nvSpPr>
                <p:cNvPr id="66" name="TextBox 65"/>
                <p:cNvSpPr txBox="1"/>
                <p:nvPr/>
              </p:nvSpPr>
              <p:spPr>
                <a:xfrm rot="16200000">
                  <a:off x="688694" y="5077799"/>
                  <a:ext cx="1673678" cy="352983"/>
                </a:xfrm>
                <a:prstGeom prst="rect">
                  <a:avLst/>
                </a:prstGeom>
                <a:noFill/>
              </p:spPr>
              <p:txBody>
                <a:bodyPr wrap="none" rtlCol="0">
                  <a:spAutoFit/>
                </a:bodyPr>
                <a:lstStyle/>
                <a:p>
                  <a:r>
                    <a:rPr lang="en-IE" sz="1000" dirty="0"/>
                    <a:t>-Log10 (1- Probability)</a:t>
                  </a:r>
                </a:p>
              </p:txBody>
            </p:sp>
          </p:grpSp>
          <p:grpSp>
            <p:nvGrpSpPr>
              <p:cNvPr id="56" name="Group 55"/>
              <p:cNvGrpSpPr/>
              <p:nvPr/>
            </p:nvGrpSpPr>
            <p:grpSpPr>
              <a:xfrm>
                <a:off x="1014087" y="5554664"/>
                <a:ext cx="2539478" cy="415520"/>
                <a:chOff x="890709" y="3978090"/>
                <a:chExt cx="3640598" cy="520074"/>
              </a:xfrm>
            </p:grpSpPr>
            <p:sp>
              <p:nvSpPr>
                <p:cNvPr id="63" name="TextBox 62"/>
                <p:cNvSpPr txBox="1"/>
                <p:nvPr/>
              </p:nvSpPr>
              <p:spPr>
                <a:xfrm>
                  <a:off x="890709" y="3978090"/>
                  <a:ext cx="3640598" cy="308176"/>
                </a:xfrm>
                <a:prstGeom prst="rect">
                  <a:avLst/>
                </a:prstGeom>
                <a:noFill/>
              </p:spPr>
              <p:txBody>
                <a:bodyPr wrap="none" rtlCol="0">
                  <a:spAutoFit/>
                </a:bodyPr>
                <a:lstStyle/>
                <a:p>
                  <a:r>
                    <a:rPr lang="en-IE" sz="1000" dirty="0"/>
                    <a:t>  -10             -5                0                5               10</a:t>
                  </a:r>
                </a:p>
              </p:txBody>
            </p:sp>
            <p:sp>
              <p:nvSpPr>
                <p:cNvPr id="64" name="TextBox 63"/>
                <p:cNvSpPr txBox="1"/>
                <p:nvPr/>
              </p:nvSpPr>
              <p:spPr>
                <a:xfrm rot="10800000" flipV="1">
                  <a:off x="1892611" y="4189991"/>
                  <a:ext cx="1671155" cy="308173"/>
                </a:xfrm>
                <a:prstGeom prst="rect">
                  <a:avLst/>
                </a:prstGeom>
                <a:noFill/>
              </p:spPr>
              <p:txBody>
                <a:bodyPr wrap="none" rtlCol="0">
                  <a:spAutoFit/>
                </a:bodyPr>
                <a:lstStyle/>
                <a:p>
                  <a:r>
                    <a:rPr lang="en-IE" sz="1000" dirty="0"/>
                    <a:t>Log2 (Fold change)</a:t>
                  </a:r>
                </a:p>
              </p:txBody>
            </p:sp>
          </p:grpSp>
          <p:grpSp>
            <p:nvGrpSpPr>
              <p:cNvPr id="57" name="Group 56"/>
              <p:cNvGrpSpPr/>
              <p:nvPr/>
            </p:nvGrpSpPr>
            <p:grpSpPr>
              <a:xfrm>
                <a:off x="3080905" y="3401505"/>
                <a:ext cx="469477" cy="400110"/>
                <a:chOff x="6751479" y="172796"/>
                <a:chExt cx="469477" cy="400110"/>
              </a:xfrm>
            </p:grpSpPr>
            <p:sp>
              <p:nvSpPr>
                <p:cNvPr id="58" name="Oval 57"/>
                <p:cNvSpPr>
                  <a:spLocks noChangeAspect="1"/>
                </p:cNvSpPr>
                <p:nvPr/>
              </p:nvSpPr>
              <p:spPr>
                <a:xfrm flipH="1">
                  <a:off x="6751479" y="265133"/>
                  <a:ext cx="36000" cy="36000"/>
                </a:xfrm>
                <a:prstGeom prst="ellipse">
                  <a:avLst/>
                </a:prstGeom>
                <a:solidFill>
                  <a:srgbClr val="FF6600"/>
                </a:solidFill>
                <a:ln>
                  <a:solidFill>
                    <a:srgbClr val="FF66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sz="1000"/>
                </a:p>
              </p:txBody>
            </p:sp>
            <p:sp>
              <p:nvSpPr>
                <p:cNvPr id="59" name="Oval 58"/>
                <p:cNvSpPr>
                  <a:spLocks noChangeAspect="1"/>
                </p:cNvSpPr>
                <p:nvPr/>
              </p:nvSpPr>
              <p:spPr>
                <a:xfrm flipH="1">
                  <a:off x="6753859" y="448487"/>
                  <a:ext cx="36000" cy="36000"/>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sz="1000"/>
                </a:p>
              </p:txBody>
            </p:sp>
            <p:sp>
              <p:nvSpPr>
                <p:cNvPr id="60" name="TextBox 59"/>
                <p:cNvSpPr txBox="1"/>
                <p:nvPr/>
              </p:nvSpPr>
              <p:spPr>
                <a:xfrm>
                  <a:off x="6773398" y="172796"/>
                  <a:ext cx="447558" cy="400110"/>
                </a:xfrm>
                <a:prstGeom prst="rect">
                  <a:avLst/>
                </a:prstGeom>
                <a:noFill/>
              </p:spPr>
              <p:txBody>
                <a:bodyPr wrap="none" rtlCol="0">
                  <a:spAutoFit/>
                </a:bodyPr>
                <a:lstStyle/>
                <a:p>
                  <a:r>
                    <a:rPr lang="en-IE" sz="1000" dirty="0"/>
                    <a:t>True</a:t>
                  </a:r>
                </a:p>
                <a:p>
                  <a:r>
                    <a:rPr lang="en-IE" sz="1000" dirty="0"/>
                    <a:t>False</a:t>
                  </a:r>
                </a:p>
              </p:txBody>
            </p:sp>
          </p:grpSp>
          <p:grpSp>
            <p:nvGrpSpPr>
              <p:cNvPr id="93" name="Group 92"/>
              <p:cNvGrpSpPr/>
              <p:nvPr/>
            </p:nvGrpSpPr>
            <p:grpSpPr>
              <a:xfrm>
                <a:off x="796944" y="572746"/>
                <a:ext cx="288862" cy="2254880"/>
                <a:chOff x="901026" y="524481"/>
                <a:chExt cx="420735" cy="3629185"/>
              </a:xfrm>
            </p:grpSpPr>
            <p:sp>
              <p:nvSpPr>
                <p:cNvPr id="95" name="TextBox 94"/>
                <p:cNvSpPr txBox="1"/>
                <p:nvPr/>
              </p:nvSpPr>
              <p:spPr>
                <a:xfrm>
                  <a:off x="943900" y="524481"/>
                  <a:ext cx="364700" cy="396288"/>
                </a:xfrm>
                <a:prstGeom prst="rect">
                  <a:avLst/>
                </a:prstGeom>
                <a:noFill/>
              </p:spPr>
              <p:txBody>
                <a:bodyPr wrap="none" rtlCol="0">
                  <a:spAutoFit/>
                </a:bodyPr>
                <a:lstStyle/>
                <a:p>
                  <a:r>
                    <a:rPr lang="en-IE" sz="1000" dirty="0">
                      <a:solidFill>
                        <a:sysClr val="windowText" lastClr="000000"/>
                      </a:solidFill>
                    </a:rPr>
                    <a:t>4</a:t>
                  </a:r>
                </a:p>
              </p:txBody>
            </p:sp>
            <p:sp>
              <p:nvSpPr>
                <p:cNvPr id="96" name="TextBox 95"/>
                <p:cNvSpPr txBox="1"/>
                <p:nvPr/>
              </p:nvSpPr>
              <p:spPr>
                <a:xfrm>
                  <a:off x="943897" y="1595072"/>
                  <a:ext cx="364700" cy="396288"/>
                </a:xfrm>
                <a:prstGeom prst="rect">
                  <a:avLst/>
                </a:prstGeom>
                <a:noFill/>
              </p:spPr>
              <p:txBody>
                <a:bodyPr wrap="none" rtlCol="0">
                  <a:spAutoFit/>
                </a:bodyPr>
                <a:lstStyle/>
                <a:p>
                  <a:r>
                    <a:rPr lang="en-IE" sz="1000" dirty="0">
                      <a:solidFill>
                        <a:sysClr val="windowText" lastClr="000000"/>
                      </a:solidFill>
                    </a:rPr>
                    <a:t>2</a:t>
                  </a:r>
                </a:p>
              </p:txBody>
            </p:sp>
            <p:sp>
              <p:nvSpPr>
                <p:cNvPr id="97" name="TextBox 96"/>
                <p:cNvSpPr txBox="1"/>
                <p:nvPr/>
              </p:nvSpPr>
              <p:spPr>
                <a:xfrm>
                  <a:off x="943890" y="2691558"/>
                  <a:ext cx="364700" cy="396288"/>
                </a:xfrm>
                <a:prstGeom prst="rect">
                  <a:avLst/>
                </a:prstGeom>
                <a:noFill/>
              </p:spPr>
              <p:txBody>
                <a:bodyPr wrap="none" rtlCol="0">
                  <a:spAutoFit/>
                </a:bodyPr>
                <a:lstStyle/>
                <a:p>
                  <a:r>
                    <a:rPr lang="en-IE" sz="1000" dirty="0">
                      <a:solidFill>
                        <a:sysClr val="windowText" lastClr="000000"/>
                      </a:solidFill>
                    </a:rPr>
                    <a:t>0</a:t>
                  </a:r>
                </a:p>
              </p:txBody>
            </p:sp>
            <p:sp>
              <p:nvSpPr>
                <p:cNvPr id="98" name="TextBox 97"/>
                <p:cNvSpPr txBox="1"/>
                <p:nvPr/>
              </p:nvSpPr>
              <p:spPr>
                <a:xfrm>
                  <a:off x="901026" y="3757378"/>
                  <a:ext cx="420735" cy="396288"/>
                </a:xfrm>
                <a:prstGeom prst="rect">
                  <a:avLst/>
                </a:prstGeom>
                <a:noFill/>
              </p:spPr>
              <p:txBody>
                <a:bodyPr wrap="none" rtlCol="0">
                  <a:spAutoFit/>
                </a:bodyPr>
                <a:lstStyle/>
                <a:p>
                  <a:r>
                    <a:rPr lang="en-IE" sz="1000" dirty="0">
                      <a:solidFill>
                        <a:sysClr val="windowText" lastClr="000000"/>
                      </a:solidFill>
                    </a:rPr>
                    <a:t>-2</a:t>
                  </a:r>
                </a:p>
              </p:txBody>
            </p:sp>
          </p:grpSp>
          <p:sp>
            <p:nvSpPr>
              <p:cNvPr id="94" name="TextBox 93"/>
              <p:cNvSpPr txBox="1"/>
              <p:nvPr/>
            </p:nvSpPr>
            <p:spPr>
              <a:xfrm rot="16200000">
                <a:off x="-357208" y="1522561"/>
                <a:ext cx="2364750" cy="246221"/>
              </a:xfrm>
              <a:prstGeom prst="rect">
                <a:avLst/>
              </a:prstGeom>
              <a:noFill/>
            </p:spPr>
            <p:txBody>
              <a:bodyPr wrap="none" rtlCol="0">
                <a:spAutoFit/>
              </a:bodyPr>
              <a:lstStyle/>
              <a:p>
                <a:r>
                  <a:rPr lang="en-IE" sz="1000" dirty="0">
                    <a:solidFill>
                      <a:sysClr val="windowText" lastClr="000000"/>
                    </a:solidFill>
                  </a:rPr>
                  <a:t>Log10 (Gene Expression Level of miR-616)</a:t>
                </a:r>
              </a:p>
            </p:txBody>
          </p:sp>
          <p:sp>
            <p:nvSpPr>
              <p:cNvPr id="79" name="TextBox 78"/>
              <p:cNvSpPr txBox="1"/>
              <p:nvPr/>
            </p:nvSpPr>
            <p:spPr>
              <a:xfrm rot="10800000" flipV="1">
                <a:off x="1041155" y="2893835"/>
                <a:ext cx="2422458" cy="246221"/>
              </a:xfrm>
              <a:prstGeom prst="rect">
                <a:avLst/>
              </a:prstGeom>
              <a:noFill/>
            </p:spPr>
            <p:txBody>
              <a:bodyPr wrap="none" rtlCol="0">
                <a:spAutoFit/>
              </a:bodyPr>
              <a:lstStyle/>
              <a:p>
                <a:r>
                  <a:rPr lang="en-IE" sz="1000" dirty="0">
                    <a:solidFill>
                      <a:sysClr val="windowText" lastClr="000000"/>
                    </a:solidFill>
                  </a:rPr>
                  <a:t>Log10 (Gene Expression Level of miR-CTRL)</a:t>
                </a:r>
              </a:p>
            </p:txBody>
          </p:sp>
          <p:sp>
            <p:nvSpPr>
              <p:cNvPr id="88" name="TextBox 87"/>
              <p:cNvSpPr txBox="1"/>
              <p:nvPr/>
            </p:nvSpPr>
            <p:spPr>
              <a:xfrm>
                <a:off x="968981" y="2784011"/>
                <a:ext cx="2563522" cy="246221"/>
              </a:xfrm>
              <a:prstGeom prst="rect">
                <a:avLst/>
              </a:prstGeom>
              <a:noFill/>
            </p:spPr>
            <p:txBody>
              <a:bodyPr wrap="none" rtlCol="0">
                <a:spAutoFit/>
              </a:bodyPr>
              <a:lstStyle/>
              <a:p>
                <a:r>
                  <a:rPr lang="en-IE" sz="1000" dirty="0">
                    <a:solidFill>
                      <a:sysClr val="windowText" lastClr="000000"/>
                    </a:solidFill>
                  </a:rPr>
                  <a:t>-2                        0                        2                        4</a:t>
                </a:r>
              </a:p>
            </p:txBody>
          </p:sp>
          <p:pic>
            <p:nvPicPr>
              <p:cNvPr id="45" name="Picture 44"/>
              <p:cNvPicPr>
                <a:picLocks noChangeAspect="1"/>
              </p:cNvPicPr>
              <p:nvPr/>
            </p:nvPicPr>
            <p:blipFill rotWithShape="1">
              <a:blip r:embed="rId4" cstate="print">
                <a:extLst>
                  <a:ext uri="{28A0092B-C50C-407E-A947-70E740481C1C}">
                    <a14:useLocalDpi xmlns:a14="http://schemas.microsoft.com/office/drawing/2010/main" val="0"/>
                  </a:ext>
                </a:extLst>
              </a:blip>
              <a:srcRect l="6391" t="9270" b="5701"/>
              <a:stretch/>
            </p:blipFill>
            <p:spPr>
              <a:xfrm>
                <a:off x="988033" y="469554"/>
                <a:ext cx="2628543" cy="2387600"/>
              </a:xfrm>
              <a:prstGeom prst="rect">
                <a:avLst/>
              </a:prstGeom>
            </p:spPr>
          </p:pic>
          <p:sp>
            <p:nvSpPr>
              <p:cNvPr id="89" name="Isosceles Triangle 88"/>
              <p:cNvSpPr>
                <a:spLocks noChangeAspect="1"/>
              </p:cNvSpPr>
              <p:nvPr/>
            </p:nvSpPr>
            <p:spPr>
              <a:xfrm>
                <a:off x="2658127" y="2256769"/>
                <a:ext cx="41760" cy="36000"/>
              </a:xfrm>
              <a:prstGeom prst="triangle">
                <a:avLst/>
              </a:prstGeom>
              <a:solidFill>
                <a:srgbClr val="FFC000"/>
              </a:solidFill>
              <a:ln>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sz="1000"/>
              </a:p>
            </p:txBody>
          </p:sp>
          <p:sp>
            <p:nvSpPr>
              <p:cNvPr id="90" name="Oval 89"/>
              <p:cNvSpPr>
                <a:spLocks noChangeAspect="1"/>
              </p:cNvSpPr>
              <p:nvPr/>
            </p:nvSpPr>
            <p:spPr>
              <a:xfrm>
                <a:off x="2663887" y="2431363"/>
                <a:ext cx="36000" cy="36000"/>
              </a:xfrm>
              <a:prstGeom prst="ellipse">
                <a:avLst/>
              </a:prstGeom>
              <a:solidFill>
                <a:srgbClr val="996600"/>
              </a:solidFill>
              <a:ln>
                <a:solidFill>
                  <a:srgbClr val="9966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sz="1000">
                  <a:ln>
                    <a:solidFill>
                      <a:srgbClr val="996600"/>
                    </a:solidFill>
                  </a:ln>
                  <a:solidFill>
                    <a:srgbClr val="996600"/>
                  </a:solidFill>
                </a:endParaRPr>
              </a:p>
            </p:txBody>
          </p:sp>
          <p:sp>
            <p:nvSpPr>
              <p:cNvPr id="91" name="Diamond 90"/>
              <p:cNvSpPr>
                <a:spLocks noChangeAspect="1"/>
              </p:cNvSpPr>
              <p:nvPr/>
            </p:nvSpPr>
            <p:spPr>
              <a:xfrm>
                <a:off x="2658127" y="2577516"/>
                <a:ext cx="36000" cy="36000"/>
              </a:xfrm>
              <a:prstGeom prst="diamond">
                <a:avLst/>
              </a:prstGeom>
              <a:solidFill>
                <a:srgbClr val="3333FF"/>
              </a:solidFill>
              <a:ln>
                <a:solidFill>
                  <a:srgbClr val="3333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sz="1000"/>
              </a:p>
            </p:txBody>
          </p:sp>
          <p:sp>
            <p:nvSpPr>
              <p:cNvPr id="92" name="TextBox 91"/>
              <p:cNvSpPr txBox="1"/>
              <p:nvPr/>
            </p:nvSpPr>
            <p:spPr>
              <a:xfrm>
                <a:off x="2718331" y="2154264"/>
                <a:ext cx="792205" cy="553998"/>
              </a:xfrm>
              <a:prstGeom prst="rect">
                <a:avLst/>
              </a:prstGeom>
              <a:noFill/>
            </p:spPr>
            <p:txBody>
              <a:bodyPr wrap="none" rtlCol="0">
                <a:spAutoFit/>
              </a:bodyPr>
              <a:lstStyle/>
              <a:p>
                <a:r>
                  <a:rPr lang="en-IE" sz="1000" dirty="0"/>
                  <a:t>Up (610)</a:t>
                </a:r>
              </a:p>
              <a:p>
                <a:r>
                  <a:rPr lang="en-IE" sz="1000" dirty="0"/>
                  <a:t>No (21259)</a:t>
                </a:r>
              </a:p>
              <a:p>
                <a:r>
                  <a:rPr lang="en-IE" sz="1000" dirty="0"/>
                  <a:t>Down (276)</a:t>
                </a:r>
              </a:p>
            </p:txBody>
          </p:sp>
        </p:grpSp>
        <p:grpSp>
          <p:nvGrpSpPr>
            <p:cNvPr id="11" name="Group 10"/>
            <p:cNvGrpSpPr/>
            <p:nvPr/>
          </p:nvGrpSpPr>
          <p:grpSpPr>
            <a:xfrm>
              <a:off x="4822868" y="270816"/>
              <a:ext cx="5487046" cy="5508000"/>
              <a:chOff x="3781468" y="461316"/>
              <a:chExt cx="3664256" cy="3628084"/>
            </a:xfrm>
          </p:grpSpPr>
          <p:pic>
            <p:nvPicPr>
              <p:cNvPr id="104" name="Picture 103"/>
              <p:cNvPicPr>
                <a:picLocks noChangeAspect="1"/>
              </p:cNvPicPr>
              <p:nvPr/>
            </p:nvPicPr>
            <p:blipFill rotWithShape="1">
              <a:blip r:embed="rId5" cstate="print">
                <a:extLst>
                  <a:ext uri="{28A0092B-C50C-407E-A947-70E740481C1C}">
                    <a14:useLocalDpi xmlns:a14="http://schemas.microsoft.com/office/drawing/2010/main" val="0"/>
                  </a:ext>
                </a:extLst>
              </a:blip>
              <a:srcRect b="33981"/>
              <a:stretch/>
            </p:blipFill>
            <p:spPr>
              <a:xfrm>
                <a:off x="3781468" y="461316"/>
                <a:ext cx="3630168" cy="3628084"/>
              </a:xfrm>
              <a:prstGeom prst="rect">
                <a:avLst/>
              </a:prstGeom>
            </p:spPr>
          </p:pic>
          <p:sp>
            <p:nvSpPr>
              <p:cNvPr id="77" name="TextBox 76">
                <a:extLst>
                  <a:ext uri="{FF2B5EF4-FFF2-40B4-BE49-F238E27FC236}">
                    <a16:creationId xmlns:a16="http://schemas.microsoft.com/office/drawing/2014/main" id="{C9FD1D75-532F-4135-9F12-53085B6D224D}"/>
                  </a:ext>
                </a:extLst>
              </p:cNvPr>
              <p:cNvSpPr txBox="1"/>
              <p:nvPr/>
            </p:nvSpPr>
            <p:spPr>
              <a:xfrm>
                <a:off x="5209330" y="1381203"/>
                <a:ext cx="395968" cy="307777"/>
              </a:xfrm>
              <a:prstGeom prst="rect">
                <a:avLst/>
              </a:prstGeom>
              <a:noFill/>
            </p:spPr>
            <p:txBody>
              <a:bodyPr wrap="square" rtlCol="0">
                <a:spAutoFit/>
              </a:bodyPr>
              <a:lstStyle/>
              <a:p>
                <a:r>
                  <a:rPr lang="en-US" sz="1400" dirty="0"/>
                  <a:t> *</a:t>
                </a:r>
              </a:p>
            </p:txBody>
          </p:sp>
          <p:sp>
            <p:nvSpPr>
              <p:cNvPr id="81" name="TextBox 80">
                <a:extLst>
                  <a:ext uri="{FF2B5EF4-FFF2-40B4-BE49-F238E27FC236}">
                    <a16:creationId xmlns:a16="http://schemas.microsoft.com/office/drawing/2014/main" id="{D9350C6C-6138-4430-B581-534962285244}"/>
                  </a:ext>
                </a:extLst>
              </p:cNvPr>
              <p:cNvSpPr txBox="1"/>
              <p:nvPr/>
            </p:nvSpPr>
            <p:spPr>
              <a:xfrm>
                <a:off x="5796554" y="1288885"/>
                <a:ext cx="395968" cy="307777"/>
              </a:xfrm>
              <a:prstGeom prst="rect">
                <a:avLst/>
              </a:prstGeom>
              <a:noFill/>
            </p:spPr>
            <p:txBody>
              <a:bodyPr wrap="square" rtlCol="0">
                <a:spAutoFit/>
              </a:bodyPr>
              <a:lstStyle/>
              <a:p>
                <a:r>
                  <a:rPr lang="en-US" sz="1400" dirty="0"/>
                  <a:t>  *</a:t>
                </a:r>
              </a:p>
            </p:txBody>
          </p:sp>
          <p:sp>
            <p:nvSpPr>
              <p:cNvPr id="82" name="TextBox 81">
                <a:extLst>
                  <a:ext uri="{FF2B5EF4-FFF2-40B4-BE49-F238E27FC236}">
                    <a16:creationId xmlns:a16="http://schemas.microsoft.com/office/drawing/2014/main" id="{0ABBB151-47E1-4492-8F81-E9F425F30996}"/>
                  </a:ext>
                </a:extLst>
              </p:cNvPr>
              <p:cNvSpPr txBox="1"/>
              <p:nvPr/>
            </p:nvSpPr>
            <p:spPr>
              <a:xfrm>
                <a:off x="6420873" y="1558373"/>
                <a:ext cx="395968" cy="307777"/>
              </a:xfrm>
              <a:prstGeom prst="rect">
                <a:avLst/>
              </a:prstGeom>
              <a:noFill/>
            </p:spPr>
            <p:txBody>
              <a:bodyPr wrap="square" rtlCol="0">
                <a:spAutoFit/>
              </a:bodyPr>
              <a:lstStyle/>
              <a:p>
                <a:r>
                  <a:rPr lang="en-US" sz="1400" dirty="0"/>
                  <a:t>  *</a:t>
                </a:r>
              </a:p>
            </p:txBody>
          </p:sp>
          <p:sp>
            <p:nvSpPr>
              <p:cNvPr id="83" name="TextBox 82">
                <a:extLst>
                  <a:ext uri="{FF2B5EF4-FFF2-40B4-BE49-F238E27FC236}">
                    <a16:creationId xmlns:a16="http://schemas.microsoft.com/office/drawing/2014/main" id="{ABB60E33-6C10-494D-8933-ABB24025BC14}"/>
                  </a:ext>
                </a:extLst>
              </p:cNvPr>
              <p:cNvSpPr txBox="1"/>
              <p:nvPr/>
            </p:nvSpPr>
            <p:spPr>
              <a:xfrm>
                <a:off x="7041275" y="1550007"/>
                <a:ext cx="395968" cy="307777"/>
              </a:xfrm>
              <a:prstGeom prst="rect">
                <a:avLst/>
              </a:prstGeom>
              <a:noFill/>
            </p:spPr>
            <p:txBody>
              <a:bodyPr wrap="square" rtlCol="0">
                <a:spAutoFit/>
              </a:bodyPr>
              <a:lstStyle/>
              <a:p>
                <a:r>
                  <a:rPr lang="en-US" sz="1400" dirty="0"/>
                  <a:t>  *</a:t>
                </a:r>
              </a:p>
            </p:txBody>
          </p:sp>
          <p:sp>
            <p:nvSpPr>
              <p:cNvPr id="84" name="TextBox 83">
                <a:extLst>
                  <a:ext uri="{FF2B5EF4-FFF2-40B4-BE49-F238E27FC236}">
                    <a16:creationId xmlns:a16="http://schemas.microsoft.com/office/drawing/2014/main" id="{0B42E249-322F-4C56-A4FE-35EB24959592}"/>
                  </a:ext>
                </a:extLst>
              </p:cNvPr>
              <p:cNvSpPr txBox="1"/>
              <p:nvPr/>
            </p:nvSpPr>
            <p:spPr>
              <a:xfrm>
                <a:off x="5801974" y="3264967"/>
                <a:ext cx="395968" cy="307777"/>
              </a:xfrm>
              <a:prstGeom prst="rect">
                <a:avLst/>
              </a:prstGeom>
              <a:noFill/>
            </p:spPr>
            <p:txBody>
              <a:bodyPr wrap="square" rtlCol="0">
                <a:spAutoFit/>
              </a:bodyPr>
              <a:lstStyle/>
              <a:p>
                <a:r>
                  <a:rPr lang="en-US" sz="1400" dirty="0"/>
                  <a:t>  *</a:t>
                </a:r>
              </a:p>
            </p:txBody>
          </p:sp>
          <p:sp>
            <p:nvSpPr>
              <p:cNvPr id="85" name="TextBox 84">
                <a:extLst>
                  <a:ext uri="{FF2B5EF4-FFF2-40B4-BE49-F238E27FC236}">
                    <a16:creationId xmlns:a16="http://schemas.microsoft.com/office/drawing/2014/main" id="{C9E96413-79A2-45DB-BABE-B4E54AA3A3D0}"/>
                  </a:ext>
                </a:extLst>
              </p:cNvPr>
              <p:cNvSpPr txBox="1"/>
              <p:nvPr/>
            </p:nvSpPr>
            <p:spPr>
              <a:xfrm>
                <a:off x="6427282" y="3251644"/>
                <a:ext cx="395968" cy="307777"/>
              </a:xfrm>
              <a:prstGeom prst="rect">
                <a:avLst/>
              </a:prstGeom>
              <a:noFill/>
            </p:spPr>
            <p:txBody>
              <a:bodyPr wrap="square" rtlCol="0">
                <a:spAutoFit/>
              </a:bodyPr>
              <a:lstStyle/>
              <a:p>
                <a:r>
                  <a:rPr lang="en-US" sz="1400" dirty="0"/>
                  <a:t>  *</a:t>
                </a:r>
              </a:p>
            </p:txBody>
          </p:sp>
          <p:sp>
            <p:nvSpPr>
              <p:cNvPr id="86" name="TextBox 85">
                <a:extLst>
                  <a:ext uri="{FF2B5EF4-FFF2-40B4-BE49-F238E27FC236}">
                    <a16:creationId xmlns:a16="http://schemas.microsoft.com/office/drawing/2014/main" id="{910E7FED-2C44-40B4-BC1E-A6F7AA30D153}"/>
                  </a:ext>
                </a:extLst>
              </p:cNvPr>
              <p:cNvSpPr txBox="1"/>
              <p:nvPr/>
            </p:nvSpPr>
            <p:spPr>
              <a:xfrm>
                <a:off x="7049756" y="3248671"/>
                <a:ext cx="395968" cy="307777"/>
              </a:xfrm>
              <a:prstGeom prst="rect">
                <a:avLst/>
              </a:prstGeom>
              <a:noFill/>
            </p:spPr>
            <p:txBody>
              <a:bodyPr wrap="square" rtlCol="0">
                <a:spAutoFit/>
              </a:bodyPr>
              <a:lstStyle/>
              <a:p>
                <a:r>
                  <a:rPr lang="en-US" sz="1400" dirty="0"/>
                  <a:t>  *</a:t>
                </a:r>
              </a:p>
            </p:txBody>
          </p:sp>
        </p:grpSp>
      </p:grpSp>
      <p:sp>
        <p:nvSpPr>
          <p:cNvPr id="3" name="Rectangle 2"/>
          <p:cNvSpPr/>
          <p:nvPr/>
        </p:nvSpPr>
        <p:spPr>
          <a:xfrm>
            <a:off x="635000" y="5603250"/>
            <a:ext cx="11049000" cy="1200329"/>
          </a:xfrm>
          <a:prstGeom prst="rect">
            <a:avLst/>
          </a:prstGeom>
        </p:spPr>
        <p:txBody>
          <a:bodyPr wrap="square">
            <a:spAutoFit/>
          </a:bodyPr>
          <a:lstStyle/>
          <a:p>
            <a:pPr algn="just">
              <a:spcAft>
                <a:spcPts val="800"/>
              </a:spcAft>
            </a:pPr>
            <a:r>
              <a:rPr lang="en-IE" sz="1200" dirty="0">
                <a:effectLst/>
                <a:ea typeface="Calibri" panose="020F0502020204030204" pitchFamily="34" charset="0"/>
                <a:cs typeface="Arial" panose="020B0604020202020204" pitchFamily="34" charset="0"/>
              </a:rPr>
              <a:t>Supplementary </a:t>
            </a:r>
            <a:r>
              <a:rPr lang="en-IE" sz="1200" dirty="0" smtClean="0">
                <a:effectLst/>
                <a:ea typeface="Calibri" panose="020F0502020204030204" pitchFamily="34" charset="0"/>
                <a:cs typeface="Arial" panose="020B0604020202020204" pitchFamily="34" charset="0"/>
              </a:rPr>
              <a:t>figure 7</a:t>
            </a:r>
            <a:r>
              <a:rPr lang="en-US" sz="1200" dirty="0" smtClean="0">
                <a:ea typeface="Calibri" panose="020F0502020204030204" pitchFamily="34" charset="0"/>
                <a:cs typeface="Times New Roman" panose="02020603050405020304" pitchFamily="18" charset="0"/>
              </a:rPr>
              <a:t>. </a:t>
            </a:r>
            <a:r>
              <a:rPr lang="en-US" sz="1200" b="1" dirty="0">
                <a:ea typeface="Calibri" panose="020F0502020204030204" pitchFamily="34" charset="0"/>
                <a:cs typeface="Times New Roman" panose="02020603050405020304" pitchFamily="18" charset="0"/>
              </a:rPr>
              <a:t>miR-616 downregulates the expression of c-MYC.</a:t>
            </a:r>
            <a:r>
              <a:rPr lang="en-US" sz="1200" dirty="0">
                <a:ea typeface="Calibri" panose="020F0502020204030204" pitchFamily="34" charset="0"/>
                <a:cs typeface="Times New Roman" panose="02020603050405020304" pitchFamily="18" charset="0"/>
              </a:rPr>
              <a:t> (</a:t>
            </a:r>
            <a:r>
              <a:rPr lang="en-US" sz="1200" b="1" dirty="0">
                <a:ea typeface="Calibri" panose="020F0502020204030204" pitchFamily="34" charset="0"/>
                <a:cs typeface="Times New Roman" panose="02020603050405020304" pitchFamily="18" charset="0"/>
              </a:rPr>
              <a:t>A</a:t>
            </a:r>
            <a:r>
              <a:rPr lang="en-US" sz="1200" dirty="0">
                <a:ea typeface="Calibri" panose="020F0502020204030204" pitchFamily="34" charset="0"/>
                <a:cs typeface="Times New Roman" panose="02020603050405020304" pitchFamily="18" charset="0"/>
              </a:rPr>
              <a:t>) Scatter plot of expressed genes in control and miR-616 expressing MCF7 cells as determined by </a:t>
            </a:r>
            <a:r>
              <a:rPr lang="en-IE" sz="1200" dirty="0">
                <a:solidFill>
                  <a:srgbClr val="000000"/>
                </a:solidFill>
                <a:ea typeface="Calibri" panose="020F0502020204030204" pitchFamily="34" charset="0"/>
                <a:cs typeface="Times New Roman" panose="02020603050405020304" pitchFamily="18" charset="0"/>
              </a:rPr>
              <a:t>NOISeq method. X-axis and Y-axis present log2 value of gene expression in control and miR-616 expressing cells. </a:t>
            </a:r>
            <a:r>
              <a:rPr lang="en-US" sz="1200" dirty="0">
                <a:ea typeface="Calibri" panose="020F0502020204030204" pitchFamily="34" charset="0"/>
                <a:cs typeface="Times New Roman" panose="02020603050405020304" pitchFamily="18" charset="0"/>
              </a:rPr>
              <a:t>(</a:t>
            </a:r>
            <a:r>
              <a:rPr lang="en-US" sz="1200" b="1" dirty="0">
                <a:ea typeface="Calibri" panose="020F0502020204030204" pitchFamily="34" charset="0"/>
                <a:cs typeface="Times New Roman" panose="02020603050405020304" pitchFamily="18" charset="0"/>
              </a:rPr>
              <a:t>B</a:t>
            </a:r>
            <a:r>
              <a:rPr lang="en-US" sz="1200" dirty="0">
                <a:ea typeface="Calibri" panose="020F0502020204030204" pitchFamily="34" charset="0"/>
                <a:cs typeface="Times New Roman" panose="02020603050405020304" pitchFamily="18" charset="0"/>
              </a:rPr>
              <a:t>) Volcano plot of differential expressed genes in control and miR-616 expressing MCF7 cells. X-axis represents the fold change and Y-axis represents threshold value. Each dot is a differential expressed gene. Dots in red mean significant differential expressed genes which passed screening threshold and black dots are non-significant differential expressed genes. (</a:t>
            </a:r>
            <a:r>
              <a:rPr lang="en-US" sz="1200" b="1" dirty="0">
                <a:ea typeface="Calibri" panose="020F0502020204030204" pitchFamily="34" charset="0"/>
                <a:cs typeface="Times New Roman" panose="02020603050405020304" pitchFamily="18" charset="0"/>
              </a:rPr>
              <a:t>C-D</a:t>
            </a:r>
            <a:r>
              <a:rPr lang="en-US" sz="1200" dirty="0">
                <a:ea typeface="Calibri" panose="020F0502020204030204" pitchFamily="34" charset="0"/>
                <a:cs typeface="Times New Roman" panose="02020603050405020304" pitchFamily="18" charset="0"/>
              </a:rPr>
              <a:t>) The expression level of indicated miR-616 regulated genes was quantified by RT-qPCR assay in control and miR-616 expressing sub-clones of (C) MCF7 and (D) HCT116 cells. Error bars represent mean </a:t>
            </a:r>
            <a:r>
              <a:rPr lang="en-GB" sz="1200" dirty="0">
                <a:solidFill>
                  <a:srgbClr val="000000"/>
                </a:solidFill>
                <a:ea typeface="SymbolMT"/>
                <a:cs typeface="Times New Roman" panose="02020603050405020304" pitchFamily="18" charset="0"/>
              </a:rPr>
              <a:t>±</a:t>
            </a:r>
            <a:r>
              <a:rPr lang="en-US" sz="1200" dirty="0">
                <a:ea typeface="Calibri" panose="020F0502020204030204" pitchFamily="34" charset="0"/>
                <a:cs typeface="Times New Roman" panose="02020603050405020304" pitchFamily="18" charset="0"/>
              </a:rPr>
              <a:t>S.D. from two independent experiments performed in triplicate. *P </a:t>
            </a:r>
            <a:r>
              <a:rPr lang="en-US" sz="1200" dirty="0">
                <a:ea typeface="EuclidSymbol"/>
                <a:cs typeface="Times New Roman" panose="02020603050405020304" pitchFamily="18" charset="0"/>
              </a:rPr>
              <a:t>&lt; </a:t>
            </a:r>
            <a:r>
              <a:rPr lang="en-US" sz="1200" dirty="0">
                <a:ea typeface="Calibri" panose="020F0502020204030204" pitchFamily="34" charset="0"/>
                <a:cs typeface="Times New Roman" panose="02020603050405020304" pitchFamily="18" charset="0"/>
              </a:rPr>
              <a:t>0.05, two-tailed unpaired t-test as compared to control.</a:t>
            </a:r>
            <a:endParaRPr lang="en-IE" sz="1200" dirty="0">
              <a:ea typeface="Calibri" panose="020F0502020204030204" pitchFamily="34" charset="0"/>
              <a:cs typeface="Times New Roman" panose="02020603050405020304" pitchFamily="18" charset="0"/>
            </a:endParaRPr>
          </a:p>
        </p:txBody>
      </p:sp>
      <p:sp>
        <p:nvSpPr>
          <p:cNvPr id="4" name="TextBox 3"/>
          <p:cNvSpPr txBox="1"/>
          <p:nvPr/>
        </p:nvSpPr>
        <p:spPr>
          <a:xfrm>
            <a:off x="1536700" y="0"/>
            <a:ext cx="3687228" cy="3139321"/>
          </a:xfrm>
          <a:prstGeom prst="rect">
            <a:avLst/>
          </a:prstGeom>
          <a:noFill/>
        </p:spPr>
        <p:txBody>
          <a:bodyPr wrap="none" rtlCol="0">
            <a:spAutoFit/>
          </a:bodyPr>
          <a:lstStyle/>
          <a:p>
            <a:r>
              <a:rPr lang="en-IE" b="1" dirty="0"/>
              <a:t>A                                                            C</a:t>
            </a:r>
          </a:p>
          <a:p>
            <a:endParaRPr lang="en-IE" b="1" dirty="0"/>
          </a:p>
          <a:p>
            <a:endParaRPr lang="en-IE" b="1" dirty="0"/>
          </a:p>
          <a:p>
            <a:endParaRPr lang="en-IE" b="1" dirty="0"/>
          </a:p>
          <a:p>
            <a:endParaRPr lang="en-IE" b="1" dirty="0"/>
          </a:p>
          <a:p>
            <a:endParaRPr lang="en-IE" b="1" dirty="0"/>
          </a:p>
          <a:p>
            <a:endParaRPr lang="en-IE" b="1" dirty="0"/>
          </a:p>
          <a:p>
            <a:endParaRPr lang="en-IE" b="1" dirty="0"/>
          </a:p>
          <a:p>
            <a:endParaRPr lang="en-IE" b="1" dirty="0"/>
          </a:p>
          <a:p>
            <a:endParaRPr lang="en-IE" b="1" dirty="0"/>
          </a:p>
          <a:p>
            <a:r>
              <a:rPr lang="en-IE" b="1" dirty="0"/>
              <a:t>B                                                             D</a:t>
            </a:r>
          </a:p>
        </p:txBody>
      </p:sp>
    </p:spTree>
    <p:extLst>
      <p:ext uri="{BB962C8B-B14F-4D97-AF65-F5344CB8AC3E}">
        <p14:creationId xmlns:p14="http://schemas.microsoft.com/office/powerpoint/2010/main" val="3550739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Group 10"/>
          <p:cNvGrpSpPr/>
          <p:nvPr/>
        </p:nvGrpSpPr>
        <p:grpSpPr>
          <a:xfrm>
            <a:off x="2326411" y="277908"/>
            <a:ext cx="6950557" cy="3877433"/>
            <a:chOff x="4012336" y="714699"/>
            <a:chExt cx="6950557" cy="3877433"/>
          </a:xfrm>
        </p:grpSpPr>
        <p:grpSp>
          <p:nvGrpSpPr>
            <p:cNvPr id="5" name="Group 4"/>
            <p:cNvGrpSpPr/>
            <p:nvPr/>
          </p:nvGrpSpPr>
          <p:grpSpPr>
            <a:xfrm>
              <a:off x="6585137" y="714699"/>
              <a:ext cx="2425292" cy="1344927"/>
              <a:chOff x="898712" y="1829124"/>
              <a:chExt cx="2425292" cy="1344927"/>
            </a:xfrm>
          </p:grpSpPr>
          <p:sp>
            <p:nvSpPr>
              <p:cNvPr id="53" name="TextBox 52">
                <a:extLst>
                  <a:ext uri="{FF2B5EF4-FFF2-40B4-BE49-F238E27FC236}">
                    <a16:creationId xmlns:a16="http://schemas.microsoft.com/office/drawing/2014/main" id="{ED97230D-B880-4D81-877D-DBFC2F4CD67E}"/>
                  </a:ext>
                </a:extLst>
              </p:cNvPr>
              <p:cNvSpPr txBox="1"/>
              <p:nvPr/>
            </p:nvSpPr>
            <p:spPr>
              <a:xfrm>
                <a:off x="898712" y="1829124"/>
                <a:ext cx="2222083" cy="230832"/>
              </a:xfrm>
              <a:prstGeom prst="rect">
                <a:avLst/>
              </a:prstGeom>
              <a:noFill/>
            </p:spPr>
            <p:txBody>
              <a:bodyPr wrap="none" rtlCol="0">
                <a:spAutoFit/>
              </a:bodyPr>
              <a:lstStyle/>
              <a:p>
                <a:r>
                  <a:rPr lang="en-US" sz="900" b="1" dirty="0"/>
                  <a:t> HCT116-miR-CTRL              HCT116-miR-616</a:t>
                </a:r>
              </a:p>
            </p:txBody>
          </p:sp>
          <p:pic>
            <p:nvPicPr>
              <p:cNvPr id="48" name="Picture 47">
                <a:extLst>
                  <a:ext uri="{FF2B5EF4-FFF2-40B4-BE49-F238E27FC236}">
                    <a16:creationId xmlns:a16="http://schemas.microsoft.com/office/drawing/2014/main" id="{0AC69B15-AF8C-47D5-9EA3-F7522F0A1EB9}"/>
                  </a:ext>
                </a:extLst>
              </p:cNvPr>
              <p:cNvPicPr preferRelativeResize="0">
                <a:picLocks noChangeAspect="1"/>
              </p:cNvPicPr>
              <p:nvPr/>
            </p:nvPicPr>
            <p:blipFill rotWithShape="1">
              <a:blip r:embed="rId2">
                <a:extLst>
                  <a:ext uri="{28A0092B-C50C-407E-A947-70E740481C1C}">
                    <a14:useLocalDpi xmlns:a14="http://schemas.microsoft.com/office/drawing/2010/main" val="0"/>
                  </a:ext>
                </a:extLst>
              </a:blip>
              <a:srcRect l="5233" t="48891" r="5505" b="9377"/>
              <a:stretch/>
            </p:blipFill>
            <p:spPr>
              <a:xfrm>
                <a:off x="912004" y="2031529"/>
                <a:ext cx="2412000" cy="1142522"/>
              </a:xfrm>
              <a:prstGeom prst="rect">
                <a:avLst/>
              </a:prstGeom>
            </p:spPr>
          </p:pic>
        </p:grpSp>
        <p:graphicFrame>
          <p:nvGraphicFramePr>
            <p:cNvPr id="85" name="Chart 84">
              <a:extLst>
                <a:ext uri="{FF2B5EF4-FFF2-40B4-BE49-F238E27FC236}">
                  <a16:creationId xmlns:a16="http://schemas.microsoft.com/office/drawing/2014/main" id="{08A1B504-B5CE-4D38-AB41-8951484DE835}"/>
                </a:ext>
              </a:extLst>
            </p:cNvPr>
            <p:cNvGraphicFramePr>
              <a:graphicFrameLocks/>
            </p:cNvGraphicFramePr>
            <p:nvPr>
              <p:extLst>
                <p:ext uri="{D42A27DB-BD31-4B8C-83A1-F6EECF244321}">
                  <p14:modId xmlns:p14="http://schemas.microsoft.com/office/powerpoint/2010/main" val="1572094652"/>
                </p:ext>
              </p:extLst>
            </p:nvPr>
          </p:nvGraphicFramePr>
          <p:xfrm>
            <a:off x="4012336" y="793398"/>
            <a:ext cx="2556000" cy="1512000"/>
          </p:xfrm>
          <a:graphic>
            <a:graphicData uri="http://schemas.openxmlformats.org/drawingml/2006/chart">
              <c:chart xmlns:c="http://schemas.openxmlformats.org/drawingml/2006/chart" xmlns:r="http://schemas.openxmlformats.org/officeDocument/2006/relationships" r:id="rId3"/>
            </a:graphicData>
          </a:graphic>
        </p:graphicFrame>
        <p:grpSp>
          <p:nvGrpSpPr>
            <p:cNvPr id="68" name="Group 67">
              <a:extLst>
                <a:ext uri="{FF2B5EF4-FFF2-40B4-BE49-F238E27FC236}">
                  <a16:creationId xmlns:a16="http://schemas.microsoft.com/office/drawing/2014/main" id="{3AD8C17E-A3CE-4B6D-A471-8B4C65086351}"/>
                </a:ext>
              </a:extLst>
            </p:cNvPr>
            <p:cNvGrpSpPr/>
            <p:nvPr/>
          </p:nvGrpSpPr>
          <p:grpSpPr>
            <a:xfrm>
              <a:off x="4148870" y="2377285"/>
              <a:ext cx="3691518" cy="2189239"/>
              <a:chOff x="5906039" y="692121"/>
              <a:chExt cx="3691518" cy="2189239"/>
            </a:xfrm>
          </p:grpSpPr>
          <p:sp>
            <p:nvSpPr>
              <p:cNvPr id="70" name="TextBox 69">
                <a:extLst>
                  <a:ext uri="{FF2B5EF4-FFF2-40B4-BE49-F238E27FC236}">
                    <a16:creationId xmlns:a16="http://schemas.microsoft.com/office/drawing/2014/main" id="{137F30EC-2926-4E73-B76D-B2E1EECDE9E0}"/>
                  </a:ext>
                </a:extLst>
              </p:cNvPr>
              <p:cNvSpPr txBox="1"/>
              <p:nvPr/>
            </p:nvSpPr>
            <p:spPr bwMode="auto">
              <a:xfrm>
                <a:off x="6544002" y="692121"/>
                <a:ext cx="2940527" cy="276999"/>
              </a:xfrm>
              <a:prstGeom prst="rect">
                <a:avLst/>
              </a:prstGeom>
              <a:noFill/>
            </p:spPr>
            <p:txBody>
              <a:bodyPr wrap="square">
                <a:spAutoFit/>
              </a:bodyPr>
              <a:lstStyle/>
              <a:p>
                <a:pPr algn="just" eaLnBrk="1" fontAlgn="auto" hangingPunct="1">
                  <a:spcBef>
                    <a:spcPts val="0"/>
                  </a:spcBef>
                  <a:spcAft>
                    <a:spcPts val="0"/>
                  </a:spcAft>
                  <a:defRPr/>
                </a:pPr>
                <a:r>
                  <a:rPr lang="en-US" sz="1200" b="1" dirty="0">
                    <a:solidFill>
                      <a:prstClr val="black"/>
                    </a:solidFill>
                    <a:ea typeface="+mn-ea"/>
                  </a:rPr>
                  <a:t>    0h                       12h                         24h</a:t>
                </a:r>
              </a:p>
            </p:txBody>
          </p:sp>
          <p:pic>
            <p:nvPicPr>
              <p:cNvPr id="74" name="Picture 73">
                <a:extLst>
                  <a:ext uri="{FF2B5EF4-FFF2-40B4-BE49-F238E27FC236}">
                    <a16:creationId xmlns:a16="http://schemas.microsoft.com/office/drawing/2014/main" id="{AC54A061-DAC1-4696-A2D7-7EB07A2E5FBE}"/>
                  </a:ext>
                </a:extLst>
              </p:cNvPr>
              <p:cNvPicPr preferRelativeResize="0">
                <a:picLocks/>
              </p:cNvPicPr>
              <p:nvPr/>
            </p:nvPicPr>
            <p:blipFill>
              <a:blip r:embed="rId4" cstate="print">
                <a:extLst>
                  <a:ext uri="{BEBA8EAE-BF5A-486C-A8C5-ECC9F3942E4B}">
                    <a14:imgProps xmlns:a14="http://schemas.microsoft.com/office/drawing/2010/main">
                      <a14:imgLayer r:embed="rId5">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a:off x="8510311" y="898692"/>
                <a:ext cx="1080000" cy="972000"/>
              </a:xfrm>
              <a:prstGeom prst="rect">
                <a:avLst/>
              </a:prstGeom>
            </p:spPr>
          </p:pic>
          <p:grpSp>
            <p:nvGrpSpPr>
              <p:cNvPr id="78" name="Group 77">
                <a:extLst>
                  <a:ext uri="{FF2B5EF4-FFF2-40B4-BE49-F238E27FC236}">
                    <a16:creationId xmlns:a16="http://schemas.microsoft.com/office/drawing/2014/main" id="{20B81AC5-1C4B-48B4-9DF7-8B586AD5C553}"/>
                  </a:ext>
                </a:extLst>
              </p:cNvPr>
              <p:cNvGrpSpPr/>
              <p:nvPr/>
            </p:nvGrpSpPr>
            <p:grpSpPr>
              <a:xfrm>
                <a:off x="6265015" y="909165"/>
                <a:ext cx="1080000" cy="972000"/>
                <a:chOff x="6589151" y="726741"/>
                <a:chExt cx="1436116" cy="1105172"/>
              </a:xfrm>
            </p:grpSpPr>
            <p:pic>
              <p:nvPicPr>
                <p:cNvPr id="108" name="Picture 107">
                  <a:extLst>
                    <a:ext uri="{FF2B5EF4-FFF2-40B4-BE49-F238E27FC236}">
                      <a16:creationId xmlns:a16="http://schemas.microsoft.com/office/drawing/2014/main" id="{46E8A8A9-5A77-4981-B103-D8997E781011}"/>
                    </a:ext>
                  </a:extLst>
                </p:cNvPr>
                <p:cNvPicPr>
                  <a:picLocks noChangeAspect="1"/>
                </p:cNvPicPr>
                <p:nvPr/>
              </p:nvPicPr>
              <p:blipFill>
                <a:blip r:embed="rId6" cstate="print">
                  <a:extLst>
                    <a:ext uri="{BEBA8EAE-BF5A-486C-A8C5-ECC9F3942E4B}">
                      <a14:imgProps xmlns:a14="http://schemas.microsoft.com/office/drawing/2010/main">
                        <a14:imgLayer r:embed="rId7">
                          <a14:imgEffect>
                            <a14:brightnessContrast bright="40000" contrast="20000"/>
                          </a14:imgEffect>
                        </a14:imgLayer>
                      </a14:imgProps>
                    </a:ext>
                    <a:ext uri="{28A0092B-C50C-407E-A947-70E740481C1C}">
                      <a14:useLocalDpi xmlns:a14="http://schemas.microsoft.com/office/drawing/2010/main" val="0"/>
                    </a:ext>
                  </a:extLst>
                </a:blip>
                <a:stretch>
                  <a:fillRect/>
                </a:stretch>
              </p:blipFill>
              <p:spPr>
                <a:xfrm>
                  <a:off x="6589151" y="726741"/>
                  <a:ext cx="1436116" cy="1077087"/>
                </a:xfrm>
                <a:prstGeom prst="rect">
                  <a:avLst/>
                </a:prstGeom>
              </p:spPr>
            </p:pic>
            <p:sp>
              <p:nvSpPr>
                <p:cNvPr id="109" name="Freeform: Shape 87">
                  <a:extLst>
                    <a:ext uri="{FF2B5EF4-FFF2-40B4-BE49-F238E27FC236}">
                      <a16:creationId xmlns:a16="http://schemas.microsoft.com/office/drawing/2014/main" id="{C627F048-A14C-4BFA-BAEF-140608F0EFC8}"/>
                    </a:ext>
                  </a:extLst>
                </p:cNvPr>
                <p:cNvSpPr/>
                <p:nvPr/>
              </p:nvSpPr>
              <p:spPr>
                <a:xfrm>
                  <a:off x="7192433" y="728133"/>
                  <a:ext cx="475502" cy="1103780"/>
                </a:xfrm>
                <a:custGeom>
                  <a:avLst/>
                  <a:gdLst>
                    <a:gd name="connsiteX0" fmla="*/ 114300 w 475502"/>
                    <a:gd name="connsiteY0" fmla="*/ 4234 h 1103780"/>
                    <a:gd name="connsiteX1" fmla="*/ 105834 w 475502"/>
                    <a:gd name="connsiteY1" fmla="*/ 38100 h 1103780"/>
                    <a:gd name="connsiteX2" fmla="*/ 93134 w 475502"/>
                    <a:gd name="connsiteY2" fmla="*/ 50800 h 1103780"/>
                    <a:gd name="connsiteX3" fmla="*/ 84667 w 475502"/>
                    <a:gd name="connsiteY3" fmla="*/ 63500 h 1103780"/>
                    <a:gd name="connsiteX4" fmla="*/ 80434 w 475502"/>
                    <a:gd name="connsiteY4" fmla="*/ 76200 h 1103780"/>
                    <a:gd name="connsiteX5" fmla="*/ 71967 w 475502"/>
                    <a:gd name="connsiteY5" fmla="*/ 88900 h 1103780"/>
                    <a:gd name="connsiteX6" fmla="*/ 59267 w 475502"/>
                    <a:gd name="connsiteY6" fmla="*/ 190500 h 1103780"/>
                    <a:gd name="connsiteX7" fmla="*/ 63500 w 475502"/>
                    <a:gd name="connsiteY7" fmla="*/ 203200 h 1103780"/>
                    <a:gd name="connsiteX8" fmla="*/ 88900 w 475502"/>
                    <a:gd name="connsiteY8" fmla="*/ 215900 h 1103780"/>
                    <a:gd name="connsiteX9" fmla="*/ 93134 w 475502"/>
                    <a:gd name="connsiteY9" fmla="*/ 245534 h 1103780"/>
                    <a:gd name="connsiteX10" fmla="*/ 97367 w 475502"/>
                    <a:gd name="connsiteY10" fmla="*/ 266700 h 1103780"/>
                    <a:gd name="connsiteX11" fmla="*/ 93134 w 475502"/>
                    <a:gd name="connsiteY11" fmla="*/ 292100 h 1103780"/>
                    <a:gd name="connsiteX12" fmla="*/ 71967 w 475502"/>
                    <a:gd name="connsiteY12" fmla="*/ 296334 h 1103780"/>
                    <a:gd name="connsiteX13" fmla="*/ 67734 w 475502"/>
                    <a:gd name="connsiteY13" fmla="*/ 359834 h 1103780"/>
                    <a:gd name="connsiteX14" fmla="*/ 59267 w 475502"/>
                    <a:gd name="connsiteY14" fmla="*/ 372534 h 1103780"/>
                    <a:gd name="connsiteX15" fmla="*/ 71967 w 475502"/>
                    <a:gd name="connsiteY15" fmla="*/ 427567 h 1103780"/>
                    <a:gd name="connsiteX16" fmla="*/ 76200 w 475502"/>
                    <a:gd name="connsiteY16" fmla="*/ 448734 h 1103780"/>
                    <a:gd name="connsiteX17" fmla="*/ 67734 w 475502"/>
                    <a:gd name="connsiteY17" fmla="*/ 491067 h 1103780"/>
                    <a:gd name="connsiteX18" fmla="*/ 59267 w 475502"/>
                    <a:gd name="connsiteY18" fmla="*/ 503767 h 1103780"/>
                    <a:gd name="connsiteX19" fmla="*/ 55034 w 475502"/>
                    <a:gd name="connsiteY19" fmla="*/ 516467 h 1103780"/>
                    <a:gd name="connsiteX20" fmla="*/ 46567 w 475502"/>
                    <a:gd name="connsiteY20" fmla="*/ 588434 h 1103780"/>
                    <a:gd name="connsiteX21" fmla="*/ 42334 w 475502"/>
                    <a:gd name="connsiteY21" fmla="*/ 622300 h 1103780"/>
                    <a:gd name="connsiteX22" fmla="*/ 29634 w 475502"/>
                    <a:gd name="connsiteY22" fmla="*/ 626534 h 1103780"/>
                    <a:gd name="connsiteX23" fmla="*/ 16934 w 475502"/>
                    <a:gd name="connsiteY23" fmla="*/ 639234 h 1103780"/>
                    <a:gd name="connsiteX24" fmla="*/ 12700 w 475502"/>
                    <a:gd name="connsiteY24" fmla="*/ 651934 h 1103780"/>
                    <a:gd name="connsiteX25" fmla="*/ 33867 w 475502"/>
                    <a:gd name="connsiteY25" fmla="*/ 685800 h 1103780"/>
                    <a:gd name="connsiteX26" fmla="*/ 33867 w 475502"/>
                    <a:gd name="connsiteY26" fmla="*/ 770467 h 1103780"/>
                    <a:gd name="connsiteX27" fmla="*/ 25400 w 475502"/>
                    <a:gd name="connsiteY27" fmla="*/ 783167 h 1103780"/>
                    <a:gd name="connsiteX28" fmla="*/ 21167 w 475502"/>
                    <a:gd name="connsiteY28" fmla="*/ 795867 h 1103780"/>
                    <a:gd name="connsiteX29" fmla="*/ 29634 w 475502"/>
                    <a:gd name="connsiteY29" fmla="*/ 910167 h 1103780"/>
                    <a:gd name="connsiteX30" fmla="*/ 25400 w 475502"/>
                    <a:gd name="connsiteY30" fmla="*/ 927100 h 1103780"/>
                    <a:gd name="connsiteX31" fmla="*/ 16934 w 475502"/>
                    <a:gd name="connsiteY31" fmla="*/ 939800 h 1103780"/>
                    <a:gd name="connsiteX32" fmla="*/ 12700 w 475502"/>
                    <a:gd name="connsiteY32" fmla="*/ 965200 h 1103780"/>
                    <a:gd name="connsiteX33" fmla="*/ 4234 w 475502"/>
                    <a:gd name="connsiteY33" fmla="*/ 994834 h 1103780"/>
                    <a:gd name="connsiteX34" fmla="*/ 0 w 475502"/>
                    <a:gd name="connsiteY34" fmla="*/ 1028700 h 1103780"/>
                    <a:gd name="connsiteX35" fmla="*/ 186267 w 475502"/>
                    <a:gd name="connsiteY35" fmla="*/ 1092200 h 1103780"/>
                    <a:gd name="connsiteX36" fmla="*/ 317500 w 475502"/>
                    <a:gd name="connsiteY36" fmla="*/ 1092200 h 1103780"/>
                    <a:gd name="connsiteX37" fmla="*/ 381000 w 475502"/>
                    <a:gd name="connsiteY37" fmla="*/ 1087967 h 1103780"/>
                    <a:gd name="connsiteX38" fmla="*/ 393700 w 475502"/>
                    <a:gd name="connsiteY38" fmla="*/ 1083734 h 1103780"/>
                    <a:gd name="connsiteX39" fmla="*/ 389467 w 475502"/>
                    <a:gd name="connsiteY39" fmla="*/ 1071034 h 1103780"/>
                    <a:gd name="connsiteX40" fmla="*/ 368300 w 475502"/>
                    <a:gd name="connsiteY40" fmla="*/ 1032934 h 1103780"/>
                    <a:gd name="connsiteX41" fmla="*/ 372534 w 475502"/>
                    <a:gd name="connsiteY41" fmla="*/ 1016000 h 1103780"/>
                    <a:gd name="connsiteX42" fmla="*/ 393700 w 475502"/>
                    <a:gd name="connsiteY42" fmla="*/ 994834 h 1103780"/>
                    <a:gd name="connsiteX43" fmla="*/ 419100 w 475502"/>
                    <a:gd name="connsiteY43" fmla="*/ 986367 h 1103780"/>
                    <a:gd name="connsiteX44" fmla="*/ 427567 w 475502"/>
                    <a:gd name="connsiteY44" fmla="*/ 973667 h 1103780"/>
                    <a:gd name="connsiteX45" fmla="*/ 436034 w 475502"/>
                    <a:gd name="connsiteY45" fmla="*/ 948267 h 1103780"/>
                    <a:gd name="connsiteX46" fmla="*/ 431800 w 475502"/>
                    <a:gd name="connsiteY46" fmla="*/ 935567 h 1103780"/>
                    <a:gd name="connsiteX47" fmla="*/ 419100 w 475502"/>
                    <a:gd name="connsiteY47" fmla="*/ 931334 h 1103780"/>
                    <a:gd name="connsiteX48" fmla="*/ 402167 w 475502"/>
                    <a:gd name="connsiteY48" fmla="*/ 918634 h 1103780"/>
                    <a:gd name="connsiteX49" fmla="*/ 376767 w 475502"/>
                    <a:gd name="connsiteY49" fmla="*/ 897467 h 1103780"/>
                    <a:gd name="connsiteX50" fmla="*/ 368300 w 475502"/>
                    <a:gd name="connsiteY50" fmla="*/ 872067 h 1103780"/>
                    <a:gd name="connsiteX51" fmla="*/ 376767 w 475502"/>
                    <a:gd name="connsiteY51" fmla="*/ 800100 h 1103780"/>
                    <a:gd name="connsiteX52" fmla="*/ 381000 w 475502"/>
                    <a:gd name="connsiteY52" fmla="*/ 787400 h 1103780"/>
                    <a:gd name="connsiteX53" fmla="*/ 389467 w 475502"/>
                    <a:gd name="connsiteY53" fmla="*/ 732367 h 1103780"/>
                    <a:gd name="connsiteX54" fmla="*/ 397934 w 475502"/>
                    <a:gd name="connsiteY54" fmla="*/ 719667 h 1103780"/>
                    <a:gd name="connsiteX55" fmla="*/ 406400 w 475502"/>
                    <a:gd name="connsiteY55" fmla="*/ 694267 h 1103780"/>
                    <a:gd name="connsiteX56" fmla="*/ 410634 w 475502"/>
                    <a:gd name="connsiteY56" fmla="*/ 596900 h 1103780"/>
                    <a:gd name="connsiteX57" fmla="*/ 414867 w 475502"/>
                    <a:gd name="connsiteY57" fmla="*/ 584200 h 1103780"/>
                    <a:gd name="connsiteX58" fmla="*/ 427567 w 475502"/>
                    <a:gd name="connsiteY58" fmla="*/ 575734 h 1103780"/>
                    <a:gd name="connsiteX59" fmla="*/ 427567 w 475502"/>
                    <a:gd name="connsiteY59" fmla="*/ 516467 h 1103780"/>
                    <a:gd name="connsiteX60" fmla="*/ 431800 w 475502"/>
                    <a:gd name="connsiteY60" fmla="*/ 452967 h 1103780"/>
                    <a:gd name="connsiteX61" fmla="*/ 448734 w 475502"/>
                    <a:gd name="connsiteY61" fmla="*/ 427567 h 1103780"/>
                    <a:gd name="connsiteX62" fmla="*/ 440267 w 475502"/>
                    <a:gd name="connsiteY62" fmla="*/ 381000 h 1103780"/>
                    <a:gd name="connsiteX63" fmla="*/ 436034 w 475502"/>
                    <a:gd name="connsiteY63" fmla="*/ 359834 h 1103780"/>
                    <a:gd name="connsiteX64" fmla="*/ 423334 w 475502"/>
                    <a:gd name="connsiteY64" fmla="*/ 351367 h 1103780"/>
                    <a:gd name="connsiteX65" fmla="*/ 427567 w 475502"/>
                    <a:gd name="connsiteY65" fmla="*/ 334434 h 1103780"/>
                    <a:gd name="connsiteX66" fmla="*/ 436034 w 475502"/>
                    <a:gd name="connsiteY66" fmla="*/ 309034 h 1103780"/>
                    <a:gd name="connsiteX67" fmla="*/ 440267 w 475502"/>
                    <a:gd name="connsiteY67" fmla="*/ 262467 h 1103780"/>
                    <a:gd name="connsiteX68" fmla="*/ 448734 w 475502"/>
                    <a:gd name="connsiteY68" fmla="*/ 249767 h 1103780"/>
                    <a:gd name="connsiteX69" fmla="*/ 457200 w 475502"/>
                    <a:gd name="connsiteY69" fmla="*/ 224367 h 1103780"/>
                    <a:gd name="connsiteX70" fmla="*/ 452967 w 475502"/>
                    <a:gd name="connsiteY70" fmla="*/ 177800 h 1103780"/>
                    <a:gd name="connsiteX71" fmla="*/ 448734 w 475502"/>
                    <a:gd name="connsiteY71" fmla="*/ 160867 h 1103780"/>
                    <a:gd name="connsiteX72" fmla="*/ 457200 w 475502"/>
                    <a:gd name="connsiteY72" fmla="*/ 131234 h 1103780"/>
                    <a:gd name="connsiteX73" fmla="*/ 469900 w 475502"/>
                    <a:gd name="connsiteY73" fmla="*/ 122767 h 1103780"/>
                    <a:gd name="connsiteX74" fmla="*/ 474134 w 475502"/>
                    <a:gd name="connsiteY74" fmla="*/ 110067 h 1103780"/>
                    <a:gd name="connsiteX75" fmla="*/ 364067 w 475502"/>
                    <a:gd name="connsiteY75" fmla="*/ 8467 h 1103780"/>
                    <a:gd name="connsiteX76" fmla="*/ 325967 w 475502"/>
                    <a:gd name="connsiteY76" fmla="*/ 4234 h 1103780"/>
                    <a:gd name="connsiteX77" fmla="*/ 304800 w 475502"/>
                    <a:gd name="connsiteY77" fmla="*/ 0 h 1103780"/>
                    <a:gd name="connsiteX78" fmla="*/ 114300 w 475502"/>
                    <a:gd name="connsiteY78" fmla="*/ 4234 h 110378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Lst>
                  <a:rect l="l" t="t" r="r" b="b"/>
                  <a:pathLst>
                    <a:path w="475502" h="1103780">
                      <a:moveTo>
                        <a:pt x="114300" y="4234"/>
                      </a:moveTo>
                      <a:cubicBezTo>
                        <a:pt x="81139" y="10584"/>
                        <a:pt x="109553" y="32522"/>
                        <a:pt x="105834" y="38100"/>
                      </a:cubicBezTo>
                      <a:cubicBezTo>
                        <a:pt x="102513" y="43081"/>
                        <a:pt x="96967" y="46201"/>
                        <a:pt x="93134" y="50800"/>
                      </a:cubicBezTo>
                      <a:cubicBezTo>
                        <a:pt x="89877" y="54709"/>
                        <a:pt x="87489" y="59267"/>
                        <a:pt x="84667" y="63500"/>
                      </a:cubicBezTo>
                      <a:cubicBezTo>
                        <a:pt x="83256" y="67733"/>
                        <a:pt x="82430" y="72209"/>
                        <a:pt x="80434" y="76200"/>
                      </a:cubicBezTo>
                      <a:cubicBezTo>
                        <a:pt x="78159" y="80751"/>
                        <a:pt x="72598" y="83851"/>
                        <a:pt x="71967" y="88900"/>
                      </a:cubicBezTo>
                      <a:cubicBezTo>
                        <a:pt x="58541" y="196308"/>
                        <a:pt x="85726" y="150813"/>
                        <a:pt x="59267" y="190500"/>
                      </a:cubicBezTo>
                      <a:cubicBezTo>
                        <a:pt x="60678" y="194733"/>
                        <a:pt x="60712" y="199715"/>
                        <a:pt x="63500" y="203200"/>
                      </a:cubicBezTo>
                      <a:cubicBezTo>
                        <a:pt x="69469" y="210661"/>
                        <a:pt x="80533" y="213111"/>
                        <a:pt x="88900" y="215900"/>
                      </a:cubicBezTo>
                      <a:cubicBezTo>
                        <a:pt x="90311" y="225778"/>
                        <a:pt x="91494" y="235691"/>
                        <a:pt x="93134" y="245534"/>
                      </a:cubicBezTo>
                      <a:cubicBezTo>
                        <a:pt x="94317" y="252631"/>
                        <a:pt x="97367" y="259505"/>
                        <a:pt x="97367" y="266700"/>
                      </a:cubicBezTo>
                      <a:cubicBezTo>
                        <a:pt x="97367" y="275283"/>
                        <a:pt x="98720" y="285583"/>
                        <a:pt x="93134" y="292100"/>
                      </a:cubicBezTo>
                      <a:cubicBezTo>
                        <a:pt x="88451" y="297563"/>
                        <a:pt x="79023" y="294923"/>
                        <a:pt x="71967" y="296334"/>
                      </a:cubicBezTo>
                      <a:cubicBezTo>
                        <a:pt x="70556" y="317501"/>
                        <a:pt x="71222" y="338909"/>
                        <a:pt x="67734" y="359834"/>
                      </a:cubicBezTo>
                      <a:cubicBezTo>
                        <a:pt x="66898" y="364853"/>
                        <a:pt x="59773" y="367471"/>
                        <a:pt x="59267" y="372534"/>
                      </a:cubicBezTo>
                      <a:cubicBezTo>
                        <a:pt x="56801" y="397189"/>
                        <a:pt x="67465" y="405056"/>
                        <a:pt x="71967" y="427567"/>
                      </a:cubicBezTo>
                      <a:lnTo>
                        <a:pt x="76200" y="448734"/>
                      </a:lnTo>
                      <a:cubicBezTo>
                        <a:pt x="74640" y="459651"/>
                        <a:pt x="73644" y="479246"/>
                        <a:pt x="67734" y="491067"/>
                      </a:cubicBezTo>
                      <a:cubicBezTo>
                        <a:pt x="65459" y="495618"/>
                        <a:pt x="62089" y="499534"/>
                        <a:pt x="59267" y="503767"/>
                      </a:cubicBezTo>
                      <a:cubicBezTo>
                        <a:pt x="57856" y="508000"/>
                        <a:pt x="55555" y="512035"/>
                        <a:pt x="55034" y="516467"/>
                      </a:cubicBezTo>
                      <a:cubicBezTo>
                        <a:pt x="45931" y="593839"/>
                        <a:pt x="58088" y="553868"/>
                        <a:pt x="46567" y="588434"/>
                      </a:cubicBezTo>
                      <a:cubicBezTo>
                        <a:pt x="45156" y="599723"/>
                        <a:pt x="46954" y="611904"/>
                        <a:pt x="42334" y="622300"/>
                      </a:cubicBezTo>
                      <a:cubicBezTo>
                        <a:pt x="40522" y="626378"/>
                        <a:pt x="33347" y="624059"/>
                        <a:pt x="29634" y="626534"/>
                      </a:cubicBezTo>
                      <a:cubicBezTo>
                        <a:pt x="24653" y="629855"/>
                        <a:pt x="21167" y="635001"/>
                        <a:pt x="16934" y="639234"/>
                      </a:cubicBezTo>
                      <a:cubicBezTo>
                        <a:pt x="15523" y="643467"/>
                        <a:pt x="12207" y="647499"/>
                        <a:pt x="12700" y="651934"/>
                      </a:cubicBezTo>
                      <a:cubicBezTo>
                        <a:pt x="15521" y="677324"/>
                        <a:pt x="17877" y="675141"/>
                        <a:pt x="33867" y="685800"/>
                      </a:cubicBezTo>
                      <a:cubicBezTo>
                        <a:pt x="39017" y="721850"/>
                        <a:pt x="41972" y="727238"/>
                        <a:pt x="33867" y="770467"/>
                      </a:cubicBezTo>
                      <a:cubicBezTo>
                        <a:pt x="32929" y="775468"/>
                        <a:pt x="28222" y="778934"/>
                        <a:pt x="25400" y="783167"/>
                      </a:cubicBezTo>
                      <a:cubicBezTo>
                        <a:pt x="23989" y="787400"/>
                        <a:pt x="21167" y="791405"/>
                        <a:pt x="21167" y="795867"/>
                      </a:cubicBezTo>
                      <a:cubicBezTo>
                        <a:pt x="21167" y="888671"/>
                        <a:pt x="15261" y="867056"/>
                        <a:pt x="29634" y="910167"/>
                      </a:cubicBezTo>
                      <a:cubicBezTo>
                        <a:pt x="28223" y="915811"/>
                        <a:pt x="27692" y="921752"/>
                        <a:pt x="25400" y="927100"/>
                      </a:cubicBezTo>
                      <a:cubicBezTo>
                        <a:pt x="23396" y="931776"/>
                        <a:pt x="18543" y="934973"/>
                        <a:pt x="16934" y="939800"/>
                      </a:cubicBezTo>
                      <a:cubicBezTo>
                        <a:pt x="14220" y="947943"/>
                        <a:pt x="14383" y="956783"/>
                        <a:pt x="12700" y="965200"/>
                      </a:cubicBezTo>
                      <a:cubicBezTo>
                        <a:pt x="10041" y="978493"/>
                        <a:pt x="8269" y="982727"/>
                        <a:pt x="4234" y="994834"/>
                      </a:cubicBezTo>
                      <a:cubicBezTo>
                        <a:pt x="2823" y="1006123"/>
                        <a:pt x="0" y="1017323"/>
                        <a:pt x="0" y="1028700"/>
                      </a:cubicBezTo>
                      <a:cubicBezTo>
                        <a:pt x="0" y="1148308"/>
                        <a:pt x="10662" y="1088116"/>
                        <a:pt x="186267" y="1092200"/>
                      </a:cubicBezTo>
                      <a:cubicBezTo>
                        <a:pt x="236079" y="1108807"/>
                        <a:pt x="198002" y="1097758"/>
                        <a:pt x="317500" y="1092200"/>
                      </a:cubicBezTo>
                      <a:cubicBezTo>
                        <a:pt x="338691" y="1091214"/>
                        <a:pt x="359833" y="1089378"/>
                        <a:pt x="381000" y="1087967"/>
                      </a:cubicBezTo>
                      <a:cubicBezTo>
                        <a:pt x="385233" y="1086556"/>
                        <a:pt x="391704" y="1087725"/>
                        <a:pt x="393700" y="1083734"/>
                      </a:cubicBezTo>
                      <a:cubicBezTo>
                        <a:pt x="395696" y="1079743"/>
                        <a:pt x="391634" y="1074935"/>
                        <a:pt x="389467" y="1071034"/>
                      </a:cubicBezTo>
                      <a:cubicBezTo>
                        <a:pt x="365204" y="1027359"/>
                        <a:pt x="377881" y="1061673"/>
                        <a:pt x="368300" y="1032934"/>
                      </a:cubicBezTo>
                      <a:cubicBezTo>
                        <a:pt x="369711" y="1027289"/>
                        <a:pt x="370242" y="1021348"/>
                        <a:pt x="372534" y="1016000"/>
                      </a:cubicBezTo>
                      <a:cubicBezTo>
                        <a:pt x="376851" y="1005927"/>
                        <a:pt x="383738" y="999262"/>
                        <a:pt x="393700" y="994834"/>
                      </a:cubicBezTo>
                      <a:cubicBezTo>
                        <a:pt x="401856" y="991209"/>
                        <a:pt x="419100" y="986367"/>
                        <a:pt x="419100" y="986367"/>
                      </a:cubicBezTo>
                      <a:cubicBezTo>
                        <a:pt x="421922" y="982134"/>
                        <a:pt x="425501" y="978316"/>
                        <a:pt x="427567" y="973667"/>
                      </a:cubicBezTo>
                      <a:cubicBezTo>
                        <a:pt x="431192" y="965512"/>
                        <a:pt x="436034" y="948267"/>
                        <a:pt x="436034" y="948267"/>
                      </a:cubicBezTo>
                      <a:cubicBezTo>
                        <a:pt x="434623" y="944034"/>
                        <a:pt x="434955" y="938722"/>
                        <a:pt x="431800" y="935567"/>
                      </a:cubicBezTo>
                      <a:cubicBezTo>
                        <a:pt x="428645" y="932412"/>
                        <a:pt x="422974" y="933548"/>
                        <a:pt x="419100" y="931334"/>
                      </a:cubicBezTo>
                      <a:cubicBezTo>
                        <a:pt x="412974" y="927834"/>
                        <a:pt x="407524" y="923226"/>
                        <a:pt x="402167" y="918634"/>
                      </a:cubicBezTo>
                      <a:cubicBezTo>
                        <a:pt x="373646" y="894187"/>
                        <a:pt x="404836" y="916181"/>
                        <a:pt x="376767" y="897467"/>
                      </a:cubicBezTo>
                      <a:cubicBezTo>
                        <a:pt x="373945" y="889000"/>
                        <a:pt x="367559" y="880961"/>
                        <a:pt x="368300" y="872067"/>
                      </a:cubicBezTo>
                      <a:cubicBezTo>
                        <a:pt x="370898" y="840901"/>
                        <a:pt x="370148" y="826579"/>
                        <a:pt x="376767" y="800100"/>
                      </a:cubicBezTo>
                      <a:cubicBezTo>
                        <a:pt x="377849" y="795771"/>
                        <a:pt x="379589" y="791633"/>
                        <a:pt x="381000" y="787400"/>
                      </a:cubicBezTo>
                      <a:cubicBezTo>
                        <a:pt x="381849" y="779758"/>
                        <a:pt x="383969" y="745196"/>
                        <a:pt x="389467" y="732367"/>
                      </a:cubicBezTo>
                      <a:cubicBezTo>
                        <a:pt x="391471" y="727690"/>
                        <a:pt x="395112" y="723900"/>
                        <a:pt x="397934" y="719667"/>
                      </a:cubicBezTo>
                      <a:cubicBezTo>
                        <a:pt x="400756" y="711200"/>
                        <a:pt x="406012" y="703183"/>
                        <a:pt x="406400" y="694267"/>
                      </a:cubicBezTo>
                      <a:cubicBezTo>
                        <a:pt x="407811" y="661811"/>
                        <a:pt x="408142" y="629291"/>
                        <a:pt x="410634" y="596900"/>
                      </a:cubicBezTo>
                      <a:cubicBezTo>
                        <a:pt x="410976" y="592451"/>
                        <a:pt x="412079" y="587684"/>
                        <a:pt x="414867" y="584200"/>
                      </a:cubicBezTo>
                      <a:cubicBezTo>
                        <a:pt x="418045" y="580227"/>
                        <a:pt x="423334" y="578556"/>
                        <a:pt x="427567" y="575734"/>
                      </a:cubicBezTo>
                      <a:cubicBezTo>
                        <a:pt x="418240" y="547750"/>
                        <a:pt x="423510" y="569217"/>
                        <a:pt x="427567" y="516467"/>
                      </a:cubicBezTo>
                      <a:cubicBezTo>
                        <a:pt x="429194" y="495316"/>
                        <a:pt x="426886" y="473604"/>
                        <a:pt x="431800" y="452967"/>
                      </a:cubicBezTo>
                      <a:cubicBezTo>
                        <a:pt x="434157" y="443068"/>
                        <a:pt x="448734" y="427567"/>
                        <a:pt x="448734" y="427567"/>
                      </a:cubicBezTo>
                      <a:cubicBezTo>
                        <a:pt x="440606" y="395061"/>
                        <a:pt x="447850" y="426500"/>
                        <a:pt x="440267" y="381000"/>
                      </a:cubicBezTo>
                      <a:cubicBezTo>
                        <a:pt x="439084" y="373903"/>
                        <a:pt x="439604" y="366081"/>
                        <a:pt x="436034" y="359834"/>
                      </a:cubicBezTo>
                      <a:cubicBezTo>
                        <a:pt x="433510" y="355416"/>
                        <a:pt x="427567" y="354189"/>
                        <a:pt x="423334" y="351367"/>
                      </a:cubicBezTo>
                      <a:cubicBezTo>
                        <a:pt x="424745" y="345723"/>
                        <a:pt x="425895" y="340007"/>
                        <a:pt x="427567" y="334434"/>
                      </a:cubicBezTo>
                      <a:cubicBezTo>
                        <a:pt x="430132" y="325886"/>
                        <a:pt x="436034" y="309034"/>
                        <a:pt x="436034" y="309034"/>
                      </a:cubicBezTo>
                      <a:cubicBezTo>
                        <a:pt x="437445" y="293512"/>
                        <a:pt x="437001" y="277707"/>
                        <a:pt x="440267" y="262467"/>
                      </a:cubicBezTo>
                      <a:cubicBezTo>
                        <a:pt x="441333" y="257492"/>
                        <a:pt x="446668" y="254416"/>
                        <a:pt x="448734" y="249767"/>
                      </a:cubicBezTo>
                      <a:cubicBezTo>
                        <a:pt x="452359" y="241612"/>
                        <a:pt x="457200" y="224367"/>
                        <a:pt x="457200" y="224367"/>
                      </a:cubicBezTo>
                      <a:cubicBezTo>
                        <a:pt x="455789" y="208845"/>
                        <a:pt x="455027" y="193250"/>
                        <a:pt x="452967" y="177800"/>
                      </a:cubicBezTo>
                      <a:cubicBezTo>
                        <a:pt x="452198" y="172033"/>
                        <a:pt x="448734" y="166685"/>
                        <a:pt x="448734" y="160867"/>
                      </a:cubicBezTo>
                      <a:cubicBezTo>
                        <a:pt x="448734" y="160107"/>
                        <a:pt x="455204" y="133729"/>
                        <a:pt x="457200" y="131234"/>
                      </a:cubicBezTo>
                      <a:cubicBezTo>
                        <a:pt x="460378" y="127261"/>
                        <a:pt x="465667" y="125589"/>
                        <a:pt x="469900" y="122767"/>
                      </a:cubicBezTo>
                      <a:cubicBezTo>
                        <a:pt x="471311" y="118534"/>
                        <a:pt x="474134" y="114529"/>
                        <a:pt x="474134" y="110067"/>
                      </a:cubicBezTo>
                      <a:cubicBezTo>
                        <a:pt x="474134" y="-22342"/>
                        <a:pt x="496092" y="13748"/>
                        <a:pt x="364067" y="8467"/>
                      </a:cubicBezTo>
                      <a:cubicBezTo>
                        <a:pt x="351367" y="7056"/>
                        <a:pt x="338617" y="6041"/>
                        <a:pt x="325967" y="4234"/>
                      </a:cubicBezTo>
                      <a:cubicBezTo>
                        <a:pt x="318844" y="3216"/>
                        <a:pt x="311994" y="156"/>
                        <a:pt x="304800" y="0"/>
                      </a:cubicBezTo>
                      <a:lnTo>
                        <a:pt x="114300" y="4234"/>
                      </a:lnTo>
                      <a:close/>
                    </a:path>
                  </a:pathLst>
                </a:custGeom>
                <a:noFill/>
                <a:ln w="158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80" name="Group 79">
                <a:extLst>
                  <a:ext uri="{FF2B5EF4-FFF2-40B4-BE49-F238E27FC236}">
                    <a16:creationId xmlns:a16="http://schemas.microsoft.com/office/drawing/2014/main" id="{C62AC929-ECE0-4792-A5D1-97653BF27667}"/>
                  </a:ext>
                </a:extLst>
              </p:cNvPr>
              <p:cNvGrpSpPr/>
              <p:nvPr/>
            </p:nvGrpSpPr>
            <p:grpSpPr>
              <a:xfrm>
                <a:off x="6270623" y="1909360"/>
                <a:ext cx="1080000" cy="972000"/>
                <a:chOff x="6626103" y="1890238"/>
                <a:chExt cx="1463040" cy="1103241"/>
              </a:xfrm>
            </p:grpSpPr>
            <p:pic>
              <p:nvPicPr>
                <p:cNvPr id="103" name="Picture 102">
                  <a:extLst>
                    <a:ext uri="{FF2B5EF4-FFF2-40B4-BE49-F238E27FC236}">
                      <a16:creationId xmlns:a16="http://schemas.microsoft.com/office/drawing/2014/main" id="{79FF3482-B1C4-459C-9551-E9DC5AFDD4C8}"/>
                    </a:ext>
                  </a:extLst>
                </p:cNvPr>
                <p:cNvPicPr>
                  <a:picLocks noChangeAspect="1"/>
                </p:cNvPicPr>
                <p:nvPr/>
              </p:nvPicPr>
              <p:blipFill>
                <a:blip r:embed="rId8" cstate="print">
                  <a:extLst>
                    <a:ext uri="{BEBA8EAE-BF5A-486C-A8C5-ECC9F3942E4B}">
                      <a14:imgProps xmlns:a14="http://schemas.microsoft.com/office/drawing/2010/main">
                        <a14:imgLayer r:embed="rId9">
                          <a14:imgEffect>
                            <a14:brightnessContrast bright="40000" contrast="-20000"/>
                          </a14:imgEffect>
                        </a14:imgLayer>
                      </a14:imgProps>
                    </a:ext>
                    <a:ext uri="{28A0092B-C50C-407E-A947-70E740481C1C}">
                      <a14:useLocalDpi xmlns:a14="http://schemas.microsoft.com/office/drawing/2010/main" val="0"/>
                    </a:ext>
                  </a:extLst>
                </a:blip>
                <a:stretch>
                  <a:fillRect/>
                </a:stretch>
              </p:blipFill>
              <p:spPr>
                <a:xfrm>
                  <a:off x="6626103" y="1894880"/>
                  <a:ext cx="1463040" cy="1097280"/>
                </a:xfrm>
                <a:prstGeom prst="rect">
                  <a:avLst/>
                </a:prstGeom>
              </p:spPr>
            </p:pic>
            <p:sp>
              <p:nvSpPr>
                <p:cNvPr id="104" name="Freeform: Shape 90">
                  <a:extLst>
                    <a:ext uri="{FF2B5EF4-FFF2-40B4-BE49-F238E27FC236}">
                      <a16:creationId xmlns:a16="http://schemas.microsoft.com/office/drawing/2014/main" id="{8ADA3BC7-D0E9-4FB3-99D4-6053710BD104}"/>
                    </a:ext>
                  </a:extLst>
                </p:cNvPr>
                <p:cNvSpPr/>
                <p:nvPr/>
              </p:nvSpPr>
              <p:spPr>
                <a:xfrm>
                  <a:off x="7167033" y="1890238"/>
                  <a:ext cx="469900" cy="1103241"/>
                </a:xfrm>
                <a:custGeom>
                  <a:avLst/>
                  <a:gdLst>
                    <a:gd name="connsiteX0" fmla="*/ 50800 w 469900"/>
                    <a:gd name="connsiteY0" fmla="*/ 6295 h 1103241"/>
                    <a:gd name="connsiteX1" fmla="*/ 46567 w 469900"/>
                    <a:gd name="connsiteY1" fmla="*/ 27462 h 1103241"/>
                    <a:gd name="connsiteX2" fmla="*/ 46567 w 469900"/>
                    <a:gd name="connsiteY2" fmla="*/ 137529 h 1103241"/>
                    <a:gd name="connsiteX3" fmla="*/ 29634 w 469900"/>
                    <a:gd name="connsiteY3" fmla="*/ 162929 h 1103241"/>
                    <a:gd name="connsiteX4" fmla="*/ 33867 w 469900"/>
                    <a:gd name="connsiteY4" fmla="*/ 196795 h 1103241"/>
                    <a:gd name="connsiteX5" fmla="*/ 50800 w 469900"/>
                    <a:gd name="connsiteY5" fmla="*/ 222195 h 1103241"/>
                    <a:gd name="connsiteX6" fmla="*/ 55034 w 469900"/>
                    <a:gd name="connsiteY6" fmla="*/ 234895 h 1103241"/>
                    <a:gd name="connsiteX7" fmla="*/ 38100 w 469900"/>
                    <a:gd name="connsiteY7" fmla="*/ 260295 h 1103241"/>
                    <a:gd name="connsiteX8" fmla="*/ 50800 w 469900"/>
                    <a:gd name="connsiteY8" fmla="*/ 311095 h 1103241"/>
                    <a:gd name="connsiteX9" fmla="*/ 55034 w 469900"/>
                    <a:gd name="connsiteY9" fmla="*/ 328029 h 1103241"/>
                    <a:gd name="connsiteX10" fmla="*/ 63500 w 469900"/>
                    <a:gd name="connsiteY10" fmla="*/ 340729 h 1103241"/>
                    <a:gd name="connsiteX11" fmla="*/ 59267 w 469900"/>
                    <a:gd name="connsiteY11" fmla="*/ 480429 h 1103241"/>
                    <a:gd name="connsiteX12" fmla="*/ 50800 w 469900"/>
                    <a:gd name="connsiteY12" fmla="*/ 493129 h 1103241"/>
                    <a:gd name="connsiteX13" fmla="*/ 46567 w 469900"/>
                    <a:gd name="connsiteY13" fmla="*/ 505829 h 1103241"/>
                    <a:gd name="connsiteX14" fmla="*/ 38100 w 469900"/>
                    <a:gd name="connsiteY14" fmla="*/ 539695 h 1103241"/>
                    <a:gd name="connsiteX15" fmla="*/ 46567 w 469900"/>
                    <a:gd name="connsiteY15" fmla="*/ 577795 h 1103241"/>
                    <a:gd name="connsiteX16" fmla="*/ 59267 w 469900"/>
                    <a:gd name="connsiteY16" fmla="*/ 586262 h 1103241"/>
                    <a:gd name="connsiteX17" fmla="*/ 80434 w 469900"/>
                    <a:gd name="connsiteY17" fmla="*/ 590495 h 1103241"/>
                    <a:gd name="connsiteX18" fmla="*/ 76200 w 469900"/>
                    <a:gd name="connsiteY18" fmla="*/ 624362 h 1103241"/>
                    <a:gd name="connsiteX19" fmla="*/ 71967 w 469900"/>
                    <a:gd name="connsiteY19" fmla="*/ 637062 h 1103241"/>
                    <a:gd name="connsiteX20" fmla="*/ 67734 w 469900"/>
                    <a:gd name="connsiteY20" fmla="*/ 658229 h 1103241"/>
                    <a:gd name="connsiteX21" fmla="*/ 59267 w 469900"/>
                    <a:gd name="connsiteY21" fmla="*/ 683629 h 1103241"/>
                    <a:gd name="connsiteX22" fmla="*/ 33867 w 469900"/>
                    <a:gd name="connsiteY22" fmla="*/ 696329 h 1103241"/>
                    <a:gd name="connsiteX23" fmla="*/ 25400 w 469900"/>
                    <a:gd name="connsiteY23" fmla="*/ 721729 h 1103241"/>
                    <a:gd name="connsiteX24" fmla="*/ 21167 w 469900"/>
                    <a:gd name="connsiteY24" fmla="*/ 747129 h 1103241"/>
                    <a:gd name="connsiteX25" fmla="*/ 8467 w 469900"/>
                    <a:gd name="connsiteY25" fmla="*/ 755595 h 1103241"/>
                    <a:gd name="connsiteX26" fmla="*/ 4234 w 469900"/>
                    <a:gd name="connsiteY26" fmla="*/ 768295 h 1103241"/>
                    <a:gd name="connsiteX27" fmla="*/ 12700 w 469900"/>
                    <a:gd name="connsiteY27" fmla="*/ 852962 h 1103241"/>
                    <a:gd name="connsiteX28" fmla="*/ 12700 w 469900"/>
                    <a:gd name="connsiteY28" fmla="*/ 903762 h 1103241"/>
                    <a:gd name="connsiteX29" fmla="*/ 4234 w 469900"/>
                    <a:gd name="connsiteY29" fmla="*/ 950329 h 1103241"/>
                    <a:gd name="connsiteX30" fmla="*/ 8467 w 469900"/>
                    <a:gd name="connsiteY30" fmla="*/ 975729 h 1103241"/>
                    <a:gd name="connsiteX31" fmla="*/ 0 w 469900"/>
                    <a:gd name="connsiteY31" fmla="*/ 1094262 h 1103241"/>
                    <a:gd name="connsiteX32" fmla="*/ 25400 w 469900"/>
                    <a:gd name="connsiteY32" fmla="*/ 1098495 h 1103241"/>
                    <a:gd name="connsiteX33" fmla="*/ 385234 w 469900"/>
                    <a:gd name="connsiteY33" fmla="*/ 1094262 h 1103241"/>
                    <a:gd name="connsiteX34" fmla="*/ 410634 w 469900"/>
                    <a:gd name="connsiteY34" fmla="*/ 1081562 h 1103241"/>
                    <a:gd name="connsiteX35" fmla="*/ 414867 w 469900"/>
                    <a:gd name="connsiteY35" fmla="*/ 1068862 h 1103241"/>
                    <a:gd name="connsiteX36" fmla="*/ 402167 w 469900"/>
                    <a:gd name="connsiteY36" fmla="*/ 933395 h 1103241"/>
                    <a:gd name="connsiteX37" fmla="*/ 397934 w 469900"/>
                    <a:gd name="connsiteY37" fmla="*/ 912229 h 1103241"/>
                    <a:gd name="connsiteX38" fmla="*/ 389467 w 469900"/>
                    <a:gd name="connsiteY38" fmla="*/ 886829 h 1103241"/>
                    <a:gd name="connsiteX39" fmla="*/ 393700 w 469900"/>
                    <a:gd name="connsiteY39" fmla="*/ 734429 h 1103241"/>
                    <a:gd name="connsiteX40" fmla="*/ 419100 w 469900"/>
                    <a:gd name="connsiteY40" fmla="*/ 717495 h 1103241"/>
                    <a:gd name="connsiteX41" fmla="*/ 423334 w 469900"/>
                    <a:gd name="connsiteY41" fmla="*/ 675162 h 1103241"/>
                    <a:gd name="connsiteX42" fmla="*/ 419100 w 469900"/>
                    <a:gd name="connsiteY42" fmla="*/ 662462 h 1103241"/>
                    <a:gd name="connsiteX43" fmla="*/ 423334 w 469900"/>
                    <a:gd name="connsiteY43" fmla="*/ 645529 h 1103241"/>
                    <a:gd name="connsiteX44" fmla="*/ 436034 w 469900"/>
                    <a:gd name="connsiteY44" fmla="*/ 641295 h 1103241"/>
                    <a:gd name="connsiteX45" fmla="*/ 448734 w 469900"/>
                    <a:gd name="connsiteY45" fmla="*/ 632829 h 1103241"/>
                    <a:gd name="connsiteX46" fmla="*/ 444500 w 469900"/>
                    <a:gd name="connsiteY46" fmla="*/ 543929 h 1103241"/>
                    <a:gd name="connsiteX47" fmla="*/ 436034 w 469900"/>
                    <a:gd name="connsiteY47" fmla="*/ 518529 h 1103241"/>
                    <a:gd name="connsiteX48" fmla="*/ 431800 w 469900"/>
                    <a:gd name="connsiteY48" fmla="*/ 505829 h 1103241"/>
                    <a:gd name="connsiteX49" fmla="*/ 436034 w 469900"/>
                    <a:gd name="connsiteY49" fmla="*/ 467729 h 1103241"/>
                    <a:gd name="connsiteX50" fmla="*/ 448734 w 469900"/>
                    <a:gd name="connsiteY50" fmla="*/ 459262 h 1103241"/>
                    <a:gd name="connsiteX51" fmla="*/ 461434 w 469900"/>
                    <a:gd name="connsiteY51" fmla="*/ 433862 h 1103241"/>
                    <a:gd name="connsiteX52" fmla="*/ 469900 w 469900"/>
                    <a:gd name="connsiteY52" fmla="*/ 421162 h 1103241"/>
                    <a:gd name="connsiteX53" fmla="*/ 461434 w 469900"/>
                    <a:gd name="connsiteY53" fmla="*/ 374595 h 1103241"/>
                    <a:gd name="connsiteX54" fmla="*/ 452967 w 469900"/>
                    <a:gd name="connsiteY54" fmla="*/ 361895 h 1103241"/>
                    <a:gd name="connsiteX55" fmla="*/ 444500 w 469900"/>
                    <a:gd name="connsiteY55" fmla="*/ 319562 h 1103241"/>
                    <a:gd name="connsiteX56" fmla="*/ 440267 w 469900"/>
                    <a:gd name="connsiteY56" fmla="*/ 306862 h 1103241"/>
                    <a:gd name="connsiteX57" fmla="*/ 427567 w 469900"/>
                    <a:gd name="connsiteY57" fmla="*/ 302629 h 1103241"/>
                    <a:gd name="connsiteX58" fmla="*/ 423334 w 469900"/>
                    <a:gd name="connsiteY58" fmla="*/ 289929 h 1103241"/>
                    <a:gd name="connsiteX59" fmla="*/ 436034 w 469900"/>
                    <a:gd name="connsiteY59" fmla="*/ 205262 h 1103241"/>
                    <a:gd name="connsiteX60" fmla="*/ 444500 w 469900"/>
                    <a:gd name="connsiteY60" fmla="*/ 179862 h 1103241"/>
                    <a:gd name="connsiteX61" fmla="*/ 448734 w 469900"/>
                    <a:gd name="connsiteY61" fmla="*/ 167162 h 1103241"/>
                    <a:gd name="connsiteX62" fmla="*/ 431800 w 469900"/>
                    <a:gd name="connsiteY62" fmla="*/ 150229 h 1103241"/>
                    <a:gd name="connsiteX63" fmla="*/ 423334 w 469900"/>
                    <a:gd name="connsiteY63" fmla="*/ 137529 h 1103241"/>
                    <a:gd name="connsiteX64" fmla="*/ 419100 w 469900"/>
                    <a:gd name="connsiteY64" fmla="*/ 112129 h 1103241"/>
                    <a:gd name="connsiteX65" fmla="*/ 406400 w 469900"/>
                    <a:gd name="connsiteY65" fmla="*/ 103662 h 1103241"/>
                    <a:gd name="connsiteX66" fmla="*/ 402167 w 469900"/>
                    <a:gd name="connsiteY66" fmla="*/ 90962 h 1103241"/>
                    <a:gd name="connsiteX67" fmla="*/ 406400 w 469900"/>
                    <a:gd name="connsiteY67" fmla="*/ 69795 h 1103241"/>
                    <a:gd name="connsiteX68" fmla="*/ 414867 w 469900"/>
                    <a:gd name="connsiteY68" fmla="*/ 57095 h 1103241"/>
                    <a:gd name="connsiteX69" fmla="*/ 419100 w 469900"/>
                    <a:gd name="connsiteY69" fmla="*/ 35929 h 1103241"/>
                    <a:gd name="connsiteX70" fmla="*/ 262467 w 469900"/>
                    <a:gd name="connsiteY70" fmla="*/ 14762 h 1103241"/>
                    <a:gd name="connsiteX71" fmla="*/ 50800 w 469900"/>
                    <a:gd name="connsiteY71" fmla="*/ 6295 h 110324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Lst>
                  <a:rect l="l" t="t" r="r" b="b"/>
                  <a:pathLst>
                    <a:path w="469900" h="1103241">
                      <a:moveTo>
                        <a:pt x="50800" y="6295"/>
                      </a:moveTo>
                      <a:cubicBezTo>
                        <a:pt x="14817" y="8412"/>
                        <a:pt x="46567" y="20267"/>
                        <a:pt x="46567" y="27462"/>
                      </a:cubicBezTo>
                      <a:cubicBezTo>
                        <a:pt x="46567" y="79181"/>
                        <a:pt x="60212" y="80219"/>
                        <a:pt x="46567" y="137529"/>
                      </a:cubicBezTo>
                      <a:cubicBezTo>
                        <a:pt x="44210" y="147428"/>
                        <a:pt x="29634" y="162929"/>
                        <a:pt x="29634" y="162929"/>
                      </a:cubicBezTo>
                      <a:cubicBezTo>
                        <a:pt x="31045" y="174218"/>
                        <a:pt x="30041" y="186081"/>
                        <a:pt x="33867" y="196795"/>
                      </a:cubicBezTo>
                      <a:cubicBezTo>
                        <a:pt x="37289" y="206378"/>
                        <a:pt x="47582" y="212542"/>
                        <a:pt x="50800" y="222195"/>
                      </a:cubicBezTo>
                      <a:lnTo>
                        <a:pt x="55034" y="234895"/>
                      </a:lnTo>
                      <a:cubicBezTo>
                        <a:pt x="49389" y="243362"/>
                        <a:pt x="36427" y="250258"/>
                        <a:pt x="38100" y="260295"/>
                      </a:cubicBezTo>
                      <a:cubicBezTo>
                        <a:pt x="49175" y="326736"/>
                        <a:pt x="34032" y="244033"/>
                        <a:pt x="50800" y="311095"/>
                      </a:cubicBezTo>
                      <a:cubicBezTo>
                        <a:pt x="52211" y="316740"/>
                        <a:pt x="52742" y="322681"/>
                        <a:pt x="55034" y="328029"/>
                      </a:cubicBezTo>
                      <a:cubicBezTo>
                        <a:pt x="57038" y="332705"/>
                        <a:pt x="60678" y="336496"/>
                        <a:pt x="63500" y="340729"/>
                      </a:cubicBezTo>
                      <a:cubicBezTo>
                        <a:pt x="62089" y="387296"/>
                        <a:pt x="63136" y="434002"/>
                        <a:pt x="59267" y="480429"/>
                      </a:cubicBezTo>
                      <a:cubicBezTo>
                        <a:pt x="58844" y="485499"/>
                        <a:pt x="53075" y="488578"/>
                        <a:pt x="50800" y="493129"/>
                      </a:cubicBezTo>
                      <a:cubicBezTo>
                        <a:pt x="48804" y="497120"/>
                        <a:pt x="47741" y="501524"/>
                        <a:pt x="46567" y="505829"/>
                      </a:cubicBezTo>
                      <a:cubicBezTo>
                        <a:pt x="43505" y="517055"/>
                        <a:pt x="38100" y="539695"/>
                        <a:pt x="38100" y="539695"/>
                      </a:cubicBezTo>
                      <a:cubicBezTo>
                        <a:pt x="38143" y="539952"/>
                        <a:pt x="42180" y="572311"/>
                        <a:pt x="46567" y="577795"/>
                      </a:cubicBezTo>
                      <a:cubicBezTo>
                        <a:pt x="49745" y="581768"/>
                        <a:pt x="54503" y="584476"/>
                        <a:pt x="59267" y="586262"/>
                      </a:cubicBezTo>
                      <a:cubicBezTo>
                        <a:pt x="66004" y="588788"/>
                        <a:pt x="73378" y="589084"/>
                        <a:pt x="80434" y="590495"/>
                      </a:cubicBezTo>
                      <a:cubicBezTo>
                        <a:pt x="79023" y="601784"/>
                        <a:pt x="78235" y="613169"/>
                        <a:pt x="76200" y="624362"/>
                      </a:cubicBezTo>
                      <a:cubicBezTo>
                        <a:pt x="75402" y="628752"/>
                        <a:pt x="73049" y="632733"/>
                        <a:pt x="71967" y="637062"/>
                      </a:cubicBezTo>
                      <a:cubicBezTo>
                        <a:pt x="70222" y="644043"/>
                        <a:pt x="69627" y="651287"/>
                        <a:pt x="67734" y="658229"/>
                      </a:cubicBezTo>
                      <a:cubicBezTo>
                        <a:pt x="65386" y="666839"/>
                        <a:pt x="66693" y="678679"/>
                        <a:pt x="59267" y="683629"/>
                      </a:cubicBezTo>
                      <a:cubicBezTo>
                        <a:pt x="42854" y="694570"/>
                        <a:pt x="51394" y="690486"/>
                        <a:pt x="33867" y="696329"/>
                      </a:cubicBezTo>
                      <a:cubicBezTo>
                        <a:pt x="31045" y="704796"/>
                        <a:pt x="26867" y="712926"/>
                        <a:pt x="25400" y="721729"/>
                      </a:cubicBezTo>
                      <a:cubicBezTo>
                        <a:pt x="23989" y="730196"/>
                        <a:pt x="25006" y="739452"/>
                        <a:pt x="21167" y="747129"/>
                      </a:cubicBezTo>
                      <a:cubicBezTo>
                        <a:pt x="18892" y="751680"/>
                        <a:pt x="12700" y="752773"/>
                        <a:pt x="8467" y="755595"/>
                      </a:cubicBezTo>
                      <a:cubicBezTo>
                        <a:pt x="7056" y="759828"/>
                        <a:pt x="4234" y="763833"/>
                        <a:pt x="4234" y="768295"/>
                      </a:cubicBezTo>
                      <a:cubicBezTo>
                        <a:pt x="4234" y="831230"/>
                        <a:pt x="1703" y="819969"/>
                        <a:pt x="12700" y="852962"/>
                      </a:cubicBezTo>
                      <a:cubicBezTo>
                        <a:pt x="1412" y="920695"/>
                        <a:pt x="12700" y="836029"/>
                        <a:pt x="12700" y="903762"/>
                      </a:cubicBezTo>
                      <a:cubicBezTo>
                        <a:pt x="12700" y="927696"/>
                        <a:pt x="10187" y="932468"/>
                        <a:pt x="4234" y="950329"/>
                      </a:cubicBezTo>
                      <a:cubicBezTo>
                        <a:pt x="5645" y="958796"/>
                        <a:pt x="8467" y="967146"/>
                        <a:pt x="8467" y="975729"/>
                      </a:cubicBezTo>
                      <a:cubicBezTo>
                        <a:pt x="8467" y="1072789"/>
                        <a:pt x="14843" y="1049741"/>
                        <a:pt x="0" y="1094262"/>
                      </a:cubicBezTo>
                      <a:cubicBezTo>
                        <a:pt x="25418" y="1111208"/>
                        <a:pt x="-24" y="1099073"/>
                        <a:pt x="25400" y="1098495"/>
                      </a:cubicBezTo>
                      <a:cubicBezTo>
                        <a:pt x="145322" y="1095769"/>
                        <a:pt x="265289" y="1095673"/>
                        <a:pt x="385234" y="1094262"/>
                      </a:cubicBezTo>
                      <a:cubicBezTo>
                        <a:pt x="393601" y="1091473"/>
                        <a:pt x="404665" y="1089023"/>
                        <a:pt x="410634" y="1081562"/>
                      </a:cubicBezTo>
                      <a:cubicBezTo>
                        <a:pt x="413422" y="1078077"/>
                        <a:pt x="413456" y="1073095"/>
                        <a:pt x="414867" y="1068862"/>
                      </a:cubicBezTo>
                      <a:cubicBezTo>
                        <a:pt x="398043" y="984743"/>
                        <a:pt x="411939" y="1065334"/>
                        <a:pt x="402167" y="933395"/>
                      </a:cubicBezTo>
                      <a:cubicBezTo>
                        <a:pt x="401636" y="926220"/>
                        <a:pt x="399827" y="919171"/>
                        <a:pt x="397934" y="912229"/>
                      </a:cubicBezTo>
                      <a:cubicBezTo>
                        <a:pt x="395586" y="903619"/>
                        <a:pt x="389467" y="886829"/>
                        <a:pt x="389467" y="886829"/>
                      </a:cubicBezTo>
                      <a:cubicBezTo>
                        <a:pt x="390878" y="836029"/>
                        <a:pt x="384940" y="784488"/>
                        <a:pt x="393700" y="734429"/>
                      </a:cubicBezTo>
                      <a:cubicBezTo>
                        <a:pt x="395454" y="724406"/>
                        <a:pt x="419100" y="717495"/>
                        <a:pt x="419100" y="717495"/>
                      </a:cubicBezTo>
                      <a:cubicBezTo>
                        <a:pt x="428651" y="688842"/>
                        <a:pt x="430224" y="699276"/>
                        <a:pt x="423334" y="675162"/>
                      </a:cubicBezTo>
                      <a:cubicBezTo>
                        <a:pt x="422108" y="670871"/>
                        <a:pt x="420511" y="666695"/>
                        <a:pt x="419100" y="662462"/>
                      </a:cubicBezTo>
                      <a:cubicBezTo>
                        <a:pt x="420511" y="656818"/>
                        <a:pt x="419699" y="650072"/>
                        <a:pt x="423334" y="645529"/>
                      </a:cubicBezTo>
                      <a:cubicBezTo>
                        <a:pt x="426122" y="642044"/>
                        <a:pt x="432043" y="643291"/>
                        <a:pt x="436034" y="641295"/>
                      </a:cubicBezTo>
                      <a:cubicBezTo>
                        <a:pt x="440585" y="639020"/>
                        <a:pt x="444501" y="635651"/>
                        <a:pt x="448734" y="632829"/>
                      </a:cubicBezTo>
                      <a:cubicBezTo>
                        <a:pt x="447323" y="603196"/>
                        <a:pt x="447776" y="573414"/>
                        <a:pt x="444500" y="543929"/>
                      </a:cubicBezTo>
                      <a:cubicBezTo>
                        <a:pt x="443514" y="535059"/>
                        <a:pt x="438856" y="526996"/>
                        <a:pt x="436034" y="518529"/>
                      </a:cubicBezTo>
                      <a:lnTo>
                        <a:pt x="431800" y="505829"/>
                      </a:lnTo>
                      <a:cubicBezTo>
                        <a:pt x="433211" y="493129"/>
                        <a:pt x="431667" y="479738"/>
                        <a:pt x="436034" y="467729"/>
                      </a:cubicBezTo>
                      <a:cubicBezTo>
                        <a:pt x="437773" y="462947"/>
                        <a:pt x="445136" y="462860"/>
                        <a:pt x="448734" y="459262"/>
                      </a:cubicBezTo>
                      <a:cubicBezTo>
                        <a:pt x="460863" y="447133"/>
                        <a:pt x="454549" y="447631"/>
                        <a:pt x="461434" y="433862"/>
                      </a:cubicBezTo>
                      <a:cubicBezTo>
                        <a:pt x="463709" y="429311"/>
                        <a:pt x="467078" y="425395"/>
                        <a:pt x="469900" y="421162"/>
                      </a:cubicBezTo>
                      <a:cubicBezTo>
                        <a:pt x="468441" y="409491"/>
                        <a:pt x="467959" y="387645"/>
                        <a:pt x="461434" y="374595"/>
                      </a:cubicBezTo>
                      <a:cubicBezTo>
                        <a:pt x="459159" y="370044"/>
                        <a:pt x="455789" y="366128"/>
                        <a:pt x="452967" y="361895"/>
                      </a:cubicBezTo>
                      <a:cubicBezTo>
                        <a:pt x="443404" y="333203"/>
                        <a:pt x="454229" y="368206"/>
                        <a:pt x="444500" y="319562"/>
                      </a:cubicBezTo>
                      <a:cubicBezTo>
                        <a:pt x="443625" y="315186"/>
                        <a:pt x="443422" y="310017"/>
                        <a:pt x="440267" y="306862"/>
                      </a:cubicBezTo>
                      <a:cubicBezTo>
                        <a:pt x="437112" y="303707"/>
                        <a:pt x="431800" y="304040"/>
                        <a:pt x="427567" y="302629"/>
                      </a:cubicBezTo>
                      <a:cubicBezTo>
                        <a:pt x="426156" y="298396"/>
                        <a:pt x="423334" y="294391"/>
                        <a:pt x="423334" y="289929"/>
                      </a:cubicBezTo>
                      <a:cubicBezTo>
                        <a:pt x="423334" y="236363"/>
                        <a:pt x="423497" y="242872"/>
                        <a:pt x="436034" y="205262"/>
                      </a:cubicBezTo>
                      <a:lnTo>
                        <a:pt x="444500" y="179862"/>
                      </a:lnTo>
                      <a:lnTo>
                        <a:pt x="448734" y="167162"/>
                      </a:lnTo>
                      <a:cubicBezTo>
                        <a:pt x="439496" y="139451"/>
                        <a:pt x="452326" y="166650"/>
                        <a:pt x="431800" y="150229"/>
                      </a:cubicBezTo>
                      <a:cubicBezTo>
                        <a:pt x="427827" y="147051"/>
                        <a:pt x="426156" y="141762"/>
                        <a:pt x="423334" y="137529"/>
                      </a:cubicBezTo>
                      <a:cubicBezTo>
                        <a:pt x="421923" y="129062"/>
                        <a:pt x="422939" y="119806"/>
                        <a:pt x="419100" y="112129"/>
                      </a:cubicBezTo>
                      <a:cubicBezTo>
                        <a:pt x="416825" y="107578"/>
                        <a:pt x="409578" y="107635"/>
                        <a:pt x="406400" y="103662"/>
                      </a:cubicBezTo>
                      <a:cubicBezTo>
                        <a:pt x="403612" y="100177"/>
                        <a:pt x="403578" y="95195"/>
                        <a:pt x="402167" y="90962"/>
                      </a:cubicBezTo>
                      <a:cubicBezTo>
                        <a:pt x="403578" y="83906"/>
                        <a:pt x="403874" y="76532"/>
                        <a:pt x="406400" y="69795"/>
                      </a:cubicBezTo>
                      <a:cubicBezTo>
                        <a:pt x="408186" y="65031"/>
                        <a:pt x="413080" y="61859"/>
                        <a:pt x="414867" y="57095"/>
                      </a:cubicBezTo>
                      <a:cubicBezTo>
                        <a:pt x="417393" y="50358"/>
                        <a:pt x="417689" y="42984"/>
                        <a:pt x="419100" y="35929"/>
                      </a:cubicBezTo>
                      <a:cubicBezTo>
                        <a:pt x="402669" y="-29804"/>
                        <a:pt x="419585" y="14762"/>
                        <a:pt x="262467" y="14762"/>
                      </a:cubicBezTo>
                      <a:cubicBezTo>
                        <a:pt x="193308" y="14762"/>
                        <a:pt x="86783" y="4178"/>
                        <a:pt x="50800" y="6295"/>
                      </a:cubicBezTo>
                      <a:close/>
                    </a:path>
                  </a:pathLst>
                </a:custGeom>
                <a:noFill/>
                <a:ln w="158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87" name="Group 86">
                <a:extLst>
                  <a:ext uri="{FF2B5EF4-FFF2-40B4-BE49-F238E27FC236}">
                    <a16:creationId xmlns:a16="http://schemas.microsoft.com/office/drawing/2014/main" id="{8CE838E0-19A4-4855-895C-B83496AFEBBD}"/>
                  </a:ext>
                </a:extLst>
              </p:cNvPr>
              <p:cNvGrpSpPr/>
              <p:nvPr/>
            </p:nvGrpSpPr>
            <p:grpSpPr>
              <a:xfrm>
                <a:off x="7382217" y="901217"/>
                <a:ext cx="1080000" cy="972000"/>
                <a:chOff x="8215532" y="749300"/>
                <a:chExt cx="1463040" cy="1103010"/>
              </a:xfrm>
            </p:grpSpPr>
            <p:pic>
              <p:nvPicPr>
                <p:cNvPr id="100" name="Picture 99">
                  <a:extLst>
                    <a:ext uri="{FF2B5EF4-FFF2-40B4-BE49-F238E27FC236}">
                      <a16:creationId xmlns:a16="http://schemas.microsoft.com/office/drawing/2014/main" id="{B93001BE-192B-48C0-B475-ED5F43A1DF0B}"/>
                    </a:ext>
                  </a:extLst>
                </p:cNvPr>
                <p:cNvPicPr>
                  <a:picLocks noChangeAspect="1"/>
                </p:cNvPicPr>
                <p:nvPr/>
              </p:nvPicPr>
              <p:blipFill>
                <a:blip r:embed="rId10" cstate="print">
                  <a:extLst>
                    <a:ext uri="{BEBA8EAE-BF5A-486C-A8C5-ECC9F3942E4B}">
                      <a14:imgProps xmlns:a14="http://schemas.microsoft.com/office/drawing/2010/main">
                        <a14:imgLayer r:embed="rId11">
                          <a14:imgEffect>
                            <a14:brightnessContrast bright="40000" contrast="20000"/>
                          </a14:imgEffect>
                        </a14:imgLayer>
                      </a14:imgProps>
                    </a:ext>
                    <a:ext uri="{28A0092B-C50C-407E-A947-70E740481C1C}">
                      <a14:useLocalDpi xmlns:a14="http://schemas.microsoft.com/office/drawing/2010/main" val="0"/>
                    </a:ext>
                  </a:extLst>
                </a:blip>
                <a:stretch>
                  <a:fillRect/>
                </a:stretch>
              </p:blipFill>
              <p:spPr>
                <a:xfrm>
                  <a:off x="8215532" y="755030"/>
                  <a:ext cx="1463040" cy="1097280"/>
                </a:xfrm>
                <a:prstGeom prst="rect">
                  <a:avLst/>
                </a:prstGeom>
              </p:spPr>
            </p:pic>
            <p:sp>
              <p:nvSpPr>
                <p:cNvPr id="101" name="Freeform: Shape 93">
                  <a:extLst>
                    <a:ext uri="{FF2B5EF4-FFF2-40B4-BE49-F238E27FC236}">
                      <a16:creationId xmlns:a16="http://schemas.microsoft.com/office/drawing/2014/main" id="{6EFBCFCA-0601-4B17-ABCB-5A967AFC7532}"/>
                    </a:ext>
                  </a:extLst>
                </p:cNvPr>
                <p:cNvSpPr/>
                <p:nvPr/>
              </p:nvSpPr>
              <p:spPr>
                <a:xfrm>
                  <a:off x="8817087" y="749300"/>
                  <a:ext cx="250839" cy="1096433"/>
                </a:xfrm>
                <a:custGeom>
                  <a:avLst/>
                  <a:gdLst>
                    <a:gd name="connsiteX0" fmla="*/ 22113 w 250839"/>
                    <a:gd name="connsiteY0" fmla="*/ 0 h 1096433"/>
                    <a:gd name="connsiteX1" fmla="*/ 946 w 250839"/>
                    <a:gd name="connsiteY1" fmla="*/ 12700 h 1096433"/>
                    <a:gd name="connsiteX2" fmla="*/ 5180 w 250839"/>
                    <a:gd name="connsiteY2" fmla="*/ 25400 h 1096433"/>
                    <a:gd name="connsiteX3" fmla="*/ 34813 w 250839"/>
                    <a:gd name="connsiteY3" fmla="*/ 29633 h 1096433"/>
                    <a:gd name="connsiteX4" fmla="*/ 55980 w 250839"/>
                    <a:gd name="connsiteY4" fmla="*/ 67733 h 1096433"/>
                    <a:gd name="connsiteX5" fmla="*/ 43280 w 250839"/>
                    <a:gd name="connsiteY5" fmla="*/ 101600 h 1096433"/>
                    <a:gd name="connsiteX6" fmla="*/ 17880 w 250839"/>
                    <a:gd name="connsiteY6" fmla="*/ 110067 h 1096433"/>
                    <a:gd name="connsiteX7" fmla="*/ 9413 w 250839"/>
                    <a:gd name="connsiteY7" fmla="*/ 122767 h 1096433"/>
                    <a:gd name="connsiteX8" fmla="*/ 13646 w 250839"/>
                    <a:gd name="connsiteY8" fmla="*/ 139700 h 1096433"/>
                    <a:gd name="connsiteX9" fmla="*/ 26346 w 250839"/>
                    <a:gd name="connsiteY9" fmla="*/ 177800 h 1096433"/>
                    <a:gd name="connsiteX10" fmla="*/ 22113 w 250839"/>
                    <a:gd name="connsiteY10" fmla="*/ 190500 h 1096433"/>
                    <a:gd name="connsiteX11" fmla="*/ 9413 w 250839"/>
                    <a:gd name="connsiteY11" fmla="*/ 198967 h 1096433"/>
                    <a:gd name="connsiteX12" fmla="*/ 13646 w 250839"/>
                    <a:gd name="connsiteY12" fmla="*/ 228600 h 1096433"/>
                    <a:gd name="connsiteX13" fmla="*/ 17880 w 250839"/>
                    <a:gd name="connsiteY13" fmla="*/ 241300 h 1096433"/>
                    <a:gd name="connsiteX14" fmla="*/ 30580 w 250839"/>
                    <a:gd name="connsiteY14" fmla="*/ 245533 h 1096433"/>
                    <a:gd name="connsiteX15" fmla="*/ 34813 w 250839"/>
                    <a:gd name="connsiteY15" fmla="*/ 258233 h 1096433"/>
                    <a:gd name="connsiteX16" fmla="*/ 39046 w 250839"/>
                    <a:gd name="connsiteY16" fmla="*/ 292100 h 1096433"/>
                    <a:gd name="connsiteX17" fmla="*/ 22113 w 250839"/>
                    <a:gd name="connsiteY17" fmla="*/ 317500 h 1096433"/>
                    <a:gd name="connsiteX18" fmla="*/ 30580 w 250839"/>
                    <a:gd name="connsiteY18" fmla="*/ 347133 h 1096433"/>
                    <a:gd name="connsiteX19" fmla="*/ 43280 w 250839"/>
                    <a:gd name="connsiteY19" fmla="*/ 351367 h 1096433"/>
                    <a:gd name="connsiteX20" fmla="*/ 47513 w 250839"/>
                    <a:gd name="connsiteY20" fmla="*/ 364067 h 1096433"/>
                    <a:gd name="connsiteX21" fmla="*/ 60213 w 250839"/>
                    <a:gd name="connsiteY21" fmla="*/ 368300 h 1096433"/>
                    <a:gd name="connsiteX22" fmla="*/ 72913 w 250839"/>
                    <a:gd name="connsiteY22" fmla="*/ 406400 h 1096433"/>
                    <a:gd name="connsiteX23" fmla="*/ 81380 w 250839"/>
                    <a:gd name="connsiteY23" fmla="*/ 431800 h 1096433"/>
                    <a:gd name="connsiteX24" fmla="*/ 85613 w 250839"/>
                    <a:gd name="connsiteY24" fmla="*/ 444500 h 1096433"/>
                    <a:gd name="connsiteX25" fmla="*/ 81380 w 250839"/>
                    <a:gd name="connsiteY25" fmla="*/ 537633 h 1096433"/>
                    <a:gd name="connsiteX26" fmla="*/ 77146 w 250839"/>
                    <a:gd name="connsiteY26" fmla="*/ 550333 h 1096433"/>
                    <a:gd name="connsiteX27" fmla="*/ 64446 w 250839"/>
                    <a:gd name="connsiteY27" fmla="*/ 554567 h 1096433"/>
                    <a:gd name="connsiteX28" fmla="*/ 51746 w 250839"/>
                    <a:gd name="connsiteY28" fmla="*/ 563033 h 1096433"/>
                    <a:gd name="connsiteX29" fmla="*/ 47513 w 250839"/>
                    <a:gd name="connsiteY29" fmla="*/ 588433 h 1096433"/>
                    <a:gd name="connsiteX30" fmla="*/ 39046 w 250839"/>
                    <a:gd name="connsiteY30" fmla="*/ 613833 h 1096433"/>
                    <a:gd name="connsiteX31" fmla="*/ 43280 w 250839"/>
                    <a:gd name="connsiteY31" fmla="*/ 656167 h 1096433"/>
                    <a:gd name="connsiteX32" fmla="*/ 39046 w 250839"/>
                    <a:gd name="connsiteY32" fmla="*/ 668867 h 1096433"/>
                    <a:gd name="connsiteX33" fmla="*/ 43280 w 250839"/>
                    <a:gd name="connsiteY33" fmla="*/ 698500 h 1096433"/>
                    <a:gd name="connsiteX34" fmla="*/ 30580 w 250839"/>
                    <a:gd name="connsiteY34" fmla="*/ 728133 h 1096433"/>
                    <a:gd name="connsiteX35" fmla="*/ 22113 w 250839"/>
                    <a:gd name="connsiteY35" fmla="*/ 753533 h 1096433"/>
                    <a:gd name="connsiteX36" fmla="*/ 39046 w 250839"/>
                    <a:gd name="connsiteY36" fmla="*/ 778933 h 1096433"/>
                    <a:gd name="connsiteX37" fmla="*/ 55980 w 250839"/>
                    <a:gd name="connsiteY37" fmla="*/ 804333 h 1096433"/>
                    <a:gd name="connsiteX38" fmla="*/ 47513 w 250839"/>
                    <a:gd name="connsiteY38" fmla="*/ 842433 h 1096433"/>
                    <a:gd name="connsiteX39" fmla="*/ 39046 w 250839"/>
                    <a:gd name="connsiteY39" fmla="*/ 855133 h 1096433"/>
                    <a:gd name="connsiteX40" fmla="*/ 43280 w 250839"/>
                    <a:gd name="connsiteY40" fmla="*/ 901700 h 1096433"/>
                    <a:gd name="connsiteX41" fmla="*/ 55980 w 250839"/>
                    <a:gd name="connsiteY41" fmla="*/ 905933 h 1096433"/>
                    <a:gd name="connsiteX42" fmla="*/ 81380 w 250839"/>
                    <a:gd name="connsiteY42" fmla="*/ 922867 h 1096433"/>
                    <a:gd name="connsiteX43" fmla="*/ 94080 w 250839"/>
                    <a:gd name="connsiteY43" fmla="*/ 931333 h 1096433"/>
                    <a:gd name="connsiteX44" fmla="*/ 106780 w 250839"/>
                    <a:gd name="connsiteY44" fmla="*/ 956733 h 1096433"/>
                    <a:gd name="connsiteX45" fmla="*/ 98313 w 250839"/>
                    <a:gd name="connsiteY45" fmla="*/ 1007533 h 1096433"/>
                    <a:gd name="connsiteX46" fmla="*/ 89846 w 250839"/>
                    <a:gd name="connsiteY46" fmla="*/ 1020233 h 1096433"/>
                    <a:gd name="connsiteX47" fmla="*/ 85613 w 250839"/>
                    <a:gd name="connsiteY47" fmla="*/ 1062567 h 1096433"/>
                    <a:gd name="connsiteX48" fmla="*/ 89846 w 250839"/>
                    <a:gd name="connsiteY48" fmla="*/ 1075267 h 1096433"/>
                    <a:gd name="connsiteX49" fmla="*/ 102546 w 250839"/>
                    <a:gd name="connsiteY49" fmla="*/ 1079500 h 1096433"/>
                    <a:gd name="connsiteX50" fmla="*/ 115246 w 250839"/>
                    <a:gd name="connsiteY50" fmla="*/ 1087967 h 1096433"/>
                    <a:gd name="connsiteX51" fmla="*/ 140646 w 250839"/>
                    <a:gd name="connsiteY51" fmla="*/ 1096433 h 1096433"/>
                    <a:gd name="connsiteX52" fmla="*/ 191446 w 250839"/>
                    <a:gd name="connsiteY52" fmla="*/ 1092200 h 1096433"/>
                    <a:gd name="connsiteX53" fmla="*/ 212613 w 250839"/>
                    <a:gd name="connsiteY53" fmla="*/ 1087967 h 1096433"/>
                    <a:gd name="connsiteX54" fmla="*/ 225313 w 250839"/>
                    <a:gd name="connsiteY54" fmla="*/ 1041400 h 1096433"/>
                    <a:gd name="connsiteX55" fmla="*/ 238013 w 250839"/>
                    <a:gd name="connsiteY55" fmla="*/ 1037167 h 1096433"/>
                    <a:gd name="connsiteX56" fmla="*/ 242246 w 250839"/>
                    <a:gd name="connsiteY56" fmla="*/ 1016000 h 1096433"/>
                    <a:gd name="connsiteX57" fmla="*/ 250713 w 250839"/>
                    <a:gd name="connsiteY57" fmla="*/ 1003300 h 1096433"/>
                    <a:gd name="connsiteX58" fmla="*/ 242246 w 250839"/>
                    <a:gd name="connsiteY58" fmla="*/ 905933 h 1096433"/>
                    <a:gd name="connsiteX59" fmla="*/ 238013 w 250839"/>
                    <a:gd name="connsiteY59" fmla="*/ 893233 h 1096433"/>
                    <a:gd name="connsiteX60" fmla="*/ 225313 w 250839"/>
                    <a:gd name="connsiteY60" fmla="*/ 884767 h 1096433"/>
                    <a:gd name="connsiteX61" fmla="*/ 221080 w 250839"/>
                    <a:gd name="connsiteY61" fmla="*/ 872067 h 1096433"/>
                    <a:gd name="connsiteX62" fmla="*/ 195680 w 250839"/>
                    <a:gd name="connsiteY62" fmla="*/ 855133 h 1096433"/>
                    <a:gd name="connsiteX63" fmla="*/ 170280 w 250839"/>
                    <a:gd name="connsiteY63" fmla="*/ 833967 h 1096433"/>
                    <a:gd name="connsiteX64" fmla="*/ 161813 w 250839"/>
                    <a:gd name="connsiteY64" fmla="*/ 821267 h 1096433"/>
                    <a:gd name="connsiteX65" fmla="*/ 140646 w 250839"/>
                    <a:gd name="connsiteY65" fmla="*/ 800100 h 1096433"/>
                    <a:gd name="connsiteX66" fmla="*/ 132180 w 250839"/>
                    <a:gd name="connsiteY66" fmla="*/ 745067 h 1096433"/>
                    <a:gd name="connsiteX67" fmla="*/ 136413 w 250839"/>
                    <a:gd name="connsiteY67" fmla="*/ 681567 h 1096433"/>
                    <a:gd name="connsiteX68" fmla="*/ 140646 w 250839"/>
                    <a:gd name="connsiteY68" fmla="*/ 664633 h 1096433"/>
                    <a:gd name="connsiteX69" fmla="*/ 153346 w 250839"/>
                    <a:gd name="connsiteY69" fmla="*/ 651933 h 1096433"/>
                    <a:gd name="connsiteX70" fmla="*/ 174513 w 250839"/>
                    <a:gd name="connsiteY70" fmla="*/ 618067 h 1096433"/>
                    <a:gd name="connsiteX71" fmla="*/ 191446 w 250839"/>
                    <a:gd name="connsiteY71" fmla="*/ 579967 h 1096433"/>
                    <a:gd name="connsiteX72" fmla="*/ 191446 w 250839"/>
                    <a:gd name="connsiteY72" fmla="*/ 524933 h 1096433"/>
                    <a:gd name="connsiteX73" fmla="*/ 208380 w 250839"/>
                    <a:gd name="connsiteY73" fmla="*/ 520700 h 1096433"/>
                    <a:gd name="connsiteX74" fmla="*/ 212613 w 250839"/>
                    <a:gd name="connsiteY74" fmla="*/ 508000 h 1096433"/>
                    <a:gd name="connsiteX75" fmla="*/ 199913 w 250839"/>
                    <a:gd name="connsiteY75" fmla="*/ 431800 h 1096433"/>
                    <a:gd name="connsiteX76" fmla="*/ 195680 w 250839"/>
                    <a:gd name="connsiteY76" fmla="*/ 419100 h 1096433"/>
                    <a:gd name="connsiteX77" fmla="*/ 187213 w 250839"/>
                    <a:gd name="connsiteY77" fmla="*/ 406400 h 1096433"/>
                    <a:gd name="connsiteX78" fmla="*/ 174513 w 250839"/>
                    <a:gd name="connsiteY78" fmla="*/ 381000 h 1096433"/>
                    <a:gd name="connsiteX79" fmla="*/ 170280 w 250839"/>
                    <a:gd name="connsiteY79" fmla="*/ 368300 h 1096433"/>
                    <a:gd name="connsiteX80" fmla="*/ 178746 w 250839"/>
                    <a:gd name="connsiteY80" fmla="*/ 287867 h 1096433"/>
                    <a:gd name="connsiteX81" fmla="*/ 182980 w 250839"/>
                    <a:gd name="connsiteY81" fmla="*/ 270933 h 1096433"/>
                    <a:gd name="connsiteX82" fmla="*/ 208380 w 250839"/>
                    <a:gd name="connsiteY82" fmla="*/ 254000 h 1096433"/>
                    <a:gd name="connsiteX83" fmla="*/ 195680 w 250839"/>
                    <a:gd name="connsiteY83" fmla="*/ 190500 h 1096433"/>
                    <a:gd name="connsiteX84" fmla="*/ 187213 w 250839"/>
                    <a:gd name="connsiteY84" fmla="*/ 177800 h 1096433"/>
                    <a:gd name="connsiteX85" fmla="*/ 182980 w 250839"/>
                    <a:gd name="connsiteY85" fmla="*/ 160867 h 1096433"/>
                    <a:gd name="connsiteX86" fmla="*/ 157580 w 250839"/>
                    <a:gd name="connsiteY86" fmla="*/ 148167 h 1096433"/>
                    <a:gd name="connsiteX87" fmla="*/ 140646 w 250839"/>
                    <a:gd name="connsiteY87" fmla="*/ 122767 h 1096433"/>
                    <a:gd name="connsiteX88" fmla="*/ 127946 w 250839"/>
                    <a:gd name="connsiteY88" fmla="*/ 97367 h 1096433"/>
                    <a:gd name="connsiteX89" fmla="*/ 119480 w 250839"/>
                    <a:gd name="connsiteY89" fmla="*/ 33867 h 1096433"/>
                    <a:gd name="connsiteX90" fmla="*/ 111013 w 250839"/>
                    <a:gd name="connsiteY90" fmla="*/ 21167 h 1096433"/>
                    <a:gd name="connsiteX91" fmla="*/ 98313 w 250839"/>
                    <a:gd name="connsiteY91" fmla="*/ 12700 h 1096433"/>
                    <a:gd name="connsiteX92" fmla="*/ 22113 w 250839"/>
                    <a:gd name="connsiteY92" fmla="*/ 0 h 109643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Lst>
                  <a:rect l="l" t="t" r="r" b="b"/>
                  <a:pathLst>
                    <a:path w="250839" h="1096433">
                      <a:moveTo>
                        <a:pt x="22113" y="0"/>
                      </a:moveTo>
                      <a:cubicBezTo>
                        <a:pt x="5885" y="0"/>
                        <a:pt x="5510" y="5854"/>
                        <a:pt x="946" y="12700"/>
                      </a:cubicBezTo>
                      <a:cubicBezTo>
                        <a:pt x="-1529" y="16413"/>
                        <a:pt x="1189" y="23404"/>
                        <a:pt x="5180" y="25400"/>
                      </a:cubicBezTo>
                      <a:cubicBezTo>
                        <a:pt x="14105" y="29862"/>
                        <a:pt x="24935" y="28222"/>
                        <a:pt x="34813" y="29633"/>
                      </a:cubicBezTo>
                      <a:cubicBezTo>
                        <a:pt x="54221" y="58746"/>
                        <a:pt x="48528" y="45380"/>
                        <a:pt x="55980" y="67733"/>
                      </a:cubicBezTo>
                      <a:cubicBezTo>
                        <a:pt x="54273" y="76269"/>
                        <a:pt x="53245" y="95372"/>
                        <a:pt x="43280" y="101600"/>
                      </a:cubicBezTo>
                      <a:cubicBezTo>
                        <a:pt x="35712" y="106330"/>
                        <a:pt x="17880" y="110067"/>
                        <a:pt x="17880" y="110067"/>
                      </a:cubicBezTo>
                      <a:cubicBezTo>
                        <a:pt x="15058" y="114300"/>
                        <a:pt x="10133" y="117730"/>
                        <a:pt x="9413" y="122767"/>
                      </a:cubicBezTo>
                      <a:cubicBezTo>
                        <a:pt x="8590" y="128527"/>
                        <a:pt x="12505" y="133995"/>
                        <a:pt x="13646" y="139700"/>
                      </a:cubicBezTo>
                      <a:cubicBezTo>
                        <a:pt x="20164" y="172290"/>
                        <a:pt x="12261" y="156671"/>
                        <a:pt x="26346" y="177800"/>
                      </a:cubicBezTo>
                      <a:cubicBezTo>
                        <a:pt x="24935" y="182033"/>
                        <a:pt x="24901" y="187015"/>
                        <a:pt x="22113" y="190500"/>
                      </a:cubicBezTo>
                      <a:cubicBezTo>
                        <a:pt x="18935" y="194473"/>
                        <a:pt x="10517" y="194000"/>
                        <a:pt x="9413" y="198967"/>
                      </a:cubicBezTo>
                      <a:cubicBezTo>
                        <a:pt x="7248" y="208707"/>
                        <a:pt x="11689" y="218816"/>
                        <a:pt x="13646" y="228600"/>
                      </a:cubicBezTo>
                      <a:cubicBezTo>
                        <a:pt x="14521" y="232976"/>
                        <a:pt x="14725" y="238145"/>
                        <a:pt x="17880" y="241300"/>
                      </a:cubicBezTo>
                      <a:cubicBezTo>
                        <a:pt x="21035" y="244455"/>
                        <a:pt x="26347" y="244122"/>
                        <a:pt x="30580" y="245533"/>
                      </a:cubicBezTo>
                      <a:cubicBezTo>
                        <a:pt x="31991" y="249766"/>
                        <a:pt x="32817" y="254242"/>
                        <a:pt x="34813" y="258233"/>
                      </a:cubicBezTo>
                      <a:cubicBezTo>
                        <a:pt x="43322" y="275252"/>
                        <a:pt x="49863" y="268303"/>
                        <a:pt x="39046" y="292100"/>
                      </a:cubicBezTo>
                      <a:cubicBezTo>
                        <a:pt x="34835" y="301364"/>
                        <a:pt x="22113" y="317500"/>
                        <a:pt x="22113" y="317500"/>
                      </a:cubicBezTo>
                      <a:cubicBezTo>
                        <a:pt x="22150" y="317649"/>
                        <a:pt x="28554" y="345107"/>
                        <a:pt x="30580" y="347133"/>
                      </a:cubicBezTo>
                      <a:cubicBezTo>
                        <a:pt x="33735" y="350288"/>
                        <a:pt x="39047" y="349956"/>
                        <a:pt x="43280" y="351367"/>
                      </a:cubicBezTo>
                      <a:cubicBezTo>
                        <a:pt x="44691" y="355600"/>
                        <a:pt x="44358" y="360912"/>
                        <a:pt x="47513" y="364067"/>
                      </a:cubicBezTo>
                      <a:cubicBezTo>
                        <a:pt x="50668" y="367222"/>
                        <a:pt x="57619" y="364669"/>
                        <a:pt x="60213" y="368300"/>
                      </a:cubicBezTo>
                      <a:cubicBezTo>
                        <a:pt x="60215" y="368303"/>
                        <a:pt x="70796" y="400048"/>
                        <a:pt x="72913" y="406400"/>
                      </a:cubicBezTo>
                      <a:lnTo>
                        <a:pt x="81380" y="431800"/>
                      </a:lnTo>
                      <a:lnTo>
                        <a:pt x="85613" y="444500"/>
                      </a:lnTo>
                      <a:cubicBezTo>
                        <a:pt x="84202" y="475544"/>
                        <a:pt x="83858" y="506656"/>
                        <a:pt x="81380" y="537633"/>
                      </a:cubicBezTo>
                      <a:cubicBezTo>
                        <a:pt x="81024" y="542081"/>
                        <a:pt x="80301" y="547178"/>
                        <a:pt x="77146" y="550333"/>
                      </a:cubicBezTo>
                      <a:cubicBezTo>
                        <a:pt x="73991" y="553488"/>
                        <a:pt x="68437" y="552571"/>
                        <a:pt x="64446" y="554567"/>
                      </a:cubicBezTo>
                      <a:cubicBezTo>
                        <a:pt x="59895" y="556842"/>
                        <a:pt x="55979" y="560211"/>
                        <a:pt x="51746" y="563033"/>
                      </a:cubicBezTo>
                      <a:cubicBezTo>
                        <a:pt x="50335" y="571500"/>
                        <a:pt x="49595" y="580106"/>
                        <a:pt x="47513" y="588433"/>
                      </a:cubicBezTo>
                      <a:cubicBezTo>
                        <a:pt x="45348" y="597091"/>
                        <a:pt x="39046" y="613833"/>
                        <a:pt x="39046" y="613833"/>
                      </a:cubicBezTo>
                      <a:cubicBezTo>
                        <a:pt x="40457" y="627944"/>
                        <a:pt x="43280" y="641985"/>
                        <a:pt x="43280" y="656167"/>
                      </a:cubicBezTo>
                      <a:cubicBezTo>
                        <a:pt x="43280" y="660629"/>
                        <a:pt x="39046" y="664405"/>
                        <a:pt x="39046" y="668867"/>
                      </a:cubicBezTo>
                      <a:cubicBezTo>
                        <a:pt x="39046" y="678845"/>
                        <a:pt x="41869" y="688622"/>
                        <a:pt x="43280" y="698500"/>
                      </a:cubicBezTo>
                      <a:cubicBezTo>
                        <a:pt x="32079" y="743295"/>
                        <a:pt x="47286" y="690543"/>
                        <a:pt x="30580" y="728133"/>
                      </a:cubicBezTo>
                      <a:cubicBezTo>
                        <a:pt x="26955" y="736289"/>
                        <a:pt x="22113" y="753533"/>
                        <a:pt x="22113" y="753533"/>
                      </a:cubicBezTo>
                      <a:cubicBezTo>
                        <a:pt x="30923" y="788776"/>
                        <a:pt x="18582" y="755546"/>
                        <a:pt x="39046" y="778933"/>
                      </a:cubicBezTo>
                      <a:cubicBezTo>
                        <a:pt x="45747" y="786591"/>
                        <a:pt x="55980" y="804333"/>
                        <a:pt x="55980" y="804333"/>
                      </a:cubicBezTo>
                      <a:cubicBezTo>
                        <a:pt x="54355" y="814083"/>
                        <a:pt x="52723" y="832014"/>
                        <a:pt x="47513" y="842433"/>
                      </a:cubicBezTo>
                      <a:cubicBezTo>
                        <a:pt x="45238" y="846984"/>
                        <a:pt x="41868" y="850900"/>
                        <a:pt x="39046" y="855133"/>
                      </a:cubicBezTo>
                      <a:cubicBezTo>
                        <a:pt x="40457" y="870655"/>
                        <a:pt x="38351" y="886914"/>
                        <a:pt x="43280" y="901700"/>
                      </a:cubicBezTo>
                      <a:cubicBezTo>
                        <a:pt x="44691" y="905933"/>
                        <a:pt x="52079" y="903766"/>
                        <a:pt x="55980" y="905933"/>
                      </a:cubicBezTo>
                      <a:cubicBezTo>
                        <a:pt x="64875" y="910875"/>
                        <a:pt x="72913" y="917222"/>
                        <a:pt x="81380" y="922867"/>
                      </a:cubicBezTo>
                      <a:lnTo>
                        <a:pt x="94080" y="931333"/>
                      </a:lnTo>
                      <a:cubicBezTo>
                        <a:pt x="98359" y="937752"/>
                        <a:pt x="106780" y="947972"/>
                        <a:pt x="106780" y="956733"/>
                      </a:cubicBezTo>
                      <a:cubicBezTo>
                        <a:pt x="106780" y="966117"/>
                        <a:pt x="104936" y="994287"/>
                        <a:pt x="98313" y="1007533"/>
                      </a:cubicBezTo>
                      <a:cubicBezTo>
                        <a:pt x="96038" y="1012084"/>
                        <a:pt x="92668" y="1016000"/>
                        <a:pt x="89846" y="1020233"/>
                      </a:cubicBezTo>
                      <a:cubicBezTo>
                        <a:pt x="80295" y="1048888"/>
                        <a:pt x="78724" y="1038451"/>
                        <a:pt x="85613" y="1062567"/>
                      </a:cubicBezTo>
                      <a:cubicBezTo>
                        <a:pt x="86839" y="1066858"/>
                        <a:pt x="86691" y="1072112"/>
                        <a:pt x="89846" y="1075267"/>
                      </a:cubicBezTo>
                      <a:cubicBezTo>
                        <a:pt x="93001" y="1078422"/>
                        <a:pt x="98313" y="1078089"/>
                        <a:pt x="102546" y="1079500"/>
                      </a:cubicBezTo>
                      <a:cubicBezTo>
                        <a:pt x="106779" y="1082322"/>
                        <a:pt x="110597" y="1085901"/>
                        <a:pt x="115246" y="1087967"/>
                      </a:cubicBezTo>
                      <a:cubicBezTo>
                        <a:pt x="123401" y="1091592"/>
                        <a:pt x="140646" y="1096433"/>
                        <a:pt x="140646" y="1096433"/>
                      </a:cubicBezTo>
                      <a:cubicBezTo>
                        <a:pt x="157579" y="1095022"/>
                        <a:pt x="174570" y="1094185"/>
                        <a:pt x="191446" y="1092200"/>
                      </a:cubicBezTo>
                      <a:cubicBezTo>
                        <a:pt x="198592" y="1091359"/>
                        <a:pt x="208622" y="1093954"/>
                        <a:pt x="212613" y="1087967"/>
                      </a:cubicBezTo>
                      <a:cubicBezTo>
                        <a:pt x="229605" y="1062480"/>
                        <a:pt x="205111" y="1057561"/>
                        <a:pt x="225313" y="1041400"/>
                      </a:cubicBezTo>
                      <a:cubicBezTo>
                        <a:pt x="228798" y="1038612"/>
                        <a:pt x="233780" y="1038578"/>
                        <a:pt x="238013" y="1037167"/>
                      </a:cubicBezTo>
                      <a:cubicBezTo>
                        <a:pt x="239424" y="1030111"/>
                        <a:pt x="239720" y="1022737"/>
                        <a:pt x="242246" y="1016000"/>
                      </a:cubicBezTo>
                      <a:cubicBezTo>
                        <a:pt x="244032" y="1011236"/>
                        <a:pt x="250713" y="1008388"/>
                        <a:pt x="250713" y="1003300"/>
                      </a:cubicBezTo>
                      <a:cubicBezTo>
                        <a:pt x="250713" y="970722"/>
                        <a:pt x="252547" y="936840"/>
                        <a:pt x="242246" y="905933"/>
                      </a:cubicBezTo>
                      <a:cubicBezTo>
                        <a:pt x="240835" y="901700"/>
                        <a:pt x="240801" y="896717"/>
                        <a:pt x="238013" y="893233"/>
                      </a:cubicBezTo>
                      <a:cubicBezTo>
                        <a:pt x="234835" y="889260"/>
                        <a:pt x="229546" y="887589"/>
                        <a:pt x="225313" y="884767"/>
                      </a:cubicBezTo>
                      <a:cubicBezTo>
                        <a:pt x="223902" y="880534"/>
                        <a:pt x="224235" y="875222"/>
                        <a:pt x="221080" y="872067"/>
                      </a:cubicBezTo>
                      <a:cubicBezTo>
                        <a:pt x="213885" y="864872"/>
                        <a:pt x="202875" y="862328"/>
                        <a:pt x="195680" y="855133"/>
                      </a:cubicBezTo>
                      <a:cubicBezTo>
                        <a:pt x="179382" y="838835"/>
                        <a:pt x="187961" y="845754"/>
                        <a:pt x="170280" y="833967"/>
                      </a:cubicBezTo>
                      <a:cubicBezTo>
                        <a:pt x="167458" y="829734"/>
                        <a:pt x="165411" y="824865"/>
                        <a:pt x="161813" y="821267"/>
                      </a:cubicBezTo>
                      <a:cubicBezTo>
                        <a:pt x="133590" y="793044"/>
                        <a:pt x="163225" y="833967"/>
                        <a:pt x="140646" y="800100"/>
                      </a:cubicBezTo>
                      <a:cubicBezTo>
                        <a:pt x="137424" y="783987"/>
                        <a:pt x="132180" y="760443"/>
                        <a:pt x="132180" y="745067"/>
                      </a:cubicBezTo>
                      <a:cubicBezTo>
                        <a:pt x="132180" y="723853"/>
                        <a:pt x="134192" y="702664"/>
                        <a:pt x="136413" y="681567"/>
                      </a:cubicBezTo>
                      <a:cubicBezTo>
                        <a:pt x="137022" y="675781"/>
                        <a:pt x="137759" y="669685"/>
                        <a:pt x="140646" y="664633"/>
                      </a:cubicBezTo>
                      <a:cubicBezTo>
                        <a:pt x="143616" y="659435"/>
                        <a:pt x="149113" y="656166"/>
                        <a:pt x="153346" y="651933"/>
                      </a:cubicBezTo>
                      <a:cubicBezTo>
                        <a:pt x="163422" y="621706"/>
                        <a:pt x="154387" y="631483"/>
                        <a:pt x="174513" y="618067"/>
                      </a:cubicBezTo>
                      <a:cubicBezTo>
                        <a:pt x="184589" y="587840"/>
                        <a:pt x="178030" y="600093"/>
                        <a:pt x="191446" y="579967"/>
                      </a:cubicBezTo>
                      <a:cubicBezTo>
                        <a:pt x="188902" y="564702"/>
                        <a:pt x="182129" y="539840"/>
                        <a:pt x="191446" y="524933"/>
                      </a:cubicBezTo>
                      <a:cubicBezTo>
                        <a:pt x="194530" y="519999"/>
                        <a:pt x="202735" y="522111"/>
                        <a:pt x="208380" y="520700"/>
                      </a:cubicBezTo>
                      <a:cubicBezTo>
                        <a:pt x="209791" y="516467"/>
                        <a:pt x="212613" y="512462"/>
                        <a:pt x="212613" y="508000"/>
                      </a:cubicBezTo>
                      <a:cubicBezTo>
                        <a:pt x="212613" y="463225"/>
                        <a:pt x="211141" y="465484"/>
                        <a:pt x="199913" y="431800"/>
                      </a:cubicBezTo>
                      <a:cubicBezTo>
                        <a:pt x="198502" y="427567"/>
                        <a:pt x="198155" y="422813"/>
                        <a:pt x="195680" y="419100"/>
                      </a:cubicBezTo>
                      <a:lnTo>
                        <a:pt x="187213" y="406400"/>
                      </a:lnTo>
                      <a:cubicBezTo>
                        <a:pt x="176573" y="374478"/>
                        <a:pt x="190926" y="413826"/>
                        <a:pt x="174513" y="381000"/>
                      </a:cubicBezTo>
                      <a:cubicBezTo>
                        <a:pt x="172517" y="377009"/>
                        <a:pt x="171691" y="372533"/>
                        <a:pt x="170280" y="368300"/>
                      </a:cubicBezTo>
                      <a:cubicBezTo>
                        <a:pt x="172733" y="338861"/>
                        <a:pt x="173642" y="315939"/>
                        <a:pt x="178746" y="287867"/>
                      </a:cubicBezTo>
                      <a:cubicBezTo>
                        <a:pt x="179787" y="282142"/>
                        <a:pt x="179149" y="275312"/>
                        <a:pt x="182980" y="270933"/>
                      </a:cubicBezTo>
                      <a:cubicBezTo>
                        <a:pt x="189681" y="263275"/>
                        <a:pt x="208380" y="254000"/>
                        <a:pt x="208380" y="254000"/>
                      </a:cubicBezTo>
                      <a:cubicBezTo>
                        <a:pt x="206743" y="239269"/>
                        <a:pt x="205684" y="205506"/>
                        <a:pt x="195680" y="190500"/>
                      </a:cubicBezTo>
                      <a:lnTo>
                        <a:pt x="187213" y="177800"/>
                      </a:lnTo>
                      <a:cubicBezTo>
                        <a:pt x="185802" y="172156"/>
                        <a:pt x="186207" y="165708"/>
                        <a:pt x="182980" y="160867"/>
                      </a:cubicBezTo>
                      <a:cubicBezTo>
                        <a:pt x="178290" y="153832"/>
                        <a:pt x="164825" y="150582"/>
                        <a:pt x="157580" y="148167"/>
                      </a:cubicBezTo>
                      <a:cubicBezTo>
                        <a:pt x="151935" y="139700"/>
                        <a:pt x="143864" y="132421"/>
                        <a:pt x="140646" y="122767"/>
                      </a:cubicBezTo>
                      <a:cubicBezTo>
                        <a:pt x="134804" y="105240"/>
                        <a:pt x="138888" y="113780"/>
                        <a:pt x="127946" y="97367"/>
                      </a:cubicBezTo>
                      <a:cubicBezTo>
                        <a:pt x="114108" y="55849"/>
                        <a:pt x="140200" y="137467"/>
                        <a:pt x="119480" y="33867"/>
                      </a:cubicBezTo>
                      <a:cubicBezTo>
                        <a:pt x="118482" y="28878"/>
                        <a:pt x="114611" y="24765"/>
                        <a:pt x="111013" y="21167"/>
                      </a:cubicBezTo>
                      <a:cubicBezTo>
                        <a:pt x="107415" y="17569"/>
                        <a:pt x="102864" y="14975"/>
                        <a:pt x="98313" y="12700"/>
                      </a:cubicBezTo>
                      <a:cubicBezTo>
                        <a:pt x="74676" y="882"/>
                        <a:pt x="38341" y="0"/>
                        <a:pt x="22113" y="0"/>
                      </a:cubicBezTo>
                      <a:close/>
                    </a:path>
                  </a:pathLst>
                </a:custGeom>
                <a:noFill/>
                <a:ln w="158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89" name="Group 88">
                <a:extLst>
                  <a:ext uri="{FF2B5EF4-FFF2-40B4-BE49-F238E27FC236}">
                    <a16:creationId xmlns:a16="http://schemas.microsoft.com/office/drawing/2014/main" id="{51BC4841-F5B6-47C6-B157-103DBFAE2AB5}"/>
                  </a:ext>
                </a:extLst>
              </p:cNvPr>
              <p:cNvGrpSpPr/>
              <p:nvPr/>
            </p:nvGrpSpPr>
            <p:grpSpPr>
              <a:xfrm>
                <a:off x="7394090" y="1908060"/>
                <a:ext cx="1080000" cy="972000"/>
                <a:chOff x="8215532" y="1916395"/>
                <a:chExt cx="1463040" cy="1097280"/>
              </a:xfrm>
            </p:grpSpPr>
            <p:pic>
              <p:nvPicPr>
                <p:cNvPr id="97" name="Picture 96">
                  <a:extLst>
                    <a:ext uri="{FF2B5EF4-FFF2-40B4-BE49-F238E27FC236}">
                      <a16:creationId xmlns:a16="http://schemas.microsoft.com/office/drawing/2014/main" id="{FC16055B-6F0A-4BFD-B56F-A56846B0D7AC}"/>
                    </a:ext>
                  </a:extLst>
                </p:cNvPr>
                <p:cNvPicPr>
                  <a:picLocks noChangeAspect="1"/>
                </p:cNvPicPr>
                <p:nvPr/>
              </p:nvPicPr>
              <p:blipFill>
                <a:blip r:embed="rId12" cstate="print">
                  <a:extLst>
                    <a:ext uri="{BEBA8EAE-BF5A-486C-A8C5-ECC9F3942E4B}">
                      <a14:imgProps xmlns:a14="http://schemas.microsoft.com/office/drawing/2010/main">
                        <a14:imgLayer r:embed="rId13">
                          <a14:imgEffect>
                            <a14:brightnessContrast bright="40000"/>
                          </a14:imgEffect>
                        </a14:imgLayer>
                      </a14:imgProps>
                    </a:ext>
                    <a:ext uri="{28A0092B-C50C-407E-A947-70E740481C1C}">
                      <a14:useLocalDpi xmlns:a14="http://schemas.microsoft.com/office/drawing/2010/main" val="0"/>
                    </a:ext>
                  </a:extLst>
                </a:blip>
                <a:stretch>
                  <a:fillRect/>
                </a:stretch>
              </p:blipFill>
              <p:spPr>
                <a:xfrm>
                  <a:off x="8215532" y="1916395"/>
                  <a:ext cx="1463040" cy="1097280"/>
                </a:xfrm>
                <a:prstGeom prst="rect">
                  <a:avLst/>
                </a:prstGeom>
              </p:spPr>
            </p:pic>
            <p:sp>
              <p:nvSpPr>
                <p:cNvPr id="98" name="Freeform: Shape 96">
                  <a:extLst>
                    <a:ext uri="{FF2B5EF4-FFF2-40B4-BE49-F238E27FC236}">
                      <a16:creationId xmlns:a16="http://schemas.microsoft.com/office/drawing/2014/main" id="{117D3F05-388C-41E1-8926-E64924D90AFF}"/>
                    </a:ext>
                  </a:extLst>
                </p:cNvPr>
                <p:cNvSpPr/>
                <p:nvPr/>
              </p:nvSpPr>
              <p:spPr>
                <a:xfrm>
                  <a:off x="8822267" y="1922183"/>
                  <a:ext cx="514101" cy="1087717"/>
                </a:xfrm>
                <a:custGeom>
                  <a:avLst/>
                  <a:gdLst>
                    <a:gd name="connsiteX0" fmla="*/ 448733 w 514101"/>
                    <a:gd name="connsiteY0" fmla="*/ 3984 h 1087717"/>
                    <a:gd name="connsiteX1" fmla="*/ 160866 w 514101"/>
                    <a:gd name="connsiteY1" fmla="*/ 3984 h 1087717"/>
                    <a:gd name="connsiteX2" fmla="*/ 156633 w 514101"/>
                    <a:gd name="connsiteY2" fmla="*/ 16684 h 1087717"/>
                    <a:gd name="connsiteX3" fmla="*/ 152400 w 514101"/>
                    <a:gd name="connsiteY3" fmla="*/ 63250 h 1087717"/>
                    <a:gd name="connsiteX4" fmla="*/ 139700 w 514101"/>
                    <a:gd name="connsiteY4" fmla="*/ 67484 h 1087717"/>
                    <a:gd name="connsiteX5" fmla="*/ 156633 w 514101"/>
                    <a:gd name="connsiteY5" fmla="*/ 92884 h 1087717"/>
                    <a:gd name="connsiteX6" fmla="*/ 152400 w 514101"/>
                    <a:gd name="connsiteY6" fmla="*/ 118284 h 1087717"/>
                    <a:gd name="connsiteX7" fmla="*/ 139700 w 514101"/>
                    <a:gd name="connsiteY7" fmla="*/ 122517 h 1087717"/>
                    <a:gd name="connsiteX8" fmla="*/ 143933 w 514101"/>
                    <a:gd name="connsiteY8" fmla="*/ 135217 h 1087717"/>
                    <a:gd name="connsiteX9" fmla="*/ 173566 w 514101"/>
                    <a:gd name="connsiteY9" fmla="*/ 152150 h 1087717"/>
                    <a:gd name="connsiteX10" fmla="*/ 186266 w 514101"/>
                    <a:gd name="connsiteY10" fmla="*/ 202950 h 1087717"/>
                    <a:gd name="connsiteX11" fmla="*/ 182033 w 514101"/>
                    <a:gd name="connsiteY11" fmla="*/ 232584 h 1087717"/>
                    <a:gd name="connsiteX12" fmla="*/ 169333 w 514101"/>
                    <a:gd name="connsiteY12" fmla="*/ 236817 h 1087717"/>
                    <a:gd name="connsiteX13" fmla="*/ 160866 w 514101"/>
                    <a:gd name="connsiteY13" fmla="*/ 262217 h 1087717"/>
                    <a:gd name="connsiteX14" fmla="*/ 156633 w 514101"/>
                    <a:gd name="connsiteY14" fmla="*/ 274917 h 1087717"/>
                    <a:gd name="connsiteX15" fmla="*/ 143933 w 514101"/>
                    <a:gd name="connsiteY15" fmla="*/ 279150 h 1087717"/>
                    <a:gd name="connsiteX16" fmla="*/ 114300 w 514101"/>
                    <a:gd name="connsiteY16" fmla="*/ 287617 h 1087717"/>
                    <a:gd name="connsiteX17" fmla="*/ 84666 w 514101"/>
                    <a:gd name="connsiteY17" fmla="*/ 317250 h 1087717"/>
                    <a:gd name="connsiteX18" fmla="*/ 76200 w 514101"/>
                    <a:gd name="connsiteY18" fmla="*/ 329950 h 1087717"/>
                    <a:gd name="connsiteX19" fmla="*/ 88900 w 514101"/>
                    <a:gd name="connsiteY19" fmla="*/ 342650 h 1087717"/>
                    <a:gd name="connsiteX20" fmla="*/ 93133 w 514101"/>
                    <a:gd name="connsiteY20" fmla="*/ 355350 h 1087717"/>
                    <a:gd name="connsiteX21" fmla="*/ 88900 w 514101"/>
                    <a:gd name="connsiteY21" fmla="*/ 372284 h 1087717"/>
                    <a:gd name="connsiteX22" fmla="*/ 80433 w 514101"/>
                    <a:gd name="connsiteY22" fmla="*/ 384984 h 1087717"/>
                    <a:gd name="connsiteX23" fmla="*/ 93133 w 514101"/>
                    <a:gd name="connsiteY23" fmla="*/ 427317 h 1087717"/>
                    <a:gd name="connsiteX24" fmla="*/ 105833 w 514101"/>
                    <a:gd name="connsiteY24" fmla="*/ 435784 h 1087717"/>
                    <a:gd name="connsiteX25" fmla="*/ 101600 w 514101"/>
                    <a:gd name="connsiteY25" fmla="*/ 452717 h 1087717"/>
                    <a:gd name="connsiteX26" fmla="*/ 88900 w 514101"/>
                    <a:gd name="connsiteY26" fmla="*/ 456950 h 1087717"/>
                    <a:gd name="connsiteX27" fmla="*/ 80433 w 514101"/>
                    <a:gd name="connsiteY27" fmla="*/ 482350 h 1087717"/>
                    <a:gd name="connsiteX28" fmla="*/ 84666 w 514101"/>
                    <a:gd name="connsiteY28" fmla="*/ 495050 h 1087717"/>
                    <a:gd name="connsiteX29" fmla="*/ 76200 w 514101"/>
                    <a:gd name="connsiteY29" fmla="*/ 537384 h 1087717"/>
                    <a:gd name="connsiteX30" fmla="*/ 80433 w 514101"/>
                    <a:gd name="connsiteY30" fmla="*/ 579717 h 1087717"/>
                    <a:gd name="connsiteX31" fmla="*/ 63500 w 514101"/>
                    <a:gd name="connsiteY31" fmla="*/ 706717 h 1087717"/>
                    <a:gd name="connsiteX32" fmla="*/ 55033 w 514101"/>
                    <a:gd name="connsiteY32" fmla="*/ 732117 h 1087717"/>
                    <a:gd name="connsiteX33" fmla="*/ 50800 w 514101"/>
                    <a:gd name="connsiteY33" fmla="*/ 778684 h 1087717"/>
                    <a:gd name="connsiteX34" fmla="*/ 46566 w 514101"/>
                    <a:gd name="connsiteY34" fmla="*/ 791384 h 1087717"/>
                    <a:gd name="connsiteX35" fmla="*/ 33866 w 514101"/>
                    <a:gd name="connsiteY35" fmla="*/ 799850 h 1087717"/>
                    <a:gd name="connsiteX36" fmla="*/ 12700 w 514101"/>
                    <a:gd name="connsiteY36" fmla="*/ 837950 h 1087717"/>
                    <a:gd name="connsiteX37" fmla="*/ 4233 w 514101"/>
                    <a:gd name="connsiteY37" fmla="*/ 850650 h 1087717"/>
                    <a:gd name="connsiteX38" fmla="*/ 0 w 514101"/>
                    <a:gd name="connsiteY38" fmla="*/ 884517 h 1087717"/>
                    <a:gd name="connsiteX39" fmla="*/ 21166 w 514101"/>
                    <a:gd name="connsiteY39" fmla="*/ 901450 h 1087717"/>
                    <a:gd name="connsiteX40" fmla="*/ 46566 w 514101"/>
                    <a:gd name="connsiteY40" fmla="*/ 914150 h 1087717"/>
                    <a:gd name="connsiteX41" fmla="*/ 55033 w 514101"/>
                    <a:gd name="connsiteY41" fmla="*/ 964950 h 1087717"/>
                    <a:gd name="connsiteX42" fmla="*/ 63500 w 514101"/>
                    <a:gd name="connsiteY42" fmla="*/ 977650 h 1087717"/>
                    <a:gd name="connsiteX43" fmla="*/ 59266 w 514101"/>
                    <a:gd name="connsiteY43" fmla="*/ 990350 h 1087717"/>
                    <a:gd name="connsiteX44" fmla="*/ 33866 w 514101"/>
                    <a:gd name="connsiteY44" fmla="*/ 998817 h 1087717"/>
                    <a:gd name="connsiteX45" fmla="*/ 29633 w 514101"/>
                    <a:gd name="connsiteY45" fmla="*/ 1024217 h 1087717"/>
                    <a:gd name="connsiteX46" fmla="*/ 25400 w 514101"/>
                    <a:gd name="connsiteY46" fmla="*/ 1036917 h 1087717"/>
                    <a:gd name="connsiteX47" fmla="*/ 29633 w 514101"/>
                    <a:gd name="connsiteY47" fmla="*/ 1087717 h 1087717"/>
                    <a:gd name="connsiteX48" fmla="*/ 76200 w 514101"/>
                    <a:gd name="connsiteY48" fmla="*/ 1083484 h 1087717"/>
                    <a:gd name="connsiteX49" fmla="*/ 88900 w 514101"/>
                    <a:gd name="connsiteY49" fmla="*/ 1079250 h 1087717"/>
                    <a:gd name="connsiteX50" fmla="*/ 190500 w 514101"/>
                    <a:gd name="connsiteY50" fmla="*/ 1083484 h 1087717"/>
                    <a:gd name="connsiteX51" fmla="*/ 245533 w 514101"/>
                    <a:gd name="connsiteY51" fmla="*/ 1079250 h 1087717"/>
                    <a:gd name="connsiteX52" fmla="*/ 224366 w 514101"/>
                    <a:gd name="connsiteY52" fmla="*/ 1041150 h 1087717"/>
                    <a:gd name="connsiteX53" fmla="*/ 237066 w 514101"/>
                    <a:gd name="connsiteY53" fmla="*/ 1028450 h 1087717"/>
                    <a:gd name="connsiteX54" fmla="*/ 249766 w 514101"/>
                    <a:gd name="connsiteY54" fmla="*/ 1024217 h 1087717"/>
                    <a:gd name="connsiteX55" fmla="*/ 258233 w 514101"/>
                    <a:gd name="connsiteY55" fmla="*/ 1011517 h 1087717"/>
                    <a:gd name="connsiteX56" fmla="*/ 262466 w 514101"/>
                    <a:gd name="connsiteY56" fmla="*/ 986117 h 1087717"/>
                    <a:gd name="connsiteX57" fmla="*/ 270933 w 514101"/>
                    <a:gd name="connsiteY57" fmla="*/ 973417 h 1087717"/>
                    <a:gd name="connsiteX58" fmla="*/ 275166 w 514101"/>
                    <a:gd name="connsiteY58" fmla="*/ 960717 h 1087717"/>
                    <a:gd name="connsiteX59" fmla="*/ 270933 w 514101"/>
                    <a:gd name="connsiteY59" fmla="*/ 897217 h 1087717"/>
                    <a:gd name="connsiteX60" fmla="*/ 279400 w 514101"/>
                    <a:gd name="connsiteY60" fmla="*/ 884517 h 1087717"/>
                    <a:gd name="connsiteX61" fmla="*/ 296333 w 514101"/>
                    <a:gd name="connsiteY61" fmla="*/ 880284 h 1087717"/>
                    <a:gd name="connsiteX62" fmla="*/ 309033 w 514101"/>
                    <a:gd name="connsiteY62" fmla="*/ 829484 h 1087717"/>
                    <a:gd name="connsiteX63" fmla="*/ 313266 w 514101"/>
                    <a:gd name="connsiteY63" fmla="*/ 812550 h 1087717"/>
                    <a:gd name="connsiteX64" fmla="*/ 317500 w 514101"/>
                    <a:gd name="connsiteY64" fmla="*/ 799850 h 1087717"/>
                    <a:gd name="connsiteX65" fmla="*/ 342900 w 514101"/>
                    <a:gd name="connsiteY65" fmla="*/ 791384 h 1087717"/>
                    <a:gd name="connsiteX66" fmla="*/ 355600 w 514101"/>
                    <a:gd name="connsiteY66" fmla="*/ 753284 h 1087717"/>
                    <a:gd name="connsiteX67" fmla="*/ 359833 w 514101"/>
                    <a:gd name="connsiteY67" fmla="*/ 740584 h 1087717"/>
                    <a:gd name="connsiteX68" fmla="*/ 355600 w 514101"/>
                    <a:gd name="connsiteY68" fmla="*/ 715184 h 1087717"/>
                    <a:gd name="connsiteX69" fmla="*/ 342900 w 514101"/>
                    <a:gd name="connsiteY69" fmla="*/ 710950 h 1087717"/>
                    <a:gd name="connsiteX70" fmla="*/ 313266 w 514101"/>
                    <a:gd name="connsiteY70" fmla="*/ 706717 h 1087717"/>
                    <a:gd name="connsiteX71" fmla="*/ 300566 w 514101"/>
                    <a:gd name="connsiteY71" fmla="*/ 702484 h 1087717"/>
                    <a:gd name="connsiteX72" fmla="*/ 300566 w 514101"/>
                    <a:gd name="connsiteY72" fmla="*/ 668617 h 1087717"/>
                    <a:gd name="connsiteX73" fmla="*/ 309033 w 514101"/>
                    <a:gd name="connsiteY73" fmla="*/ 655917 h 1087717"/>
                    <a:gd name="connsiteX74" fmla="*/ 338666 w 514101"/>
                    <a:gd name="connsiteY74" fmla="*/ 647450 h 1087717"/>
                    <a:gd name="connsiteX75" fmla="*/ 351366 w 514101"/>
                    <a:gd name="connsiteY75" fmla="*/ 634750 h 1087717"/>
                    <a:gd name="connsiteX76" fmla="*/ 355600 w 514101"/>
                    <a:gd name="connsiteY76" fmla="*/ 622050 h 1087717"/>
                    <a:gd name="connsiteX77" fmla="*/ 359833 w 514101"/>
                    <a:gd name="connsiteY77" fmla="*/ 490817 h 1087717"/>
                    <a:gd name="connsiteX78" fmla="*/ 364066 w 514101"/>
                    <a:gd name="connsiteY78" fmla="*/ 473884 h 1087717"/>
                    <a:gd name="connsiteX79" fmla="*/ 381000 w 514101"/>
                    <a:gd name="connsiteY79" fmla="*/ 435784 h 1087717"/>
                    <a:gd name="connsiteX80" fmla="*/ 385233 w 514101"/>
                    <a:gd name="connsiteY80" fmla="*/ 414617 h 1087717"/>
                    <a:gd name="connsiteX81" fmla="*/ 410633 w 514101"/>
                    <a:gd name="connsiteY81" fmla="*/ 397684 h 1087717"/>
                    <a:gd name="connsiteX82" fmla="*/ 427566 w 514101"/>
                    <a:gd name="connsiteY82" fmla="*/ 372284 h 1087717"/>
                    <a:gd name="connsiteX83" fmla="*/ 444500 w 514101"/>
                    <a:gd name="connsiteY83" fmla="*/ 334184 h 1087717"/>
                    <a:gd name="connsiteX84" fmla="*/ 431800 w 514101"/>
                    <a:gd name="connsiteY84" fmla="*/ 321484 h 1087717"/>
                    <a:gd name="connsiteX85" fmla="*/ 423333 w 514101"/>
                    <a:gd name="connsiteY85" fmla="*/ 283384 h 1087717"/>
                    <a:gd name="connsiteX86" fmla="*/ 406400 w 514101"/>
                    <a:gd name="connsiteY86" fmla="*/ 257984 h 1087717"/>
                    <a:gd name="connsiteX87" fmla="*/ 402166 w 514101"/>
                    <a:gd name="connsiteY87" fmla="*/ 198717 h 1087717"/>
                    <a:gd name="connsiteX88" fmla="*/ 389466 w 514101"/>
                    <a:gd name="connsiteY88" fmla="*/ 190250 h 1087717"/>
                    <a:gd name="connsiteX89" fmla="*/ 410633 w 514101"/>
                    <a:gd name="connsiteY89" fmla="*/ 147917 h 1087717"/>
                    <a:gd name="connsiteX90" fmla="*/ 423333 w 514101"/>
                    <a:gd name="connsiteY90" fmla="*/ 75950 h 1087717"/>
                    <a:gd name="connsiteX91" fmla="*/ 461433 w 514101"/>
                    <a:gd name="connsiteY91" fmla="*/ 80184 h 1087717"/>
                    <a:gd name="connsiteX92" fmla="*/ 469900 w 514101"/>
                    <a:gd name="connsiteY92" fmla="*/ 92884 h 1087717"/>
                    <a:gd name="connsiteX93" fmla="*/ 482600 w 514101"/>
                    <a:gd name="connsiteY93" fmla="*/ 101350 h 1087717"/>
                    <a:gd name="connsiteX94" fmla="*/ 512233 w 514101"/>
                    <a:gd name="connsiteY94" fmla="*/ 97117 h 1087717"/>
                    <a:gd name="connsiteX95" fmla="*/ 508000 w 514101"/>
                    <a:gd name="connsiteY95" fmla="*/ 71717 h 1087717"/>
                    <a:gd name="connsiteX96" fmla="*/ 503766 w 514101"/>
                    <a:gd name="connsiteY96" fmla="*/ 37850 h 1087717"/>
                    <a:gd name="connsiteX97" fmla="*/ 478366 w 514101"/>
                    <a:gd name="connsiteY97" fmla="*/ 29384 h 1087717"/>
                    <a:gd name="connsiteX98" fmla="*/ 457200 w 514101"/>
                    <a:gd name="connsiteY98" fmla="*/ 8217 h 1087717"/>
                    <a:gd name="connsiteX99" fmla="*/ 444500 w 514101"/>
                    <a:gd name="connsiteY99" fmla="*/ 3984 h 1087717"/>
                    <a:gd name="connsiteX100" fmla="*/ 448733 w 514101"/>
                    <a:gd name="connsiteY100" fmla="*/ 3984 h 108771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Lst>
                  <a:rect l="l" t="t" r="r" b="b"/>
                  <a:pathLst>
                    <a:path w="514101" h="1087717">
                      <a:moveTo>
                        <a:pt x="448733" y="3984"/>
                      </a:moveTo>
                      <a:cubicBezTo>
                        <a:pt x="401461" y="3984"/>
                        <a:pt x="228111" y="-4982"/>
                        <a:pt x="160866" y="3984"/>
                      </a:cubicBezTo>
                      <a:cubicBezTo>
                        <a:pt x="156443" y="4574"/>
                        <a:pt x="158044" y="12451"/>
                        <a:pt x="156633" y="16684"/>
                      </a:cubicBezTo>
                      <a:cubicBezTo>
                        <a:pt x="155222" y="32206"/>
                        <a:pt x="157329" y="48464"/>
                        <a:pt x="152400" y="63250"/>
                      </a:cubicBezTo>
                      <a:cubicBezTo>
                        <a:pt x="150989" y="67483"/>
                        <a:pt x="141357" y="63341"/>
                        <a:pt x="139700" y="67484"/>
                      </a:cubicBezTo>
                      <a:cubicBezTo>
                        <a:pt x="133945" y="81871"/>
                        <a:pt x="148906" y="87732"/>
                        <a:pt x="156633" y="92884"/>
                      </a:cubicBezTo>
                      <a:cubicBezTo>
                        <a:pt x="155222" y="101351"/>
                        <a:pt x="156659" y="110831"/>
                        <a:pt x="152400" y="118284"/>
                      </a:cubicBezTo>
                      <a:cubicBezTo>
                        <a:pt x="150186" y="122158"/>
                        <a:pt x="141696" y="118526"/>
                        <a:pt x="139700" y="122517"/>
                      </a:cubicBezTo>
                      <a:cubicBezTo>
                        <a:pt x="137704" y="126508"/>
                        <a:pt x="141937" y="131226"/>
                        <a:pt x="143933" y="135217"/>
                      </a:cubicBezTo>
                      <a:cubicBezTo>
                        <a:pt x="152930" y="153211"/>
                        <a:pt x="152305" y="147898"/>
                        <a:pt x="173566" y="152150"/>
                      </a:cubicBezTo>
                      <a:cubicBezTo>
                        <a:pt x="184747" y="185693"/>
                        <a:pt x="180566" y="168747"/>
                        <a:pt x="186266" y="202950"/>
                      </a:cubicBezTo>
                      <a:cubicBezTo>
                        <a:pt x="184855" y="212828"/>
                        <a:pt x="186495" y="223659"/>
                        <a:pt x="182033" y="232584"/>
                      </a:cubicBezTo>
                      <a:cubicBezTo>
                        <a:pt x="180037" y="236575"/>
                        <a:pt x="171927" y="233186"/>
                        <a:pt x="169333" y="236817"/>
                      </a:cubicBezTo>
                      <a:cubicBezTo>
                        <a:pt x="164146" y="244079"/>
                        <a:pt x="163688" y="253750"/>
                        <a:pt x="160866" y="262217"/>
                      </a:cubicBezTo>
                      <a:cubicBezTo>
                        <a:pt x="159455" y="266450"/>
                        <a:pt x="160866" y="273506"/>
                        <a:pt x="156633" y="274917"/>
                      </a:cubicBezTo>
                      <a:cubicBezTo>
                        <a:pt x="152400" y="276328"/>
                        <a:pt x="148224" y="277924"/>
                        <a:pt x="143933" y="279150"/>
                      </a:cubicBezTo>
                      <a:cubicBezTo>
                        <a:pt x="106724" y="289782"/>
                        <a:pt x="144750" y="277468"/>
                        <a:pt x="114300" y="287617"/>
                      </a:cubicBezTo>
                      <a:cubicBezTo>
                        <a:pt x="94891" y="316730"/>
                        <a:pt x="107020" y="309799"/>
                        <a:pt x="84666" y="317250"/>
                      </a:cubicBezTo>
                      <a:cubicBezTo>
                        <a:pt x="81844" y="321483"/>
                        <a:pt x="75363" y="324932"/>
                        <a:pt x="76200" y="329950"/>
                      </a:cubicBezTo>
                      <a:cubicBezTo>
                        <a:pt x="77184" y="335855"/>
                        <a:pt x="85579" y="337669"/>
                        <a:pt x="88900" y="342650"/>
                      </a:cubicBezTo>
                      <a:cubicBezTo>
                        <a:pt x="91375" y="346363"/>
                        <a:pt x="91722" y="351117"/>
                        <a:pt x="93133" y="355350"/>
                      </a:cubicBezTo>
                      <a:cubicBezTo>
                        <a:pt x="91722" y="360995"/>
                        <a:pt x="91192" y="366936"/>
                        <a:pt x="88900" y="372284"/>
                      </a:cubicBezTo>
                      <a:cubicBezTo>
                        <a:pt x="86896" y="376961"/>
                        <a:pt x="80939" y="379921"/>
                        <a:pt x="80433" y="384984"/>
                      </a:cubicBezTo>
                      <a:cubicBezTo>
                        <a:pt x="78979" y="399519"/>
                        <a:pt x="82398" y="416582"/>
                        <a:pt x="93133" y="427317"/>
                      </a:cubicBezTo>
                      <a:cubicBezTo>
                        <a:pt x="96731" y="430915"/>
                        <a:pt x="101600" y="432962"/>
                        <a:pt x="105833" y="435784"/>
                      </a:cubicBezTo>
                      <a:cubicBezTo>
                        <a:pt x="104422" y="441428"/>
                        <a:pt x="105235" y="448174"/>
                        <a:pt x="101600" y="452717"/>
                      </a:cubicBezTo>
                      <a:cubicBezTo>
                        <a:pt x="98812" y="456201"/>
                        <a:pt x="91494" y="453319"/>
                        <a:pt x="88900" y="456950"/>
                      </a:cubicBezTo>
                      <a:cubicBezTo>
                        <a:pt x="83713" y="464212"/>
                        <a:pt x="80433" y="482350"/>
                        <a:pt x="80433" y="482350"/>
                      </a:cubicBezTo>
                      <a:cubicBezTo>
                        <a:pt x="81844" y="486583"/>
                        <a:pt x="84666" y="490588"/>
                        <a:pt x="84666" y="495050"/>
                      </a:cubicBezTo>
                      <a:cubicBezTo>
                        <a:pt x="84666" y="505429"/>
                        <a:pt x="78997" y="526195"/>
                        <a:pt x="76200" y="537384"/>
                      </a:cubicBezTo>
                      <a:cubicBezTo>
                        <a:pt x="77611" y="551495"/>
                        <a:pt x="80433" y="565536"/>
                        <a:pt x="80433" y="579717"/>
                      </a:cubicBezTo>
                      <a:cubicBezTo>
                        <a:pt x="80433" y="700391"/>
                        <a:pt x="108528" y="676697"/>
                        <a:pt x="63500" y="706717"/>
                      </a:cubicBezTo>
                      <a:cubicBezTo>
                        <a:pt x="60678" y="715184"/>
                        <a:pt x="55841" y="723229"/>
                        <a:pt x="55033" y="732117"/>
                      </a:cubicBezTo>
                      <a:cubicBezTo>
                        <a:pt x="53622" y="747639"/>
                        <a:pt x="53004" y="763254"/>
                        <a:pt x="50800" y="778684"/>
                      </a:cubicBezTo>
                      <a:cubicBezTo>
                        <a:pt x="50169" y="783102"/>
                        <a:pt x="49354" y="787900"/>
                        <a:pt x="46566" y="791384"/>
                      </a:cubicBezTo>
                      <a:cubicBezTo>
                        <a:pt x="43388" y="795357"/>
                        <a:pt x="38099" y="797028"/>
                        <a:pt x="33866" y="799850"/>
                      </a:cubicBezTo>
                      <a:cubicBezTo>
                        <a:pt x="26416" y="822203"/>
                        <a:pt x="32108" y="808838"/>
                        <a:pt x="12700" y="837950"/>
                      </a:cubicBezTo>
                      <a:lnTo>
                        <a:pt x="4233" y="850650"/>
                      </a:lnTo>
                      <a:cubicBezTo>
                        <a:pt x="2822" y="861939"/>
                        <a:pt x="0" y="873140"/>
                        <a:pt x="0" y="884517"/>
                      </a:cubicBezTo>
                      <a:cubicBezTo>
                        <a:pt x="0" y="901584"/>
                        <a:pt x="7822" y="897637"/>
                        <a:pt x="21166" y="901450"/>
                      </a:cubicBezTo>
                      <a:cubicBezTo>
                        <a:pt x="36500" y="905831"/>
                        <a:pt x="32653" y="904876"/>
                        <a:pt x="46566" y="914150"/>
                      </a:cubicBezTo>
                      <a:cubicBezTo>
                        <a:pt x="47907" y="926215"/>
                        <a:pt x="47942" y="950768"/>
                        <a:pt x="55033" y="964950"/>
                      </a:cubicBezTo>
                      <a:cubicBezTo>
                        <a:pt x="57308" y="969501"/>
                        <a:pt x="60678" y="973417"/>
                        <a:pt x="63500" y="977650"/>
                      </a:cubicBezTo>
                      <a:cubicBezTo>
                        <a:pt x="62089" y="981883"/>
                        <a:pt x="62897" y="987756"/>
                        <a:pt x="59266" y="990350"/>
                      </a:cubicBezTo>
                      <a:cubicBezTo>
                        <a:pt x="52004" y="995537"/>
                        <a:pt x="33866" y="998817"/>
                        <a:pt x="33866" y="998817"/>
                      </a:cubicBezTo>
                      <a:cubicBezTo>
                        <a:pt x="32455" y="1007284"/>
                        <a:pt x="31495" y="1015838"/>
                        <a:pt x="29633" y="1024217"/>
                      </a:cubicBezTo>
                      <a:cubicBezTo>
                        <a:pt x="28665" y="1028573"/>
                        <a:pt x="25400" y="1032455"/>
                        <a:pt x="25400" y="1036917"/>
                      </a:cubicBezTo>
                      <a:cubicBezTo>
                        <a:pt x="25400" y="1053909"/>
                        <a:pt x="28222" y="1070784"/>
                        <a:pt x="29633" y="1087717"/>
                      </a:cubicBezTo>
                      <a:cubicBezTo>
                        <a:pt x="45155" y="1086306"/>
                        <a:pt x="60770" y="1085688"/>
                        <a:pt x="76200" y="1083484"/>
                      </a:cubicBezTo>
                      <a:cubicBezTo>
                        <a:pt x="80618" y="1082853"/>
                        <a:pt x="84438" y="1079250"/>
                        <a:pt x="88900" y="1079250"/>
                      </a:cubicBezTo>
                      <a:cubicBezTo>
                        <a:pt x="122796" y="1079250"/>
                        <a:pt x="156633" y="1082073"/>
                        <a:pt x="190500" y="1083484"/>
                      </a:cubicBezTo>
                      <a:cubicBezTo>
                        <a:pt x="208844" y="1082073"/>
                        <a:pt x="230011" y="1089128"/>
                        <a:pt x="245533" y="1079250"/>
                      </a:cubicBezTo>
                      <a:cubicBezTo>
                        <a:pt x="258195" y="1071192"/>
                        <a:pt x="227933" y="1044717"/>
                        <a:pt x="224366" y="1041150"/>
                      </a:cubicBezTo>
                      <a:cubicBezTo>
                        <a:pt x="228599" y="1036917"/>
                        <a:pt x="232085" y="1031771"/>
                        <a:pt x="237066" y="1028450"/>
                      </a:cubicBezTo>
                      <a:cubicBezTo>
                        <a:pt x="240779" y="1025975"/>
                        <a:pt x="246281" y="1027005"/>
                        <a:pt x="249766" y="1024217"/>
                      </a:cubicBezTo>
                      <a:cubicBezTo>
                        <a:pt x="253739" y="1021039"/>
                        <a:pt x="255411" y="1015750"/>
                        <a:pt x="258233" y="1011517"/>
                      </a:cubicBezTo>
                      <a:cubicBezTo>
                        <a:pt x="259644" y="1003050"/>
                        <a:pt x="259752" y="994260"/>
                        <a:pt x="262466" y="986117"/>
                      </a:cubicBezTo>
                      <a:cubicBezTo>
                        <a:pt x="264075" y="981290"/>
                        <a:pt x="268658" y="977968"/>
                        <a:pt x="270933" y="973417"/>
                      </a:cubicBezTo>
                      <a:cubicBezTo>
                        <a:pt x="272929" y="969426"/>
                        <a:pt x="273755" y="964950"/>
                        <a:pt x="275166" y="960717"/>
                      </a:cubicBezTo>
                      <a:cubicBezTo>
                        <a:pt x="265263" y="931006"/>
                        <a:pt x="261987" y="933002"/>
                        <a:pt x="270933" y="897217"/>
                      </a:cubicBezTo>
                      <a:cubicBezTo>
                        <a:pt x="272167" y="892281"/>
                        <a:pt x="275167" y="887339"/>
                        <a:pt x="279400" y="884517"/>
                      </a:cubicBezTo>
                      <a:cubicBezTo>
                        <a:pt x="284241" y="881290"/>
                        <a:pt x="290689" y="881695"/>
                        <a:pt x="296333" y="880284"/>
                      </a:cubicBezTo>
                      <a:cubicBezTo>
                        <a:pt x="310477" y="837854"/>
                        <a:pt x="300484" y="872235"/>
                        <a:pt x="309033" y="829484"/>
                      </a:cubicBezTo>
                      <a:cubicBezTo>
                        <a:pt x="310174" y="823779"/>
                        <a:pt x="311668" y="818144"/>
                        <a:pt x="313266" y="812550"/>
                      </a:cubicBezTo>
                      <a:cubicBezTo>
                        <a:pt x="314492" y="808259"/>
                        <a:pt x="313869" y="802444"/>
                        <a:pt x="317500" y="799850"/>
                      </a:cubicBezTo>
                      <a:cubicBezTo>
                        <a:pt x="324762" y="794663"/>
                        <a:pt x="342900" y="791384"/>
                        <a:pt x="342900" y="791384"/>
                      </a:cubicBezTo>
                      <a:lnTo>
                        <a:pt x="355600" y="753284"/>
                      </a:lnTo>
                      <a:lnTo>
                        <a:pt x="359833" y="740584"/>
                      </a:lnTo>
                      <a:cubicBezTo>
                        <a:pt x="358422" y="732117"/>
                        <a:pt x="359858" y="722637"/>
                        <a:pt x="355600" y="715184"/>
                      </a:cubicBezTo>
                      <a:cubicBezTo>
                        <a:pt x="353386" y="711310"/>
                        <a:pt x="347276" y="711825"/>
                        <a:pt x="342900" y="710950"/>
                      </a:cubicBezTo>
                      <a:cubicBezTo>
                        <a:pt x="333116" y="708993"/>
                        <a:pt x="323144" y="708128"/>
                        <a:pt x="313266" y="706717"/>
                      </a:cubicBezTo>
                      <a:cubicBezTo>
                        <a:pt x="309033" y="705306"/>
                        <a:pt x="303354" y="705969"/>
                        <a:pt x="300566" y="702484"/>
                      </a:cubicBezTo>
                      <a:cubicBezTo>
                        <a:pt x="293216" y="693296"/>
                        <a:pt x="296628" y="677805"/>
                        <a:pt x="300566" y="668617"/>
                      </a:cubicBezTo>
                      <a:cubicBezTo>
                        <a:pt x="302570" y="663940"/>
                        <a:pt x="305060" y="659095"/>
                        <a:pt x="309033" y="655917"/>
                      </a:cubicBezTo>
                      <a:cubicBezTo>
                        <a:pt x="311792" y="653710"/>
                        <a:pt x="337563" y="647726"/>
                        <a:pt x="338666" y="647450"/>
                      </a:cubicBezTo>
                      <a:cubicBezTo>
                        <a:pt x="342899" y="643217"/>
                        <a:pt x="348045" y="639731"/>
                        <a:pt x="351366" y="634750"/>
                      </a:cubicBezTo>
                      <a:cubicBezTo>
                        <a:pt x="353841" y="631037"/>
                        <a:pt x="355338" y="626505"/>
                        <a:pt x="355600" y="622050"/>
                      </a:cubicBezTo>
                      <a:cubicBezTo>
                        <a:pt x="358170" y="578358"/>
                        <a:pt x="357336" y="534513"/>
                        <a:pt x="359833" y="490817"/>
                      </a:cubicBezTo>
                      <a:cubicBezTo>
                        <a:pt x="360165" y="485008"/>
                        <a:pt x="362394" y="479457"/>
                        <a:pt x="364066" y="473884"/>
                      </a:cubicBezTo>
                      <a:cubicBezTo>
                        <a:pt x="372310" y="446406"/>
                        <a:pt x="368627" y="454343"/>
                        <a:pt x="381000" y="435784"/>
                      </a:cubicBezTo>
                      <a:cubicBezTo>
                        <a:pt x="382411" y="428728"/>
                        <a:pt x="380816" y="420297"/>
                        <a:pt x="385233" y="414617"/>
                      </a:cubicBezTo>
                      <a:cubicBezTo>
                        <a:pt x="391480" y="406585"/>
                        <a:pt x="410633" y="397684"/>
                        <a:pt x="410633" y="397684"/>
                      </a:cubicBezTo>
                      <a:cubicBezTo>
                        <a:pt x="416277" y="389217"/>
                        <a:pt x="424348" y="381937"/>
                        <a:pt x="427566" y="372284"/>
                      </a:cubicBezTo>
                      <a:cubicBezTo>
                        <a:pt x="437642" y="342057"/>
                        <a:pt x="431082" y="354310"/>
                        <a:pt x="444500" y="334184"/>
                      </a:cubicBezTo>
                      <a:cubicBezTo>
                        <a:pt x="440267" y="329951"/>
                        <a:pt x="434232" y="326955"/>
                        <a:pt x="431800" y="321484"/>
                      </a:cubicBezTo>
                      <a:cubicBezTo>
                        <a:pt x="421083" y="297372"/>
                        <a:pt x="433269" y="301269"/>
                        <a:pt x="423333" y="283384"/>
                      </a:cubicBezTo>
                      <a:cubicBezTo>
                        <a:pt x="418391" y="274489"/>
                        <a:pt x="406400" y="257984"/>
                        <a:pt x="406400" y="257984"/>
                      </a:cubicBezTo>
                      <a:cubicBezTo>
                        <a:pt x="404989" y="238228"/>
                        <a:pt x="406970" y="217932"/>
                        <a:pt x="402166" y="198717"/>
                      </a:cubicBezTo>
                      <a:cubicBezTo>
                        <a:pt x="400932" y="193781"/>
                        <a:pt x="390376" y="195256"/>
                        <a:pt x="389466" y="190250"/>
                      </a:cubicBezTo>
                      <a:cubicBezTo>
                        <a:pt x="382047" y="149441"/>
                        <a:pt x="386902" y="153849"/>
                        <a:pt x="410633" y="147917"/>
                      </a:cubicBezTo>
                      <a:cubicBezTo>
                        <a:pt x="424029" y="107731"/>
                        <a:pt x="418292" y="131405"/>
                        <a:pt x="423333" y="75950"/>
                      </a:cubicBezTo>
                      <a:cubicBezTo>
                        <a:pt x="436033" y="77361"/>
                        <a:pt x="449424" y="75817"/>
                        <a:pt x="461433" y="80184"/>
                      </a:cubicBezTo>
                      <a:cubicBezTo>
                        <a:pt x="466215" y="81923"/>
                        <a:pt x="466302" y="89286"/>
                        <a:pt x="469900" y="92884"/>
                      </a:cubicBezTo>
                      <a:cubicBezTo>
                        <a:pt x="473498" y="96481"/>
                        <a:pt x="478367" y="98528"/>
                        <a:pt x="482600" y="101350"/>
                      </a:cubicBezTo>
                      <a:lnTo>
                        <a:pt x="512233" y="97117"/>
                      </a:lnTo>
                      <a:cubicBezTo>
                        <a:pt x="517819" y="90600"/>
                        <a:pt x="509214" y="80214"/>
                        <a:pt x="508000" y="71717"/>
                      </a:cubicBezTo>
                      <a:cubicBezTo>
                        <a:pt x="506391" y="60454"/>
                        <a:pt x="510290" y="47170"/>
                        <a:pt x="503766" y="37850"/>
                      </a:cubicBezTo>
                      <a:cubicBezTo>
                        <a:pt x="498648" y="30539"/>
                        <a:pt x="478366" y="29384"/>
                        <a:pt x="478366" y="29384"/>
                      </a:cubicBezTo>
                      <a:cubicBezTo>
                        <a:pt x="469900" y="16684"/>
                        <a:pt x="471311" y="15272"/>
                        <a:pt x="457200" y="8217"/>
                      </a:cubicBezTo>
                      <a:cubicBezTo>
                        <a:pt x="453209" y="6221"/>
                        <a:pt x="448876" y="3109"/>
                        <a:pt x="444500" y="3984"/>
                      </a:cubicBezTo>
                      <a:cubicBezTo>
                        <a:pt x="440586" y="4767"/>
                        <a:pt x="496005" y="3984"/>
                        <a:pt x="448733" y="3984"/>
                      </a:cubicBezTo>
                      <a:close/>
                    </a:path>
                  </a:pathLst>
                </a:custGeom>
                <a:noFill/>
                <a:ln w="158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90" name="Group 89">
                <a:extLst>
                  <a:ext uri="{FF2B5EF4-FFF2-40B4-BE49-F238E27FC236}">
                    <a16:creationId xmlns:a16="http://schemas.microsoft.com/office/drawing/2014/main" id="{0C0AAA4D-8475-404C-BC6B-85A1062A2C19}"/>
                  </a:ext>
                </a:extLst>
              </p:cNvPr>
              <p:cNvGrpSpPr/>
              <p:nvPr/>
            </p:nvGrpSpPr>
            <p:grpSpPr>
              <a:xfrm>
                <a:off x="8517557" y="1901593"/>
                <a:ext cx="1080000" cy="972000"/>
                <a:chOff x="9841914" y="1911343"/>
                <a:chExt cx="1463040" cy="1102332"/>
              </a:xfrm>
            </p:grpSpPr>
            <p:pic>
              <p:nvPicPr>
                <p:cNvPr id="93" name="Picture 92">
                  <a:extLst>
                    <a:ext uri="{FF2B5EF4-FFF2-40B4-BE49-F238E27FC236}">
                      <a16:creationId xmlns:a16="http://schemas.microsoft.com/office/drawing/2014/main" id="{5EA1AE76-18F9-4EC3-A0F5-A409085C15BA}"/>
                    </a:ext>
                  </a:extLst>
                </p:cNvPr>
                <p:cNvPicPr>
                  <a:picLocks noChangeAspect="1"/>
                </p:cNvPicPr>
                <p:nvPr/>
              </p:nvPicPr>
              <p:blipFill>
                <a:blip r:embed="rId14" cstate="print">
                  <a:extLst>
                    <a:ext uri="{BEBA8EAE-BF5A-486C-A8C5-ECC9F3942E4B}">
                      <a14:imgProps xmlns:a14="http://schemas.microsoft.com/office/drawing/2010/main">
                        <a14:imgLayer r:embed="rId15">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a:off x="9841914" y="1916395"/>
                  <a:ext cx="1463040" cy="1097280"/>
                </a:xfrm>
                <a:prstGeom prst="rect">
                  <a:avLst/>
                </a:prstGeom>
              </p:spPr>
            </p:pic>
            <p:sp>
              <p:nvSpPr>
                <p:cNvPr id="95" name="Freeform: Shape 99">
                  <a:extLst>
                    <a:ext uri="{FF2B5EF4-FFF2-40B4-BE49-F238E27FC236}">
                      <a16:creationId xmlns:a16="http://schemas.microsoft.com/office/drawing/2014/main" id="{15767D7D-0E09-4E6E-97EE-C86159C7D444}"/>
                    </a:ext>
                  </a:extLst>
                </p:cNvPr>
                <p:cNvSpPr/>
                <p:nvPr/>
              </p:nvSpPr>
              <p:spPr>
                <a:xfrm>
                  <a:off x="10541000" y="1911343"/>
                  <a:ext cx="246197" cy="1090103"/>
                </a:xfrm>
                <a:custGeom>
                  <a:avLst/>
                  <a:gdLst>
                    <a:gd name="connsiteX0" fmla="*/ 97367 w 246197"/>
                    <a:gd name="connsiteY0" fmla="*/ 6357 h 1090103"/>
                    <a:gd name="connsiteX1" fmla="*/ 4233 w 246197"/>
                    <a:gd name="connsiteY1" fmla="*/ 10590 h 1090103"/>
                    <a:gd name="connsiteX2" fmla="*/ 0 w 246197"/>
                    <a:gd name="connsiteY2" fmla="*/ 23290 h 1090103"/>
                    <a:gd name="connsiteX3" fmla="*/ 4233 w 246197"/>
                    <a:gd name="connsiteY3" fmla="*/ 40224 h 1090103"/>
                    <a:gd name="connsiteX4" fmla="*/ 29633 w 246197"/>
                    <a:gd name="connsiteY4" fmla="*/ 52924 h 1090103"/>
                    <a:gd name="connsiteX5" fmla="*/ 42333 w 246197"/>
                    <a:gd name="connsiteY5" fmla="*/ 78324 h 1090103"/>
                    <a:gd name="connsiteX6" fmla="*/ 29633 w 246197"/>
                    <a:gd name="connsiteY6" fmla="*/ 82557 h 1090103"/>
                    <a:gd name="connsiteX7" fmla="*/ 21167 w 246197"/>
                    <a:gd name="connsiteY7" fmla="*/ 107957 h 1090103"/>
                    <a:gd name="connsiteX8" fmla="*/ 16933 w 246197"/>
                    <a:gd name="connsiteY8" fmla="*/ 120657 h 1090103"/>
                    <a:gd name="connsiteX9" fmla="*/ 16933 w 246197"/>
                    <a:gd name="connsiteY9" fmla="*/ 234957 h 1090103"/>
                    <a:gd name="connsiteX10" fmla="*/ 55033 w 246197"/>
                    <a:gd name="connsiteY10" fmla="*/ 239190 h 1090103"/>
                    <a:gd name="connsiteX11" fmla="*/ 59267 w 246197"/>
                    <a:gd name="connsiteY11" fmla="*/ 294224 h 1090103"/>
                    <a:gd name="connsiteX12" fmla="*/ 50800 w 246197"/>
                    <a:gd name="connsiteY12" fmla="*/ 306924 h 1090103"/>
                    <a:gd name="connsiteX13" fmla="*/ 33867 w 246197"/>
                    <a:gd name="connsiteY13" fmla="*/ 323857 h 1090103"/>
                    <a:gd name="connsiteX14" fmla="*/ 29633 w 246197"/>
                    <a:gd name="connsiteY14" fmla="*/ 336557 h 1090103"/>
                    <a:gd name="connsiteX15" fmla="*/ 33867 w 246197"/>
                    <a:gd name="connsiteY15" fmla="*/ 361957 h 1090103"/>
                    <a:gd name="connsiteX16" fmla="*/ 29633 w 246197"/>
                    <a:gd name="connsiteY16" fmla="*/ 391590 h 1090103"/>
                    <a:gd name="connsiteX17" fmla="*/ 42333 w 246197"/>
                    <a:gd name="connsiteY17" fmla="*/ 433924 h 1090103"/>
                    <a:gd name="connsiteX18" fmla="*/ 55033 w 246197"/>
                    <a:gd name="connsiteY18" fmla="*/ 476257 h 1090103"/>
                    <a:gd name="connsiteX19" fmla="*/ 67733 w 246197"/>
                    <a:gd name="connsiteY19" fmla="*/ 484724 h 1090103"/>
                    <a:gd name="connsiteX20" fmla="*/ 76200 w 246197"/>
                    <a:gd name="connsiteY20" fmla="*/ 518590 h 1090103"/>
                    <a:gd name="connsiteX21" fmla="*/ 80433 w 246197"/>
                    <a:gd name="connsiteY21" fmla="*/ 535524 h 1090103"/>
                    <a:gd name="connsiteX22" fmla="*/ 84667 w 246197"/>
                    <a:gd name="connsiteY22" fmla="*/ 556690 h 1090103"/>
                    <a:gd name="connsiteX23" fmla="*/ 93133 w 246197"/>
                    <a:gd name="connsiteY23" fmla="*/ 582090 h 1090103"/>
                    <a:gd name="connsiteX24" fmla="*/ 88900 w 246197"/>
                    <a:gd name="connsiteY24" fmla="*/ 632890 h 1090103"/>
                    <a:gd name="connsiteX25" fmla="*/ 76200 w 246197"/>
                    <a:gd name="connsiteY25" fmla="*/ 641357 h 1090103"/>
                    <a:gd name="connsiteX26" fmla="*/ 55033 w 246197"/>
                    <a:gd name="connsiteY26" fmla="*/ 679457 h 1090103"/>
                    <a:gd name="connsiteX27" fmla="*/ 50800 w 246197"/>
                    <a:gd name="connsiteY27" fmla="*/ 738724 h 1090103"/>
                    <a:gd name="connsiteX28" fmla="*/ 46567 w 246197"/>
                    <a:gd name="connsiteY28" fmla="*/ 751424 h 1090103"/>
                    <a:gd name="connsiteX29" fmla="*/ 38100 w 246197"/>
                    <a:gd name="connsiteY29" fmla="*/ 806457 h 1090103"/>
                    <a:gd name="connsiteX30" fmla="*/ 42333 w 246197"/>
                    <a:gd name="connsiteY30" fmla="*/ 827624 h 1090103"/>
                    <a:gd name="connsiteX31" fmla="*/ 50800 w 246197"/>
                    <a:gd name="connsiteY31" fmla="*/ 853024 h 1090103"/>
                    <a:gd name="connsiteX32" fmla="*/ 63500 w 246197"/>
                    <a:gd name="connsiteY32" fmla="*/ 903824 h 1090103"/>
                    <a:gd name="connsiteX33" fmla="*/ 67733 w 246197"/>
                    <a:gd name="connsiteY33" fmla="*/ 916524 h 1090103"/>
                    <a:gd name="connsiteX34" fmla="*/ 80433 w 246197"/>
                    <a:gd name="connsiteY34" fmla="*/ 920757 h 1090103"/>
                    <a:gd name="connsiteX35" fmla="*/ 84667 w 246197"/>
                    <a:gd name="connsiteY35" fmla="*/ 933457 h 1090103"/>
                    <a:gd name="connsiteX36" fmla="*/ 93133 w 246197"/>
                    <a:gd name="connsiteY36" fmla="*/ 967324 h 1090103"/>
                    <a:gd name="connsiteX37" fmla="*/ 88900 w 246197"/>
                    <a:gd name="connsiteY37" fmla="*/ 1047757 h 1090103"/>
                    <a:gd name="connsiteX38" fmla="*/ 59267 w 246197"/>
                    <a:gd name="connsiteY38" fmla="*/ 1051990 h 1090103"/>
                    <a:gd name="connsiteX39" fmla="*/ 76200 w 246197"/>
                    <a:gd name="connsiteY39" fmla="*/ 1090090 h 1090103"/>
                    <a:gd name="connsiteX40" fmla="*/ 165100 w 246197"/>
                    <a:gd name="connsiteY40" fmla="*/ 1085857 h 1090103"/>
                    <a:gd name="connsiteX41" fmla="*/ 237067 w 246197"/>
                    <a:gd name="connsiteY41" fmla="*/ 1085857 h 1090103"/>
                    <a:gd name="connsiteX42" fmla="*/ 241300 w 246197"/>
                    <a:gd name="connsiteY42" fmla="*/ 1035057 h 1090103"/>
                    <a:gd name="connsiteX43" fmla="*/ 215900 w 246197"/>
                    <a:gd name="connsiteY43" fmla="*/ 1022357 h 1090103"/>
                    <a:gd name="connsiteX44" fmla="*/ 186267 w 246197"/>
                    <a:gd name="connsiteY44" fmla="*/ 992724 h 1090103"/>
                    <a:gd name="connsiteX45" fmla="*/ 186267 w 246197"/>
                    <a:gd name="connsiteY45" fmla="*/ 933457 h 1090103"/>
                    <a:gd name="connsiteX46" fmla="*/ 177800 w 246197"/>
                    <a:gd name="connsiteY46" fmla="*/ 908057 h 1090103"/>
                    <a:gd name="connsiteX47" fmla="*/ 173567 w 246197"/>
                    <a:gd name="connsiteY47" fmla="*/ 878424 h 1090103"/>
                    <a:gd name="connsiteX48" fmla="*/ 169333 w 246197"/>
                    <a:gd name="connsiteY48" fmla="*/ 848790 h 1090103"/>
                    <a:gd name="connsiteX49" fmla="*/ 156633 w 246197"/>
                    <a:gd name="connsiteY49" fmla="*/ 802224 h 1090103"/>
                    <a:gd name="connsiteX50" fmla="*/ 143933 w 246197"/>
                    <a:gd name="connsiteY50" fmla="*/ 776824 h 1090103"/>
                    <a:gd name="connsiteX51" fmla="*/ 131233 w 246197"/>
                    <a:gd name="connsiteY51" fmla="*/ 772590 h 1090103"/>
                    <a:gd name="connsiteX52" fmla="*/ 118533 w 246197"/>
                    <a:gd name="connsiteY52" fmla="*/ 764124 h 1090103"/>
                    <a:gd name="connsiteX53" fmla="*/ 114300 w 246197"/>
                    <a:gd name="connsiteY53" fmla="*/ 751424 h 1090103"/>
                    <a:gd name="connsiteX54" fmla="*/ 105833 w 246197"/>
                    <a:gd name="connsiteY54" fmla="*/ 738724 h 1090103"/>
                    <a:gd name="connsiteX55" fmla="*/ 122767 w 246197"/>
                    <a:gd name="connsiteY55" fmla="*/ 692157 h 1090103"/>
                    <a:gd name="connsiteX56" fmla="*/ 148167 w 246197"/>
                    <a:gd name="connsiteY56" fmla="*/ 662524 h 1090103"/>
                    <a:gd name="connsiteX57" fmla="*/ 156633 w 246197"/>
                    <a:gd name="connsiteY57" fmla="*/ 649824 h 1090103"/>
                    <a:gd name="connsiteX58" fmla="*/ 156633 w 246197"/>
                    <a:gd name="connsiteY58" fmla="*/ 586324 h 1090103"/>
                    <a:gd name="connsiteX59" fmla="*/ 148167 w 246197"/>
                    <a:gd name="connsiteY59" fmla="*/ 573624 h 1090103"/>
                    <a:gd name="connsiteX60" fmla="*/ 143933 w 246197"/>
                    <a:gd name="connsiteY60" fmla="*/ 518590 h 1090103"/>
                    <a:gd name="connsiteX61" fmla="*/ 135467 w 246197"/>
                    <a:gd name="connsiteY61" fmla="*/ 505890 h 1090103"/>
                    <a:gd name="connsiteX62" fmla="*/ 127000 w 246197"/>
                    <a:gd name="connsiteY62" fmla="*/ 472024 h 1090103"/>
                    <a:gd name="connsiteX63" fmla="*/ 127000 w 246197"/>
                    <a:gd name="connsiteY63" fmla="*/ 400057 h 1090103"/>
                    <a:gd name="connsiteX64" fmla="*/ 118533 w 246197"/>
                    <a:gd name="connsiteY64" fmla="*/ 374657 h 1090103"/>
                    <a:gd name="connsiteX65" fmla="*/ 122767 w 246197"/>
                    <a:gd name="connsiteY65" fmla="*/ 332324 h 1090103"/>
                    <a:gd name="connsiteX66" fmla="*/ 127000 w 246197"/>
                    <a:gd name="connsiteY66" fmla="*/ 319624 h 1090103"/>
                    <a:gd name="connsiteX67" fmla="*/ 139700 w 246197"/>
                    <a:gd name="connsiteY67" fmla="*/ 311157 h 1090103"/>
                    <a:gd name="connsiteX68" fmla="*/ 143933 w 246197"/>
                    <a:gd name="connsiteY68" fmla="*/ 298457 h 1090103"/>
                    <a:gd name="connsiteX69" fmla="*/ 148167 w 246197"/>
                    <a:gd name="connsiteY69" fmla="*/ 281524 h 1090103"/>
                    <a:gd name="connsiteX70" fmla="*/ 156633 w 246197"/>
                    <a:gd name="connsiteY70" fmla="*/ 268824 h 1090103"/>
                    <a:gd name="connsiteX71" fmla="*/ 160867 w 246197"/>
                    <a:gd name="connsiteY71" fmla="*/ 247657 h 1090103"/>
                    <a:gd name="connsiteX72" fmla="*/ 148167 w 246197"/>
                    <a:gd name="connsiteY72" fmla="*/ 251890 h 1090103"/>
                    <a:gd name="connsiteX73" fmla="*/ 114300 w 246197"/>
                    <a:gd name="connsiteY73" fmla="*/ 247657 h 1090103"/>
                    <a:gd name="connsiteX74" fmla="*/ 110067 w 246197"/>
                    <a:gd name="connsiteY74" fmla="*/ 234957 h 1090103"/>
                    <a:gd name="connsiteX75" fmla="*/ 105833 w 246197"/>
                    <a:gd name="connsiteY75" fmla="*/ 171457 h 1090103"/>
                    <a:gd name="connsiteX76" fmla="*/ 93133 w 246197"/>
                    <a:gd name="connsiteY76" fmla="*/ 162990 h 1090103"/>
                    <a:gd name="connsiteX77" fmla="*/ 84667 w 246197"/>
                    <a:gd name="connsiteY77" fmla="*/ 137590 h 1090103"/>
                    <a:gd name="connsiteX78" fmla="*/ 88900 w 246197"/>
                    <a:gd name="connsiteY78" fmla="*/ 95257 h 1090103"/>
                    <a:gd name="connsiteX79" fmla="*/ 97367 w 246197"/>
                    <a:gd name="connsiteY79" fmla="*/ 6357 h 109010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Lst>
                  <a:rect l="l" t="t" r="r" b="b"/>
                  <a:pathLst>
                    <a:path w="246197" h="1090103">
                      <a:moveTo>
                        <a:pt x="97367" y="6357"/>
                      </a:moveTo>
                      <a:cubicBezTo>
                        <a:pt x="83256" y="-7754"/>
                        <a:pt x="34850" y="5265"/>
                        <a:pt x="4233" y="10590"/>
                      </a:cubicBezTo>
                      <a:cubicBezTo>
                        <a:pt x="-163" y="11355"/>
                        <a:pt x="0" y="18828"/>
                        <a:pt x="0" y="23290"/>
                      </a:cubicBezTo>
                      <a:cubicBezTo>
                        <a:pt x="0" y="29108"/>
                        <a:pt x="1006" y="35383"/>
                        <a:pt x="4233" y="40224"/>
                      </a:cubicBezTo>
                      <a:cubicBezTo>
                        <a:pt x="8921" y="47256"/>
                        <a:pt x="22390" y="50509"/>
                        <a:pt x="29633" y="52924"/>
                      </a:cubicBezTo>
                      <a:cubicBezTo>
                        <a:pt x="31059" y="55063"/>
                        <a:pt x="44837" y="73316"/>
                        <a:pt x="42333" y="78324"/>
                      </a:cubicBezTo>
                      <a:cubicBezTo>
                        <a:pt x="40337" y="82315"/>
                        <a:pt x="33866" y="81146"/>
                        <a:pt x="29633" y="82557"/>
                      </a:cubicBezTo>
                      <a:lnTo>
                        <a:pt x="21167" y="107957"/>
                      </a:lnTo>
                      <a:lnTo>
                        <a:pt x="16933" y="120657"/>
                      </a:lnTo>
                      <a:cubicBezTo>
                        <a:pt x="16053" y="132973"/>
                        <a:pt x="6848" y="220839"/>
                        <a:pt x="16933" y="234957"/>
                      </a:cubicBezTo>
                      <a:cubicBezTo>
                        <a:pt x="24360" y="245355"/>
                        <a:pt x="42333" y="237779"/>
                        <a:pt x="55033" y="239190"/>
                      </a:cubicBezTo>
                      <a:cubicBezTo>
                        <a:pt x="63810" y="265519"/>
                        <a:pt x="67944" y="265300"/>
                        <a:pt x="59267" y="294224"/>
                      </a:cubicBezTo>
                      <a:cubicBezTo>
                        <a:pt x="57805" y="299097"/>
                        <a:pt x="53622" y="302691"/>
                        <a:pt x="50800" y="306924"/>
                      </a:cubicBezTo>
                      <a:cubicBezTo>
                        <a:pt x="39513" y="340789"/>
                        <a:pt x="56444" y="301282"/>
                        <a:pt x="33867" y="323857"/>
                      </a:cubicBezTo>
                      <a:cubicBezTo>
                        <a:pt x="30712" y="327012"/>
                        <a:pt x="31044" y="332324"/>
                        <a:pt x="29633" y="336557"/>
                      </a:cubicBezTo>
                      <a:cubicBezTo>
                        <a:pt x="31044" y="345024"/>
                        <a:pt x="33867" y="353374"/>
                        <a:pt x="33867" y="361957"/>
                      </a:cubicBezTo>
                      <a:cubicBezTo>
                        <a:pt x="33867" y="371935"/>
                        <a:pt x="29633" y="381612"/>
                        <a:pt x="29633" y="391590"/>
                      </a:cubicBezTo>
                      <a:cubicBezTo>
                        <a:pt x="29633" y="418830"/>
                        <a:pt x="30858" y="416710"/>
                        <a:pt x="42333" y="433924"/>
                      </a:cubicBezTo>
                      <a:cubicBezTo>
                        <a:pt x="44998" y="452574"/>
                        <a:pt x="42200" y="463423"/>
                        <a:pt x="55033" y="476257"/>
                      </a:cubicBezTo>
                      <a:cubicBezTo>
                        <a:pt x="58631" y="479855"/>
                        <a:pt x="63500" y="481902"/>
                        <a:pt x="67733" y="484724"/>
                      </a:cubicBezTo>
                      <a:cubicBezTo>
                        <a:pt x="75298" y="507415"/>
                        <a:pt x="69391" y="487945"/>
                        <a:pt x="76200" y="518590"/>
                      </a:cubicBezTo>
                      <a:cubicBezTo>
                        <a:pt x="77462" y="524270"/>
                        <a:pt x="79171" y="529844"/>
                        <a:pt x="80433" y="535524"/>
                      </a:cubicBezTo>
                      <a:cubicBezTo>
                        <a:pt x="81994" y="542548"/>
                        <a:pt x="82774" y="549748"/>
                        <a:pt x="84667" y="556690"/>
                      </a:cubicBezTo>
                      <a:cubicBezTo>
                        <a:pt x="87015" y="565300"/>
                        <a:pt x="93133" y="582090"/>
                        <a:pt x="93133" y="582090"/>
                      </a:cubicBezTo>
                      <a:cubicBezTo>
                        <a:pt x="91722" y="599023"/>
                        <a:pt x="93568" y="616552"/>
                        <a:pt x="88900" y="632890"/>
                      </a:cubicBezTo>
                      <a:cubicBezTo>
                        <a:pt x="87502" y="637782"/>
                        <a:pt x="78897" y="637042"/>
                        <a:pt x="76200" y="641357"/>
                      </a:cubicBezTo>
                      <a:cubicBezTo>
                        <a:pt x="41667" y="696609"/>
                        <a:pt x="90259" y="644231"/>
                        <a:pt x="55033" y="679457"/>
                      </a:cubicBezTo>
                      <a:cubicBezTo>
                        <a:pt x="53622" y="699213"/>
                        <a:pt x="53114" y="719054"/>
                        <a:pt x="50800" y="738724"/>
                      </a:cubicBezTo>
                      <a:cubicBezTo>
                        <a:pt x="50279" y="743156"/>
                        <a:pt x="47246" y="747014"/>
                        <a:pt x="46567" y="751424"/>
                      </a:cubicBezTo>
                      <a:cubicBezTo>
                        <a:pt x="37212" y="812229"/>
                        <a:pt x="48289" y="775888"/>
                        <a:pt x="38100" y="806457"/>
                      </a:cubicBezTo>
                      <a:cubicBezTo>
                        <a:pt x="39511" y="813513"/>
                        <a:pt x="40440" y="820682"/>
                        <a:pt x="42333" y="827624"/>
                      </a:cubicBezTo>
                      <a:cubicBezTo>
                        <a:pt x="44681" y="836234"/>
                        <a:pt x="50800" y="853024"/>
                        <a:pt x="50800" y="853024"/>
                      </a:cubicBezTo>
                      <a:cubicBezTo>
                        <a:pt x="58385" y="921297"/>
                        <a:pt x="46834" y="870491"/>
                        <a:pt x="63500" y="903824"/>
                      </a:cubicBezTo>
                      <a:cubicBezTo>
                        <a:pt x="65496" y="907815"/>
                        <a:pt x="64578" y="913369"/>
                        <a:pt x="67733" y="916524"/>
                      </a:cubicBezTo>
                      <a:cubicBezTo>
                        <a:pt x="70888" y="919679"/>
                        <a:pt x="76200" y="919346"/>
                        <a:pt x="80433" y="920757"/>
                      </a:cubicBezTo>
                      <a:cubicBezTo>
                        <a:pt x="81844" y="924990"/>
                        <a:pt x="83585" y="929128"/>
                        <a:pt x="84667" y="933457"/>
                      </a:cubicBezTo>
                      <a:cubicBezTo>
                        <a:pt x="94888" y="974339"/>
                        <a:pt x="83454" y="938285"/>
                        <a:pt x="93133" y="967324"/>
                      </a:cubicBezTo>
                      <a:cubicBezTo>
                        <a:pt x="91722" y="994135"/>
                        <a:pt x="98871" y="1022829"/>
                        <a:pt x="88900" y="1047757"/>
                      </a:cubicBezTo>
                      <a:cubicBezTo>
                        <a:pt x="85194" y="1057021"/>
                        <a:pt x="65254" y="1044008"/>
                        <a:pt x="59267" y="1051990"/>
                      </a:cubicBezTo>
                      <a:cubicBezTo>
                        <a:pt x="43582" y="1072903"/>
                        <a:pt x="65720" y="1083104"/>
                        <a:pt x="76200" y="1090090"/>
                      </a:cubicBezTo>
                      <a:cubicBezTo>
                        <a:pt x="105833" y="1088679"/>
                        <a:pt x="135433" y="1085857"/>
                        <a:pt x="165100" y="1085857"/>
                      </a:cubicBezTo>
                      <a:cubicBezTo>
                        <a:pt x="250278" y="1085857"/>
                        <a:pt x="179737" y="1095411"/>
                        <a:pt x="237067" y="1085857"/>
                      </a:cubicBezTo>
                      <a:cubicBezTo>
                        <a:pt x="243506" y="1066540"/>
                        <a:pt x="251560" y="1055578"/>
                        <a:pt x="241300" y="1035057"/>
                      </a:cubicBezTo>
                      <a:cubicBezTo>
                        <a:pt x="238017" y="1028491"/>
                        <a:pt x="221911" y="1024361"/>
                        <a:pt x="215900" y="1022357"/>
                      </a:cubicBezTo>
                      <a:cubicBezTo>
                        <a:pt x="186787" y="1002949"/>
                        <a:pt x="193718" y="1015078"/>
                        <a:pt x="186267" y="992724"/>
                      </a:cubicBezTo>
                      <a:cubicBezTo>
                        <a:pt x="192952" y="965981"/>
                        <a:pt x="193485" y="971953"/>
                        <a:pt x="186267" y="933457"/>
                      </a:cubicBezTo>
                      <a:cubicBezTo>
                        <a:pt x="184622" y="924685"/>
                        <a:pt x="177800" y="908057"/>
                        <a:pt x="177800" y="908057"/>
                      </a:cubicBezTo>
                      <a:cubicBezTo>
                        <a:pt x="176389" y="898179"/>
                        <a:pt x="176434" y="887981"/>
                        <a:pt x="173567" y="878424"/>
                      </a:cubicBezTo>
                      <a:cubicBezTo>
                        <a:pt x="164796" y="849187"/>
                        <a:pt x="160523" y="884034"/>
                        <a:pt x="169333" y="848790"/>
                      </a:cubicBezTo>
                      <a:cubicBezTo>
                        <a:pt x="163349" y="818870"/>
                        <a:pt x="167376" y="834453"/>
                        <a:pt x="156633" y="802224"/>
                      </a:cubicBezTo>
                      <a:cubicBezTo>
                        <a:pt x="153844" y="793856"/>
                        <a:pt x="151395" y="782794"/>
                        <a:pt x="143933" y="776824"/>
                      </a:cubicBezTo>
                      <a:cubicBezTo>
                        <a:pt x="140448" y="774036"/>
                        <a:pt x="135224" y="774586"/>
                        <a:pt x="131233" y="772590"/>
                      </a:cubicBezTo>
                      <a:cubicBezTo>
                        <a:pt x="126682" y="770315"/>
                        <a:pt x="122766" y="766946"/>
                        <a:pt x="118533" y="764124"/>
                      </a:cubicBezTo>
                      <a:cubicBezTo>
                        <a:pt x="117122" y="759891"/>
                        <a:pt x="116296" y="755415"/>
                        <a:pt x="114300" y="751424"/>
                      </a:cubicBezTo>
                      <a:cubicBezTo>
                        <a:pt x="112025" y="746873"/>
                        <a:pt x="105833" y="743812"/>
                        <a:pt x="105833" y="738724"/>
                      </a:cubicBezTo>
                      <a:cubicBezTo>
                        <a:pt x="105833" y="714472"/>
                        <a:pt x="112087" y="708177"/>
                        <a:pt x="122767" y="692157"/>
                      </a:cubicBezTo>
                      <a:cubicBezTo>
                        <a:pt x="133073" y="661237"/>
                        <a:pt x="122575" y="668921"/>
                        <a:pt x="148167" y="662524"/>
                      </a:cubicBezTo>
                      <a:cubicBezTo>
                        <a:pt x="150989" y="658291"/>
                        <a:pt x="155399" y="654760"/>
                        <a:pt x="156633" y="649824"/>
                      </a:cubicBezTo>
                      <a:cubicBezTo>
                        <a:pt x="161475" y="630456"/>
                        <a:pt x="163197" y="606015"/>
                        <a:pt x="156633" y="586324"/>
                      </a:cubicBezTo>
                      <a:cubicBezTo>
                        <a:pt x="155024" y="581497"/>
                        <a:pt x="150989" y="577857"/>
                        <a:pt x="148167" y="573624"/>
                      </a:cubicBezTo>
                      <a:cubicBezTo>
                        <a:pt x="146756" y="555279"/>
                        <a:pt x="147324" y="536674"/>
                        <a:pt x="143933" y="518590"/>
                      </a:cubicBezTo>
                      <a:cubicBezTo>
                        <a:pt x="142995" y="513589"/>
                        <a:pt x="137742" y="510441"/>
                        <a:pt x="135467" y="505890"/>
                      </a:cubicBezTo>
                      <a:cubicBezTo>
                        <a:pt x="131126" y="497208"/>
                        <a:pt x="128611" y="480081"/>
                        <a:pt x="127000" y="472024"/>
                      </a:cubicBezTo>
                      <a:cubicBezTo>
                        <a:pt x="130576" y="436261"/>
                        <a:pt x="134399" y="432120"/>
                        <a:pt x="127000" y="400057"/>
                      </a:cubicBezTo>
                      <a:cubicBezTo>
                        <a:pt x="124993" y="391361"/>
                        <a:pt x="118533" y="374657"/>
                        <a:pt x="118533" y="374657"/>
                      </a:cubicBezTo>
                      <a:cubicBezTo>
                        <a:pt x="119944" y="360546"/>
                        <a:pt x="120611" y="346340"/>
                        <a:pt x="122767" y="332324"/>
                      </a:cubicBezTo>
                      <a:cubicBezTo>
                        <a:pt x="123446" y="327914"/>
                        <a:pt x="124212" y="323109"/>
                        <a:pt x="127000" y="319624"/>
                      </a:cubicBezTo>
                      <a:cubicBezTo>
                        <a:pt x="130178" y="315651"/>
                        <a:pt x="135467" y="313979"/>
                        <a:pt x="139700" y="311157"/>
                      </a:cubicBezTo>
                      <a:cubicBezTo>
                        <a:pt x="141111" y="306924"/>
                        <a:pt x="142707" y="302748"/>
                        <a:pt x="143933" y="298457"/>
                      </a:cubicBezTo>
                      <a:cubicBezTo>
                        <a:pt x="145531" y="292863"/>
                        <a:pt x="145875" y="286872"/>
                        <a:pt x="148167" y="281524"/>
                      </a:cubicBezTo>
                      <a:cubicBezTo>
                        <a:pt x="150171" y="276848"/>
                        <a:pt x="153811" y="273057"/>
                        <a:pt x="156633" y="268824"/>
                      </a:cubicBezTo>
                      <a:cubicBezTo>
                        <a:pt x="158044" y="261768"/>
                        <a:pt x="164085" y="254093"/>
                        <a:pt x="160867" y="247657"/>
                      </a:cubicBezTo>
                      <a:cubicBezTo>
                        <a:pt x="158872" y="243666"/>
                        <a:pt x="152629" y="251890"/>
                        <a:pt x="148167" y="251890"/>
                      </a:cubicBezTo>
                      <a:cubicBezTo>
                        <a:pt x="136790" y="251890"/>
                        <a:pt x="125589" y="249068"/>
                        <a:pt x="114300" y="247657"/>
                      </a:cubicBezTo>
                      <a:cubicBezTo>
                        <a:pt x="112889" y="243424"/>
                        <a:pt x="110560" y="239392"/>
                        <a:pt x="110067" y="234957"/>
                      </a:cubicBezTo>
                      <a:cubicBezTo>
                        <a:pt x="107724" y="213873"/>
                        <a:pt x="110692" y="192107"/>
                        <a:pt x="105833" y="171457"/>
                      </a:cubicBezTo>
                      <a:cubicBezTo>
                        <a:pt x="104668" y="166504"/>
                        <a:pt x="97366" y="165812"/>
                        <a:pt x="93133" y="162990"/>
                      </a:cubicBezTo>
                      <a:cubicBezTo>
                        <a:pt x="90311" y="154523"/>
                        <a:pt x="83779" y="146470"/>
                        <a:pt x="84667" y="137590"/>
                      </a:cubicBezTo>
                      <a:cubicBezTo>
                        <a:pt x="86078" y="123479"/>
                        <a:pt x="86287" y="109195"/>
                        <a:pt x="88900" y="95257"/>
                      </a:cubicBezTo>
                      <a:cubicBezTo>
                        <a:pt x="100491" y="33440"/>
                        <a:pt x="111478" y="20468"/>
                        <a:pt x="97367" y="6357"/>
                      </a:cubicBezTo>
                      <a:close/>
                    </a:path>
                  </a:pathLst>
                </a:custGeom>
                <a:noFill/>
                <a:ln w="158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91" name="TextBox 90">
                <a:extLst>
                  <a:ext uri="{FF2B5EF4-FFF2-40B4-BE49-F238E27FC236}">
                    <a16:creationId xmlns:a16="http://schemas.microsoft.com/office/drawing/2014/main" id="{43E62974-1B5C-4923-A549-77CC98BE1C78}"/>
                  </a:ext>
                </a:extLst>
              </p:cNvPr>
              <p:cNvSpPr txBox="1"/>
              <p:nvPr/>
            </p:nvSpPr>
            <p:spPr bwMode="auto">
              <a:xfrm rot="16200000">
                <a:off x="5740547" y="1201738"/>
                <a:ext cx="731094" cy="400110"/>
              </a:xfrm>
              <a:prstGeom prst="rect">
                <a:avLst/>
              </a:prstGeom>
              <a:noFill/>
            </p:spPr>
            <p:txBody>
              <a:bodyPr wrap="square">
                <a:spAutoFit/>
              </a:bodyPr>
              <a:lstStyle/>
              <a:p>
                <a:pPr algn="ctr">
                  <a:defRPr/>
                </a:pPr>
                <a:r>
                  <a:rPr lang="en-US" sz="1000" b="1" dirty="0">
                    <a:solidFill>
                      <a:prstClr val="black"/>
                    </a:solidFill>
                    <a:latin typeface="Calibri" panose="020F0502020204030204"/>
                  </a:rPr>
                  <a:t>HCT116</a:t>
                </a:r>
              </a:p>
              <a:p>
                <a:pPr algn="ctr">
                  <a:defRPr/>
                </a:pPr>
                <a:r>
                  <a:rPr lang="en-US" sz="1000" b="1" dirty="0" err="1">
                    <a:solidFill>
                      <a:prstClr val="black"/>
                    </a:solidFill>
                    <a:latin typeface="Calibri" panose="020F0502020204030204"/>
                  </a:rPr>
                  <a:t>miR</a:t>
                </a:r>
                <a:r>
                  <a:rPr lang="en-US" sz="1000" b="1" dirty="0">
                    <a:solidFill>
                      <a:prstClr val="black"/>
                    </a:solidFill>
                    <a:latin typeface="Calibri" panose="020F0502020204030204"/>
                  </a:rPr>
                  <a:t>-CTRL</a:t>
                </a:r>
              </a:p>
            </p:txBody>
          </p:sp>
          <p:sp>
            <p:nvSpPr>
              <p:cNvPr id="92" name="TextBox 91">
                <a:extLst>
                  <a:ext uri="{FF2B5EF4-FFF2-40B4-BE49-F238E27FC236}">
                    <a16:creationId xmlns:a16="http://schemas.microsoft.com/office/drawing/2014/main" id="{CEFF7704-6209-48D5-BDCA-95994C4A1076}"/>
                  </a:ext>
                </a:extLst>
              </p:cNvPr>
              <p:cNvSpPr txBox="1"/>
              <p:nvPr/>
            </p:nvSpPr>
            <p:spPr bwMode="auto">
              <a:xfrm rot="16200000">
                <a:off x="5786943" y="2179324"/>
                <a:ext cx="673074" cy="400110"/>
              </a:xfrm>
              <a:prstGeom prst="rect">
                <a:avLst/>
              </a:prstGeom>
              <a:noFill/>
            </p:spPr>
            <p:txBody>
              <a:bodyPr wrap="square">
                <a:spAutoFit/>
              </a:bodyPr>
              <a:lstStyle/>
              <a:p>
                <a:pPr algn="ctr">
                  <a:defRPr/>
                </a:pPr>
                <a:r>
                  <a:rPr lang="en-US" sz="1000" b="1" dirty="0">
                    <a:solidFill>
                      <a:prstClr val="black"/>
                    </a:solidFill>
                    <a:latin typeface="Calibri" panose="020F0502020204030204"/>
                  </a:rPr>
                  <a:t>HCT116</a:t>
                </a:r>
              </a:p>
              <a:p>
                <a:pPr algn="ctr">
                  <a:defRPr/>
                </a:pPr>
                <a:r>
                  <a:rPr lang="en-US" sz="1000" b="1" dirty="0">
                    <a:solidFill>
                      <a:prstClr val="black"/>
                    </a:solidFill>
                    <a:latin typeface="Calibri" panose="020F0502020204030204"/>
                  </a:rPr>
                  <a:t>miR-616</a:t>
                </a:r>
              </a:p>
            </p:txBody>
          </p:sp>
        </p:grpSp>
        <p:grpSp>
          <p:nvGrpSpPr>
            <p:cNvPr id="118" name="Group 117">
              <a:extLst>
                <a:ext uri="{FF2B5EF4-FFF2-40B4-BE49-F238E27FC236}">
                  <a16:creationId xmlns:a16="http://schemas.microsoft.com/office/drawing/2014/main" id="{42E9D277-232A-47AB-A5AD-E2E77CB0F291}"/>
                </a:ext>
              </a:extLst>
            </p:cNvPr>
            <p:cNvGrpSpPr/>
            <p:nvPr/>
          </p:nvGrpSpPr>
          <p:grpSpPr>
            <a:xfrm>
              <a:off x="8082893" y="2612132"/>
              <a:ext cx="2880000" cy="1980000"/>
              <a:chOff x="4285247" y="3246019"/>
              <a:chExt cx="4572000" cy="2743200"/>
            </a:xfrm>
          </p:grpSpPr>
          <p:graphicFrame>
            <p:nvGraphicFramePr>
              <p:cNvPr id="119" name="Chart 118">
                <a:extLst>
                  <a:ext uri="{FF2B5EF4-FFF2-40B4-BE49-F238E27FC236}">
                    <a16:creationId xmlns:a16="http://schemas.microsoft.com/office/drawing/2014/main" id="{1C817AF1-EE15-4515-9FCB-16AEC8DACC1B}"/>
                  </a:ext>
                </a:extLst>
              </p:cNvPr>
              <p:cNvGraphicFramePr>
                <a:graphicFrameLocks/>
              </p:cNvGraphicFramePr>
              <p:nvPr/>
            </p:nvGraphicFramePr>
            <p:xfrm>
              <a:off x="4285247" y="3246019"/>
              <a:ext cx="4572000" cy="2743200"/>
            </p:xfrm>
            <a:graphic>
              <a:graphicData uri="http://schemas.openxmlformats.org/drawingml/2006/chart">
                <c:chart xmlns:c="http://schemas.openxmlformats.org/drawingml/2006/chart" xmlns:r="http://schemas.openxmlformats.org/officeDocument/2006/relationships" r:id="rId16"/>
              </a:graphicData>
            </a:graphic>
          </p:graphicFrame>
          <p:sp>
            <p:nvSpPr>
              <p:cNvPr id="120" name="TextBox 3">
                <a:extLst>
                  <a:ext uri="{FF2B5EF4-FFF2-40B4-BE49-F238E27FC236}">
                    <a16:creationId xmlns:a16="http://schemas.microsoft.com/office/drawing/2014/main" id="{B10B48D0-B38F-47D2-96AF-29324A576E7C}"/>
                  </a:ext>
                </a:extLst>
              </p:cNvPr>
              <p:cNvSpPr txBox="1"/>
              <p:nvPr/>
            </p:nvSpPr>
            <p:spPr bwMode="auto">
              <a:xfrm>
                <a:off x="6824560" y="3852376"/>
                <a:ext cx="249357" cy="307787"/>
              </a:xfrm>
              <a:prstGeom prst="rect">
                <a:avLst/>
              </a:prstGeom>
              <a:noFill/>
            </p:spPr>
            <p:txBody>
              <a:bodyPr wrap="square">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eaLnBrk="1" fontAlgn="auto" hangingPunct="1">
                  <a:spcBef>
                    <a:spcPts val="0"/>
                  </a:spcBef>
                  <a:spcAft>
                    <a:spcPts val="0"/>
                  </a:spcAft>
                  <a:defRPr/>
                </a:pPr>
                <a:r>
                  <a:rPr lang="en-US" sz="1400" kern="0" dirty="0">
                    <a:solidFill>
                      <a:prstClr val="black"/>
                    </a:solidFill>
                    <a:latin typeface="Calibri" panose="020F0502020204030204"/>
                    <a:ea typeface="+mn-ea"/>
                  </a:rPr>
                  <a:t>*</a:t>
                </a:r>
              </a:p>
            </p:txBody>
          </p:sp>
          <p:sp>
            <p:nvSpPr>
              <p:cNvPr id="121" name="TextBox 3">
                <a:extLst>
                  <a:ext uri="{FF2B5EF4-FFF2-40B4-BE49-F238E27FC236}">
                    <a16:creationId xmlns:a16="http://schemas.microsoft.com/office/drawing/2014/main" id="{C6C6F1EC-54A0-4D61-8931-24025BAC26ED}"/>
                  </a:ext>
                </a:extLst>
              </p:cNvPr>
              <p:cNvSpPr txBox="1"/>
              <p:nvPr/>
            </p:nvSpPr>
            <p:spPr bwMode="auto">
              <a:xfrm>
                <a:off x="7893158" y="4463725"/>
                <a:ext cx="249357" cy="307787"/>
              </a:xfrm>
              <a:prstGeom prst="rect">
                <a:avLst/>
              </a:prstGeom>
              <a:noFill/>
            </p:spPr>
            <p:txBody>
              <a:bodyPr wrap="square">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eaLnBrk="1" fontAlgn="auto" hangingPunct="1">
                  <a:spcBef>
                    <a:spcPts val="0"/>
                  </a:spcBef>
                  <a:spcAft>
                    <a:spcPts val="0"/>
                  </a:spcAft>
                  <a:defRPr/>
                </a:pPr>
                <a:r>
                  <a:rPr lang="en-US" sz="1400" kern="0" dirty="0">
                    <a:solidFill>
                      <a:prstClr val="black"/>
                    </a:solidFill>
                    <a:latin typeface="Calibri" panose="020F0502020204030204"/>
                    <a:ea typeface="+mn-ea"/>
                  </a:rPr>
                  <a:t>*</a:t>
                </a:r>
              </a:p>
            </p:txBody>
          </p:sp>
        </p:grpSp>
        <p:grpSp>
          <p:nvGrpSpPr>
            <p:cNvPr id="122" name="Group 121"/>
            <p:cNvGrpSpPr/>
            <p:nvPr/>
          </p:nvGrpSpPr>
          <p:grpSpPr>
            <a:xfrm>
              <a:off x="9128559" y="922647"/>
              <a:ext cx="1806141" cy="1033966"/>
              <a:chOff x="1749484" y="1919452"/>
              <a:chExt cx="1806141" cy="1033966"/>
            </a:xfrm>
          </p:grpSpPr>
          <p:grpSp>
            <p:nvGrpSpPr>
              <p:cNvPr id="123" name="Group 122"/>
              <p:cNvGrpSpPr/>
              <p:nvPr/>
            </p:nvGrpSpPr>
            <p:grpSpPr>
              <a:xfrm>
                <a:off x="1749484" y="1919452"/>
                <a:ext cx="1806141" cy="1033966"/>
                <a:chOff x="1749484" y="2590572"/>
                <a:chExt cx="1806141" cy="1033966"/>
              </a:xfrm>
            </p:grpSpPr>
            <p:grpSp>
              <p:nvGrpSpPr>
                <p:cNvPr id="125" name="Group 124"/>
                <p:cNvGrpSpPr/>
                <p:nvPr/>
              </p:nvGrpSpPr>
              <p:grpSpPr>
                <a:xfrm>
                  <a:off x="1787418" y="2933668"/>
                  <a:ext cx="1768207" cy="690870"/>
                  <a:chOff x="4475951" y="3482260"/>
                  <a:chExt cx="1768207" cy="690870"/>
                </a:xfrm>
              </p:grpSpPr>
              <p:grpSp>
                <p:nvGrpSpPr>
                  <p:cNvPr id="129" name="Group 128">
                    <a:extLst>
                      <a:ext uri="{FF2B5EF4-FFF2-40B4-BE49-F238E27FC236}">
                        <a16:creationId xmlns:a16="http://schemas.microsoft.com/office/drawing/2014/main" id="{A696723A-0F7C-4A96-B169-036C815E5709}"/>
                      </a:ext>
                    </a:extLst>
                  </p:cNvPr>
                  <p:cNvGrpSpPr/>
                  <p:nvPr/>
                </p:nvGrpSpPr>
                <p:grpSpPr>
                  <a:xfrm>
                    <a:off x="4475951" y="3482260"/>
                    <a:ext cx="1281324" cy="679150"/>
                    <a:chOff x="2098328" y="3149903"/>
                    <a:chExt cx="1281324" cy="679150"/>
                  </a:xfrm>
                </p:grpSpPr>
                <p:pic>
                  <p:nvPicPr>
                    <p:cNvPr id="132" name="Picture 131">
                      <a:extLst>
                        <a:ext uri="{FF2B5EF4-FFF2-40B4-BE49-F238E27FC236}">
                          <a16:creationId xmlns:a16="http://schemas.microsoft.com/office/drawing/2014/main" id="{429CBB43-296B-4862-9010-343285D104B6}"/>
                        </a:ext>
                      </a:extLst>
                    </p:cNvPr>
                    <p:cNvPicPr>
                      <a:picLocks noChangeAspect="1"/>
                    </p:cNvPicPr>
                    <p:nvPr/>
                  </p:nvPicPr>
                  <p:blipFill rotWithShape="1">
                    <a:blip r:embed="rId17"/>
                    <a:srcRect t="18997" b="13530"/>
                    <a:stretch/>
                  </p:blipFill>
                  <p:spPr>
                    <a:xfrm>
                      <a:off x="2100871" y="3149903"/>
                      <a:ext cx="1278781" cy="396000"/>
                    </a:xfrm>
                    <a:prstGeom prst="rect">
                      <a:avLst/>
                    </a:prstGeom>
                  </p:spPr>
                </p:pic>
                <p:pic>
                  <p:nvPicPr>
                    <p:cNvPr id="133" name="Picture 132">
                      <a:extLst>
                        <a:ext uri="{FF2B5EF4-FFF2-40B4-BE49-F238E27FC236}">
                          <a16:creationId xmlns:a16="http://schemas.microsoft.com/office/drawing/2014/main" id="{CFB204DB-E7CC-4BB2-A48D-1B47A7B8EBFC}"/>
                        </a:ext>
                      </a:extLst>
                    </p:cNvPr>
                    <p:cNvPicPr>
                      <a:picLocks noChangeAspect="1"/>
                    </p:cNvPicPr>
                    <p:nvPr/>
                  </p:nvPicPr>
                  <p:blipFill rotWithShape="1">
                    <a:blip r:embed="rId18"/>
                    <a:srcRect t="37492" b="23451"/>
                    <a:stretch/>
                  </p:blipFill>
                  <p:spPr>
                    <a:xfrm>
                      <a:off x="2098328" y="3609453"/>
                      <a:ext cx="1276957" cy="219600"/>
                    </a:xfrm>
                    <a:prstGeom prst="rect">
                      <a:avLst/>
                    </a:prstGeom>
                  </p:spPr>
                </p:pic>
              </p:grpSp>
              <p:sp>
                <p:nvSpPr>
                  <p:cNvPr id="130" name="TextBox 129">
                    <a:extLst>
                      <a:ext uri="{FF2B5EF4-FFF2-40B4-BE49-F238E27FC236}">
                        <a16:creationId xmlns:a16="http://schemas.microsoft.com/office/drawing/2014/main" id="{272B03DF-D5B2-4C49-BA64-D5BF2B00507C}"/>
                      </a:ext>
                    </a:extLst>
                  </p:cNvPr>
                  <p:cNvSpPr txBox="1"/>
                  <p:nvPr/>
                </p:nvSpPr>
                <p:spPr>
                  <a:xfrm>
                    <a:off x="5674771" y="3926909"/>
                    <a:ext cx="569387"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CTIN</a:t>
                    </a:r>
                  </a:p>
                </p:txBody>
              </p:sp>
              <p:sp>
                <p:nvSpPr>
                  <p:cNvPr id="131" name="TextBox 130">
                    <a:extLst>
                      <a:ext uri="{FF2B5EF4-FFF2-40B4-BE49-F238E27FC236}">
                        <a16:creationId xmlns:a16="http://schemas.microsoft.com/office/drawing/2014/main" id="{1D2FD3C2-3CC1-4A72-8DD1-28A702F6B54D}"/>
                      </a:ext>
                    </a:extLst>
                  </p:cNvPr>
                  <p:cNvSpPr txBox="1"/>
                  <p:nvPr/>
                </p:nvSpPr>
                <p:spPr>
                  <a:xfrm>
                    <a:off x="5674770" y="3511646"/>
                    <a:ext cx="527709"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r>
                      <a:rPr lang="en-US" sz="1000" dirty="0" err="1">
                        <a:latin typeface="Arial" panose="020B0604020202020204" pitchFamily="34" charset="0"/>
                        <a:cs typeface="Arial" panose="020B0604020202020204" pitchFamily="34" charset="0"/>
                      </a:rPr>
                      <a:t>Myc</a:t>
                    </a:r>
                    <a:endParaRPr lang="en-US" sz="1000" dirty="0">
                      <a:latin typeface="Arial" panose="020B0604020202020204" pitchFamily="34" charset="0"/>
                      <a:cs typeface="Arial" panose="020B0604020202020204" pitchFamily="34" charset="0"/>
                    </a:endParaRPr>
                  </a:p>
                </p:txBody>
              </p:sp>
            </p:grpSp>
            <p:sp>
              <p:nvSpPr>
                <p:cNvPr id="126" name="TextBox 125">
                  <a:extLst>
                    <a:ext uri="{FF2B5EF4-FFF2-40B4-BE49-F238E27FC236}">
                      <a16:creationId xmlns:a16="http://schemas.microsoft.com/office/drawing/2014/main" id="{4BA7F144-6CD7-43EF-B5D8-DEA35FAD7631}"/>
                    </a:ext>
                  </a:extLst>
                </p:cNvPr>
                <p:cNvSpPr txBox="1"/>
                <p:nvPr/>
              </p:nvSpPr>
              <p:spPr>
                <a:xfrm>
                  <a:off x="1749484" y="2747517"/>
                  <a:ext cx="1452642" cy="246221"/>
                </a:xfrm>
                <a:prstGeom prst="rect">
                  <a:avLst/>
                </a:prstGeom>
                <a:noFill/>
              </p:spPr>
              <p:txBody>
                <a:bodyPr wrap="none" rtlCol="0">
                  <a:spAutoFit/>
                </a:bodyPr>
                <a:lstStyle/>
                <a:p>
                  <a:r>
                    <a:rPr lang="en-US" sz="1000" dirty="0" err="1">
                      <a:latin typeface="Arial" panose="020B0604020202020204" pitchFamily="34" charset="0"/>
                      <a:cs typeface="Arial" panose="020B0604020202020204" pitchFamily="34" charset="0"/>
                    </a:rPr>
                    <a:t>miR</a:t>
                  </a:r>
                  <a:r>
                    <a:rPr lang="en-US" sz="1000" dirty="0">
                      <a:latin typeface="Arial" panose="020B0604020202020204" pitchFamily="34" charset="0"/>
                      <a:cs typeface="Arial" panose="020B0604020202020204" pitchFamily="34" charset="0"/>
                    </a:rPr>
                    <a:t>-CTRL    miR-616</a:t>
                  </a:r>
                </a:p>
              </p:txBody>
            </p:sp>
            <p:cxnSp>
              <p:nvCxnSpPr>
                <p:cNvPr id="127" name="Straight Connector 126"/>
                <p:cNvCxnSpPr/>
                <p:nvPr/>
              </p:nvCxnSpPr>
              <p:spPr>
                <a:xfrm>
                  <a:off x="1816641" y="2782358"/>
                  <a:ext cx="1224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28" name="TextBox 127"/>
                <p:cNvSpPr txBox="1"/>
                <p:nvPr/>
              </p:nvSpPr>
              <p:spPr>
                <a:xfrm>
                  <a:off x="1952494" y="2590572"/>
                  <a:ext cx="981359" cy="246221"/>
                </a:xfrm>
                <a:prstGeom prst="rect">
                  <a:avLst/>
                </a:prstGeom>
                <a:noFill/>
              </p:spPr>
              <p:txBody>
                <a:bodyPr wrap="none" rtlCol="0">
                  <a:spAutoFit/>
                </a:bodyPr>
                <a:lstStyle/>
                <a:p>
                  <a:r>
                    <a:rPr lang="en-IE" sz="1000" dirty="0">
                      <a:latin typeface="Arial" panose="020B0604020202020204" pitchFamily="34" charset="0"/>
                      <a:cs typeface="Arial" panose="020B0604020202020204" pitchFamily="34" charset="0"/>
                    </a:rPr>
                    <a:t>HCT116 Cells</a:t>
                  </a:r>
                </a:p>
              </p:txBody>
            </p:sp>
          </p:grpSp>
          <p:sp>
            <p:nvSpPr>
              <p:cNvPr id="124" name="TextBox 123"/>
              <p:cNvSpPr txBox="1"/>
              <p:nvPr/>
            </p:nvSpPr>
            <p:spPr>
              <a:xfrm>
                <a:off x="2910980" y="2466362"/>
                <a:ext cx="248786" cy="246221"/>
              </a:xfrm>
              <a:prstGeom prst="rect">
                <a:avLst/>
              </a:prstGeom>
              <a:noFill/>
            </p:spPr>
            <p:txBody>
              <a:bodyPr wrap="none" rtlCol="0">
                <a:spAutoFit/>
              </a:bodyPr>
              <a:lstStyle/>
              <a:p>
                <a:r>
                  <a:rPr lang="en-IE" sz="1000" dirty="0"/>
                  <a:t>*</a:t>
                </a:r>
              </a:p>
            </p:txBody>
          </p:sp>
        </p:grpSp>
      </p:grpSp>
      <p:sp>
        <p:nvSpPr>
          <p:cNvPr id="2" name="TextBox 1"/>
          <p:cNvSpPr txBox="1"/>
          <p:nvPr/>
        </p:nvSpPr>
        <p:spPr>
          <a:xfrm>
            <a:off x="2225040" y="224244"/>
            <a:ext cx="5466561" cy="2031325"/>
          </a:xfrm>
          <a:prstGeom prst="rect">
            <a:avLst/>
          </a:prstGeom>
          <a:noFill/>
        </p:spPr>
        <p:txBody>
          <a:bodyPr wrap="none" rtlCol="0">
            <a:spAutoFit/>
          </a:bodyPr>
          <a:lstStyle/>
          <a:p>
            <a:r>
              <a:rPr lang="en-IE" sz="1400" b="1" dirty="0"/>
              <a:t>A                                                            B                                                                D</a:t>
            </a:r>
          </a:p>
          <a:p>
            <a:endParaRPr lang="en-IE" sz="1400" b="1" dirty="0"/>
          </a:p>
          <a:p>
            <a:endParaRPr lang="en-IE" sz="1400" b="1" dirty="0"/>
          </a:p>
          <a:p>
            <a:endParaRPr lang="en-IE" sz="1400" b="1" dirty="0"/>
          </a:p>
          <a:p>
            <a:endParaRPr lang="en-IE" sz="1400" b="1" dirty="0"/>
          </a:p>
          <a:p>
            <a:endParaRPr lang="en-IE" sz="1400" b="1" dirty="0"/>
          </a:p>
          <a:p>
            <a:endParaRPr lang="en-IE" sz="1400" b="1" dirty="0"/>
          </a:p>
          <a:p>
            <a:endParaRPr lang="en-IE" sz="1400" b="1" dirty="0"/>
          </a:p>
          <a:p>
            <a:r>
              <a:rPr lang="en-IE" sz="1400" b="1" dirty="0"/>
              <a:t>C</a:t>
            </a:r>
          </a:p>
        </p:txBody>
      </p:sp>
      <p:sp>
        <p:nvSpPr>
          <p:cNvPr id="44" name="Rectangle 43"/>
          <p:cNvSpPr/>
          <p:nvPr/>
        </p:nvSpPr>
        <p:spPr>
          <a:xfrm>
            <a:off x="2255909" y="4297096"/>
            <a:ext cx="7406640" cy="1938992"/>
          </a:xfrm>
          <a:prstGeom prst="rect">
            <a:avLst/>
          </a:prstGeom>
        </p:spPr>
        <p:txBody>
          <a:bodyPr wrap="square">
            <a:spAutoFit/>
          </a:bodyPr>
          <a:lstStyle/>
          <a:p>
            <a:pPr algn="just"/>
            <a:r>
              <a:rPr lang="en-IE" sz="1200" dirty="0">
                <a:effectLst/>
                <a:ea typeface="Calibri" panose="020F0502020204030204" pitchFamily="34" charset="0"/>
                <a:cs typeface="Arial" panose="020B0604020202020204" pitchFamily="34" charset="0"/>
              </a:rPr>
              <a:t>Supplementary figure </a:t>
            </a:r>
            <a:r>
              <a:rPr lang="en-IE" sz="1200" dirty="0" smtClean="0">
                <a:effectLst/>
                <a:ea typeface="Calibri" panose="020F0502020204030204" pitchFamily="34" charset="0"/>
                <a:cs typeface="Arial" panose="020B0604020202020204" pitchFamily="34" charset="0"/>
              </a:rPr>
              <a:t>8</a:t>
            </a:r>
            <a:r>
              <a:rPr lang="en-IE" sz="1200" dirty="0" smtClean="0">
                <a:cs typeface="Calibri" panose="020F0502020204030204" pitchFamily="34" charset="0"/>
              </a:rPr>
              <a:t>. </a:t>
            </a:r>
            <a:r>
              <a:rPr lang="en-IE" sz="1200" b="1" dirty="0">
                <a:cs typeface="Calibri" panose="020F0502020204030204" pitchFamily="34" charset="0"/>
              </a:rPr>
              <a:t>miR-616 reduces the proliferation of HCT116 cells. </a:t>
            </a:r>
            <a:r>
              <a:rPr lang="en-US" sz="1200" dirty="0"/>
              <a:t>(A) </a:t>
            </a:r>
            <a:r>
              <a:rPr lang="en-IE" sz="1200" dirty="0"/>
              <a:t>Control (HCT116-miR-CTRL) and miR-616-overexpressing (HCT116-miR-616) sub-clones of HCT116 cells were plated and cell growth was determined by MTS assay. Line graphs show the absorbance in cells at the indicated time points. Error bars represent mean ± S.D. from three independent experiments performed in triplicate. (B) HCT116-miR-CTRL and HCT116-miR-616 cells were plated in 6- well plate (1000 cells/well) and grown for 14 days. Colonies stained with crystal violet are shown. (C) HCT116-miR-CTRL and HCT116-miR-616 cells were plated in 6-well plate. The monolayer of cells was scratched with a micropipette tip (200 µl). Black lines indicate the wound borders at indicated time points post-scratching. Scale bar, 1000 µM. Line graph shows the scratch gap quantified using Image J software at the indicated time points. (D) The expression level of c-Myc protein is shown in HCT116-miR-CTRL and HCT116-miR-616 cells. *P &lt; 0.05, two-tailed unpaired t-test as compared to the control sub-clone.</a:t>
            </a:r>
            <a:endParaRPr lang="en-IE" sz="1200" dirty="0">
              <a:cs typeface="Calibri" panose="020F0502020204030204" pitchFamily="34" charset="0"/>
            </a:endParaRPr>
          </a:p>
        </p:txBody>
      </p:sp>
      <p:sp>
        <p:nvSpPr>
          <p:cNvPr id="3" name="TextBox 2"/>
          <p:cNvSpPr txBox="1"/>
          <p:nvPr/>
        </p:nvSpPr>
        <p:spPr>
          <a:xfrm>
            <a:off x="8682827" y="1001865"/>
            <a:ext cx="1088760" cy="230832"/>
          </a:xfrm>
          <a:prstGeom prst="rect">
            <a:avLst/>
          </a:prstGeom>
          <a:noFill/>
        </p:spPr>
        <p:txBody>
          <a:bodyPr wrap="none" rtlCol="0">
            <a:spAutoFit/>
          </a:bodyPr>
          <a:lstStyle/>
          <a:p>
            <a:r>
              <a:rPr lang="en-IE" sz="900" dirty="0">
                <a:latin typeface="Arial" panose="020B0604020202020204" pitchFamily="34" charset="0"/>
                <a:cs typeface="Arial" panose="020B0604020202020204" pitchFamily="34" charset="0"/>
              </a:rPr>
              <a:t>n</a:t>
            </a:r>
            <a:r>
              <a:rPr lang="en-IE" sz="900" dirty="0" smtClean="0">
                <a:latin typeface="Arial" panose="020B0604020202020204" pitchFamily="34" charset="0"/>
                <a:cs typeface="Arial" panose="020B0604020202020204" pitchFamily="34" charset="0"/>
              </a:rPr>
              <a:t>on-specific band</a:t>
            </a:r>
            <a:endParaRPr lang="en-IE" sz="9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16356982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6229506" y="179115"/>
            <a:ext cx="5171237" cy="5562683"/>
            <a:chOff x="352338" y="412235"/>
            <a:chExt cx="5171237" cy="5562683"/>
          </a:xfrm>
        </p:grpSpPr>
        <p:grpSp>
          <p:nvGrpSpPr>
            <p:cNvPr id="3" name="Group 2"/>
            <p:cNvGrpSpPr/>
            <p:nvPr/>
          </p:nvGrpSpPr>
          <p:grpSpPr>
            <a:xfrm>
              <a:off x="1126472" y="4040287"/>
              <a:ext cx="4388880" cy="1934631"/>
              <a:chOff x="5700890" y="866198"/>
              <a:chExt cx="4388880" cy="1934631"/>
            </a:xfrm>
          </p:grpSpPr>
          <p:pic>
            <p:nvPicPr>
              <p:cNvPr id="10" name="Picture 9"/>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700890" y="923306"/>
                <a:ext cx="1689122" cy="1877523"/>
              </a:xfrm>
              <a:prstGeom prst="rect">
                <a:avLst/>
              </a:prstGeom>
            </p:spPr>
          </p:pic>
          <p:pic>
            <p:nvPicPr>
              <p:cNvPr id="11" name="Picture 10"/>
              <p:cNvPicPr>
                <a:picLocks noChangeAspect="1"/>
              </p:cNvPicPr>
              <p:nvPr/>
            </p:nvPicPr>
            <p:blipFill rotWithShape="1">
              <a:blip r:embed="rId3"/>
              <a:srcRect t="22568" r="48433" b="11146"/>
              <a:stretch/>
            </p:blipFill>
            <p:spPr>
              <a:xfrm>
                <a:off x="7528770" y="866198"/>
                <a:ext cx="2561000" cy="1728000"/>
              </a:xfrm>
              <a:prstGeom prst="rect">
                <a:avLst/>
              </a:prstGeom>
            </p:spPr>
          </p:pic>
        </p:grpSp>
        <p:grpSp>
          <p:nvGrpSpPr>
            <p:cNvPr id="4" name="Group 3"/>
            <p:cNvGrpSpPr/>
            <p:nvPr/>
          </p:nvGrpSpPr>
          <p:grpSpPr>
            <a:xfrm>
              <a:off x="530579" y="412235"/>
              <a:ext cx="4992996" cy="1728000"/>
              <a:chOff x="519290" y="1894255"/>
              <a:chExt cx="4992996" cy="1728000"/>
            </a:xfrm>
          </p:grpSpPr>
          <p:pic>
            <p:nvPicPr>
              <p:cNvPr id="8" name="Picture 2" descr="https://bibiserv.cebitec.uni-bielefeld.de/spool?id=bibiserv2_2023-01-11_165507_ArU6E&amp;name=NM_002467.6_hsa-miR-616-3p_917.jpg&amp;tool=rnahybrid&amp;contenttype=image/jpe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519290" y="1983695"/>
                <a:ext cx="2348453" cy="1584000"/>
              </a:xfrm>
              <a:prstGeom prst="rect">
                <a:avLst/>
              </a:prstGeom>
              <a:noFill/>
              <a:extLst>
                <a:ext uri="{909E8E84-426E-40DD-AFC4-6F175D3DCCD1}">
                  <a14:hiddenFill xmlns:a14="http://schemas.microsoft.com/office/drawing/2010/main">
                    <a:solidFill>
                      <a:srgbClr val="FFFFFF"/>
                    </a:solidFill>
                  </a14:hiddenFill>
                </a:ext>
              </a:extLst>
            </p:spPr>
          </p:pic>
          <p:pic>
            <p:nvPicPr>
              <p:cNvPr id="9" name="Picture 8"/>
              <p:cNvPicPr>
                <a:picLocks noChangeAspect="1"/>
              </p:cNvPicPr>
              <p:nvPr/>
            </p:nvPicPr>
            <p:blipFill rotWithShape="1">
              <a:blip r:embed="rId5"/>
              <a:srcRect t="15011" r="49965"/>
              <a:stretch/>
            </p:blipFill>
            <p:spPr>
              <a:xfrm>
                <a:off x="2939810" y="1894255"/>
                <a:ext cx="2572476" cy="1728000"/>
              </a:xfrm>
              <a:prstGeom prst="rect">
                <a:avLst/>
              </a:prstGeom>
            </p:spPr>
          </p:pic>
        </p:grpSp>
        <p:grpSp>
          <p:nvGrpSpPr>
            <p:cNvPr id="5" name="Group 4"/>
            <p:cNvGrpSpPr/>
            <p:nvPr/>
          </p:nvGrpSpPr>
          <p:grpSpPr>
            <a:xfrm>
              <a:off x="352338" y="2246991"/>
              <a:ext cx="4888012" cy="1728000"/>
              <a:chOff x="352338" y="3902225"/>
              <a:chExt cx="4888012" cy="1728000"/>
            </a:xfrm>
          </p:grpSpPr>
          <p:pic>
            <p:nvPicPr>
              <p:cNvPr id="6" name="Picture 4" descr="https://bibiserv.cebitec.uni-bielefeld.de/spool?id=bibiserv2_2023-01-11_165507_ArU6E&amp;name=NM_002467.6_hsa-miR-616-3p_1525.jpg&amp;tool=rnahybrid&amp;contenttype=image/jpeg"/>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352338" y="4009600"/>
                <a:ext cx="2639736" cy="1532750"/>
              </a:xfrm>
              <a:prstGeom prst="rect">
                <a:avLst/>
              </a:prstGeom>
              <a:noFill/>
              <a:extLst>
                <a:ext uri="{909E8E84-426E-40DD-AFC4-6F175D3DCCD1}">
                  <a14:hiddenFill xmlns:a14="http://schemas.microsoft.com/office/drawing/2010/main">
                    <a:solidFill>
                      <a:srgbClr val="FFFFFF"/>
                    </a:solidFill>
                  </a14:hiddenFill>
                </a:ext>
              </a:extLst>
            </p:spPr>
          </p:pic>
          <p:pic>
            <p:nvPicPr>
              <p:cNvPr id="7" name="Picture 6"/>
              <p:cNvPicPr>
                <a:picLocks noChangeAspect="1"/>
              </p:cNvPicPr>
              <p:nvPr/>
            </p:nvPicPr>
            <p:blipFill rotWithShape="1">
              <a:blip r:embed="rId7"/>
              <a:srcRect t="12539" r="58730"/>
              <a:stretch/>
            </p:blipFill>
            <p:spPr>
              <a:xfrm>
                <a:off x="2951670" y="3902225"/>
                <a:ext cx="2288680" cy="1728000"/>
              </a:xfrm>
              <a:prstGeom prst="rect">
                <a:avLst/>
              </a:prstGeom>
            </p:spPr>
          </p:pic>
        </p:grpSp>
      </p:grpSp>
      <p:grpSp>
        <p:nvGrpSpPr>
          <p:cNvPr id="12" name="Group 11"/>
          <p:cNvGrpSpPr/>
          <p:nvPr/>
        </p:nvGrpSpPr>
        <p:grpSpPr>
          <a:xfrm>
            <a:off x="120690" y="175006"/>
            <a:ext cx="5596751" cy="5654565"/>
            <a:chOff x="0" y="329361"/>
            <a:chExt cx="5596751" cy="5654565"/>
          </a:xfrm>
        </p:grpSpPr>
        <p:grpSp>
          <p:nvGrpSpPr>
            <p:cNvPr id="13" name="Group 12"/>
            <p:cNvGrpSpPr/>
            <p:nvPr/>
          </p:nvGrpSpPr>
          <p:grpSpPr>
            <a:xfrm>
              <a:off x="457200" y="329361"/>
              <a:ext cx="5117639" cy="1728000"/>
              <a:chOff x="0" y="1294561"/>
              <a:chExt cx="5117639" cy="1728000"/>
            </a:xfrm>
          </p:grpSpPr>
          <p:pic>
            <p:nvPicPr>
              <p:cNvPr id="20" name="Picture 19"/>
              <p:cNvPicPr>
                <a:picLocks noChangeAspect="1"/>
              </p:cNvPicPr>
              <p:nvPr/>
            </p:nvPicPr>
            <p:blipFill>
              <a:blip r:embed="rId8"/>
              <a:stretch>
                <a:fillRect/>
              </a:stretch>
            </p:blipFill>
            <p:spPr>
              <a:xfrm>
                <a:off x="2736266" y="1294561"/>
                <a:ext cx="2381373" cy="1728000"/>
              </a:xfrm>
              <a:prstGeom prst="rect">
                <a:avLst/>
              </a:prstGeom>
            </p:spPr>
          </p:pic>
          <p:pic>
            <p:nvPicPr>
              <p:cNvPr id="21" name="Picture 2" descr="https://bibiserv.cebitec.uni-bielefeld.de/spool?id=bibiserv2_2023-01-16_113440_Vabsv&amp;name=NM_002467.6_hsa-miR-616-5p_3067.jpg&amp;tool=rnahybrid&amp;contenttype=image/jpeg"/>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0" y="1372065"/>
                <a:ext cx="2710906" cy="1435614"/>
              </a:xfrm>
              <a:prstGeom prst="rect">
                <a:avLst/>
              </a:prstGeom>
              <a:noFill/>
              <a:extLst>
                <a:ext uri="{909E8E84-426E-40DD-AFC4-6F175D3DCCD1}">
                  <a14:hiddenFill xmlns:a14="http://schemas.microsoft.com/office/drawing/2010/main">
                    <a:solidFill>
                      <a:srgbClr val="FFFFFF"/>
                    </a:solidFill>
                  </a14:hiddenFill>
                </a:ext>
              </a:extLst>
            </p:spPr>
          </p:pic>
        </p:grpSp>
        <p:grpSp>
          <p:nvGrpSpPr>
            <p:cNvPr id="14" name="Group 13"/>
            <p:cNvGrpSpPr/>
            <p:nvPr/>
          </p:nvGrpSpPr>
          <p:grpSpPr>
            <a:xfrm>
              <a:off x="507507" y="3925931"/>
              <a:ext cx="5069218" cy="2057995"/>
              <a:chOff x="-5494597" y="6447808"/>
              <a:chExt cx="5069218" cy="2057995"/>
            </a:xfrm>
          </p:grpSpPr>
          <p:pic>
            <p:nvPicPr>
              <p:cNvPr id="18" name="Picture 17"/>
              <p:cNvPicPr>
                <a:picLocks noChangeAspect="1"/>
              </p:cNvPicPr>
              <p:nvPr/>
            </p:nvPicPr>
            <p:blipFill>
              <a:blip r:embed="rId10"/>
              <a:stretch>
                <a:fillRect/>
              </a:stretch>
            </p:blipFill>
            <p:spPr>
              <a:xfrm>
                <a:off x="-2807468" y="6447808"/>
                <a:ext cx="2382089" cy="1804613"/>
              </a:xfrm>
              <a:prstGeom prst="rect">
                <a:avLst/>
              </a:prstGeom>
            </p:spPr>
          </p:pic>
          <p:pic>
            <p:nvPicPr>
              <p:cNvPr id="19" name="Picture 4" descr="https://bibiserv.cebitec.uni-bielefeld.de/spool?id=bibiserv2_2023-01-16_113440_Vabsv&amp;name=NM_002467.6_hsa-miR-616-5p_2501.jpg&amp;tool=rnahybrid&amp;contenttype=image/jpeg"/>
              <p:cNvPicPr>
                <a:picLocks noChangeAspect="1"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5494597" y="6529889"/>
                <a:ext cx="2060295" cy="1975914"/>
              </a:xfrm>
              <a:prstGeom prst="rect">
                <a:avLst/>
              </a:prstGeom>
              <a:noFill/>
              <a:extLst>
                <a:ext uri="{909E8E84-426E-40DD-AFC4-6F175D3DCCD1}">
                  <a14:hiddenFill xmlns:a14="http://schemas.microsoft.com/office/drawing/2010/main">
                    <a:solidFill>
                      <a:srgbClr val="FFFFFF"/>
                    </a:solidFill>
                  </a14:hiddenFill>
                </a:ext>
              </a:extLst>
            </p:spPr>
          </p:pic>
        </p:grpSp>
        <p:grpSp>
          <p:nvGrpSpPr>
            <p:cNvPr id="15" name="Group 14"/>
            <p:cNvGrpSpPr/>
            <p:nvPr/>
          </p:nvGrpSpPr>
          <p:grpSpPr>
            <a:xfrm>
              <a:off x="0" y="2168937"/>
              <a:ext cx="5596751" cy="1692000"/>
              <a:chOff x="5518684" y="3213995"/>
              <a:chExt cx="5596751" cy="1692000"/>
            </a:xfrm>
          </p:grpSpPr>
          <p:pic>
            <p:nvPicPr>
              <p:cNvPr id="16" name="Picture 6" descr="https://bibiserv.cebitec.uni-bielefeld.de/spool?id=bibiserv2_2023-01-16_113440_Vabsv&amp;name=NM_002467.6_hsa-miR-616-5p_77.jpg&amp;tool=rnahybrid&amp;contenttype=image/jpeg"/>
              <p:cNvPicPr>
                <a:picLocks noChangeAspect="1" noChangeArrowheads="1"/>
              </p:cNvPicPr>
              <p:nvPr/>
            </p:nvPicPr>
            <p:blipFill>
              <a:blip r:embed="rId12">
                <a:extLst>
                  <a:ext uri="{28A0092B-C50C-407E-A947-70E740481C1C}">
                    <a14:useLocalDpi xmlns:a14="http://schemas.microsoft.com/office/drawing/2010/main" val="0"/>
                  </a:ext>
                </a:extLst>
              </a:blip>
              <a:srcRect/>
              <a:stretch>
                <a:fillRect/>
              </a:stretch>
            </p:blipFill>
            <p:spPr bwMode="auto">
              <a:xfrm>
                <a:off x="5518684" y="3253637"/>
                <a:ext cx="3216479" cy="1589408"/>
              </a:xfrm>
              <a:prstGeom prst="rect">
                <a:avLst/>
              </a:prstGeom>
              <a:noFill/>
              <a:extLst>
                <a:ext uri="{909E8E84-426E-40DD-AFC4-6F175D3DCCD1}">
                  <a14:hiddenFill xmlns:a14="http://schemas.microsoft.com/office/drawing/2010/main">
                    <a:solidFill>
                      <a:srgbClr val="FFFFFF"/>
                    </a:solidFill>
                  </a14:hiddenFill>
                </a:ext>
              </a:extLst>
            </p:spPr>
          </p:pic>
          <p:pic>
            <p:nvPicPr>
              <p:cNvPr id="17" name="Picture 16"/>
              <p:cNvPicPr>
                <a:picLocks noChangeAspect="1"/>
              </p:cNvPicPr>
              <p:nvPr/>
            </p:nvPicPr>
            <p:blipFill>
              <a:blip r:embed="rId13"/>
              <a:stretch>
                <a:fillRect/>
              </a:stretch>
            </p:blipFill>
            <p:spPr>
              <a:xfrm>
                <a:off x="8712795" y="3213995"/>
                <a:ext cx="2402640" cy="1692000"/>
              </a:xfrm>
              <a:prstGeom prst="rect">
                <a:avLst/>
              </a:prstGeom>
            </p:spPr>
          </p:pic>
        </p:grpSp>
      </p:grpSp>
      <p:sp>
        <p:nvSpPr>
          <p:cNvPr id="27" name="Rectangle 26"/>
          <p:cNvSpPr/>
          <p:nvPr/>
        </p:nvSpPr>
        <p:spPr>
          <a:xfrm>
            <a:off x="1361673" y="5917290"/>
            <a:ext cx="9854268" cy="461665"/>
          </a:xfrm>
          <a:prstGeom prst="rect">
            <a:avLst/>
          </a:prstGeom>
        </p:spPr>
        <p:txBody>
          <a:bodyPr wrap="square">
            <a:spAutoFit/>
          </a:bodyPr>
          <a:lstStyle/>
          <a:p>
            <a:pPr algn="just"/>
            <a:r>
              <a:rPr lang="en-IE" sz="1200" dirty="0">
                <a:effectLst/>
                <a:ea typeface="Calibri" panose="020F0502020204030204" pitchFamily="34" charset="0"/>
                <a:cs typeface="Arial" panose="020B0604020202020204" pitchFamily="34" charset="0"/>
              </a:rPr>
              <a:t>Supplementary figure </a:t>
            </a:r>
            <a:r>
              <a:rPr lang="en-IE" sz="1200" dirty="0" smtClean="0">
                <a:effectLst/>
                <a:ea typeface="Calibri" panose="020F0502020204030204" pitchFamily="34" charset="0"/>
                <a:cs typeface="Arial" panose="020B0604020202020204" pitchFamily="34" charset="0"/>
              </a:rPr>
              <a:t>9</a:t>
            </a:r>
            <a:r>
              <a:rPr lang="en-IE" sz="1200" dirty="0" smtClean="0"/>
              <a:t>. </a:t>
            </a:r>
            <a:r>
              <a:rPr lang="en-IE" sz="1200" b="1" dirty="0"/>
              <a:t>Identification of a miR-616-5p and miR-616-3p -binding sites in the c-Myc. </a:t>
            </a:r>
            <a:r>
              <a:rPr lang="en-IE" sz="1200" dirty="0" err="1"/>
              <a:t>RNAhybrid</a:t>
            </a:r>
            <a:r>
              <a:rPr lang="en-IE" sz="1200" dirty="0"/>
              <a:t> analysis of c-MYC reference sequence and miR-616. The secondary structure of miRNA-mRNA duplex is shown with miRNA in green and mRNA in red. </a:t>
            </a:r>
            <a:r>
              <a:rPr lang="en-IE" sz="1200" dirty="0" err="1"/>
              <a:t>mfe</a:t>
            </a:r>
            <a:r>
              <a:rPr lang="en-IE" sz="1200" dirty="0"/>
              <a:t>: minimum free energy. </a:t>
            </a:r>
          </a:p>
        </p:txBody>
      </p:sp>
    </p:spTree>
    <p:extLst>
      <p:ext uri="{BB962C8B-B14F-4D97-AF65-F5344CB8AC3E}">
        <p14:creationId xmlns:p14="http://schemas.microsoft.com/office/powerpoint/2010/main" val="6341103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1_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Theme">
      <a:majorFont>
        <a:latin typeface="Helvetica Neue"/>
        <a:ea typeface="Helvetica Neue"/>
        <a:cs typeface="Helvetica Neue"/>
      </a:majorFont>
      <a:minorFont>
        <a:latin typeface="Helvetica"/>
        <a:ea typeface="Helvetica"/>
        <a:cs typeface="Helvetica"/>
      </a:minorFont>
    </a:fontScheme>
    <a:fmtScheme name="Office Them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38100" dist="23000" dir="5400000" rotWithShape="0">
              <a:srgbClr val="000000">
                <a:alpha val="35000"/>
              </a:srgbClr>
            </a:outerShdw>
          </a:effectLst>
        </a:effectStyle>
        <a:effectStyle>
          <a:effectLst>
            <a:outerShdw blurRad="38100" dist="23000" dir="5400000" rotWithShape="0">
              <a:srgbClr val="000000">
                <a:alpha val="35000"/>
              </a:srgbClr>
            </a:outerShdw>
          </a:effectLst>
        </a:effectStyle>
        <a:effectStyle>
          <a:effectLst>
            <a:outerShdw blurRad="38100" dist="20000" dir="5400000" rotWithShape="0">
              <a:srgbClr val="000000">
                <a:alpha val="38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chemeClr val="accent1"/>
          </a:solidFill>
          <a:prstDash val="solid"/>
          <a:round/>
        </a:ln>
        <a:effectLst>
          <a:outerShdw blurRad="38100" dist="23000" dir="5400000" rotWithShape="0">
            <a:srgbClr val="000000">
              <a:alpha val="35000"/>
            </a:srgbClr>
          </a:outerShdw>
        </a:effectLst>
        <a:sp3d/>
      </a:spPr>
      <a:bodyPr rot="0" spcFirstLastPara="1" vertOverflow="overflow" horzOverflow="overflow" vert="horz" wrap="square" lIns="45719" tIns="45719" rIns="45719" bIns="45719" numCol="1" spcCol="38100" rtlCol="0" anchor="ctr">
        <a:spAutoFit/>
      </a:bodyPr>
      <a:lstStyle>
        <a:defPPr marL="0" marR="0" indent="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Calibri"/>
            <a:ea typeface="Calibri"/>
            <a:cs typeface="Calibri"/>
            <a:sym typeface="Calibri"/>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outerShdw blurRad="38100" dist="20000" dir="5400000" rotWithShape="0">
            <a:srgbClr val="000000">
              <a:alpha val="38000"/>
            </a:srgbClr>
          </a:outerShdw>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45719" tIns="45719" rIns="45719" bIns="45719" numCol="1" spcCol="38100" rtlCol="0" anchor="t">
        <a:spAutoFit/>
      </a:bodyPr>
      <a:lstStyle>
        <a:defPPr marL="0" marR="0" indent="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Calibri"/>
            <a:ea typeface="Calibri"/>
            <a:cs typeface="Calibri"/>
            <a:sym typeface="Calibri"/>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124334E90161F04FBC841F5562821D8D" ma:contentTypeVersion="15" ma:contentTypeDescription="Create a new document." ma:contentTypeScope="" ma:versionID="dc575bf7efe72591f8d5fa7cb4d22386">
  <xsd:schema xmlns:xsd="http://www.w3.org/2001/XMLSchema" xmlns:xs="http://www.w3.org/2001/XMLSchema" xmlns:p="http://schemas.microsoft.com/office/2006/metadata/properties" xmlns:ns3="4fc988d4-577e-42e9-9b2a-2c85a526e18d" xmlns:ns4="405233e3-2b02-4cc3-b510-aa513db20907" targetNamespace="http://schemas.microsoft.com/office/2006/metadata/properties" ma:root="true" ma:fieldsID="132471165f19c1ff8483e92beb31df83" ns3:_="" ns4:_="">
    <xsd:import namespace="4fc988d4-577e-42e9-9b2a-2c85a526e18d"/>
    <xsd:import namespace="405233e3-2b02-4cc3-b510-aa513db20907"/>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4:SharedWithUsers" minOccurs="0"/>
                <xsd:element ref="ns4:SharedWithDetails" minOccurs="0"/>
                <xsd:element ref="ns4:SharingHintHash" minOccurs="0"/>
                <xsd:element ref="ns3:MediaServiceDateTaken" minOccurs="0"/>
                <xsd:element ref="ns3:MediaServiceAutoTags" minOccurs="0"/>
                <xsd:element ref="ns3:MediaLengthInSeconds" minOccurs="0"/>
                <xsd:element ref="ns3:MediaServiceGenerationTime" minOccurs="0"/>
                <xsd:element ref="ns3:MediaServiceEventHashCode" minOccurs="0"/>
                <xsd:element ref="ns3:MediaServiceOCR" minOccurs="0"/>
                <xsd:element ref="ns3:MediaServiceLocation" minOccurs="0"/>
                <xsd:element ref="ns3:_activity"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4fc988d4-577e-42e9-9b2a-2c85a526e18d"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DateTaken" ma:index="15" nillable="true" ma:displayName="MediaServiceDateTaken" ma:hidden="true" ma:internalName="MediaServiceDateTaken" ma:readOnly="true">
      <xsd:simpleType>
        <xsd:restriction base="dms:Text"/>
      </xsd:simpleType>
    </xsd:element>
    <xsd:element name="MediaServiceAutoTags" ma:index="16" nillable="true" ma:displayName="Tags" ma:internalName="MediaServiceAutoTags" ma:readOnly="true">
      <xsd:simpleType>
        <xsd:restriction base="dms:Text"/>
      </xsd:simpleType>
    </xsd:element>
    <xsd:element name="MediaLengthInSeconds" ma:index="17" nillable="true" ma:displayName="Length (seconds)" ma:internalName="MediaLengthInSeconds" ma:readOnly="true">
      <xsd:simpleType>
        <xsd:restriction base="dms:Unknown"/>
      </xsd:simpleType>
    </xsd:element>
    <xsd:element name="MediaServiceGenerationTime" ma:index="18" nillable="true" ma:displayName="MediaServiceGenerationTime" ma:hidden="true" ma:internalName="MediaServiceGenerationTime" ma:readOnly="true">
      <xsd:simpleType>
        <xsd:restriction base="dms:Text"/>
      </xsd:simpleType>
    </xsd:element>
    <xsd:element name="MediaServiceEventHashCode" ma:index="19" nillable="true" ma:displayName="MediaServiceEventHashCode" ma:hidden="true" ma:internalName="MediaServiceEventHashCode" ma:readOnly="true">
      <xsd:simpleType>
        <xsd:restriction base="dms:Text"/>
      </xsd:simpleType>
    </xsd:element>
    <xsd:element name="MediaServiceOCR" ma:index="20" nillable="true" ma:displayName="Extracted Text" ma:internalName="MediaServiceOCR" ma:readOnly="true">
      <xsd:simpleType>
        <xsd:restriction base="dms:Note">
          <xsd:maxLength value="255"/>
        </xsd:restriction>
      </xsd:simpleType>
    </xsd:element>
    <xsd:element name="MediaServiceLocation" ma:index="21" nillable="true" ma:displayName="Location" ma:internalName="MediaServiceLocation" ma:readOnly="true">
      <xsd:simpleType>
        <xsd:restriction base="dms:Text"/>
      </xsd:simpleType>
    </xsd:element>
    <xsd:element name="_activity" ma:index="22" nillable="true" ma:displayName="_activity" ma:hidden="true" ma:internalName="_activity">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405233e3-2b02-4cc3-b510-aa513db20907" elementFormDefault="qualified">
    <xsd:import namespace="http://schemas.microsoft.com/office/2006/documentManagement/types"/>
    <xsd:import namespace="http://schemas.microsoft.com/office/infopath/2007/PartnerControls"/>
    <xsd:element name="SharedWithUsers" ma:index="12"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3" nillable="true" ma:displayName="Shared With Details" ma:internalName="SharedWithDetails" ma:readOnly="true">
      <xsd:simpleType>
        <xsd:restriction base="dms:Note">
          <xsd:maxLength value="255"/>
        </xsd:restriction>
      </xsd:simpleType>
    </xsd:element>
    <xsd:element name="SharingHintHash" ma:index="14"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_activity xmlns="4fc988d4-577e-42e9-9b2a-2c85a526e18d" xsi:nil="true"/>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59788B9D-7E80-4FA6-BDD1-74FC84351F80}">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4fc988d4-577e-42e9-9b2a-2c85a526e18d"/>
    <ds:schemaRef ds:uri="405233e3-2b02-4cc3-b510-aa513db20907"/>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FC105D21-567A-4E56-A0E4-78291F008F95}">
  <ds:schemaRefs>
    <ds:schemaRef ds:uri="http://purl.org/dc/elements/1.1/"/>
    <ds:schemaRef ds:uri="http://schemas.microsoft.com/office/2006/metadata/properties"/>
    <ds:schemaRef ds:uri="405233e3-2b02-4cc3-b510-aa513db20907"/>
    <ds:schemaRef ds:uri="http://purl.org/dc/terms/"/>
    <ds:schemaRef ds:uri="http://schemas.openxmlformats.org/package/2006/metadata/core-properties"/>
    <ds:schemaRef ds:uri="http://schemas.microsoft.com/office/2006/documentManagement/types"/>
    <ds:schemaRef ds:uri="http://schemas.microsoft.com/office/infopath/2007/PartnerControls"/>
    <ds:schemaRef ds:uri="4fc988d4-577e-42e9-9b2a-2c85a526e18d"/>
    <ds:schemaRef ds:uri="http://www.w3.org/XML/1998/namespace"/>
    <ds:schemaRef ds:uri="http://purl.org/dc/dcmitype/"/>
  </ds:schemaRefs>
</ds:datastoreItem>
</file>

<file path=customXml/itemProps3.xml><?xml version="1.0" encoding="utf-8"?>
<ds:datastoreItem xmlns:ds="http://schemas.openxmlformats.org/officeDocument/2006/customXml" ds:itemID="{E2B96C37-A14A-4588-A89B-5FF10DBC4A9F}">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34788</TotalTime>
  <Words>1376</Words>
  <Application>Microsoft Office PowerPoint</Application>
  <PresentationFormat>Widescreen</PresentationFormat>
  <Paragraphs>104</Paragraphs>
  <Slides>10</Slides>
  <Notes>1</Notes>
  <HiddenSlides>0</HiddenSlides>
  <MMClips>0</MMClips>
  <ScaleCrop>false</ScaleCrop>
  <HeadingPairs>
    <vt:vector size="8" baseType="variant">
      <vt:variant>
        <vt:lpstr>Fonts Used</vt:lpstr>
      </vt:variant>
      <vt:variant>
        <vt:i4>8</vt:i4>
      </vt:variant>
      <vt:variant>
        <vt:lpstr>Theme</vt:lpstr>
      </vt:variant>
      <vt:variant>
        <vt:i4>2</vt:i4>
      </vt:variant>
      <vt:variant>
        <vt:lpstr>Embedded OLE Servers</vt:lpstr>
      </vt:variant>
      <vt:variant>
        <vt:i4>1</vt:i4>
      </vt:variant>
      <vt:variant>
        <vt:lpstr>Slide Titles</vt:lpstr>
      </vt:variant>
      <vt:variant>
        <vt:i4>10</vt:i4>
      </vt:variant>
    </vt:vector>
  </HeadingPairs>
  <TitlesOfParts>
    <vt:vector size="21" baseType="lpstr">
      <vt:lpstr>Arial</vt:lpstr>
      <vt:lpstr>Calibri</vt:lpstr>
      <vt:lpstr>Calibri Light</vt:lpstr>
      <vt:lpstr>EuclidSymbol</vt:lpstr>
      <vt:lpstr>Helvetica</vt:lpstr>
      <vt:lpstr>Poppins-ExtraBold</vt:lpstr>
      <vt:lpstr>SymbolMT</vt:lpstr>
      <vt:lpstr>Times New Roman</vt:lpstr>
      <vt:lpstr>Office Theme</vt:lpstr>
      <vt:lpstr>1_Office Theme</vt:lpstr>
      <vt:lpstr>Prism 8</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ULTANA, AFRIN</dc:creator>
  <cp:lastModifiedBy>Gupta, Sanjeev</cp:lastModifiedBy>
  <cp:revision>329</cp:revision>
  <dcterms:created xsi:type="dcterms:W3CDTF">2023-01-03T02:12:38Z</dcterms:created>
  <dcterms:modified xsi:type="dcterms:W3CDTF">2023-08-21T12:02:5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124334E90161F04FBC841F5562821D8D</vt:lpwstr>
  </property>
</Properties>
</file>